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81" r:id="rId2"/>
    <p:sldId id="284" r:id="rId3"/>
    <p:sldId id="283" r:id="rId4"/>
    <p:sldId id="668" r:id="rId5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FFCA2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0767"/>
    <p:restoredTop sz="94648"/>
  </p:normalViewPr>
  <p:slideViewPr>
    <p:cSldViewPr snapToGrid="0" snapToObjects="1">
      <p:cViewPr varScale="1">
        <p:scale>
          <a:sx n="87" d="100"/>
          <a:sy n="87" d="100"/>
        </p:scale>
        <p:origin x="3264" y="2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Wencai Zhang" userId="4a86a1d0-2108-4707-8228-1110f3c1be85" providerId="ADAL" clId="{920F07FE-E293-934A-8ABE-C25D5FB2EFC8}"/>
    <pc:docChg chg="custSel delSld modSld">
      <pc:chgData name="Wencai Zhang" userId="4a86a1d0-2108-4707-8228-1110f3c1be85" providerId="ADAL" clId="{920F07FE-E293-934A-8ABE-C25D5FB2EFC8}" dt="2021-06-16T14:12:48.365" v="32" actId="2696"/>
      <pc:docMkLst>
        <pc:docMk/>
      </pc:docMkLst>
      <pc:sldChg chg="del">
        <pc:chgData name="Wencai Zhang" userId="4a86a1d0-2108-4707-8228-1110f3c1be85" providerId="ADAL" clId="{920F07FE-E293-934A-8ABE-C25D5FB2EFC8}" dt="2021-06-16T14:12:48.341" v="30" actId="2696"/>
        <pc:sldMkLst>
          <pc:docMk/>
          <pc:sldMk cId="2562103204" sldId="271"/>
        </pc:sldMkLst>
      </pc:sldChg>
      <pc:sldChg chg="del">
        <pc:chgData name="Wencai Zhang" userId="4a86a1d0-2108-4707-8228-1110f3c1be85" providerId="ADAL" clId="{920F07FE-E293-934A-8ABE-C25D5FB2EFC8}" dt="2021-06-16T14:12:48.350" v="31" actId="2696"/>
        <pc:sldMkLst>
          <pc:docMk/>
          <pc:sldMk cId="3603884933" sldId="273"/>
        </pc:sldMkLst>
      </pc:sldChg>
      <pc:sldChg chg="del">
        <pc:chgData name="Wencai Zhang" userId="4a86a1d0-2108-4707-8228-1110f3c1be85" providerId="ADAL" clId="{920F07FE-E293-934A-8ABE-C25D5FB2EFC8}" dt="2021-06-16T14:12:48.365" v="32" actId="2696"/>
        <pc:sldMkLst>
          <pc:docMk/>
          <pc:sldMk cId="4021043559" sldId="274"/>
        </pc:sldMkLst>
      </pc:sldChg>
      <pc:sldChg chg="del">
        <pc:chgData name="Wencai Zhang" userId="4a86a1d0-2108-4707-8228-1110f3c1be85" providerId="ADAL" clId="{920F07FE-E293-934A-8ABE-C25D5FB2EFC8}" dt="2021-06-16T14:12:48.302" v="29" actId="2696"/>
        <pc:sldMkLst>
          <pc:docMk/>
          <pc:sldMk cId="4220638819" sldId="275"/>
        </pc:sldMkLst>
      </pc:sldChg>
      <pc:sldChg chg="del">
        <pc:chgData name="Wencai Zhang" userId="4a86a1d0-2108-4707-8228-1110f3c1be85" providerId="ADAL" clId="{920F07FE-E293-934A-8ABE-C25D5FB2EFC8}" dt="2021-06-16T14:12:48.201" v="27" actId="2696"/>
        <pc:sldMkLst>
          <pc:docMk/>
          <pc:sldMk cId="399587783" sldId="276"/>
        </pc:sldMkLst>
      </pc:sldChg>
      <pc:sldChg chg="del">
        <pc:chgData name="Wencai Zhang" userId="4a86a1d0-2108-4707-8228-1110f3c1be85" providerId="ADAL" clId="{920F07FE-E293-934A-8ABE-C25D5FB2EFC8}" dt="2021-06-16T14:12:48.283" v="28" actId="2696"/>
        <pc:sldMkLst>
          <pc:docMk/>
          <pc:sldMk cId="2650755790" sldId="277"/>
        </pc:sldMkLst>
      </pc:sldChg>
      <pc:sldChg chg="delSp modSp">
        <pc:chgData name="Wencai Zhang" userId="4a86a1d0-2108-4707-8228-1110f3c1be85" providerId="ADAL" clId="{920F07FE-E293-934A-8ABE-C25D5FB2EFC8}" dt="2021-06-16T14:12:17.416" v="26" actId="478"/>
        <pc:sldMkLst>
          <pc:docMk/>
          <pc:sldMk cId="2833226476" sldId="280"/>
        </pc:sldMkLst>
        <pc:spChg chg="mod">
          <ac:chgData name="Wencai Zhang" userId="4a86a1d0-2108-4707-8228-1110f3c1be85" providerId="ADAL" clId="{920F07FE-E293-934A-8ABE-C25D5FB2EFC8}" dt="2021-06-16T14:12:11.176" v="25" actId="20577"/>
          <ac:spMkLst>
            <pc:docMk/>
            <pc:sldMk cId="2833226476" sldId="280"/>
            <ac:spMk id="4" creationId="{3F93EE33-98E6-3A41-B628-C0D0014E8476}"/>
          </ac:spMkLst>
        </pc:spChg>
        <pc:graphicFrameChg chg="del">
          <ac:chgData name="Wencai Zhang" userId="4a86a1d0-2108-4707-8228-1110f3c1be85" providerId="ADAL" clId="{920F07FE-E293-934A-8ABE-C25D5FB2EFC8}" dt="2021-06-16T14:12:17.416" v="26" actId="478"/>
          <ac:graphicFrameMkLst>
            <pc:docMk/>
            <pc:sldMk cId="2833226476" sldId="280"/>
            <ac:graphicFrameMk id="6" creationId="{66CD7BB6-CDE1-9447-BECE-C681B2FA2E90}"/>
          </ac:graphicFrameMkLst>
        </pc:graphicFrameChg>
        <pc:graphicFrameChg chg="del">
          <ac:chgData name="Wencai Zhang" userId="4a86a1d0-2108-4707-8228-1110f3c1be85" providerId="ADAL" clId="{920F07FE-E293-934A-8ABE-C25D5FB2EFC8}" dt="2021-06-16T14:12:17.416" v="26" actId="478"/>
          <ac:graphicFrameMkLst>
            <pc:docMk/>
            <pc:sldMk cId="2833226476" sldId="280"/>
            <ac:graphicFrameMk id="7" creationId="{C6071921-8BB5-C343-B396-FB0E39F887EA}"/>
          </ac:graphicFrameMkLst>
        </pc:graphicFrameChg>
      </pc:sldChg>
    </pc:docChg>
  </pc:docChgLst>
  <pc:docChgLst>
    <pc:chgData name="Cerena Moreno" clId="Web-{A69D5505-5708-4080-A7DF-FFF29BF9E319}"/>
    <pc:docChg chg="modSld">
      <pc:chgData name="Cerena Moreno" userId="" providerId="" clId="Web-{A69D5505-5708-4080-A7DF-FFF29BF9E319}" dt="2021-06-24T18:02:28.162" v="3"/>
      <pc:docMkLst>
        <pc:docMk/>
      </pc:docMkLst>
      <pc:sldChg chg="addSp delSp modSp">
        <pc:chgData name="Cerena Moreno" userId="" providerId="" clId="Web-{A69D5505-5708-4080-A7DF-FFF29BF9E319}" dt="2021-06-24T18:02:28.162" v="3"/>
        <pc:sldMkLst>
          <pc:docMk/>
          <pc:sldMk cId="555486090" sldId="272"/>
        </pc:sldMkLst>
        <pc:spChg chg="add del mod">
          <ac:chgData name="Cerena Moreno" userId="" providerId="" clId="Web-{A69D5505-5708-4080-A7DF-FFF29BF9E319}" dt="2021-06-24T18:02:28.162" v="3"/>
          <ac:spMkLst>
            <pc:docMk/>
            <pc:sldMk cId="555486090" sldId="272"/>
            <ac:spMk id="98" creationId="{A4F4F6D3-D3F0-EE48-8EFA-0C5664BEBC17}"/>
          </ac:spMkLst>
        </pc:spChg>
        <pc:grpChg chg="add del">
          <ac:chgData name="Cerena Moreno" userId="" providerId="" clId="Web-{A69D5505-5708-4080-A7DF-FFF29BF9E319}" dt="2021-06-24T18:01:52.270" v="2"/>
          <ac:grpSpMkLst>
            <pc:docMk/>
            <pc:sldMk cId="555486090" sldId="272"/>
            <ac:grpSpMk id="7" creationId="{342218EC-3DC6-874E-9013-0A30C4B3A472}"/>
          </ac:grpSpMkLst>
        </pc:grpChg>
        <pc:grpChg chg="add del">
          <ac:chgData name="Cerena Moreno" userId="" providerId="" clId="Web-{A69D5505-5708-4080-A7DF-FFF29BF9E319}" dt="2021-06-24T18:02:28.162" v="3"/>
          <ac:grpSpMkLst>
            <pc:docMk/>
            <pc:sldMk cId="555486090" sldId="272"/>
            <ac:grpSpMk id="69" creationId="{95F8E9A3-2B4F-0D4F-A796-9A2303112CFA}"/>
          </ac:grpSpMkLst>
        </pc:grpChg>
        <pc:picChg chg="mod">
          <ac:chgData name="Cerena Moreno" userId="" providerId="" clId="Web-{A69D5505-5708-4080-A7DF-FFF29BF9E319}" dt="2021-06-24T18:02:28.162" v="3"/>
          <ac:picMkLst>
            <pc:docMk/>
            <pc:sldMk cId="555486090" sldId="272"/>
            <ac:picMk id="71" creationId="{D8626C9B-0494-124D-BB3F-210F16016F7E}"/>
          </ac:picMkLst>
        </pc:picChg>
      </pc:sldChg>
    </pc:docChg>
  </pc:docChgLst>
  <pc:docChgLst>
    <pc:chgData name="Wencai Zhang" userId="4a86a1d0-2108-4707-8228-1110f3c1be85" providerId="ADAL" clId="{47CE5B07-09FF-8543-972E-E6329A8ECB40}"/>
    <pc:docChg chg="undo custSel addSld modSld">
      <pc:chgData name="Wencai Zhang" userId="4a86a1d0-2108-4707-8228-1110f3c1be85" providerId="ADAL" clId="{47CE5B07-09FF-8543-972E-E6329A8ECB40}" dt="2021-06-11T19:17:05.948" v="270" actId="478"/>
      <pc:docMkLst>
        <pc:docMk/>
      </pc:docMkLst>
      <pc:sldChg chg="addSp delSp modSp">
        <pc:chgData name="Wencai Zhang" userId="4a86a1d0-2108-4707-8228-1110f3c1be85" providerId="ADAL" clId="{47CE5B07-09FF-8543-972E-E6329A8ECB40}" dt="2021-06-11T19:17:05.948" v="270" actId="478"/>
        <pc:sldMkLst>
          <pc:docMk/>
          <pc:sldMk cId="555486090" sldId="272"/>
        </pc:sldMkLst>
        <pc:spChg chg="mod">
          <ac:chgData name="Wencai Zhang" userId="4a86a1d0-2108-4707-8228-1110f3c1be85" providerId="ADAL" clId="{47CE5B07-09FF-8543-972E-E6329A8ECB40}" dt="2021-06-11T17:38:24.888" v="7" actId="1076"/>
          <ac:spMkLst>
            <pc:docMk/>
            <pc:sldMk cId="555486090" sldId="272"/>
            <ac:spMk id="2" creationId="{62A0247D-6003-704B-9909-D67560E97746}"/>
          </ac:spMkLst>
        </pc:spChg>
        <pc:spChg chg="add mod">
          <ac:chgData name="Wencai Zhang" userId="4a86a1d0-2108-4707-8228-1110f3c1be85" providerId="ADAL" clId="{47CE5B07-09FF-8543-972E-E6329A8ECB40}" dt="2021-06-11T19:13:02.622" v="235" actId="1076"/>
          <ac:spMkLst>
            <pc:docMk/>
            <pc:sldMk cId="555486090" sldId="272"/>
            <ac:spMk id="10" creationId="{62912344-2FB8-3C40-9A45-09AA43D769D8}"/>
          </ac:spMkLst>
        </pc:spChg>
        <pc:spChg chg="add mod">
          <ac:chgData name="Wencai Zhang" userId="4a86a1d0-2108-4707-8228-1110f3c1be85" providerId="ADAL" clId="{47CE5B07-09FF-8543-972E-E6329A8ECB40}" dt="2021-06-11T19:12:06.239" v="137" actId="164"/>
          <ac:spMkLst>
            <pc:docMk/>
            <pc:sldMk cId="555486090" sldId="272"/>
            <ac:spMk id="11" creationId="{9FB77A55-FEA7-6844-93B7-727730A29A86}"/>
          </ac:spMkLst>
        </pc:spChg>
        <pc:spChg chg="mod">
          <ac:chgData name="Wencai Zhang" userId="4a86a1d0-2108-4707-8228-1110f3c1be85" providerId="ADAL" clId="{47CE5B07-09FF-8543-972E-E6329A8ECB40}" dt="2021-06-11T19:10:58.237" v="115"/>
          <ac:spMkLst>
            <pc:docMk/>
            <pc:sldMk cId="555486090" sldId="272"/>
            <ac:spMk id="14" creationId="{F2CF0DDF-2105-41B2-A771-E6152B5E7EAC}"/>
          </ac:spMkLst>
        </pc:spChg>
        <pc:spChg chg="mod">
          <ac:chgData name="Wencai Zhang" userId="4a86a1d0-2108-4707-8228-1110f3c1be85" providerId="ADAL" clId="{47CE5B07-09FF-8543-972E-E6329A8ECB40}" dt="2021-06-11T19:10:34.910" v="110" actId="20577"/>
          <ac:spMkLst>
            <pc:docMk/>
            <pc:sldMk cId="555486090" sldId="272"/>
            <ac:spMk id="15" creationId="{FA8A4BA1-E8A5-4368-8B8E-D6B9C65F24D5}"/>
          </ac:spMkLst>
        </pc:spChg>
        <pc:spChg chg="mod">
          <ac:chgData name="Wencai Zhang" userId="4a86a1d0-2108-4707-8228-1110f3c1be85" providerId="ADAL" clId="{47CE5B07-09FF-8543-972E-E6329A8ECB40}" dt="2021-06-11T19:09:27.717" v="87" actId="404"/>
          <ac:spMkLst>
            <pc:docMk/>
            <pc:sldMk cId="555486090" sldId="272"/>
            <ac:spMk id="17" creationId="{AA556D15-7026-4ACB-8A16-89B31966DE69}"/>
          </ac:spMkLst>
        </pc:spChg>
        <pc:spChg chg="del">
          <ac:chgData name="Wencai Zhang" userId="4a86a1d0-2108-4707-8228-1110f3c1be85" providerId="ADAL" clId="{47CE5B07-09FF-8543-972E-E6329A8ECB40}" dt="2021-06-11T19:17:05.948" v="270" actId="478"/>
          <ac:spMkLst>
            <pc:docMk/>
            <pc:sldMk cId="555486090" sldId="272"/>
            <ac:spMk id="44" creationId="{6B65C643-D0FC-764C-BE41-6D5DB9FE3C3C}"/>
          </ac:spMkLst>
        </pc:spChg>
        <pc:spChg chg="mod">
          <ac:chgData name="Wencai Zhang" userId="4a86a1d0-2108-4707-8228-1110f3c1be85" providerId="ADAL" clId="{47CE5B07-09FF-8543-972E-E6329A8ECB40}" dt="2021-06-11T19:12:50.666" v="227" actId="404"/>
          <ac:spMkLst>
            <pc:docMk/>
            <pc:sldMk cId="555486090" sldId="272"/>
            <ac:spMk id="45" creationId="{B2AA6943-EB8B-EE4C-9137-93FF3149EADA}"/>
          </ac:spMkLst>
        </pc:spChg>
        <pc:spChg chg="mod">
          <ac:chgData name="Wencai Zhang" userId="4a86a1d0-2108-4707-8228-1110f3c1be85" providerId="ADAL" clId="{47CE5B07-09FF-8543-972E-E6329A8ECB40}" dt="2021-06-11T19:13:21.692" v="239" actId="1076"/>
          <ac:spMkLst>
            <pc:docMk/>
            <pc:sldMk cId="555486090" sldId="272"/>
            <ac:spMk id="46" creationId="{AE153BE9-E801-9F46-B19E-88780C594949}"/>
          </ac:spMkLst>
        </pc:spChg>
        <pc:spChg chg="mod">
          <ac:chgData name="Wencai Zhang" userId="4a86a1d0-2108-4707-8228-1110f3c1be85" providerId="ADAL" clId="{47CE5B07-09FF-8543-972E-E6329A8ECB40}" dt="2021-06-11T19:12:50.666" v="227" actId="404"/>
          <ac:spMkLst>
            <pc:docMk/>
            <pc:sldMk cId="555486090" sldId="272"/>
            <ac:spMk id="51" creationId="{E37AD563-CB3E-E24F-B69A-5D3C8532C49B}"/>
          </ac:spMkLst>
        </pc:spChg>
        <pc:grpChg chg="del">
          <ac:chgData name="Wencai Zhang" userId="4a86a1d0-2108-4707-8228-1110f3c1be85" providerId="ADAL" clId="{47CE5B07-09FF-8543-972E-E6329A8ECB40}" dt="2021-06-11T18:44:44.449" v="19" actId="478"/>
          <ac:grpSpMkLst>
            <pc:docMk/>
            <pc:sldMk cId="555486090" sldId="272"/>
            <ac:grpSpMk id="6" creationId="{5BBCE63B-3F6E-4628-9D2A-69AE69EAC276}"/>
          </ac:grpSpMkLst>
        </pc:grpChg>
        <pc:grpChg chg="mod">
          <ac:chgData name="Wencai Zhang" userId="4a86a1d0-2108-4707-8228-1110f3c1be85" providerId="ADAL" clId="{47CE5B07-09FF-8543-972E-E6329A8ECB40}" dt="2021-06-11T19:12:06.239" v="137" actId="164"/>
          <ac:grpSpMkLst>
            <pc:docMk/>
            <pc:sldMk cId="555486090" sldId="272"/>
            <ac:grpSpMk id="12" creationId="{15B01F17-AC59-4BA2-BA55-EFB794259900}"/>
          </ac:grpSpMkLst>
        </pc:grpChg>
        <pc:grpChg chg="mod">
          <ac:chgData name="Wencai Zhang" userId="4a86a1d0-2108-4707-8228-1110f3c1be85" providerId="ADAL" clId="{47CE5B07-09FF-8543-972E-E6329A8ECB40}" dt="2021-06-11T19:10:58.237" v="115"/>
          <ac:grpSpMkLst>
            <pc:docMk/>
            <pc:sldMk cId="555486090" sldId="272"/>
            <ac:grpSpMk id="13" creationId="{A8ADF8AD-4936-453B-8E63-1FAC7F47221D}"/>
          </ac:grpSpMkLst>
        </pc:grpChg>
        <pc:grpChg chg="mod">
          <ac:chgData name="Wencai Zhang" userId="4a86a1d0-2108-4707-8228-1110f3c1be85" providerId="ADAL" clId="{47CE5B07-09FF-8543-972E-E6329A8ECB40}" dt="2021-06-11T19:10:58.237" v="115"/>
          <ac:grpSpMkLst>
            <pc:docMk/>
            <pc:sldMk cId="555486090" sldId="272"/>
            <ac:grpSpMk id="16" creationId="{E75124E7-0FAF-4238-B9D2-FC3DF7199FBF}"/>
          </ac:grpSpMkLst>
        </pc:grpChg>
        <pc:grpChg chg="add mod">
          <ac:chgData name="Wencai Zhang" userId="4a86a1d0-2108-4707-8228-1110f3c1be85" providerId="ADAL" clId="{47CE5B07-09FF-8543-972E-E6329A8ECB40}" dt="2021-06-11T19:12:20.593" v="192" actId="1037"/>
          <ac:grpSpMkLst>
            <pc:docMk/>
            <pc:sldMk cId="555486090" sldId="272"/>
            <ac:grpSpMk id="31" creationId="{20A76283-C9D6-A84C-BBD1-29CD353A19C2}"/>
          </ac:grpSpMkLst>
        </pc:grpChg>
        <pc:graphicFrameChg chg="mod topLvl modGraphic">
          <ac:chgData name="Wencai Zhang" userId="4a86a1d0-2108-4707-8228-1110f3c1be85" providerId="ADAL" clId="{47CE5B07-09FF-8543-972E-E6329A8ECB40}" dt="2021-06-11T19:17:01.708" v="269" actId="1076"/>
          <ac:graphicFrameMkLst>
            <pc:docMk/>
            <pc:sldMk cId="555486090" sldId="272"/>
            <ac:graphicFrameMk id="3" creationId="{7067052F-377D-4FB1-BCD6-25BD2CA7B2C7}"/>
          </ac:graphicFrameMkLst>
        </pc:graphicFrameChg>
        <pc:graphicFrameChg chg="del">
          <ac:chgData name="Wencai Zhang" userId="4a86a1d0-2108-4707-8228-1110f3c1be85" providerId="ADAL" clId="{47CE5B07-09FF-8543-972E-E6329A8ECB40}" dt="2021-06-11T18:44:44.449" v="19" actId="478"/>
          <ac:graphicFrameMkLst>
            <pc:docMk/>
            <pc:sldMk cId="555486090" sldId="272"/>
            <ac:graphicFrameMk id="5" creationId="{91492FF7-4DC1-45F4-90C6-3ADE091545C6}"/>
          </ac:graphicFrameMkLst>
        </pc:graphicFrameChg>
      </pc:sldChg>
      <pc:sldChg chg="addSp delSp add">
        <pc:chgData name="Wencai Zhang" userId="4a86a1d0-2108-4707-8228-1110f3c1be85" providerId="ADAL" clId="{47CE5B07-09FF-8543-972E-E6329A8ECB40}" dt="2021-06-11T14:25:47.208" v="4"/>
        <pc:sldMkLst>
          <pc:docMk/>
          <pc:sldMk cId="4220638819" sldId="275"/>
        </pc:sldMkLst>
        <pc:spChg chg="del">
          <ac:chgData name="Wencai Zhang" userId="4a86a1d0-2108-4707-8228-1110f3c1be85" providerId="ADAL" clId="{47CE5B07-09FF-8543-972E-E6329A8ECB40}" dt="2021-06-11T14:25:41.558" v="1" actId="478"/>
          <ac:spMkLst>
            <pc:docMk/>
            <pc:sldMk cId="4220638819" sldId="275"/>
            <ac:spMk id="2" creationId="{83CD3FD3-6594-5648-8124-C7560B8B3341}"/>
          </ac:spMkLst>
        </pc:spChg>
        <pc:spChg chg="del">
          <ac:chgData name="Wencai Zhang" userId="4a86a1d0-2108-4707-8228-1110f3c1be85" providerId="ADAL" clId="{47CE5B07-09FF-8543-972E-E6329A8ECB40}" dt="2021-06-11T14:25:41.558" v="1" actId="478"/>
          <ac:spMkLst>
            <pc:docMk/>
            <pc:sldMk cId="4220638819" sldId="275"/>
            <ac:spMk id="3" creationId="{E3C0D0EF-57F1-F849-9076-ABE95A42274A}"/>
          </ac:spMkLst>
        </pc:spChg>
        <pc:graphicFrameChg chg="add del">
          <ac:chgData name="Wencai Zhang" userId="4a86a1d0-2108-4707-8228-1110f3c1be85" providerId="ADAL" clId="{47CE5B07-09FF-8543-972E-E6329A8ECB40}" dt="2021-06-11T14:25:47.125" v="3"/>
          <ac:graphicFrameMkLst>
            <pc:docMk/>
            <pc:sldMk cId="4220638819" sldId="275"/>
            <ac:graphicFrameMk id="4" creationId="{EE5B9F22-A8A6-3640-A5B5-F08816464969}"/>
          </ac:graphicFrameMkLst>
        </pc:graphicFrameChg>
        <pc:graphicFrameChg chg="add">
          <ac:chgData name="Wencai Zhang" userId="4a86a1d0-2108-4707-8228-1110f3c1be85" providerId="ADAL" clId="{47CE5B07-09FF-8543-972E-E6329A8ECB40}" dt="2021-06-11T14:25:47.208" v="4"/>
          <ac:graphicFrameMkLst>
            <pc:docMk/>
            <pc:sldMk cId="4220638819" sldId="275"/>
            <ac:graphicFrameMk id="5" creationId="{438C620D-E82F-0343-8D7E-A1371316BB8B}"/>
          </ac:graphicFrameMkLst>
        </pc:graphicFrameChg>
      </pc:sldChg>
      <pc:sldChg chg="delSp modSp add">
        <pc:chgData name="Wencai Zhang" userId="4a86a1d0-2108-4707-8228-1110f3c1be85" providerId="ADAL" clId="{47CE5B07-09FF-8543-972E-E6329A8ECB40}" dt="2021-06-11T18:44:57.008" v="20" actId="478"/>
        <pc:sldMkLst>
          <pc:docMk/>
          <pc:sldMk cId="399587783" sldId="276"/>
        </pc:sldMkLst>
        <pc:spChg chg="mod">
          <ac:chgData name="Wencai Zhang" userId="4a86a1d0-2108-4707-8228-1110f3c1be85" providerId="ADAL" clId="{47CE5B07-09FF-8543-972E-E6329A8ECB40}" dt="2021-06-11T18:42:33.986" v="10" actId="20577"/>
          <ac:spMkLst>
            <pc:docMk/>
            <pc:sldMk cId="399587783" sldId="276"/>
            <ac:spMk id="2" creationId="{62A0247D-6003-704B-9909-D67560E97746}"/>
          </ac:spMkLst>
        </pc:spChg>
        <pc:spChg chg="del">
          <ac:chgData name="Wencai Zhang" userId="4a86a1d0-2108-4707-8228-1110f3c1be85" providerId="ADAL" clId="{47CE5B07-09FF-8543-972E-E6329A8ECB40}" dt="2021-06-11T18:43:01.627" v="16" actId="478"/>
          <ac:spMkLst>
            <pc:docMk/>
            <pc:sldMk cId="399587783" sldId="276"/>
            <ac:spMk id="43" creationId="{37CFE433-1F3F-2F4B-90BE-2C0A049BAF5D}"/>
          </ac:spMkLst>
        </pc:spChg>
        <pc:spChg chg="mod">
          <ac:chgData name="Wencai Zhang" userId="4a86a1d0-2108-4707-8228-1110f3c1be85" providerId="ADAL" clId="{47CE5B07-09FF-8543-972E-E6329A8ECB40}" dt="2021-06-11T18:42:59.299" v="15" actId="1076"/>
          <ac:spMkLst>
            <pc:docMk/>
            <pc:sldMk cId="399587783" sldId="276"/>
            <ac:spMk id="51" creationId="{E37AD563-CB3E-E24F-B69A-5D3C8532C49B}"/>
          </ac:spMkLst>
        </pc:spChg>
        <pc:grpChg chg="mod">
          <ac:chgData name="Wencai Zhang" userId="4a86a1d0-2108-4707-8228-1110f3c1be85" providerId="ADAL" clId="{47CE5B07-09FF-8543-972E-E6329A8ECB40}" dt="2021-06-11T18:44:16.812" v="17" actId="1076"/>
          <ac:grpSpMkLst>
            <pc:docMk/>
            <pc:sldMk cId="399587783" sldId="276"/>
            <ac:grpSpMk id="6" creationId="{5BBCE63B-3F6E-4628-9D2A-69AE69EAC276}"/>
          </ac:grpSpMkLst>
        </pc:grpChg>
        <pc:grpChg chg="del">
          <ac:chgData name="Wencai Zhang" userId="4a86a1d0-2108-4707-8228-1110f3c1be85" providerId="ADAL" clId="{47CE5B07-09FF-8543-972E-E6329A8ECB40}" dt="2021-06-11T18:42:39.700" v="11" actId="478"/>
          <ac:grpSpMkLst>
            <pc:docMk/>
            <pc:sldMk cId="399587783" sldId="276"/>
            <ac:grpSpMk id="12" creationId="{15B01F17-AC59-4BA2-BA55-EFB794259900}"/>
          </ac:grpSpMkLst>
        </pc:grpChg>
        <pc:graphicFrameChg chg="del">
          <ac:chgData name="Wencai Zhang" userId="4a86a1d0-2108-4707-8228-1110f3c1be85" providerId="ADAL" clId="{47CE5B07-09FF-8543-972E-E6329A8ECB40}" dt="2021-06-11T18:44:57.008" v="20" actId="478"/>
          <ac:graphicFrameMkLst>
            <pc:docMk/>
            <pc:sldMk cId="399587783" sldId="276"/>
            <ac:graphicFrameMk id="3" creationId="{7067052F-377D-4FB1-BCD6-25BD2CA7B2C7}"/>
          </ac:graphicFrameMkLst>
        </pc:graphicFrameChg>
        <pc:graphicFrameChg chg="mod">
          <ac:chgData name="Wencai Zhang" userId="4a86a1d0-2108-4707-8228-1110f3c1be85" providerId="ADAL" clId="{47CE5B07-09FF-8543-972E-E6329A8ECB40}" dt="2021-06-11T18:44:20.400" v="18" actId="1076"/>
          <ac:graphicFrameMkLst>
            <pc:docMk/>
            <pc:sldMk cId="399587783" sldId="276"/>
            <ac:graphicFrameMk id="5" creationId="{91492FF7-4DC1-45F4-90C6-3ADE091545C6}"/>
          </ac:graphicFrameMkLst>
        </pc:graphicFrameChg>
      </pc:sldChg>
    </pc:docChg>
  </pc:docChgLst>
  <pc:docChgLst>
    <pc:chgData name="Wencai Zhang" userId="4a86a1d0-2108-4707-8228-1110f3c1be85" providerId="ADAL" clId="{16283776-4D00-FC4E-A55A-552C82537BBB}"/>
    <pc:docChg chg="custSel modSld">
      <pc:chgData name="Wencai Zhang" userId="4a86a1d0-2108-4707-8228-1110f3c1be85" providerId="ADAL" clId="{16283776-4D00-FC4E-A55A-552C82537BBB}" dt="2022-06-15T19:41:59.307" v="16" actId="478"/>
      <pc:docMkLst>
        <pc:docMk/>
      </pc:docMkLst>
      <pc:sldChg chg="delSp modSp">
        <pc:chgData name="Wencai Zhang" userId="4a86a1d0-2108-4707-8228-1110f3c1be85" providerId="ADAL" clId="{16283776-4D00-FC4E-A55A-552C82537BBB}" dt="2022-06-15T19:40:17.258" v="6" actId="478"/>
        <pc:sldMkLst>
          <pc:docMk/>
          <pc:sldMk cId="3759201367" sldId="279"/>
        </pc:sldMkLst>
        <pc:spChg chg="del">
          <ac:chgData name="Wencai Zhang" userId="4a86a1d0-2108-4707-8228-1110f3c1be85" providerId="ADAL" clId="{16283776-4D00-FC4E-A55A-552C82537BBB}" dt="2022-06-15T19:40:03.036" v="0" actId="478"/>
          <ac:spMkLst>
            <pc:docMk/>
            <pc:sldMk cId="3759201367" sldId="279"/>
            <ac:spMk id="15" creationId="{0F7D241E-2962-4A4C-8D85-6B8E7786806D}"/>
          </ac:spMkLst>
        </pc:spChg>
        <pc:spChg chg="del">
          <ac:chgData name="Wencai Zhang" userId="4a86a1d0-2108-4707-8228-1110f3c1be85" providerId="ADAL" clId="{16283776-4D00-FC4E-A55A-552C82537BBB}" dt="2022-06-15T19:40:17.258" v="6" actId="478"/>
          <ac:spMkLst>
            <pc:docMk/>
            <pc:sldMk cId="3759201367" sldId="279"/>
            <ac:spMk id="18" creationId="{7FB24E40-FCA8-C9EC-6ACB-6324262ABC70}"/>
          </ac:spMkLst>
        </pc:spChg>
        <pc:grpChg chg="del">
          <ac:chgData name="Wencai Zhang" userId="4a86a1d0-2108-4707-8228-1110f3c1be85" providerId="ADAL" clId="{16283776-4D00-FC4E-A55A-552C82537BBB}" dt="2022-06-15T19:40:10.024" v="5" actId="478"/>
          <ac:grpSpMkLst>
            <pc:docMk/>
            <pc:sldMk cId="3759201367" sldId="279"/>
            <ac:grpSpMk id="6" creationId="{5BBCE63B-3F6E-4628-9D2A-69AE69EAC276}"/>
          </ac:grpSpMkLst>
        </pc:grpChg>
        <pc:graphicFrameChg chg="del">
          <ac:chgData name="Wencai Zhang" userId="4a86a1d0-2108-4707-8228-1110f3c1be85" providerId="ADAL" clId="{16283776-4D00-FC4E-A55A-552C82537BBB}" dt="2022-06-15T19:40:08.176" v="4" actId="478"/>
          <ac:graphicFrameMkLst>
            <pc:docMk/>
            <pc:sldMk cId="3759201367" sldId="279"/>
            <ac:graphicFrameMk id="5" creationId="{91492FF7-4DC1-45F4-90C6-3ADE091545C6}"/>
          </ac:graphicFrameMkLst>
        </pc:graphicFrameChg>
        <pc:picChg chg="del">
          <ac:chgData name="Wencai Zhang" userId="4a86a1d0-2108-4707-8228-1110f3c1be85" providerId="ADAL" clId="{16283776-4D00-FC4E-A55A-552C82537BBB}" dt="2022-06-15T19:40:05.164" v="2" actId="478"/>
          <ac:picMkLst>
            <pc:docMk/>
            <pc:sldMk cId="3759201367" sldId="279"/>
            <ac:picMk id="16" creationId="{055A586B-2AE6-784A-A11C-07886E0DC81A}"/>
          </ac:picMkLst>
        </pc:picChg>
        <pc:picChg chg="del mod">
          <ac:chgData name="Wencai Zhang" userId="4a86a1d0-2108-4707-8228-1110f3c1be85" providerId="ADAL" clId="{16283776-4D00-FC4E-A55A-552C82537BBB}" dt="2022-06-15T19:40:05.895" v="3" actId="478"/>
          <ac:picMkLst>
            <pc:docMk/>
            <pc:sldMk cId="3759201367" sldId="279"/>
            <ac:picMk id="17" creationId="{5D3B74DC-3E20-1D46-8E5B-367DF83508FD}"/>
          </ac:picMkLst>
        </pc:picChg>
      </pc:sldChg>
      <pc:sldChg chg="delSp">
        <pc:chgData name="Wencai Zhang" userId="4a86a1d0-2108-4707-8228-1110f3c1be85" providerId="ADAL" clId="{16283776-4D00-FC4E-A55A-552C82537BBB}" dt="2022-06-15T19:41:15.489" v="7" actId="478"/>
        <pc:sldMkLst>
          <pc:docMk/>
          <pc:sldMk cId="2061921346" sldId="281"/>
        </pc:sldMkLst>
        <pc:spChg chg="del">
          <ac:chgData name="Wencai Zhang" userId="4a86a1d0-2108-4707-8228-1110f3c1be85" providerId="ADAL" clId="{16283776-4D00-FC4E-A55A-552C82537BBB}" dt="2022-06-15T19:41:15.489" v="7" actId="478"/>
          <ac:spMkLst>
            <pc:docMk/>
            <pc:sldMk cId="2061921346" sldId="281"/>
            <ac:spMk id="31" creationId="{10210D5A-DB67-9844-99BE-8F67F8904355}"/>
          </ac:spMkLst>
        </pc:spChg>
      </pc:sldChg>
      <pc:sldChg chg="delSp">
        <pc:chgData name="Wencai Zhang" userId="4a86a1d0-2108-4707-8228-1110f3c1be85" providerId="ADAL" clId="{16283776-4D00-FC4E-A55A-552C82537BBB}" dt="2022-06-15T19:41:51.399" v="14" actId="478"/>
        <pc:sldMkLst>
          <pc:docMk/>
          <pc:sldMk cId="495234596" sldId="282"/>
        </pc:sldMkLst>
        <pc:spChg chg="del">
          <ac:chgData name="Wencai Zhang" userId="4a86a1d0-2108-4707-8228-1110f3c1be85" providerId="ADAL" clId="{16283776-4D00-FC4E-A55A-552C82537BBB}" dt="2022-06-15T19:41:51.399" v="14" actId="478"/>
          <ac:spMkLst>
            <pc:docMk/>
            <pc:sldMk cId="495234596" sldId="282"/>
            <ac:spMk id="5" creationId="{3DDAAADC-4070-A747-8C1A-EEAE7CFF713C}"/>
          </ac:spMkLst>
        </pc:spChg>
      </pc:sldChg>
      <pc:sldChg chg="delSp">
        <pc:chgData name="Wencai Zhang" userId="4a86a1d0-2108-4707-8228-1110f3c1be85" providerId="ADAL" clId="{16283776-4D00-FC4E-A55A-552C82537BBB}" dt="2022-06-15T19:41:35.648" v="11" actId="478"/>
        <pc:sldMkLst>
          <pc:docMk/>
          <pc:sldMk cId="2930520000" sldId="283"/>
        </pc:sldMkLst>
        <pc:spChg chg="del">
          <ac:chgData name="Wencai Zhang" userId="4a86a1d0-2108-4707-8228-1110f3c1be85" providerId="ADAL" clId="{16283776-4D00-FC4E-A55A-552C82537BBB}" dt="2022-06-15T19:41:35.648" v="11" actId="478"/>
          <ac:spMkLst>
            <pc:docMk/>
            <pc:sldMk cId="2930520000" sldId="283"/>
            <ac:spMk id="26" creationId="{67890AAD-A826-104E-BE3E-0DB542F0062D}"/>
          </ac:spMkLst>
        </pc:spChg>
        <pc:spChg chg="del">
          <ac:chgData name="Wencai Zhang" userId="4a86a1d0-2108-4707-8228-1110f3c1be85" providerId="ADAL" clId="{16283776-4D00-FC4E-A55A-552C82537BBB}" dt="2022-06-15T19:41:34.029" v="10" actId="478"/>
          <ac:spMkLst>
            <pc:docMk/>
            <pc:sldMk cId="2930520000" sldId="283"/>
            <ac:spMk id="28" creationId="{1620E729-4744-F342-B600-393EB63F604F}"/>
          </ac:spMkLst>
        </pc:spChg>
        <pc:spChg chg="del">
          <ac:chgData name="Wencai Zhang" userId="4a86a1d0-2108-4707-8228-1110f3c1be85" providerId="ADAL" clId="{16283776-4D00-FC4E-A55A-552C82537BBB}" dt="2022-06-15T19:41:34.029" v="10" actId="478"/>
          <ac:spMkLst>
            <pc:docMk/>
            <pc:sldMk cId="2930520000" sldId="283"/>
            <ac:spMk id="29" creationId="{A128D25D-BCC9-2048-8382-35CBD5CCDD93}"/>
          </ac:spMkLst>
        </pc:spChg>
        <pc:spChg chg="del">
          <ac:chgData name="Wencai Zhang" userId="4a86a1d0-2108-4707-8228-1110f3c1be85" providerId="ADAL" clId="{16283776-4D00-FC4E-A55A-552C82537BBB}" dt="2022-06-15T19:41:34.029" v="10" actId="478"/>
          <ac:spMkLst>
            <pc:docMk/>
            <pc:sldMk cId="2930520000" sldId="283"/>
            <ac:spMk id="30" creationId="{D3D644A6-1A5D-BC4B-9CE1-F65CA87C23E1}"/>
          </ac:spMkLst>
        </pc:spChg>
        <pc:spChg chg="del">
          <ac:chgData name="Wencai Zhang" userId="4a86a1d0-2108-4707-8228-1110f3c1be85" providerId="ADAL" clId="{16283776-4D00-FC4E-A55A-552C82537BBB}" dt="2022-06-15T19:41:34.029" v="10" actId="478"/>
          <ac:spMkLst>
            <pc:docMk/>
            <pc:sldMk cId="2930520000" sldId="283"/>
            <ac:spMk id="31" creationId="{24E582C5-ECF7-144D-92D2-E5AD54222C37}"/>
          </ac:spMkLst>
        </pc:spChg>
        <pc:spChg chg="del">
          <ac:chgData name="Wencai Zhang" userId="4a86a1d0-2108-4707-8228-1110f3c1be85" providerId="ADAL" clId="{16283776-4D00-FC4E-A55A-552C82537BBB}" dt="2022-06-15T19:41:34.029" v="10" actId="478"/>
          <ac:spMkLst>
            <pc:docMk/>
            <pc:sldMk cId="2930520000" sldId="283"/>
            <ac:spMk id="33" creationId="{441C8A0D-EDEE-194A-8184-2474853E450B}"/>
          </ac:spMkLst>
        </pc:spChg>
      </pc:sldChg>
      <pc:sldChg chg="delSp">
        <pc:chgData name="Wencai Zhang" userId="4a86a1d0-2108-4707-8228-1110f3c1be85" providerId="ADAL" clId="{16283776-4D00-FC4E-A55A-552C82537BBB}" dt="2022-06-15T19:41:30.361" v="9" actId="478"/>
        <pc:sldMkLst>
          <pc:docMk/>
          <pc:sldMk cId="3756175224" sldId="284"/>
        </pc:sldMkLst>
        <pc:spChg chg="del">
          <ac:chgData name="Wencai Zhang" userId="4a86a1d0-2108-4707-8228-1110f3c1be85" providerId="ADAL" clId="{16283776-4D00-FC4E-A55A-552C82537BBB}" dt="2022-06-15T19:41:22.711" v="8" actId="478"/>
          <ac:spMkLst>
            <pc:docMk/>
            <pc:sldMk cId="3756175224" sldId="284"/>
            <ac:spMk id="31" creationId="{7F3D7F35-06B9-4943-84B9-6DF15AE47D97}"/>
          </ac:spMkLst>
        </pc:spChg>
        <pc:grpChg chg="del">
          <ac:chgData name="Wencai Zhang" userId="4a86a1d0-2108-4707-8228-1110f3c1be85" providerId="ADAL" clId="{16283776-4D00-FC4E-A55A-552C82537BBB}" dt="2022-06-15T19:41:30.361" v="9" actId="478"/>
          <ac:grpSpMkLst>
            <pc:docMk/>
            <pc:sldMk cId="3756175224" sldId="284"/>
            <ac:grpSpMk id="36" creationId="{285AC0BC-FF77-6872-942F-B0185A00644F}"/>
          </ac:grpSpMkLst>
        </pc:grpChg>
      </pc:sldChg>
      <pc:sldChg chg="delSp">
        <pc:chgData name="Wencai Zhang" userId="4a86a1d0-2108-4707-8228-1110f3c1be85" providerId="ADAL" clId="{16283776-4D00-FC4E-A55A-552C82537BBB}" dt="2022-06-15T19:41:43.929" v="13" actId="478"/>
        <pc:sldMkLst>
          <pc:docMk/>
          <pc:sldMk cId="3813348304" sldId="285"/>
        </pc:sldMkLst>
        <pc:spChg chg="del">
          <ac:chgData name="Wencai Zhang" userId="4a86a1d0-2108-4707-8228-1110f3c1be85" providerId="ADAL" clId="{16283776-4D00-FC4E-A55A-552C82537BBB}" dt="2022-06-15T19:41:43.929" v="13" actId="478"/>
          <ac:spMkLst>
            <pc:docMk/>
            <pc:sldMk cId="3813348304" sldId="285"/>
            <ac:spMk id="5" creationId="{3DDAAADC-4070-A747-8C1A-EEAE7CFF713C}"/>
          </ac:spMkLst>
        </pc:spChg>
        <pc:picChg chg="del">
          <ac:chgData name="Wencai Zhang" userId="4a86a1d0-2108-4707-8228-1110f3c1be85" providerId="ADAL" clId="{16283776-4D00-FC4E-A55A-552C82537BBB}" dt="2022-06-15T19:41:43.929" v="13" actId="478"/>
          <ac:picMkLst>
            <pc:docMk/>
            <pc:sldMk cId="3813348304" sldId="285"/>
            <ac:picMk id="7" creationId="{31FD5166-8B6D-6742-848B-7A8A4CAD43BC}"/>
          </ac:picMkLst>
        </pc:picChg>
      </pc:sldChg>
      <pc:sldChg chg="delSp">
        <pc:chgData name="Wencai Zhang" userId="4a86a1d0-2108-4707-8228-1110f3c1be85" providerId="ADAL" clId="{16283776-4D00-FC4E-A55A-552C82537BBB}" dt="2022-06-15T19:41:59.307" v="16" actId="478"/>
        <pc:sldMkLst>
          <pc:docMk/>
          <pc:sldMk cId="3541618713" sldId="666"/>
        </pc:sldMkLst>
        <pc:spChg chg="del">
          <ac:chgData name="Wencai Zhang" userId="4a86a1d0-2108-4707-8228-1110f3c1be85" providerId="ADAL" clId="{16283776-4D00-FC4E-A55A-552C82537BBB}" dt="2022-06-15T19:41:59.307" v="16" actId="478"/>
          <ac:spMkLst>
            <pc:docMk/>
            <pc:sldMk cId="3541618713" sldId="666"/>
            <ac:spMk id="2" creationId="{9C268384-A989-0C40-9716-C30417941384}"/>
          </ac:spMkLst>
        </pc:spChg>
        <pc:spChg chg="del">
          <ac:chgData name="Wencai Zhang" userId="4a86a1d0-2108-4707-8228-1110f3c1be85" providerId="ADAL" clId="{16283776-4D00-FC4E-A55A-552C82537BBB}" dt="2022-06-15T19:41:56.980" v="15" actId="478"/>
          <ac:spMkLst>
            <pc:docMk/>
            <pc:sldMk cId="3541618713" sldId="666"/>
            <ac:spMk id="10" creationId="{764FC35E-E199-8E40-AD2F-6B50B5821997}"/>
          </ac:spMkLst>
        </pc:spChg>
        <pc:spChg chg="del">
          <ac:chgData name="Wencai Zhang" userId="4a86a1d0-2108-4707-8228-1110f3c1be85" providerId="ADAL" clId="{16283776-4D00-FC4E-A55A-552C82537BBB}" dt="2022-06-15T19:41:56.980" v="15" actId="478"/>
          <ac:spMkLst>
            <pc:docMk/>
            <pc:sldMk cId="3541618713" sldId="666"/>
            <ac:spMk id="82" creationId="{D9A20610-2CD0-B640-984E-313F07A102C1}"/>
          </ac:spMkLst>
        </pc:spChg>
        <pc:spChg chg="del">
          <ac:chgData name="Wencai Zhang" userId="4a86a1d0-2108-4707-8228-1110f3c1be85" providerId="ADAL" clId="{16283776-4D00-FC4E-A55A-552C82537BBB}" dt="2022-06-15T19:41:56.980" v="15" actId="478"/>
          <ac:spMkLst>
            <pc:docMk/>
            <pc:sldMk cId="3541618713" sldId="666"/>
            <ac:spMk id="83" creationId="{BF60F3B4-E808-034F-B708-F3917C9F301B}"/>
          </ac:spMkLst>
        </pc:spChg>
        <pc:spChg chg="del">
          <ac:chgData name="Wencai Zhang" userId="4a86a1d0-2108-4707-8228-1110f3c1be85" providerId="ADAL" clId="{16283776-4D00-FC4E-A55A-552C82537BBB}" dt="2022-06-15T19:41:56.980" v="15" actId="478"/>
          <ac:spMkLst>
            <pc:docMk/>
            <pc:sldMk cId="3541618713" sldId="666"/>
            <ac:spMk id="162" creationId="{57C97C19-A020-D546-8AC7-BFA81726CFAC}"/>
          </ac:spMkLst>
        </pc:spChg>
        <pc:spChg chg="del">
          <ac:chgData name="Wencai Zhang" userId="4a86a1d0-2108-4707-8228-1110f3c1be85" providerId="ADAL" clId="{16283776-4D00-FC4E-A55A-552C82537BBB}" dt="2022-06-15T19:41:56.980" v="15" actId="478"/>
          <ac:spMkLst>
            <pc:docMk/>
            <pc:sldMk cId="3541618713" sldId="666"/>
            <ac:spMk id="176" creationId="{404D4F78-C706-194F-BCA2-B8C1CCE6DE5F}"/>
          </ac:spMkLst>
        </pc:spChg>
        <pc:spChg chg="del">
          <ac:chgData name="Wencai Zhang" userId="4a86a1d0-2108-4707-8228-1110f3c1be85" providerId="ADAL" clId="{16283776-4D00-FC4E-A55A-552C82537BBB}" dt="2022-06-15T19:41:56.980" v="15" actId="478"/>
          <ac:spMkLst>
            <pc:docMk/>
            <pc:sldMk cId="3541618713" sldId="666"/>
            <ac:spMk id="224" creationId="{C3207D5B-27A1-7843-8A6F-B764CDB01140}"/>
          </ac:spMkLst>
        </pc:spChg>
        <pc:spChg chg="del">
          <ac:chgData name="Wencai Zhang" userId="4a86a1d0-2108-4707-8228-1110f3c1be85" providerId="ADAL" clId="{16283776-4D00-FC4E-A55A-552C82537BBB}" dt="2022-06-15T19:41:56.980" v="15" actId="478"/>
          <ac:spMkLst>
            <pc:docMk/>
            <pc:sldMk cId="3541618713" sldId="666"/>
            <ac:spMk id="232" creationId="{6C77EEB5-3073-A846-B3DA-7C840601B1D3}"/>
          </ac:spMkLst>
        </pc:spChg>
        <pc:spChg chg="del">
          <ac:chgData name="Wencai Zhang" userId="4a86a1d0-2108-4707-8228-1110f3c1be85" providerId="ADAL" clId="{16283776-4D00-FC4E-A55A-552C82537BBB}" dt="2022-06-15T19:41:56.980" v="15" actId="478"/>
          <ac:spMkLst>
            <pc:docMk/>
            <pc:sldMk cId="3541618713" sldId="666"/>
            <ac:spMk id="257" creationId="{9A0A5181-7D45-3B4D-BED9-25025121045B}"/>
          </ac:spMkLst>
        </pc:spChg>
        <pc:grpChg chg="del">
          <ac:chgData name="Wencai Zhang" userId="4a86a1d0-2108-4707-8228-1110f3c1be85" providerId="ADAL" clId="{16283776-4D00-FC4E-A55A-552C82537BBB}" dt="2022-06-15T19:41:59.307" v="16" actId="478"/>
          <ac:grpSpMkLst>
            <pc:docMk/>
            <pc:sldMk cId="3541618713" sldId="666"/>
            <ac:grpSpMk id="3" creationId="{DE190408-1F9D-0046-9DFD-86430CEEC452}"/>
          </ac:grpSpMkLst>
        </pc:grpChg>
        <pc:grpChg chg="del">
          <ac:chgData name="Wencai Zhang" userId="4a86a1d0-2108-4707-8228-1110f3c1be85" providerId="ADAL" clId="{16283776-4D00-FC4E-A55A-552C82537BBB}" dt="2022-06-15T19:41:56.980" v="15" actId="478"/>
          <ac:grpSpMkLst>
            <pc:docMk/>
            <pc:sldMk cId="3541618713" sldId="666"/>
            <ac:grpSpMk id="4" creationId="{0EA780D2-78DF-F34F-B455-4E3FFA348744}"/>
          </ac:grpSpMkLst>
        </pc:grpChg>
        <pc:grpChg chg="del">
          <ac:chgData name="Wencai Zhang" userId="4a86a1d0-2108-4707-8228-1110f3c1be85" providerId="ADAL" clId="{16283776-4D00-FC4E-A55A-552C82537BBB}" dt="2022-06-15T19:41:56.980" v="15" actId="478"/>
          <ac:grpSpMkLst>
            <pc:docMk/>
            <pc:sldMk cId="3541618713" sldId="666"/>
            <ac:grpSpMk id="6" creationId="{6A66C6AC-B9FF-3443-92D8-BC83C143C0EF}"/>
          </ac:grpSpMkLst>
        </pc:grpChg>
        <pc:grpChg chg="del">
          <ac:chgData name="Wencai Zhang" userId="4a86a1d0-2108-4707-8228-1110f3c1be85" providerId="ADAL" clId="{16283776-4D00-FC4E-A55A-552C82537BBB}" dt="2022-06-15T19:41:56.980" v="15" actId="478"/>
          <ac:grpSpMkLst>
            <pc:docMk/>
            <pc:sldMk cId="3541618713" sldId="666"/>
            <ac:grpSpMk id="122" creationId="{4A553EEC-C997-2046-8B8B-EEC8B90C77D8}"/>
          </ac:grpSpMkLst>
        </pc:grpChg>
        <pc:grpChg chg="del">
          <ac:chgData name="Wencai Zhang" userId="4a86a1d0-2108-4707-8228-1110f3c1be85" providerId="ADAL" clId="{16283776-4D00-FC4E-A55A-552C82537BBB}" dt="2022-06-15T19:41:56.980" v="15" actId="478"/>
          <ac:grpSpMkLst>
            <pc:docMk/>
            <pc:sldMk cId="3541618713" sldId="666"/>
            <ac:grpSpMk id="177" creationId="{D1851ED6-0EF7-C647-8FE6-A17EC4DF1B4D}"/>
          </ac:grpSpMkLst>
        </pc:grpChg>
        <pc:grpChg chg="del">
          <ac:chgData name="Wencai Zhang" userId="4a86a1d0-2108-4707-8228-1110f3c1be85" providerId="ADAL" clId="{16283776-4D00-FC4E-A55A-552C82537BBB}" dt="2022-06-15T19:41:56.980" v="15" actId="478"/>
          <ac:grpSpMkLst>
            <pc:docMk/>
            <pc:sldMk cId="3541618713" sldId="666"/>
            <ac:grpSpMk id="194" creationId="{3E012EAE-46E4-0D45-8ACB-BE594F2C998F}"/>
          </ac:grpSpMkLst>
        </pc:grpChg>
        <pc:grpChg chg="del">
          <ac:chgData name="Wencai Zhang" userId="4a86a1d0-2108-4707-8228-1110f3c1be85" providerId="ADAL" clId="{16283776-4D00-FC4E-A55A-552C82537BBB}" dt="2022-06-15T19:41:56.980" v="15" actId="478"/>
          <ac:grpSpMkLst>
            <pc:docMk/>
            <pc:sldMk cId="3541618713" sldId="666"/>
            <ac:grpSpMk id="199" creationId="{52D4694C-B1A8-B34E-964E-7F0915CE6DAF}"/>
          </ac:grpSpMkLst>
        </pc:grpChg>
        <pc:grpChg chg="del">
          <ac:chgData name="Wencai Zhang" userId="4a86a1d0-2108-4707-8228-1110f3c1be85" providerId="ADAL" clId="{16283776-4D00-FC4E-A55A-552C82537BBB}" dt="2022-06-15T19:41:56.980" v="15" actId="478"/>
          <ac:grpSpMkLst>
            <pc:docMk/>
            <pc:sldMk cId="3541618713" sldId="666"/>
            <ac:grpSpMk id="206" creationId="{6BF5002B-316E-0F46-843D-2F9F2EE49337}"/>
          </ac:grpSpMkLst>
        </pc:grpChg>
        <pc:grpChg chg="del">
          <ac:chgData name="Wencai Zhang" userId="4a86a1d0-2108-4707-8228-1110f3c1be85" providerId="ADAL" clId="{16283776-4D00-FC4E-A55A-552C82537BBB}" dt="2022-06-15T19:41:56.980" v="15" actId="478"/>
          <ac:grpSpMkLst>
            <pc:docMk/>
            <pc:sldMk cId="3541618713" sldId="666"/>
            <ac:grpSpMk id="213" creationId="{49B15EE0-C296-0F4C-A8D4-238BA70DF348}"/>
          </ac:grpSpMkLst>
        </pc:grpChg>
        <pc:grpChg chg="del">
          <ac:chgData name="Wencai Zhang" userId="4a86a1d0-2108-4707-8228-1110f3c1be85" providerId="ADAL" clId="{16283776-4D00-FC4E-A55A-552C82537BBB}" dt="2022-06-15T19:41:56.980" v="15" actId="478"/>
          <ac:grpSpMkLst>
            <pc:docMk/>
            <pc:sldMk cId="3541618713" sldId="666"/>
            <ac:grpSpMk id="233" creationId="{FB86B9BD-9686-6943-9879-6919F7DCB8D8}"/>
          </ac:grpSpMkLst>
        </pc:grpChg>
        <pc:grpChg chg="del">
          <ac:chgData name="Wencai Zhang" userId="4a86a1d0-2108-4707-8228-1110f3c1be85" providerId="ADAL" clId="{16283776-4D00-FC4E-A55A-552C82537BBB}" dt="2022-06-15T19:41:56.980" v="15" actId="478"/>
          <ac:grpSpMkLst>
            <pc:docMk/>
            <pc:sldMk cId="3541618713" sldId="666"/>
            <ac:grpSpMk id="238" creationId="{8129F932-D4B3-9C4A-A8B4-E1473CA879C3}"/>
          </ac:grpSpMkLst>
        </pc:grpChg>
        <pc:grpChg chg="del">
          <ac:chgData name="Wencai Zhang" userId="4a86a1d0-2108-4707-8228-1110f3c1be85" providerId="ADAL" clId="{16283776-4D00-FC4E-A55A-552C82537BBB}" dt="2022-06-15T19:41:56.980" v="15" actId="478"/>
          <ac:grpSpMkLst>
            <pc:docMk/>
            <pc:sldMk cId="3541618713" sldId="666"/>
            <ac:grpSpMk id="243" creationId="{D6E23419-29C0-E74B-8CE7-4F388663BD4E}"/>
          </ac:grpSpMkLst>
        </pc:grpChg>
        <pc:grpChg chg="del">
          <ac:chgData name="Wencai Zhang" userId="4a86a1d0-2108-4707-8228-1110f3c1be85" providerId="ADAL" clId="{16283776-4D00-FC4E-A55A-552C82537BBB}" dt="2022-06-15T19:41:56.980" v="15" actId="478"/>
          <ac:grpSpMkLst>
            <pc:docMk/>
            <pc:sldMk cId="3541618713" sldId="666"/>
            <ac:grpSpMk id="248" creationId="{A48A6746-BFB7-2D4E-AB14-589331CE5A30}"/>
          </ac:grpSpMkLst>
        </pc:grpChg>
        <pc:grpChg chg="del">
          <ac:chgData name="Wencai Zhang" userId="4a86a1d0-2108-4707-8228-1110f3c1be85" providerId="ADAL" clId="{16283776-4D00-FC4E-A55A-552C82537BBB}" dt="2022-06-15T19:41:56.980" v="15" actId="478"/>
          <ac:grpSpMkLst>
            <pc:docMk/>
            <pc:sldMk cId="3541618713" sldId="666"/>
            <ac:grpSpMk id="253" creationId="{6F6EF5B0-0E45-2D4F-8B90-FF517F4C2BE9}"/>
          </ac:grpSpMkLst>
        </pc:grpChg>
        <pc:picChg chg="del">
          <ac:chgData name="Wencai Zhang" userId="4a86a1d0-2108-4707-8228-1110f3c1be85" providerId="ADAL" clId="{16283776-4D00-FC4E-A55A-552C82537BBB}" dt="2022-06-15T19:41:59.307" v="16" actId="478"/>
          <ac:picMkLst>
            <pc:docMk/>
            <pc:sldMk cId="3541618713" sldId="666"/>
            <ac:picMk id="7" creationId="{75DF4509-2ECF-A94C-88FA-79A5824F7715}"/>
          </ac:picMkLst>
        </pc:picChg>
        <pc:picChg chg="del">
          <ac:chgData name="Wencai Zhang" userId="4a86a1d0-2108-4707-8228-1110f3c1be85" providerId="ADAL" clId="{16283776-4D00-FC4E-A55A-552C82537BBB}" dt="2022-06-15T19:41:59.307" v="16" actId="478"/>
          <ac:picMkLst>
            <pc:docMk/>
            <pc:sldMk cId="3541618713" sldId="666"/>
            <ac:picMk id="8" creationId="{FD7D5821-C2D5-CD4E-BAE7-A9466EECEAE2}"/>
          </ac:picMkLst>
        </pc:picChg>
        <pc:picChg chg="del">
          <ac:chgData name="Wencai Zhang" userId="4a86a1d0-2108-4707-8228-1110f3c1be85" providerId="ADAL" clId="{16283776-4D00-FC4E-A55A-552C82537BBB}" dt="2022-06-15T19:41:59.307" v="16" actId="478"/>
          <ac:picMkLst>
            <pc:docMk/>
            <pc:sldMk cId="3541618713" sldId="666"/>
            <ac:picMk id="13" creationId="{512EB60B-7A98-6944-BC25-64C88EBDABDB}"/>
          </ac:picMkLst>
        </pc:picChg>
        <pc:picChg chg="del">
          <ac:chgData name="Wencai Zhang" userId="4a86a1d0-2108-4707-8228-1110f3c1be85" providerId="ADAL" clId="{16283776-4D00-FC4E-A55A-552C82537BBB}" dt="2022-06-15T19:41:59.307" v="16" actId="478"/>
          <ac:picMkLst>
            <pc:docMk/>
            <pc:sldMk cId="3541618713" sldId="666"/>
            <ac:picMk id="15" creationId="{DC29B884-2DEE-EB46-8E42-7D09B81C545A}"/>
          </ac:picMkLst>
        </pc:picChg>
        <pc:picChg chg="del">
          <ac:chgData name="Wencai Zhang" userId="4a86a1d0-2108-4707-8228-1110f3c1be85" providerId="ADAL" clId="{16283776-4D00-FC4E-A55A-552C82537BBB}" dt="2022-06-15T19:41:56.980" v="15" actId="478"/>
          <ac:picMkLst>
            <pc:docMk/>
            <pc:sldMk cId="3541618713" sldId="666"/>
            <ac:picMk id="163" creationId="{CF9877FE-ADC0-C94E-8422-07F2C13298CD}"/>
          </ac:picMkLst>
        </pc:picChg>
        <pc:picChg chg="del">
          <ac:chgData name="Wencai Zhang" userId="4a86a1d0-2108-4707-8228-1110f3c1be85" providerId="ADAL" clId="{16283776-4D00-FC4E-A55A-552C82537BBB}" dt="2022-06-15T19:41:56.980" v="15" actId="478"/>
          <ac:picMkLst>
            <pc:docMk/>
            <pc:sldMk cId="3541618713" sldId="666"/>
            <ac:picMk id="169" creationId="{58A52B1C-E496-4E49-A4F9-651BD26FF5AB}"/>
          </ac:picMkLst>
        </pc:picChg>
        <pc:picChg chg="del">
          <ac:chgData name="Wencai Zhang" userId="4a86a1d0-2108-4707-8228-1110f3c1be85" providerId="ADAL" clId="{16283776-4D00-FC4E-A55A-552C82537BBB}" dt="2022-06-15T19:41:56.980" v="15" actId="478"/>
          <ac:picMkLst>
            <pc:docMk/>
            <pc:sldMk cId="3541618713" sldId="666"/>
            <ac:picMk id="170" creationId="{1E5919F0-8334-F14A-9AE0-DB778DFD2D64}"/>
          </ac:picMkLst>
        </pc:picChg>
        <pc:picChg chg="del">
          <ac:chgData name="Wencai Zhang" userId="4a86a1d0-2108-4707-8228-1110f3c1be85" providerId="ADAL" clId="{16283776-4D00-FC4E-A55A-552C82537BBB}" dt="2022-06-15T19:41:56.980" v="15" actId="478"/>
          <ac:picMkLst>
            <pc:docMk/>
            <pc:sldMk cId="3541618713" sldId="666"/>
            <ac:picMk id="220" creationId="{97B90C4B-3F10-2644-AEAE-61D80E6EC636}"/>
          </ac:picMkLst>
        </pc:picChg>
        <pc:picChg chg="del">
          <ac:chgData name="Wencai Zhang" userId="4a86a1d0-2108-4707-8228-1110f3c1be85" providerId="ADAL" clId="{16283776-4D00-FC4E-A55A-552C82537BBB}" dt="2022-06-15T19:41:56.980" v="15" actId="478"/>
          <ac:picMkLst>
            <pc:docMk/>
            <pc:sldMk cId="3541618713" sldId="666"/>
            <ac:picMk id="221" creationId="{E3F3A5C9-E2C2-BF42-B524-5B714C0ECBAE}"/>
          </ac:picMkLst>
        </pc:picChg>
        <pc:picChg chg="del">
          <ac:chgData name="Wencai Zhang" userId="4a86a1d0-2108-4707-8228-1110f3c1be85" providerId="ADAL" clId="{16283776-4D00-FC4E-A55A-552C82537BBB}" dt="2022-06-15T19:41:56.980" v="15" actId="478"/>
          <ac:picMkLst>
            <pc:docMk/>
            <pc:sldMk cId="3541618713" sldId="666"/>
            <ac:picMk id="225" creationId="{2CD42E40-65E4-5249-8C42-8931B441A6E4}"/>
          </ac:picMkLst>
        </pc:picChg>
        <pc:picChg chg="del">
          <ac:chgData name="Wencai Zhang" userId="4a86a1d0-2108-4707-8228-1110f3c1be85" providerId="ADAL" clId="{16283776-4D00-FC4E-A55A-552C82537BBB}" dt="2022-06-15T19:41:56.980" v="15" actId="478"/>
          <ac:picMkLst>
            <pc:docMk/>
            <pc:sldMk cId="3541618713" sldId="666"/>
            <ac:picMk id="226" creationId="{6A04A849-B9EE-9246-98BC-77B5F9910933}"/>
          </ac:picMkLst>
        </pc:picChg>
        <pc:picChg chg="del">
          <ac:chgData name="Wencai Zhang" userId="4a86a1d0-2108-4707-8228-1110f3c1be85" providerId="ADAL" clId="{16283776-4D00-FC4E-A55A-552C82537BBB}" dt="2022-06-15T19:41:56.980" v="15" actId="478"/>
          <ac:picMkLst>
            <pc:docMk/>
            <pc:sldMk cId="3541618713" sldId="666"/>
            <ac:picMk id="227" creationId="{A130B70F-340F-C64B-8BAC-3F241ECCD891}"/>
          </ac:picMkLst>
        </pc:picChg>
        <pc:picChg chg="del">
          <ac:chgData name="Wencai Zhang" userId="4a86a1d0-2108-4707-8228-1110f3c1be85" providerId="ADAL" clId="{16283776-4D00-FC4E-A55A-552C82537BBB}" dt="2022-06-15T19:41:56.980" v="15" actId="478"/>
          <ac:picMkLst>
            <pc:docMk/>
            <pc:sldMk cId="3541618713" sldId="666"/>
            <ac:picMk id="228" creationId="{5A213F1E-F9B9-2C4F-AB37-BA0BE0D22ADA}"/>
          </ac:picMkLst>
        </pc:picChg>
        <pc:picChg chg="del">
          <ac:chgData name="Wencai Zhang" userId="4a86a1d0-2108-4707-8228-1110f3c1be85" providerId="ADAL" clId="{16283776-4D00-FC4E-A55A-552C82537BBB}" dt="2022-06-15T19:41:56.980" v="15" actId="478"/>
          <ac:picMkLst>
            <pc:docMk/>
            <pc:sldMk cId="3541618713" sldId="666"/>
            <ac:picMk id="229" creationId="{2F4483FE-7258-B44C-8776-19AC58C147F3}"/>
          </ac:picMkLst>
        </pc:picChg>
        <pc:picChg chg="del">
          <ac:chgData name="Wencai Zhang" userId="4a86a1d0-2108-4707-8228-1110f3c1be85" providerId="ADAL" clId="{16283776-4D00-FC4E-A55A-552C82537BBB}" dt="2022-06-15T19:41:56.980" v="15" actId="478"/>
          <ac:picMkLst>
            <pc:docMk/>
            <pc:sldMk cId="3541618713" sldId="666"/>
            <ac:picMk id="230" creationId="{FAE16E2D-0666-7745-888D-22835EDD3A37}"/>
          </ac:picMkLst>
        </pc:picChg>
        <pc:picChg chg="del">
          <ac:chgData name="Wencai Zhang" userId="4a86a1d0-2108-4707-8228-1110f3c1be85" providerId="ADAL" clId="{16283776-4D00-FC4E-A55A-552C82537BBB}" dt="2022-06-15T19:41:56.980" v="15" actId="478"/>
          <ac:picMkLst>
            <pc:docMk/>
            <pc:sldMk cId="3541618713" sldId="666"/>
            <ac:picMk id="231" creationId="{64750205-7734-774C-9D95-61F4AF54207D}"/>
          </ac:picMkLst>
        </pc:picChg>
        <pc:cxnChg chg="del">
          <ac:chgData name="Wencai Zhang" userId="4a86a1d0-2108-4707-8228-1110f3c1be85" providerId="ADAL" clId="{16283776-4D00-FC4E-A55A-552C82537BBB}" dt="2022-06-15T19:41:56.980" v="15" actId="478"/>
          <ac:cxnSpMkLst>
            <pc:docMk/>
            <pc:sldMk cId="3541618713" sldId="666"/>
            <ac:cxnSpMk id="222" creationId="{926C437B-8960-C046-8933-FBB896CE9992}"/>
          </ac:cxnSpMkLst>
        </pc:cxnChg>
        <pc:cxnChg chg="del">
          <ac:chgData name="Wencai Zhang" userId="4a86a1d0-2108-4707-8228-1110f3c1be85" providerId="ADAL" clId="{16283776-4D00-FC4E-A55A-552C82537BBB}" dt="2022-06-15T19:41:56.980" v="15" actId="478"/>
          <ac:cxnSpMkLst>
            <pc:docMk/>
            <pc:sldMk cId="3541618713" sldId="666"/>
            <ac:cxnSpMk id="223" creationId="{A736B73C-695F-CF4B-8099-EAEA2CC1DD38}"/>
          </ac:cxnSpMkLst>
        </pc:cxnChg>
        <pc:cxnChg chg="del">
          <ac:chgData name="Wencai Zhang" userId="4a86a1d0-2108-4707-8228-1110f3c1be85" providerId="ADAL" clId="{16283776-4D00-FC4E-A55A-552C82537BBB}" dt="2022-06-15T19:41:56.980" v="15" actId="478"/>
          <ac:cxnSpMkLst>
            <pc:docMk/>
            <pc:sldMk cId="3541618713" sldId="666"/>
            <ac:cxnSpMk id="258" creationId="{8F229508-4E2A-2047-B2B4-4D472F1FE298}"/>
          </ac:cxnSpMkLst>
        </pc:cxnChg>
        <pc:cxnChg chg="del">
          <ac:chgData name="Wencai Zhang" userId="4a86a1d0-2108-4707-8228-1110f3c1be85" providerId="ADAL" clId="{16283776-4D00-FC4E-A55A-552C82537BBB}" dt="2022-06-15T19:41:56.980" v="15" actId="478"/>
          <ac:cxnSpMkLst>
            <pc:docMk/>
            <pc:sldMk cId="3541618713" sldId="666"/>
            <ac:cxnSpMk id="259" creationId="{BA9E0C58-962A-6942-B7AA-46BA682E503F}"/>
          </ac:cxnSpMkLst>
        </pc:cxnChg>
      </pc:sldChg>
      <pc:sldChg chg="delSp">
        <pc:chgData name="Wencai Zhang" userId="4a86a1d0-2108-4707-8228-1110f3c1be85" providerId="ADAL" clId="{16283776-4D00-FC4E-A55A-552C82537BBB}" dt="2022-06-15T19:41:40.183" v="12" actId="478"/>
        <pc:sldMkLst>
          <pc:docMk/>
          <pc:sldMk cId="328925770" sldId="668"/>
        </pc:sldMkLst>
        <pc:spChg chg="del">
          <ac:chgData name="Wencai Zhang" userId="4a86a1d0-2108-4707-8228-1110f3c1be85" providerId="ADAL" clId="{16283776-4D00-FC4E-A55A-552C82537BBB}" dt="2022-06-15T19:41:40.183" v="12" actId="478"/>
          <ac:spMkLst>
            <pc:docMk/>
            <pc:sldMk cId="328925770" sldId="668"/>
            <ac:spMk id="20" creationId="{C6CB0638-1ED0-824B-9AB5-180EBE5C00EF}"/>
          </ac:spMkLst>
        </pc:spChg>
      </pc:sldChg>
    </pc:docChg>
  </pc:docChgLst>
  <pc:docChgLst>
    <pc:chgData name="Wencai Zhang" userId="4a86a1d0-2108-4707-8228-1110f3c1be85" providerId="ADAL" clId="{10F8A7B9-0731-2448-B9C8-E908721C99F3}"/>
    <pc:docChg chg="custSel addSld delSld modSld sldOrd">
      <pc:chgData name="Wencai Zhang" userId="4a86a1d0-2108-4707-8228-1110f3c1be85" providerId="ADAL" clId="{10F8A7B9-0731-2448-B9C8-E908721C99F3}" dt="2022-05-02T15:43:17.021" v="180" actId="478"/>
      <pc:docMkLst>
        <pc:docMk/>
      </pc:docMkLst>
      <pc:sldChg chg="del">
        <pc:chgData name="Wencai Zhang" userId="4a86a1d0-2108-4707-8228-1110f3c1be85" providerId="ADAL" clId="{10F8A7B9-0731-2448-B9C8-E908721C99F3}" dt="2022-04-28T17:10:49.879" v="0" actId="2696"/>
        <pc:sldMkLst>
          <pc:docMk/>
          <pc:sldMk cId="555486090" sldId="272"/>
        </pc:sldMkLst>
      </pc:sldChg>
      <pc:sldChg chg="del">
        <pc:chgData name="Wencai Zhang" userId="4a86a1d0-2108-4707-8228-1110f3c1be85" providerId="ADAL" clId="{10F8A7B9-0731-2448-B9C8-E908721C99F3}" dt="2022-04-28T17:10:49.969" v="1" actId="2696"/>
        <pc:sldMkLst>
          <pc:docMk/>
          <pc:sldMk cId="2842178971" sldId="278"/>
        </pc:sldMkLst>
      </pc:sldChg>
      <pc:sldChg chg="addSp modSp">
        <pc:chgData name="Wencai Zhang" userId="4a86a1d0-2108-4707-8228-1110f3c1be85" providerId="ADAL" clId="{10F8A7B9-0731-2448-B9C8-E908721C99F3}" dt="2022-04-28T17:12:42.416" v="5" actId="20577"/>
        <pc:sldMkLst>
          <pc:docMk/>
          <pc:sldMk cId="3759201367" sldId="279"/>
        </pc:sldMkLst>
        <pc:spChg chg="add mod">
          <ac:chgData name="Wencai Zhang" userId="4a86a1d0-2108-4707-8228-1110f3c1be85" providerId="ADAL" clId="{10F8A7B9-0731-2448-B9C8-E908721C99F3}" dt="2022-04-28T17:12:42.416" v="5" actId="20577"/>
          <ac:spMkLst>
            <pc:docMk/>
            <pc:sldMk cId="3759201367" sldId="279"/>
            <ac:spMk id="19" creationId="{88137E89-8D1E-6C49-A427-D34BCC0E0C3F}"/>
          </ac:spMkLst>
        </pc:spChg>
      </pc:sldChg>
      <pc:sldChg chg="addSp modSp">
        <pc:chgData name="Wencai Zhang" userId="4a86a1d0-2108-4707-8228-1110f3c1be85" providerId="ADAL" clId="{10F8A7B9-0731-2448-B9C8-E908721C99F3}" dt="2022-04-28T17:13:15.616" v="15" actId="20577"/>
        <pc:sldMkLst>
          <pc:docMk/>
          <pc:sldMk cId="2061921346" sldId="281"/>
        </pc:sldMkLst>
        <pc:spChg chg="mod">
          <ac:chgData name="Wencai Zhang" userId="4a86a1d0-2108-4707-8228-1110f3c1be85" providerId="ADAL" clId="{10F8A7B9-0731-2448-B9C8-E908721C99F3}" dt="2022-04-28T17:13:15.616" v="15" actId="20577"/>
          <ac:spMkLst>
            <pc:docMk/>
            <pc:sldMk cId="2061921346" sldId="281"/>
            <ac:spMk id="31" creationId="{10210D5A-DB67-9844-99BE-8F67F8904355}"/>
          </ac:spMkLst>
        </pc:spChg>
        <pc:spChg chg="mod">
          <ac:chgData name="Wencai Zhang" userId="4a86a1d0-2108-4707-8228-1110f3c1be85" providerId="ADAL" clId="{10F8A7B9-0731-2448-B9C8-E908721C99F3}" dt="2022-04-28T17:13:10.180" v="12" actId="20577"/>
          <ac:spMkLst>
            <pc:docMk/>
            <pc:sldMk cId="2061921346" sldId="281"/>
            <ac:spMk id="32" creationId="{9A1608EA-6953-DD48-95F6-035EE1A431A4}"/>
          </ac:spMkLst>
        </pc:spChg>
        <pc:spChg chg="add mod">
          <ac:chgData name="Wencai Zhang" userId="4a86a1d0-2108-4707-8228-1110f3c1be85" providerId="ADAL" clId="{10F8A7B9-0731-2448-B9C8-E908721C99F3}" dt="2022-04-28T17:13:04.599" v="9" actId="20577"/>
          <ac:spMkLst>
            <pc:docMk/>
            <pc:sldMk cId="2061921346" sldId="281"/>
            <ac:spMk id="35" creationId="{F7465C9C-78DF-3542-8882-81639FF3A4F4}"/>
          </ac:spMkLst>
        </pc:spChg>
      </pc:sldChg>
      <pc:sldChg chg="addSp modSp">
        <pc:chgData name="Wencai Zhang" userId="4a86a1d0-2108-4707-8228-1110f3c1be85" providerId="ADAL" clId="{10F8A7B9-0731-2448-B9C8-E908721C99F3}" dt="2022-04-28T17:13:58.590" v="34" actId="20577"/>
        <pc:sldMkLst>
          <pc:docMk/>
          <pc:sldMk cId="495234596" sldId="282"/>
        </pc:sldMkLst>
        <pc:spChg chg="add mod">
          <ac:chgData name="Wencai Zhang" userId="4a86a1d0-2108-4707-8228-1110f3c1be85" providerId="ADAL" clId="{10F8A7B9-0731-2448-B9C8-E908721C99F3}" dt="2022-04-28T17:13:58.590" v="34" actId="20577"/>
          <ac:spMkLst>
            <pc:docMk/>
            <pc:sldMk cId="495234596" sldId="282"/>
            <ac:spMk id="7" creationId="{A76311FD-6BEF-6E48-AD9A-66A2F87DF128}"/>
          </ac:spMkLst>
        </pc:spChg>
      </pc:sldChg>
      <pc:sldChg chg="addSp modSp">
        <pc:chgData name="Wencai Zhang" userId="4a86a1d0-2108-4707-8228-1110f3c1be85" providerId="ADAL" clId="{10F8A7B9-0731-2448-B9C8-E908721C99F3}" dt="2022-04-28T17:13:30.533" v="23" actId="20577"/>
        <pc:sldMkLst>
          <pc:docMk/>
          <pc:sldMk cId="2930520000" sldId="283"/>
        </pc:sldMkLst>
        <pc:spChg chg="add mod">
          <ac:chgData name="Wencai Zhang" userId="4a86a1d0-2108-4707-8228-1110f3c1be85" providerId="ADAL" clId="{10F8A7B9-0731-2448-B9C8-E908721C99F3}" dt="2022-04-28T17:13:30.533" v="23" actId="20577"/>
          <ac:spMkLst>
            <pc:docMk/>
            <pc:sldMk cId="2930520000" sldId="283"/>
            <ac:spMk id="41" creationId="{BB3EF1F2-108C-AB4E-ADCA-6E324EEB0D13}"/>
          </ac:spMkLst>
        </pc:spChg>
      </pc:sldChg>
      <pc:sldChg chg="addSp modSp">
        <pc:chgData name="Wencai Zhang" userId="4a86a1d0-2108-4707-8228-1110f3c1be85" providerId="ADAL" clId="{10F8A7B9-0731-2448-B9C8-E908721C99F3}" dt="2022-04-28T17:13:24.343" v="20" actId="20577"/>
        <pc:sldMkLst>
          <pc:docMk/>
          <pc:sldMk cId="3756175224" sldId="284"/>
        </pc:sldMkLst>
        <pc:spChg chg="add mod">
          <ac:chgData name="Wencai Zhang" userId="4a86a1d0-2108-4707-8228-1110f3c1be85" providerId="ADAL" clId="{10F8A7B9-0731-2448-B9C8-E908721C99F3}" dt="2022-04-28T17:13:24.343" v="20" actId="20577"/>
          <ac:spMkLst>
            <pc:docMk/>
            <pc:sldMk cId="3756175224" sldId="284"/>
            <ac:spMk id="35" creationId="{B533D00D-0568-104C-A03C-30A15EA72F6E}"/>
          </ac:spMkLst>
        </pc:spChg>
      </pc:sldChg>
      <pc:sldChg chg="addSp modSp">
        <pc:chgData name="Wencai Zhang" userId="4a86a1d0-2108-4707-8228-1110f3c1be85" providerId="ADAL" clId="{10F8A7B9-0731-2448-B9C8-E908721C99F3}" dt="2022-04-28T17:13:48.892" v="31" actId="20577"/>
        <pc:sldMkLst>
          <pc:docMk/>
          <pc:sldMk cId="3813348304" sldId="285"/>
        </pc:sldMkLst>
        <pc:spChg chg="add mod">
          <ac:chgData name="Wencai Zhang" userId="4a86a1d0-2108-4707-8228-1110f3c1be85" providerId="ADAL" clId="{10F8A7B9-0731-2448-B9C8-E908721C99F3}" dt="2022-04-28T17:13:48.892" v="31" actId="20577"/>
          <ac:spMkLst>
            <pc:docMk/>
            <pc:sldMk cId="3813348304" sldId="285"/>
            <ac:spMk id="10" creationId="{8BDD8655-50B0-6B4A-9822-B72CC7B84BD0}"/>
          </ac:spMkLst>
        </pc:spChg>
      </pc:sldChg>
      <pc:sldChg chg="addSp delSp modSp add">
        <pc:chgData name="Wencai Zhang" userId="4a86a1d0-2108-4707-8228-1110f3c1be85" providerId="ADAL" clId="{10F8A7B9-0731-2448-B9C8-E908721C99F3}" dt="2022-05-02T15:43:17.021" v="180" actId="478"/>
        <pc:sldMkLst>
          <pc:docMk/>
          <pc:sldMk cId="3541618713" sldId="666"/>
        </pc:sldMkLst>
        <pc:spChg chg="mod">
          <ac:chgData name="Wencai Zhang" userId="4a86a1d0-2108-4707-8228-1110f3c1be85" providerId="ADAL" clId="{10F8A7B9-0731-2448-B9C8-E908721C99F3}" dt="2022-05-02T13:38:33.686" v="159" actId="20577"/>
          <ac:spMkLst>
            <pc:docMk/>
            <pc:sldMk cId="3541618713" sldId="666"/>
            <ac:spMk id="2" creationId="{9C268384-A989-0C40-9716-C30417941384}"/>
          </ac:spMkLst>
        </pc:spChg>
        <pc:picChg chg="mod">
          <ac:chgData name="Wencai Zhang" userId="4a86a1d0-2108-4707-8228-1110f3c1be85" providerId="ADAL" clId="{10F8A7B9-0731-2448-B9C8-E908721C99F3}" dt="2022-04-29T20:32:36.124" v="99" actId="1076"/>
          <ac:picMkLst>
            <pc:docMk/>
            <pc:sldMk cId="3541618713" sldId="666"/>
            <ac:picMk id="7" creationId="{75DF4509-2ECF-A94C-88FA-79A5824F7715}"/>
          </ac:picMkLst>
        </pc:picChg>
        <pc:picChg chg="mod">
          <ac:chgData name="Wencai Zhang" userId="4a86a1d0-2108-4707-8228-1110f3c1be85" providerId="ADAL" clId="{10F8A7B9-0731-2448-B9C8-E908721C99F3}" dt="2022-04-29T20:32:36.124" v="99" actId="1076"/>
          <ac:picMkLst>
            <pc:docMk/>
            <pc:sldMk cId="3541618713" sldId="666"/>
            <ac:picMk id="8" creationId="{FD7D5821-C2D5-CD4E-BAE7-A9466EECEAE2}"/>
          </ac:picMkLst>
        </pc:picChg>
        <pc:picChg chg="add del mod">
          <ac:chgData name="Wencai Zhang" userId="4a86a1d0-2108-4707-8228-1110f3c1be85" providerId="ADAL" clId="{10F8A7B9-0731-2448-B9C8-E908721C99F3}" dt="2022-05-02T13:31:41.330" v="120" actId="478"/>
          <ac:picMkLst>
            <pc:docMk/>
            <pc:sldMk cId="3541618713" sldId="666"/>
            <ac:picMk id="9" creationId="{1726E957-8321-CB4D-80DB-2F8948BAEBB9}"/>
          </ac:picMkLst>
        </pc:picChg>
        <pc:picChg chg="mod">
          <ac:chgData name="Wencai Zhang" userId="4a86a1d0-2108-4707-8228-1110f3c1be85" providerId="ADAL" clId="{10F8A7B9-0731-2448-B9C8-E908721C99F3}" dt="2022-04-29T20:29:47.392" v="87" actId="1076"/>
          <ac:picMkLst>
            <pc:docMk/>
            <pc:sldMk cId="3541618713" sldId="666"/>
            <ac:picMk id="13" creationId="{512EB60B-7A98-6944-BC25-64C88EBDABDB}"/>
          </ac:picMkLst>
        </pc:picChg>
        <pc:picChg chg="mod">
          <ac:chgData name="Wencai Zhang" userId="4a86a1d0-2108-4707-8228-1110f3c1be85" providerId="ADAL" clId="{10F8A7B9-0731-2448-B9C8-E908721C99F3}" dt="2022-04-29T20:29:47.392" v="87" actId="1076"/>
          <ac:picMkLst>
            <pc:docMk/>
            <pc:sldMk cId="3541618713" sldId="666"/>
            <ac:picMk id="15" creationId="{DC29B884-2DEE-EB46-8E42-7D09B81C545A}"/>
          </ac:picMkLst>
        </pc:picChg>
        <pc:picChg chg="add del mod">
          <ac:chgData name="Wencai Zhang" userId="4a86a1d0-2108-4707-8228-1110f3c1be85" providerId="ADAL" clId="{10F8A7B9-0731-2448-B9C8-E908721C99F3}" dt="2022-05-02T13:31:41.330" v="120" actId="478"/>
          <ac:picMkLst>
            <pc:docMk/>
            <pc:sldMk cId="3541618713" sldId="666"/>
            <ac:picMk id="16" creationId="{611C47D4-C579-D04A-BDC3-09F33DE2A9A3}"/>
          </ac:picMkLst>
        </pc:picChg>
        <pc:picChg chg="add del mod">
          <ac:chgData name="Wencai Zhang" userId="4a86a1d0-2108-4707-8228-1110f3c1be85" providerId="ADAL" clId="{10F8A7B9-0731-2448-B9C8-E908721C99F3}" dt="2022-05-02T15:39:20.692" v="173" actId="478"/>
          <ac:picMkLst>
            <pc:docMk/>
            <pc:sldMk cId="3541618713" sldId="666"/>
            <ac:picMk id="18" creationId="{9AE8DF4A-82C7-CB4B-BD9C-13B402B96180}"/>
          </ac:picMkLst>
        </pc:picChg>
        <pc:picChg chg="add mod">
          <ac:chgData name="Wencai Zhang" userId="4a86a1d0-2108-4707-8228-1110f3c1be85" providerId="ADAL" clId="{10F8A7B9-0731-2448-B9C8-E908721C99F3}" dt="2022-05-02T15:39:42.722" v="179" actId="1076"/>
          <ac:picMkLst>
            <pc:docMk/>
            <pc:sldMk cId="3541618713" sldId="666"/>
            <ac:picMk id="19" creationId="{6AADD48B-00A2-8F44-8EBC-F234315875CE}"/>
          </ac:picMkLst>
        </pc:picChg>
        <pc:picChg chg="add del mod">
          <ac:chgData name="Wencai Zhang" userId="4a86a1d0-2108-4707-8228-1110f3c1be85" providerId="ADAL" clId="{10F8A7B9-0731-2448-B9C8-E908721C99F3}" dt="2022-05-02T15:39:20.692" v="173" actId="478"/>
          <ac:picMkLst>
            <pc:docMk/>
            <pc:sldMk cId="3541618713" sldId="666"/>
            <ac:picMk id="23" creationId="{35A6ABF1-51A9-C94F-9B2C-207F8A463865}"/>
          </ac:picMkLst>
        </pc:picChg>
        <pc:picChg chg="add del mod">
          <ac:chgData name="Wencai Zhang" userId="4a86a1d0-2108-4707-8228-1110f3c1be85" providerId="ADAL" clId="{10F8A7B9-0731-2448-B9C8-E908721C99F3}" dt="2022-05-02T15:22:20.902" v="166" actId="478"/>
          <ac:picMkLst>
            <pc:docMk/>
            <pc:sldMk cId="3541618713" sldId="666"/>
            <ac:picMk id="24" creationId="{DCE54106-ADFE-AB4F-ACB2-8976E29079E7}"/>
          </ac:picMkLst>
        </pc:picChg>
        <pc:picChg chg="add del mod">
          <ac:chgData name="Wencai Zhang" userId="4a86a1d0-2108-4707-8228-1110f3c1be85" providerId="ADAL" clId="{10F8A7B9-0731-2448-B9C8-E908721C99F3}" dt="2022-05-02T15:43:17.021" v="180" actId="478"/>
          <ac:picMkLst>
            <pc:docMk/>
            <pc:sldMk cId="3541618713" sldId="666"/>
            <ac:picMk id="39" creationId="{767AB17D-C326-934D-80B7-A2974B842D1D}"/>
          </ac:picMkLst>
        </pc:picChg>
        <pc:picChg chg="add mod">
          <ac:chgData name="Wencai Zhang" userId="4a86a1d0-2108-4707-8228-1110f3c1be85" providerId="ADAL" clId="{10F8A7B9-0731-2448-B9C8-E908721C99F3}" dt="2022-05-02T15:39:38.514" v="178" actId="1076"/>
          <ac:picMkLst>
            <pc:docMk/>
            <pc:sldMk cId="3541618713" sldId="666"/>
            <ac:picMk id="40" creationId="{5691EE49-59D9-9F4B-B995-14B73ACF6824}"/>
          </ac:picMkLst>
        </pc:picChg>
        <pc:picChg chg="add mod">
          <ac:chgData name="Wencai Zhang" userId="4a86a1d0-2108-4707-8228-1110f3c1be85" providerId="ADAL" clId="{10F8A7B9-0731-2448-B9C8-E908721C99F3}" dt="2022-05-02T15:39:31.348" v="177" actId="1076"/>
          <ac:picMkLst>
            <pc:docMk/>
            <pc:sldMk cId="3541618713" sldId="666"/>
            <ac:picMk id="41" creationId="{598BE55F-225E-B04E-91F0-0AC898703D92}"/>
          </ac:picMkLst>
        </pc:picChg>
        <pc:picChg chg="add mod">
          <ac:chgData name="Wencai Zhang" userId="4a86a1d0-2108-4707-8228-1110f3c1be85" providerId="ADAL" clId="{10F8A7B9-0731-2448-B9C8-E908721C99F3}" dt="2022-05-02T15:39:28.366" v="176" actId="1076"/>
          <ac:picMkLst>
            <pc:docMk/>
            <pc:sldMk cId="3541618713" sldId="666"/>
            <ac:picMk id="42" creationId="{6D5B3413-E8B6-EE40-B36E-306A8C08D012}"/>
          </ac:picMkLst>
        </pc:picChg>
        <pc:cxnChg chg="del">
          <ac:chgData name="Wencai Zhang" userId="4a86a1d0-2108-4707-8228-1110f3c1be85" providerId="ADAL" clId="{10F8A7B9-0731-2448-B9C8-E908721C99F3}" dt="2022-05-02T13:31:43.022" v="121" actId="478"/>
          <ac:cxnSpMkLst>
            <pc:docMk/>
            <pc:sldMk cId="3541618713" sldId="666"/>
            <ac:cxnSpMk id="38" creationId="{85BEC5E9-6483-6249-A3BD-939443D3D6DF}"/>
          </ac:cxnSpMkLst>
        </pc:cxnChg>
        <pc:cxnChg chg="del">
          <ac:chgData name="Wencai Zhang" userId="4a86a1d0-2108-4707-8228-1110f3c1be85" providerId="ADAL" clId="{10F8A7B9-0731-2448-B9C8-E908721C99F3}" dt="2022-05-02T15:39:22.807" v="174" actId="478"/>
          <ac:cxnSpMkLst>
            <pc:docMk/>
            <pc:sldMk cId="3541618713" sldId="666"/>
            <ac:cxnSpMk id="260" creationId="{59B9FF1B-CA78-5A40-8DFE-6C686DA86935}"/>
          </ac:cxnSpMkLst>
        </pc:cxnChg>
        <pc:cxnChg chg="del">
          <ac:chgData name="Wencai Zhang" userId="4a86a1d0-2108-4707-8228-1110f3c1be85" providerId="ADAL" clId="{10F8A7B9-0731-2448-B9C8-E908721C99F3}" dt="2022-05-02T15:39:24.573" v="175" actId="478"/>
          <ac:cxnSpMkLst>
            <pc:docMk/>
            <pc:sldMk cId="3541618713" sldId="666"/>
            <ac:cxnSpMk id="261" creationId="{44D255A7-5F7E-A145-82FE-F0283B7F63CB}"/>
          </ac:cxnSpMkLst>
        </pc:cxnChg>
      </pc:sldChg>
      <pc:sldChg chg="addSp modSp add ord">
        <pc:chgData name="Wencai Zhang" userId="4a86a1d0-2108-4707-8228-1110f3c1be85" providerId="ADAL" clId="{10F8A7B9-0731-2448-B9C8-E908721C99F3}" dt="2022-04-28T17:45:46.318" v="72" actId="20577"/>
        <pc:sldMkLst>
          <pc:docMk/>
          <pc:sldMk cId="328925770" sldId="668"/>
        </pc:sldMkLst>
        <pc:spChg chg="add mod">
          <ac:chgData name="Wencai Zhang" userId="4a86a1d0-2108-4707-8228-1110f3c1be85" providerId="ADAL" clId="{10F8A7B9-0731-2448-B9C8-E908721C99F3}" dt="2022-04-28T17:13:39.475" v="26" actId="20577"/>
          <ac:spMkLst>
            <pc:docMk/>
            <pc:sldMk cId="328925770" sldId="668"/>
            <ac:spMk id="2" creationId="{67924208-D2B4-B24D-8A38-44DCDBFAF8C8}"/>
          </ac:spMkLst>
        </pc:spChg>
        <pc:spChg chg="add mod">
          <ac:chgData name="Wencai Zhang" userId="4a86a1d0-2108-4707-8228-1110f3c1be85" providerId="ADAL" clId="{10F8A7B9-0731-2448-B9C8-E908721C99F3}" dt="2022-04-28T17:41:12.163" v="36" actId="1076"/>
          <ac:spMkLst>
            <pc:docMk/>
            <pc:sldMk cId="328925770" sldId="668"/>
            <ac:spMk id="19" creationId="{63159054-BA53-7942-8AE8-26607FF3DBD8}"/>
          </ac:spMkLst>
        </pc:spChg>
        <pc:spChg chg="add mod">
          <ac:chgData name="Wencai Zhang" userId="4a86a1d0-2108-4707-8228-1110f3c1be85" providerId="ADAL" clId="{10F8A7B9-0731-2448-B9C8-E908721C99F3}" dt="2022-04-28T17:45:46.318" v="72" actId="20577"/>
          <ac:spMkLst>
            <pc:docMk/>
            <pc:sldMk cId="328925770" sldId="668"/>
            <ac:spMk id="20" creationId="{C6CB0638-1ED0-824B-9AB5-180EBE5C00EF}"/>
          </ac:spMkLst>
        </pc:spChg>
        <pc:grpChg chg="add mod">
          <ac:chgData name="Wencai Zhang" userId="4a86a1d0-2108-4707-8228-1110f3c1be85" providerId="ADAL" clId="{10F8A7B9-0731-2448-B9C8-E908721C99F3}" dt="2022-04-28T17:43:07.001" v="51" actId="1037"/>
          <ac:grpSpMkLst>
            <pc:docMk/>
            <pc:sldMk cId="328925770" sldId="668"/>
            <ac:grpSpMk id="4" creationId="{C66AF02D-AB56-D24A-AAE9-572EAC944459}"/>
          </ac:grpSpMkLst>
        </pc:grpChg>
        <pc:grpChg chg="add mod">
          <ac:chgData name="Wencai Zhang" userId="4a86a1d0-2108-4707-8228-1110f3c1be85" providerId="ADAL" clId="{10F8A7B9-0731-2448-B9C8-E908721C99F3}" dt="2022-04-28T17:43:12.186" v="53" actId="1038"/>
          <ac:grpSpMkLst>
            <pc:docMk/>
            <pc:sldMk cId="328925770" sldId="668"/>
            <ac:grpSpMk id="7" creationId="{F5F1AD83-C790-5746-B315-A5F7208ADF8A}"/>
          </ac:grpSpMkLst>
        </pc:grpChg>
        <pc:grpChg chg="add mod">
          <ac:chgData name="Wencai Zhang" userId="4a86a1d0-2108-4707-8228-1110f3c1be85" providerId="ADAL" clId="{10F8A7B9-0731-2448-B9C8-E908721C99F3}" dt="2022-04-28T17:41:12.163" v="36" actId="1076"/>
          <ac:grpSpMkLst>
            <pc:docMk/>
            <pc:sldMk cId="328925770" sldId="668"/>
            <ac:grpSpMk id="10" creationId="{1EDFC152-EC5E-F948-A1F8-79C5A64DB038}"/>
          </ac:grpSpMkLst>
        </pc:grpChg>
        <pc:grpChg chg="add mod">
          <ac:chgData name="Wencai Zhang" userId="4a86a1d0-2108-4707-8228-1110f3c1be85" providerId="ADAL" clId="{10F8A7B9-0731-2448-B9C8-E908721C99F3}" dt="2022-04-28T17:43:07.001" v="51" actId="1037"/>
          <ac:grpSpMkLst>
            <pc:docMk/>
            <pc:sldMk cId="328925770" sldId="668"/>
            <ac:grpSpMk id="13" creationId="{41101740-8FC0-5F4E-B44C-B32B0B0B1FFC}"/>
          </ac:grpSpMkLst>
        </pc:grpChg>
        <pc:grpChg chg="add mod">
          <ac:chgData name="Wencai Zhang" userId="4a86a1d0-2108-4707-8228-1110f3c1be85" providerId="ADAL" clId="{10F8A7B9-0731-2448-B9C8-E908721C99F3}" dt="2022-04-28T17:43:03.142" v="48" actId="1036"/>
          <ac:grpSpMkLst>
            <pc:docMk/>
            <pc:sldMk cId="328925770" sldId="668"/>
            <ac:grpSpMk id="16" creationId="{1C519FD9-7211-914E-A0C4-A8F29F723DD8}"/>
          </ac:grpSpMkLst>
        </pc:grpChg>
        <pc:picChg chg="add mod">
          <ac:chgData name="Wencai Zhang" userId="4a86a1d0-2108-4707-8228-1110f3c1be85" providerId="ADAL" clId="{10F8A7B9-0731-2448-B9C8-E908721C99F3}" dt="2022-04-28T17:43:30.277" v="54" actId="1036"/>
          <ac:picMkLst>
            <pc:docMk/>
            <pc:sldMk cId="328925770" sldId="668"/>
            <ac:picMk id="3" creationId="{5E0C93A0-4CB8-7347-9839-5156E1234286}"/>
          </ac:picMkLst>
        </pc:picChg>
      </pc:sldChg>
    </pc:docChg>
  </pc:docChgLst>
  <pc:docChgLst>
    <pc:chgData name="Wencai Zhang" userId="4a86a1d0-2108-4707-8228-1110f3c1be85" providerId="ADAL" clId="{5D13D192-A431-0440-A34B-CA198DD15CA1}"/>
    <pc:docChg chg="undo custSel addSld delSld modSld">
      <pc:chgData name="Wencai Zhang" userId="4a86a1d0-2108-4707-8228-1110f3c1be85" providerId="ADAL" clId="{5D13D192-A431-0440-A34B-CA198DD15CA1}" dt="2022-05-26T19:52:21.452" v="2121" actId="1038"/>
      <pc:docMkLst>
        <pc:docMk/>
      </pc:docMkLst>
      <pc:sldChg chg="addSp delSp modSp mod">
        <pc:chgData name="Wencai Zhang" userId="4a86a1d0-2108-4707-8228-1110f3c1be85" providerId="ADAL" clId="{5D13D192-A431-0440-A34B-CA198DD15CA1}" dt="2022-05-26T13:24:57.885" v="2099" actId="113"/>
        <pc:sldMkLst>
          <pc:docMk/>
          <pc:sldMk cId="3759201367" sldId="279"/>
        </pc:sldMkLst>
        <pc:spChg chg="del">
          <ac:chgData name="Wencai Zhang" userId="4a86a1d0-2108-4707-8228-1110f3c1be85" providerId="ADAL" clId="{5D13D192-A431-0440-A34B-CA198DD15CA1}" dt="2022-05-24T12:46:57.495" v="2065" actId="21"/>
          <ac:spMkLst>
            <pc:docMk/>
            <pc:sldMk cId="3759201367" sldId="279"/>
            <ac:spMk id="14" creationId="{B5B84F48-21E1-4F4D-8496-D8168C39FDFA}"/>
          </ac:spMkLst>
        </pc:spChg>
        <pc:spChg chg="add mod">
          <ac:chgData name="Wencai Zhang" userId="4a86a1d0-2108-4707-8228-1110f3c1be85" providerId="ADAL" clId="{5D13D192-A431-0440-A34B-CA198DD15CA1}" dt="2022-05-24T12:47:12.607" v="2067" actId="1076"/>
          <ac:spMkLst>
            <pc:docMk/>
            <pc:sldMk cId="3759201367" sldId="279"/>
            <ac:spMk id="18" creationId="{7FB24E40-FCA8-C9EC-6ACB-6324262ABC70}"/>
          </ac:spMkLst>
        </pc:spChg>
        <pc:spChg chg="del">
          <ac:chgData name="Wencai Zhang" userId="4a86a1d0-2108-4707-8228-1110f3c1be85" providerId="ADAL" clId="{5D13D192-A431-0440-A34B-CA198DD15CA1}" dt="2022-05-01T21:14:44.242" v="1116" actId="478"/>
          <ac:spMkLst>
            <pc:docMk/>
            <pc:sldMk cId="3759201367" sldId="279"/>
            <ac:spMk id="18" creationId="{A9CD4968-2811-2646-9A08-3E8F3F718B57}"/>
          </ac:spMkLst>
        </pc:spChg>
        <pc:spChg chg="mod">
          <ac:chgData name="Wencai Zhang" userId="4a86a1d0-2108-4707-8228-1110f3c1be85" providerId="ADAL" clId="{5D13D192-A431-0440-A34B-CA198DD15CA1}" dt="2022-05-26T13:24:57.885" v="2099" actId="113"/>
          <ac:spMkLst>
            <pc:docMk/>
            <pc:sldMk cId="3759201367" sldId="279"/>
            <ac:spMk id="19" creationId="{88137E89-8D1E-6C49-A427-D34BCC0E0C3F}"/>
          </ac:spMkLst>
        </pc:spChg>
        <pc:spChg chg="mod">
          <ac:chgData name="Wencai Zhang" userId="4a86a1d0-2108-4707-8228-1110f3c1be85" providerId="ADAL" clId="{5D13D192-A431-0440-A34B-CA198DD15CA1}" dt="2022-05-01T21:20:41.153" v="1250" actId="1036"/>
          <ac:spMkLst>
            <pc:docMk/>
            <pc:sldMk cId="3759201367" sldId="279"/>
            <ac:spMk id="45" creationId="{B2AA6943-EB8B-EE4C-9137-93FF3149EADA}"/>
          </ac:spMkLst>
        </pc:spChg>
        <pc:spChg chg="mod">
          <ac:chgData name="Wencai Zhang" userId="4a86a1d0-2108-4707-8228-1110f3c1be85" providerId="ADAL" clId="{5D13D192-A431-0440-A34B-CA198DD15CA1}" dt="2022-05-01T21:20:34.189" v="1231" actId="1036"/>
          <ac:spMkLst>
            <pc:docMk/>
            <pc:sldMk cId="3759201367" sldId="279"/>
            <ac:spMk id="46" creationId="{AE153BE9-E801-9F46-B19E-88780C594949}"/>
          </ac:spMkLst>
        </pc:spChg>
        <pc:picChg chg="mod modCrop">
          <ac:chgData name="Wencai Zhang" userId="4a86a1d0-2108-4707-8228-1110f3c1be85" providerId="ADAL" clId="{5D13D192-A431-0440-A34B-CA198DD15CA1}" dt="2022-05-01T21:18:59.429" v="1193" actId="1076"/>
          <ac:picMkLst>
            <pc:docMk/>
            <pc:sldMk cId="3759201367" sldId="279"/>
            <ac:picMk id="13" creationId="{23370E1D-80EC-D347-B1F7-2DF6B0EDFA48}"/>
          </ac:picMkLst>
        </pc:picChg>
        <pc:picChg chg="mod">
          <ac:chgData name="Wencai Zhang" userId="4a86a1d0-2108-4707-8228-1110f3c1be85" providerId="ADAL" clId="{5D13D192-A431-0440-A34B-CA198DD15CA1}" dt="2022-05-01T21:14:12.787" v="1089" actId="1076"/>
          <ac:picMkLst>
            <pc:docMk/>
            <pc:sldMk cId="3759201367" sldId="279"/>
            <ac:picMk id="16" creationId="{055A586B-2AE6-784A-A11C-07886E0DC81A}"/>
          </ac:picMkLst>
        </pc:picChg>
        <pc:picChg chg="mod">
          <ac:chgData name="Wencai Zhang" userId="4a86a1d0-2108-4707-8228-1110f3c1be85" providerId="ADAL" clId="{5D13D192-A431-0440-A34B-CA198DD15CA1}" dt="2022-05-01T21:14:12.787" v="1089" actId="1076"/>
          <ac:picMkLst>
            <pc:docMk/>
            <pc:sldMk cId="3759201367" sldId="279"/>
            <ac:picMk id="17" creationId="{5D3B74DC-3E20-1D46-8E5B-367DF83508FD}"/>
          </ac:picMkLst>
        </pc:picChg>
        <pc:picChg chg="add mod">
          <ac:chgData name="Wencai Zhang" userId="4a86a1d0-2108-4707-8228-1110f3c1be85" providerId="ADAL" clId="{5D13D192-A431-0440-A34B-CA198DD15CA1}" dt="2022-05-01T21:17:47.332" v="1145" actId="1038"/>
          <ac:picMkLst>
            <pc:docMk/>
            <pc:sldMk cId="3759201367" sldId="279"/>
            <ac:picMk id="20" creationId="{5901980D-4E23-D841-B3C7-0190AAF55F72}"/>
          </ac:picMkLst>
        </pc:picChg>
        <pc:picChg chg="add mod">
          <ac:chgData name="Wencai Zhang" userId="4a86a1d0-2108-4707-8228-1110f3c1be85" providerId="ADAL" clId="{5D13D192-A431-0440-A34B-CA198DD15CA1}" dt="2022-05-01T21:17:37.745" v="1136" actId="1037"/>
          <ac:picMkLst>
            <pc:docMk/>
            <pc:sldMk cId="3759201367" sldId="279"/>
            <ac:picMk id="21" creationId="{09C4753E-589C-5142-9173-4B4593507228}"/>
          </ac:picMkLst>
        </pc:picChg>
      </pc:sldChg>
      <pc:sldChg chg="addSp delSp modSp mod">
        <pc:chgData name="Wencai Zhang" userId="4a86a1d0-2108-4707-8228-1110f3c1be85" providerId="ADAL" clId="{5D13D192-A431-0440-A34B-CA198DD15CA1}" dt="2022-05-24T12:47:37.074" v="2070" actId="478"/>
        <pc:sldMkLst>
          <pc:docMk/>
          <pc:sldMk cId="2061921346" sldId="281"/>
        </pc:sldMkLst>
        <pc:spChg chg="add del mod">
          <ac:chgData name="Wencai Zhang" userId="4a86a1d0-2108-4707-8228-1110f3c1be85" providerId="ADAL" clId="{5D13D192-A431-0440-A34B-CA198DD15CA1}" dt="2022-05-15T22:52:26.586" v="1552"/>
          <ac:spMkLst>
            <pc:docMk/>
            <pc:sldMk cId="2061921346" sldId="281"/>
            <ac:spMk id="4" creationId="{405A89F6-F084-B768-D485-AC5F6BC3839E}"/>
          </ac:spMkLst>
        </pc:spChg>
        <pc:spChg chg="mod topLvl">
          <ac:chgData name="Wencai Zhang" userId="4a86a1d0-2108-4707-8228-1110f3c1be85" providerId="ADAL" clId="{5D13D192-A431-0440-A34B-CA198DD15CA1}" dt="2022-05-15T22:51:46.653" v="1547" actId="338"/>
          <ac:spMkLst>
            <pc:docMk/>
            <pc:sldMk cId="2061921346" sldId="281"/>
            <ac:spMk id="5" creationId="{E24D37FD-B82F-244B-9B7C-E21C817CCD6A}"/>
          </ac:spMkLst>
        </pc:spChg>
        <pc:spChg chg="mod topLvl">
          <ac:chgData name="Wencai Zhang" userId="4a86a1d0-2108-4707-8228-1110f3c1be85" providerId="ADAL" clId="{5D13D192-A431-0440-A34B-CA198DD15CA1}" dt="2022-05-15T23:05:48.603" v="1590" actId="20577"/>
          <ac:spMkLst>
            <pc:docMk/>
            <pc:sldMk cId="2061921346" sldId="281"/>
            <ac:spMk id="6" creationId="{AF39F428-A678-4A45-93FC-ECC6CA219AF5}"/>
          </ac:spMkLst>
        </pc:spChg>
        <pc:spChg chg="mod topLvl">
          <ac:chgData name="Wencai Zhang" userId="4a86a1d0-2108-4707-8228-1110f3c1be85" providerId="ADAL" clId="{5D13D192-A431-0440-A34B-CA198DD15CA1}" dt="2022-05-15T22:51:46.653" v="1547" actId="338"/>
          <ac:spMkLst>
            <pc:docMk/>
            <pc:sldMk cId="2061921346" sldId="281"/>
            <ac:spMk id="7" creationId="{E8544362-E367-4C4E-A7F7-030AE51C3C55}"/>
          </ac:spMkLst>
        </pc:spChg>
        <pc:spChg chg="mod topLvl">
          <ac:chgData name="Wencai Zhang" userId="4a86a1d0-2108-4707-8228-1110f3c1be85" providerId="ADAL" clId="{5D13D192-A431-0440-A34B-CA198DD15CA1}" dt="2022-05-15T23:22:44.791" v="1746" actId="947"/>
          <ac:spMkLst>
            <pc:docMk/>
            <pc:sldMk cId="2061921346" sldId="281"/>
            <ac:spMk id="8" creationId="{2D87C540-6C98-8944-ADCD-9E7EE911A211}"/>
          </ac:spMkLst>
        </pc:spChg>
        <pc:spChg chg="mod topLvl">
          <ac:chgData name="Wencai Zhang" userId="4a86a1d0-2108-4707-8228-1110f3c1be85" providerId="ADAL" clId="{5D13D192-A431-0440-A34B-CA198DD15CA1}" dt="2022-05-15T22:51:46.653" v="1547" actId="338"/>
          <ac:spMkLst>
            <pc:docMk/>
            <pc:sldMk cId="2061921346" sldId="281"/>
            <ac:spMk id="9" creationId="{3029990C-85AF-2147-A476-733A63D9A31A}"/>
          </ac:spMkLst>
        </pc:spChg>
        <pc:spChg chg="mod topLvl">
          <ac:chgData name="Wencai Zhang" userId="4a86a1d0-2108-4707-8228-1110f3c1be85" providerId="ADAL" clId="{5D13D192-A431-0440-A34B-CA198DD15CA1}" dt="2022-05-15T22:51:46.653" v="1547" actId="338"/>
          <ac:spMkLst>
            <pc:docMk/>
            <pc:sldMk cId="2061921346" sldId="281"/>
            <ac:spMk id="10" creationId="{CC732350-498E-3D4A-944D-D00BD90F72DA}"/>
          </ac:spMkLst>
        </pc:spChg>
        <pc:spChg chg="mod topLvl">
          <ac:chgData name="Wencai Zhang" userId="4a86a1d0-2108-4707-8228-1110f3c1be85" providerId="ADAL" clId="{5D13D192-A431-0440-A34B-CA198DD15CA1}" dt="2022-05-15T22:51:46.653" v="1547" actId="338"/>
          <ac:spMkLst>
            <pc:docMk/>
            <pc:sldMk cId="2061921346" sldId="281"/>
            <ac:spMk id="12" creationId="{CD400E5E-D023-5A44-9C8D-9B326987F385}"/>
          </ac:spMkLst>
        </pc:spChg>
        <pc:spChg chg="mod topLvl">
          <ac:chgData name="Wencai Zhang" userId="4a86a1d0-2108-4707-8228-1110f3c1be85" providerId="ADAL" clId="{5D13D192-A431-0440-A34B-CA198DD15CA1}" dt="2022-05-15T23:45:56.134" v="1868" actId="20577"/>
          <ac:spMkLst>
            <pc:docMk/>
            <pc:sldMk cId="2061921346" sldId="281"/>
            <ac:spMk id="14" creationId="{66C163A3-4B0C-B943-9E35-18288CBA2E5B}"/>
          </ac:spMkLst>
        </pc:spChg>
        <pc:spChg chg="mod topLvl">
          <ac:chgData name="Wencai Zhang" userId="4a86a1d0-2108-4707-8228-1110f3c1be85" providerId="ADAL" clId="{5D13D192-A431-0440-A34B-CA198DD15CA1}" dt="2022-05-15T22:51:46.653" v="1547" actId="338"/>
          <ac:spMkLst>
            <pc:docMk/>
            <pc:sldMk cId="2061921346" sldId="281"/>
            <ac:spMk id="15" creationId="{79F0A85D-8E83-3547-BC53-8BB087B3ACE7}"/>
          </ac:spMkLst>
        </pc:spChg>
        <pc:spChg chg="mod topLvl">
          <ac:chgData name="Wencai Zhang" userId="4a86a1d0-2108-4707-8228-1110f3c1be85" providerId="ADAL" clId="{5D13D192-A431-0440-A34B-CA198DD15CA1}" dt="2022-05-15T23:21:28.984" v="1744" actId="947"/>
          <ac:spMkLst>
            <pc:docMk/>
            <pc:sldMk cId="2061921346" sldId="281"/>
            <ac:spMk id="16" creationId="{C403BB40-8BC6-CF49-A3BB-DAEC3345D7FA}"/>
          </ac:spMkLst>
        </pc:spChg>
        <pc:spChg chg="mod topLvl">
          <ac:chgData name="Wencai Zhang" userId="4a86a1d0-2108-4707-8228-1110f3c1be85" providerId="ADAL" clId="{5D13D192-A431-0440-A34B-CA198DD15CA1}" dt="2022-05-15T22:51:46.653" v="1547" actId="338"/>
          <ac:spMkLst>
            <pc:docMk/>
            <pc:sldMk cId="2061921346" sldId="281"/>
            <ac:spMk id="17" creationId="{E0F7AE23-AD41-384B-A913-D043051A7E7D}"/>
          </ac:spMkLst>
        </pc:spChg>
        <pc:spChg chg="mod topLvl">
          <ac:chgData name="Wencai Zhang" userId="4a86a1d0-2108-4707-8228-1110f3c1be85" providerId="ADAL" clId="{5D13D192-A431-0440-A34B-CA198DD15CA1}" dt="2022-05-15T22:51:46.653" v="1547" actId="338"/>
          <ac:spMkLst>
            <pc:docMk/>
            <pc:sldMk cId="2061921346" sldId="281"/>
            <ac:spMk id="19" creationId="{E4EC7EC8-0B71-3849-A5F4-D5835D07F86D}"/>
          </ac:spMkLst>
        </pc:spChg>
        <pc:spChg chg="mod topLvl">
          <ac:chgData name="Wencai Zhang" userId="4a86a1d0-2108-4707-8228-1110f3c1be85" providerId="ADAL" clId="{5D13D192-A431-0440-A34B-CA198DD15CA1}" dt="2022-05-15T22:51:46.653" v="1547" actId="338"/>
          <ac:spMkLst>
            <pc:docMk/>
            <pc:sldMk cId="2061921346" sldId="281"/>
            <ac:spMk id="20" creationId="{2FAF02D3-E7CF-7C4E-AE19-426909884E31}"/>
          </ac:spMkLst>
        </pc:spChg>
        <pc:spChg chg="mod topLvl">
          <ac:chgData name="Wencai Zhang" userId="4a86a1d0-2108-4707-8228-1110f3c1be85" providerId="ADAL" clId="{5D13D192-A431-0440-A34B-CA198DD15CA1}" dt="2022-05-15T23:47:54.148" v="1874" actId="947"/>
          <ac:spMkLst>
            <pc:docMk/>
            <pc:sldMk cId="2061921346" sldId="281"/>
            <ac:spMk id="21" creationId="{0F904C23-6C9E-4244-8CEE-9015521B7052}"/>
          </ac:spMkLst>
        </pc:spChg>
        <pc:spChg chg="mod topLvl">
          <ac:chgData name="Wencai Zhang" userId="4a86a1d0-2108-4707-8228-1110f3c1be85" providerId="ADAL" clId="{5D13D192-A431-0440-A34B-CA198DD15CA1}" dt="2022-05-15T22:51:46.653" v="1547" actId="338"/>
          <ac:spMkLst>
            <pc:docMk/>
            <pc:sldMk cId="2061921346" sldId="281"/>
            <ac:spMk id="22" creationId="{4E8A3E89-780F-DE43-94D5-228C1F89DBC5}"/>
          </ac:spMkLst>
        </pc:spChg>
        <pc:spChg chg="mod topLvl">
          <ac:chgData name="Wencai Zhang" userId="4a86a1d0-2108-4707-8228-1110f3c1be85" providerId="ADAL" clId="{5D13D192-A431-0440-A34B-CA198DD15CA1}" dt="2022-05-15T22:51:46.653" v="1547" actId="338"/>
          <ac:spMkLst>
            <pc:docMk/>
            <pc:sldMk cId="2061921346" sldId="281"/>
            <ac:spMk id="23" creationId="{7D156526-8BD0-E947-9E49-69DA17E8F015}"/>
          </ac:spMkLst>
        </pc:spChg>
        <pc:spChg chg="mod topLvl">
          <ac:chgData name="Wencai Zhang" userId="4a86a1d0-2108-4707-8228-1110f3c1be85" providerId="ADAL" clId="{5D13D192-A431-0440-A34B-CA198DD15CA1}" dt="2022-05-15T23:10:34.454" v="1614" actId="947"/>
          <ac:spMkLst>
            <pc:docMk/>
            <pc:sldMk cId="2061921346" sldId="281"/>
            <ac:spMk id="24" creationId="{543F5E0E-E137-8446-9C3A-056AF9CB57D0}"/>
          </ac:spMkLst>
        </pc:spChg>
        <pc:spChg chg="mod topLvl">
          <ac:chgData name="Wencai Zhang" userId="4a86a1d0-2108-4707-8228-1110f3c1be85" providerId="ADAL" clId="{5D13D192-A431-0440-A34B-CA198DD15CA1}" dt="2022-05-15T22:51:46.653" v="1547" actId="338"/>
          <ac:spMkLst>
            <pc:docMk/>
            <pc:sldMk cId="2061921346" sldId="281"/>
            <ac:spMk id="25" creationId="{6CA175CA-787A-6747-ABDE-C150D4B207F0}"/>
          </ac:spMkLst>
        </pc:spChg>
        <pc:spChg chg="mod topLvl">
          <ac:chgData name="Wencai Zhang" userId="4a86a1d0-2108-4707-8228-1110f3c1be85" providerId="ADAL" clId="{5D13D192-A431-0440-A34B-CA198DD15CA1}" dt="2022-05-15T22:51:46.653" v="1547" actId="338"/>
          <ac:spMkLst>
            <pc:docMk/>
            <pc:sldMk cId="2061921346" sldId="281"/>
            <ac:spMk id="26" creationId="{DB089539-C70F-014A-A770-BE7FB6A49579}"/>
          </ac:spMkLst>
        </pc:spChg>
        <pc:spChg chg="mod topLvl">
          <ac:chgData name="Wencai Zhang" userId="4a86a1d0-2108-4707-8228-1110f3c1be85" providerId="ADAL" clId="{5D13D192-A431-0440-A34B-CA198DD15CA1}" dt="2022-05-15T22:51:46.653" v="1547" actId="338"/>
          <ac:spMkLst>
            <pc:docMk/>
            <pc:sldMk cId="2061921346" sldId="281"/>
            <ac:spMk id="27" creationId="{8497600A-7AF0-F443-A5AA-ECED2C713EE6}"/>
          </ac:spMkLst>
        </pc:spChg>
        <pc:spChg chg="mod topLvl">
          <ac:chgData name="Wencai Zhang" userId="4a86a1d0-2108-4707-8228-1110f3c1be85" providerId="ADAL" clId="{5D13D192-A431-0440-A34B-CA198DD15CA1}" dt="2022-05-15T22:51:46.653" v="1547" actId="338"/>
          <ac:spMkLst>
            <pc:docMk/>
            <pc:sldMk cId="2061921346" sldId="281"/>
            <ac:spMk id="28" creationId="{238F39F9-8419-7843-927A-563426EF3AD1}"/>
          </ac:spMkLst>
        </pc:spChg>
        <pc:spChg chg="add del mod">
          <ac:chgData name="Wencai Zhang" userId="4a86a1d0-2108-4707-8228-1110f3c1be85" providerId="ADAL" clId="{5D13D192-A431-0440-A34B-CA198DD15CA1}" dt="2022-05-15T22:52:26.588" v="1554"/>
          <ac:spMkLst>
            <pc:docMk/>
            <pc:sldMk cId="2061921346" sldId="281"/>
            <ac:spMk id="29" creationId="{602253BF-9958-2029-9DF7-0123F51BF8FD}"/>
          </ac:spMkLst>
        </pc:spChg>
        <pc:spChg chg="mod">
          <ac:chgData name="Wencai Zhang" userId="4a86a1d0-2108-4707-8228-1110f3c1be85" providerId="ADAL" clId="{5D13D192-A431-0440-A34B-CA198DD15CA1}" dt="2022-05-24T12:47:32.445" v="2069" actId="1076"/>
          <ac:spMkLst>
            <pc:docMk/>
            <pc:sldMk cId="2061921346" sldId="281"/>
            <ac:spMk id="31" creationId="{10210D5A-DB67-9844-99BE-8F67F8904355}"/>
          </ac:spMkLst>
        </pc:spChg>
        <pc:spChg chg="del">
          <ac:chgData name="Wencai Zhang" userId="4a86a1d0-2108-4707-8228-1110f3c1be85" providerId="ADAL" clId="{5D13D192-A431-0440-A34B-CA198DD15CA1}" dt="2022-05-24T12:47:37.074" v="2070" actId="478"/>
          <ac:spMkLst>
            <pc:docMk/>
            <pc:sldMk cId="2061921346" sldId="281"/>
            <ac:spMk id="32" creationId="{9A1608EA-6953-DD48-95F6-035EE1A431A4}"/>
          </ac:spMkLst>
        </pc:spChg>
        <pc:spChg chg="mod topLvl">
          <ac:chgData name="Wencai Zhang" userId="4a86a1d0-2108-4707-8228-1110f3c1be85" providerId="ADAL" clId="{5D13D192-A431-0440-A34B-CA198DD15CA1}" dt="2022-05-15T22:51:19.081" v="1544" actId="165"/>
          <ac:spMkLst>
            <pc:docMk/>
            <pc:sldMk cId="2061921346" sldId="281"/>
            <ac:spMk id="33" creationId="{3FA65C62-1519-8441-A07C-377FBAE60173}"/>
          </ac:spMkLst>
        </pc:spChg>
        <pc:spChg chg="mod topLvl">
          <ac:chgData name="Wencai Zhang" userId="4a86a1d0-2108-4707-8228-1110f3c1be85" providerId="ADAL" clId="{5D13D192-A431-0440-A34B-CA198DD15CA1}" dt="2022-05-15T22:51:19.081" v="1544" actId="165"/>
          <ac:spMkLst>
            <pc:docMk/>
            <pc:sldMk cId="2061921346" sldId="281"/>
            <ac:spMk id="34" creationId="{359977FD-2673-6F41-81CE-3CA2D7E8124E}"/>
          </ac:spMkLst>
        </pc:spChg>
        <pc:spChg chg="mod">
          <ac:chgData name="Wencai Zhang" userId="4a86a1d0-2108-4707-8228-1110f3c1be85" providerId="ADAL" clId="{5D13D192-A431-0440-A34B-CA198DD15CA1}" dt="2022-05-24T12:47:23.277" v="2068" actId="113"/>
          <ac:spMkLst>
            <pc:docMk/>
            <pc:sldMk cId="2061921346" sldId="281"/>
            <ac:spMk id="35" creationId="{F7465C9C-78DF-3542-8882-81639FF3A4F4}"/>
          </ac:spMkLst>
        </pc:spChg>
        <pc:spChg chg="add del mod">
          <ac:chgData name="Wencai Zhang" userId="4a86a1d0-2108-4707-8228-1110f3c1be85" providerId="ADAL" clId="{5D13D192-A431-0440-A34B-CA198DD15CA1}" dt="2022-05-15T22:52:30.170" v="1556"/>
          <ac:spMkLst>
            <pc:docMk/>
            <pc:sldMk cId="2061921346" sldId="281"/>
            <ac:spMk id="36" creationId="{96C44ED8-8F6B-8FA7-D72D-A0DAF38177AF}"/>
          </ac:spMkLst>
        </pc:spChg>
        <pc:grpChg chg="del">
          <ac:chgData name="Wencai Zhang" userId="4a86a1d0-2108-4707-8228-1110f3c1be85" providerId="ADAL" clId="{5D13D192-A431-0440-A34B-CA198DD15CA1}" dt="2022-05-15T22:51:19.081" v="1544" actId="165"/>
          <ac:grpSpMkLst>
            <pc:docMk/>
            <pc:sldMk cId="2061921346" sldId="281"/>
            <ac:grpSpMk id="2" creationId="{5AC5EB32-3E0D-D445-BFFB-A928AA9BF687}"/>
          </ac:grpSpMkLst>
        </pc:grpChg>
        <pc:grpChg chg="add mod">
          <ac:chgData name="Wencai Zhang" userId="4a86a1d0-2108-4707-8228-1110f3c1be85" providerId="ADAL" clId="{5D13D192-A431-0440-A34B-CA198DD15CA1}" dt="2022-05-15T22:51:46.653" v="1547" actId="338"/>
          <ac:grpSpMkLst>
            <pc:docMk/>
            <pc:sldMk cId="2061921346" sldId="281"/>
            <ac:grpSpMk id="3" creationId="{F0C0A510-0698-1DA8-7DD4-9E7C2801168A}"/>
          </ac:grpSpMkLst>
        </pc:grpChg>
        <pc:grpChg chg="del mod topLvl">
          <ac:chgData name="Wencai Zhang" userId="4a86a1d0-2108-4707-8228-1110f3c1be85" providerId="ADAL" clId="{5D13D192-A431-0440-A34B-CA198DD15CA1}" dt="2022-05-15T22:51:28.404" v="1545" actId="165"/>
          <ac:grpSpMkLst>
            <pc:docMk/>
            <pc:sldMk cId="2061921346" sldId="281"/>
            <ac:grpSpMk id="30" creationId="{ECF31ABE-5FAC-B645-BEE5-9D1102CD3570}"/>
          </ac:grpSpMkLst>
        </pc:grpChg>
        <pc:grpChg chg="add del mod">
          <ac:chgData name="Wencai Zhang" userId="4a86a1d0-2108-4707-8228-1110f3c1be85" providerId="ADAL" clId="{5D13D192-A431-0440-A34B-CA198DD15CA1}" dt="2022-05-15T23:49:34.890" v="1959" actId="21"/>
          <ac:grpSpMkLst>
            <pc:docMk/>
            <pc:sldMk cId="2061921346" sldId="281"/>
            <ac:grpSpMk id="47" creationId="{3D96CE7F-4E65-6841-A8F3-5C75C3A67BED}"/>
          </ac:grpSpMkLst>
        </pc:grpChg>
        <pc:cxnChg chg="mod topLvl">
          <ac:chgData name="Wencai Zhang" userId="4a86a1d0-2108-4707-8228-1110f3c1be85" providerId="ADAL" clId="{5D13D192-A431-0440-A34B-CA198DD15CA1}" dt="2022-05-15T22:51:46.653" v="1547" actId="338"/>
          <ac:cxnSpMkLst>
            <pc:docMk/>
            <pc:sldMk cId="2061921346" sldId="281"/>
            <ac:cxnSpMk id="11" creationId="{258738F4-CE87-844B-80E0-81D7E5D4E9EF}"/>
          </ac:cxnSpMkLst>
        </pc:cxnChg>
        <pc:cxnChg chg="mod topLvl">
          <ac:chgData name="Wencai Zhang" userId="4a86a1d0-2108-4707-8228-1110f3c1be85" providerId="ADAL" clId="{5D13D192-A431-0440-A34B-CA198DD15CA1}" dt="2022-05-15T22:51:46.653" v="1547" actId="338"/>
          <ac:cxnSpMkLst>
            <pc:docMk/>
            <pc:sldMk cId="2061921346" sldId="281"/>
            <ac:cxnSpMk id="13" creationId="{551A3CCA-DB79-1F4A-8493-460CA8910744}"/>
          </ac:cxnSpMkLst>
        </pc:cxnChg>
        <pc:cxnChg chg="mod topLvl">
          <ac:chgData name="Wencai Zhang" userId="4a86a1d0-2108-4707-8228-1110f3c1be85" providerId="ADAL" clId="{5D13D192-A431-0440-A34B-CA198DD15CA1}" dt="2022-05-15T22:51:46.653" v="1547" actId="338"/>
          <ac:cxnSpMkLst>
            <pc:docMk/>
            <pc:sldMk cId="2061921346" sldId="281"/>
            <ac:cxnSpMk id="18" creationId="{44431CC5-B24D-DD43-A06B-132FECB5C457}"/>
          </ac:cxnSpMkLst>
        </pc:cxnChg>
        <pc:cxnChg chg="add del">
          <ac:chgData name="Wencai Zhang" userId="4a86a1d0-2108-4707-8228-1110f3c1be85" providerId="ADAL" clId="{5D13D192-A431-0440-A34B-CA198DD15CA1}" dt="2022-05-15T23:09:28.635" v="1610" actId="478"/>
          <ac:cxnSpMkLst>
            <pc:docMk/>
            <pc:sldMk cId="2061921346" sldId="281"/>
            <ac:cxnSpMk id="38" creationId="{3467F36D-168F-0CA5-C0D9-58FAC1EBFA04}"/>
          </ac:cxnSpMkLst>
        </pc:cxnChg>
        <pc:cxnChg chg="add mod">
          <ac:chgData name="Wencai Zhang" userId="4a86a1d0-2108-4707-8228-1110f3c1be85" providerId="ADAL" clId="{5D13D192-A431-0440-A34B-CA198DD15CA1}" dt="2022-05-15T23:49:33.512" v="1958" actId="164"/>
          <ac:cxnSpMkLst>
            <pc:docMk/>
            <pc:sldMk cId="2061921346" sldId="281"/>
            <ac:cxnSpMk id="39" creationId="{FE843848-7D3A-215E-527A-C47196A40E57}"/>
          </ac:cxnSpMkLst>
        </pc:cxnChg>
        <pc:cxnChg chg="add mod">
          <ac:chgData name="Wencai Zhang" userId="4a86a1d0-2108-4707-8228-1110f3c1be85" providerId="ADAL" clId="{5D13D192-A431-0440-A34B-CA198DD15CA1}" dt="2022-05-15T23:49:33.512" v="1958" actId="164"/>
          <ac:cxnSpMkLst>
            <pc:docMk/>
            <pc:sldMk cId="2061921346" sldId="281"/>
            <ac:cxnSpMk id="40" creationId="{330DD8F6-2EEA-D426-0701-A509D81A0810}"/>
          </ac:cxnSpMkLst>
        </pc:cxnChg>
        <pc:cxnChg chg="add mod">
          <ac:chgData name="Wencai Zhang" userId="4a86a1d0-2108-4707-8228-1110f3c1be85" providerId="ADAL" clId="{5D13D192-A431-0440-A34B-CA198DD15CA1}" dt="2022-05-15T23:49:33.512" v="1958" actId="164"/>
          <ac:cxnSpMkLst>
            <pc:docMk/>
            <pc:sldMk cId="2061921346" sldId="281"/>
            <ac:cxnSpMk id="41" creationId="{A08C6034-81A5-EA1C-4F91-60D760F7E7EE}"/>
          </ac:cxnSpMkLst>
        </pc:cxnChg>
        <pc:cxnChg chg="add mod">
          <ac:chgData name="Wencai Zhang" userId="4a86a1d0-2108-4707-8228-1110f3c1be85" providerId="ADAL" clId="{5D13D192-A431-0440-A34B-CA198DD15CA1}" dt="2022-05-15T23:49:33.512" v="1958" actId="164"/>
          <ac:cxnSpMkLst>
            <pc:docMk/>
            <pc:sldMk cId="2061921346" sldId="281"/>
            <ac:cxnSpMk id="42" creationId="{C9905BF3-E93E-3FC9-05E9-8D1302913827}"/>
          </ac:cxnSpMkLst>
        </pc:cxnChg>
        <pc:cxnChg chg="add mod">
          <ac:chgData name="Wencai Zhang" userId="4a86a1d0-2108-4707-8228-1110f3c1be85" providerId="ADAL" clId="{5D13D192-A431-0440-A34B-CA198DD15CA1}" dt="2022-05-15T23:49:33.512" v="1958" actId="164"/>
          <ac:cxnSpMkLst>
            <pc:docMk/>
            <pc:sldMk cId="2061921346" sldId="281"/>
            <ac:cxnSpMk id="43" creationId="{6A0ECAEE-7F2A-1B50-4EC3-DAC6EAD64AFC}"/>
          </ac:cxnSpMkLst>
        </pc:cxnChg>
        <pc:cxnChg chg="add mod">
          <ac:chgData name="Wencai Zhang" userId="4a86a1d0-2108-4707-8228-1110f3c1be85" providerId="ADAL" clId="{5D13D192-A431-0440-A34B-CA198DD15CA1}" dt="2022-05-15T23:49:33.512" v="1958" actId="164"/>
          <ac:cxnSpMkLst>
            <pc:docMk/>
            <pc:sldMk cId="2061921346" sldId="281"/>
            <ac:cxnSpMk id="44" creationId="{16E8D1C2-E269-6AF9-F00A-3B5CEDBCC84F}"/>
          </ac:cxnSpMkLst>
        </pc:cxnChg>
        <pc:cxnChg chg="add mod">
          <ac:chgData name="Wencai Zhang" userId="4a86a1d0-2108-4707-8228-1110f3c1be85" providerId="ADAL" clId="{5D13D192-A431-0440-A34B-CA198DD15CA1}" dt="2022-05-15T23:49:33.512" v="1958" actId="164"/>
          <ac:cxnSpMkLst>
            <pc:docMk/>
            <pc:sldMk cId="2061921346" sldId="281"/>
            <ac:cxnSpMk id="45" creationId="{F29EC1B0-C86D-0047-4DAA-3C65E413802A}"/>
          </ac:cxnSpMkLst>
        </pc:cxnChg>
        <pc:cxnChg chg="add mod">
          <ac:chgData name="Wencai Zhang" userId="4a86a1d0-2108-4707-8228-1110f3c1be85" providerId="ADAL" clId="{5D13D192-A431-0440-A34B-CA198DD15CA1}" dt="2022-05-15T23:49:33.512" v="1958" actId="164"/>
          <ac:cxnSpMkLst>
            <pc:docMk/>
            <pc:sldMk cId="2061921346" sldId="281"/>
            <ac:cxnSpMk id="46" creationId="{51D0B9B6-3736-A0C7-3BCB-421201913EB5}"/>
          </ac:cxnSpMkLst>
        </pc:cxnChg>
      </pc:sldChg>
      <pc:sldChg chg="delSp modSp mod">
        <pc:chgData name="Wencai Zhang" userId="4a86a1d0-2108-4707-8228-1110f3c1be85" providerId="ADAL" clId="{5D13D192-A431-0440-A34B-CA198DD15CA1}" dt="2022-05-26T19:52:21.452" v="2121" actId="1038"/>
        <pc:sldMkLst>
          <pc:docMk/>
          <pc:sldMk cId="495234596" sldId="282"/>
        </pc:sldMkLst>
        <pc:spChg chg="mod">
          <ac:chgData name="Wencai Zhang" userId="4a86a1d0-2108-4707-8228-1110f3c1be85" providerId="ADAL" clId="{5D13D192-A431-0440-A34B-CA198DD15CA1}" dt="2022-05-24T12:49:55.572" v="2095" actId="1038"/>
          <ac:spMkLst>
            <pc:docMk/>
            <pc:sldMk cId="495234596" sldId="282"/>
            <ac:spMk id="5" creationId="{3DDAAADC-4070-A747-8C1A-EEAE7CFF713C}"/>
          </ac:spMkLst>
        </pc:spChg>
        <pc:spChg chg="del">
          <ac:chgData name="Wencai Zhang" userId="4a86a1d0-2108-4707-8228-1110f3c1be85" providerId="ADAL" clId="{5D13D192-A431-0440-A34B-CA198DD15CA1}" dt="2022-05-24T12:49:58.247" v="2096" actId="478"/>
          <ac:spMkLst>
            <pc:docMk/>
            <pc:sldMk cId="495234596" sldId="282"/>
            <ac:spMk id="6" creationId="{1C695B3C-3E32-3F49-9033-3C5810C8B422}"/>
          </ac:spMkLst>
        </pc:spChg>
        <pc:spChg chg="mod">
          <ac:chgData name="Wencai Zhang" userId="4a86a1d0-2108-4707-8228-1110f3c1be85" providerId="ADAL" clId="{5D13D192-A431-0440-A34B-CA198DD15CA1}" dt="2022-05-26T19:52:21.452" v="2121" actId="1038"/>
          <ac:spMkLst>
            <pc:docMk/>
            <pc:sldMk cId="495234596" sldId="282"/>
            <ac:spMk id="7" creationId="{A76311FD-6BEF-6E48-AD9A-66A2F87DF128}"/>
          </ac:spMkLst>
        </pc:spChg>
        <pc:picChg chg="mod">
          <ac:chgData name="Wencai Zhang" userId="4a86a1d0-2108-4707-8228-1110f3c1be85" providerId="ADAL" clId="{5D13D192-A431-0440-A34B-CA198DD15CA1}" dt="2022-05-26T19:52:16.623" v="2118" actId="1035"/>
          <ac:picMkLst>
            <pc:docMk/>
            <pc:sldMk cId="495234596" sldId="282"/>
            <ac:picMk id="4" creationId="{49796C3D-B7CF-5A4D-B5F2-58B16E15E100}"/>
          </ac:picMkLst>
        </pc:picChg>
      </pc:sldChg>
      <pc:sldChg chg="addSp delSp modSp mod">
        <pc:chgData name="Wencai Zhang" userId="4a86a1d0-2108-4707-8228-1110f3c1be85" providerId="ADAL" clId="{5D13D192-A431-0440-A34B-CA198DD15CA1}" dt="2022-05-24T12:48:28.367" v="2084" actId="20577"/>
        <pc:sldMkLst>
          <pc:docMk/>
          <pc:sldMk cId="2930520000" sldId="283"/>
        </pc:sldMkLst>
        <pc:spChg chg="del">
          <ac:chgData name="Wencai Zhang" userId="4a86a1d0-2108-4707-8228-1110f3c1be85" providerId="ADAL" clId="{5D13D192-A431-0440-A34B-CA198DD15CA1}" dt="2022-05-15T23:57:12.435" v="1967" actId="478"/>
          <ac:spMkLst>
            <pc:docMk/>
            <pc:sldMk cId="2930520000" sldId="283"/>
            <ac:spMk id="5" creationId="{05F5D03A-E3E8-C946-8CBE-C178D69FFD43}"/>
          </ac:spMkLst>
        </pc:spChg>
        <pc:spChg chg="mod">
          <ac:chgData name="Wencai Zhang" userId="4a86a1d0-2108-4707-8228-1110f3c1be85" providerId="ADAL" clId="{5D13D192-A431-0440-A34B-CA198DD15CA1}" dt="2022-05-16T00:25:13.090" v="2055" actId="6559"/>
          <ac:spMkLst>
            <pc:docMk/>
            <pc:sldMk cId="2930520000" sldId="283"/>
            <ac:spMk id="14" creationId="{FDC5025F-043B-114B-A3B9-4EA1C905A43E}"/>
          </ac:spMkLst>
        </pc:spChg>
        <pc:spChg chg="mod">
          <ac:chgData name="Wencai Zhang" userId="4a86a1d0-2108-4707-8228-1110f3c1be85" providerId="ADAL" clId="{5D13D192-A431-0440-A34B-CA198DD15CA1}" dt="2022-05-16T00:27:20.228" v="2062" actId="947"/>
          <ac:spMkLst>
            <pc:docMk/>
            <pc:sldMk cId="2930520000" sldId="283"/>
            <ac:spMk id="18" creationId="{BE258A10-5065-074C-8CB5-DF8B319EA916}"/>
          </ac:spMkLst>
        </pc:spChg>
        <pc:spChg chg="mod">
          <ac:chgData name="Wencai Zhang" userId="4a86a1d0-2108-4707-8228-1110f3c1be85" providerId="ADAL" clId="{5D13D192-A431-0440-A34B-CA198DD15CA1}" dt="2022-05-16T00:22:16.929" v="2037" actId="947"/>
          <ac:spMkLst>
            <pc:docMk/>
            <pc:sldMk cId="2930520000" sldId="283"/>
            <ac:spMk id="21" creationId="{28ECE194-1B00-0144-BF88-FAC9FC03051A}"/>
          </ac:spMkLst>
        </pc:spChg>
        <pc:spChg chg="mod">
          <ac:chgData name="Wencai Zhang" userId="4a86a1d0-2108-4707-8228-1110f3c1be85" providerId="ADAL" clId="{5D13D192-A431-0440-A34B-CA198DD15CA1}" dt="2022-05-24T12:48:28.367" v="2084" actId="20577"/>
          <ac:spMkLst>
            <pc:docMk/>
            <pc:sldMk cId="2930520000" sldId="283"/>
            <ac:spMk id="26" creationId="{67890AAD-A826-104E-BE3E-0DB542F0062D}"/>
          </ac:spMkLst>
        </pc:spChg>
        <pc:spChg chg="del">
          <ac:chgData name="Wencai Zhang" userId="4a86a1d0-2108-4707-8228-1110f3c1be85" providerId="ADAL" clId="{5D13D192-A431-0440-A34B-CA198DD15CA1}" dt="2022-05-24T12:48:18.711" v="2080" actId="478"/>
          <ac:spMkLst>
            <pc:docMk/>
            <pc:sldMk cId="2930520000" sldId="283"/>
            <ac:spMk id="36" creationId="{293DB052-C68B-D54E-AA5B-53A93BDC075C}"/>
          </ac:spMkLst>
        </pc:spChg>
        <pc:spChg chg="mod">
          <ac:chgData name="Wencai Zhang" userId="4a86a1d0-2108-4707-8228-1110f3c1be85" providerId="ADAL" clId="{5D13D192-A431-0440-A34B-CA198DD15CA1}" dt="2022-04-30T09:15:43.021" v="1067"/>
          <ac:spMkLst>
            <pc:docMk/>
            <pc:sldMk cId="2930520000" sldId="283"/>
            <ac:spMk id="38" creationId="{436F94E7-C0D7-7E45-BB33-669ABD51469F}"/>
          </ac:spMkLst>
        </pc:spChg>
        <pc:spChg chg="mod">
          <ac:chgData name="Wencai Zhang" userId="4a86a1d0-2108-4707-8228-1110f3c1be85" providerId="ADAL" clId="{5D13D192-A431-0440-A34B-CA198DD15CA1}" dt="2022-04-30T09:15:50.625" v="1068"/>
          <ac:spMkLst>
            <pc:docMk/>
            <pc:sldMk cId="2930520000" sldId="283"/>
            <ac:spMk id="39" creationId="{54E02CFD-3761-8444-89C5-5ED0AD6C5385}"/>
          </ac:spMkLst>
        </pc:spChg>
        <pc:spChg chg="mod">
          <ac:chgData name="Wencai Zhang" userId="4a86a1d0-2108-4707-8228-1110f3c1be85" providerId="ADAL" clId="{5D13D192-A431-0440-A34B-CA198DD15CA1}" dt="2022-05-24T12:48:13.424" v="2079" actId="113"/>
          <ac:spMkLst>
            <pc:docMk/>
            <pc:sldMk cId="2930520000" sldId="283"/>
            <ac:spMk id="41" creationId="{BB3EF1F2-108C-AB4E-ADCA-6E324EEB0D13}"/>
          </ac:spMkLst>
        </pc:spChg>
        <pc:spChg chg="add mod">
          <ac:chgData name="Wencai Zhang" userId="4a86a1d0-2108-4707-8228-1110f3c1be85" providerId="ADAL" clId="{5D13D192-A431-0440-A34B-CA198DD15CA1}" dt="2022-05-15T23:57:13.041" v="1968"/>
          <ac:spMkLst>
            <pc:docMk/>
            <pc:sldMk cId="2930520000" sldId="283"/>
            <ac:spMk id="51" creationId="{E26891AD-B512-7B63-ABEA-2E7B3EFAF224}"/>
          </ac:spMkLst>
        </pc:spChg>
        <pc:grpChg chg="mod">
          <ac:chgData name="Wencai Zhang" userId="4a86a1d0-2108-4707-8228-1110f3c1be85" providerId="ADAL" clId="{5D13D192-A431-0440-A34B-CA198DD15CA1}" dt="2022-04-30T09:14:56.067" v="1047" actId="1035"/>
          <ac:grpSpMkLst>
            <pc:docMk/>
            <pc:sldMk cId="2930520000" sldId="283"/>
            <ac:grpSpMk id="40" creationId="{C129A40F-6004-F644-B127-48703E4242A3}"/>
          </ac:grpSpMkLst>
        </pc:grpChg>
        <pc:grpChg chg="add del mod">
          <ac:chgData name="Wencai Zhang" userId="4a86a1d0-2108-4707-8228-1110f3c1be85" providerId="ADAL" clId="{5D13D192-A431-0440-A34B-CA198DD15CA1}" dt="2022-05-16T00:27:36.394" v="2063" actId="478"/>
          <ac:grpSpMkLst>
            <pc:docMk/>
            <pc:sldMk cId="2930520000" sldId="283"/>
            <ac:grpSpMk id="42" creationId="{FA6C4DC2-9D72-8E09-7C51-C2A06A092364}"/>
          </ac:grpSpMkLst>
        </pc:grpChg>
        <pc:cxnChg chg="mod">
          <ac:chgData name="Wencai Zhang" userId="4a86a1d0-2108-4707-8228-1110f3c1be85" providerId="ADAL" clId="{5D13D192-A431-0440-A34B-CA198DD15CA1}" dt="2022-05-15T23:54:34.672" v="1962"/>
          <ac:cxnSpMkLst>
            <pc:docMk/>
            <pc:sldMk cId="2930520000" sldId="283"/>
            <ac:cxnSpMk id="43" creationId="{CE52E5F3-E970-E01D-8534-C8B245821918}"/>
          </ac:cxnSpMkLst>
        </pc:cxnChg>
        <pc:cxnChg chg="mod">
          <ac:chgData name="Wencai Zhang" userId="4a86a1d0-2108-4707-8228-1110f3c1be85" providerId="ADAL" clId="{5D13D192-A431-0440-A34B-CA198DD15CA1}" dt="2022-05-15T23:54:34.672" v="1962"/>
          <ac:cxnSpMkLst>
            <pc:docMk/>
            <pc:sldMk cId="2930520000" sldId="283"/>
            <ac:cxnSpMk id="44" creationId="{06394BAB-03EA-05E8-9390-6EEC86B46E09}"/>
          </ac:cxnSpMkLst>
        </pc:cxnChg>
        <pc:cxnChg chg="mod">
          <ac:chgData name="Wencai Zhang" userId="4a86a1d0-2108-4707-8228-1110f3c1be85" providerId="ADAL" clId="{5D13D192-A431-0440-A34B-CA198DD15CA1}" dt="2022-05-15T23:54:34.672" v="1962"/>
          <ac:cxnSpMkLst>
            <pc:docMk/>
            <pc:sldMk cId="2930520000" sldId="283"/>
            <ac:cxnSpMk id="45" creationId="{621F536D-AF9E-ED07-971B-9875002AFB2B}"/>
          </ac:cxnSpMkLst>
        </pc:cxnChg>
        <pc:cxnChg chg="mod">
          <ac:chgData name="Wencai Zhang" userId="4a86a1d0-2108-4707-8228-1110f3c1be85" providerId="ADAL" clId="{5D13D192-A431-0440-A34B-CA198DD15CA1}" dt="2022-05-15T23:54:34.672" v="1962"/>
          <ac:cxnSpMkLst>
            <pc:docMk/>
            <pc:sldMk cId="2930520000" sldId="283"/>
            <ac:cxnSpMk id="46" creationId="{B537EC05-5731-A869-5930-DFB798F49B63}"/>
          </ac:cxnSpMkLst>
        </pc:cxnChg>
        <pc:cxnChg chg="mod">
          <ac:chgData name="Wencai Zhang" userId="4a86a1d0-2108-4707-8228-1110f3c1be85" providerId="ADAL" clId="{5D13D192-A431-0440-A34B-CA198DD15CA1}" dt="2022-05-15T23:54:34.672" v="1962"/>
          <ac:cxnSpMkLst>
            <pc:docMk/>
            <pc:sldMk cId="2930520000" sldId="283"/>
            <ac:cxnSpMk id="47" creationId="{135CF8DD-D915-FE7B-B9D4-BA390F6C2594}"/>
          </ac:cxnSpMkLst>
        </pc:cxnChg>
        <pc:cxnChg chg="mod">
          <ac:chgData name="Wencai Zhang" userId="4a86a1d0-2108-4707-8228-1110f3c1be85" providerId="ADAL" clId="{5D13D192-A431-0440-A34B-CA198DD15CA1}" dt="2022-05-15T23:54:34.672" v="1962"/>
          <ac:cxnSpMkLst>
            <pc:docMk/>
            <pc:sldMk cId="2930520000" sldId="283"/>
            <ac:cxnSpMk id="48" creationId="{7A94B9AF-87B5-9820-51AF-92A3E46855DA}"/>
          </ac:cxnSpMkLst>
        </pc:cxnChg>
        <pc:cxnChg chg="mod">
          <ac:chgData name="Wencai Zhang" userId="4a86a1d0-2108-4707-8228-1110f3c1be85" providerId="ADAL" clId="{5D13D192-A431-0440-A34B-CA198DD15CA1}" dt="2022-05-15T23:54:34.672" v="1962"/>
          <ac:cxnSpMkLst>
            <pc:docMk/>
            <pc:sldMk cId="2930520000" sldId="283"/>
            <ac:cxnSpMk id="49" creationId="{AC4FA46A-9106-5D66-692A-C2120B6FAEE2}"/>
          </ac:cxnSpMkLst>
        </pc:cxnChg>
        <pc:cxnChg chg="mod">
          <ac:chgData name="Wencai Zhang" userId="4a86a1d0-2108-4707-8228-1110f3c1be85" providerId="ADAL" clId="{5D13D192-A431-0440-A34B-CA198DD15CA1}" dt="2022-05-15T23:54:34.672" v="1962"/>
          <ac:cxnSpMkLst>
            <pc:docMk/>
            <pc:sldMk cId="2930520000" sldId="283"/>
            <ac:cxnSpMk id="50" creationId="{3DCF0DC7-AA40-F198-3458-9335A30A0D69}"/>
          </ac:cxnSpMkLst>
        </pc:cxnChg>
      </pc:sldChg>
      <pc:sldChg chg="addSp delSp modSp mod">
        <pc:chgData name="Wencai Zhang" userId="4a86a1d0-2108-4707-8228-1110f3c1be85" providerId="ADAL" clId="{5D13D192-A431-0440-A34B-CA198DD15CA1}" dt="2022-05-24T12:48:00.707" v="2078" actId="113"/>
        <pc:sldMkLst>
          <pc:docMk/>
          <pc:sldMk cId="3756175224" sldId="284"/>
        </pc:sldMkLst>
        <pc:spChg chg="del">
          <ac:chgData name="Wencai Zhang" userId="4a86a1d0-2108-4707-8228-1110f3c1be85" providerId="ADAL" clId="{5D13D192-A431-0440-A34B-CA198DD15CA1}" dt="2022-05-24T12:47:56.211" v="2077" actId="478"/>
          <ac:spMkLst>
            <pc:docMk/>
            <pc:sldMk cId="3756175224" sldId="284"/>
            <ac:spMk id="4" creationId="{6023C86F-C0DE-F54E-B631-D368B3384311}"/>
          </ac:spMkLst>
        </pc:spChg>
        <pc:spChg chg="del">
          <ac:chgData name="Wencai Zhang" userId="4a86a1d0-2108-4707-8228-1110f3c1be85" providerId="ADAL" clId="{5D13D192-A431-0440-A34B-CA198DD15CA1}" dt="2022-05-15T23:56:24.832" v="1965" actId="478"/>
          <ac:spMkLst>
            <pc:docMk/>
            <pc:sldMk cId="3756175224" sldId="284"/>
            <ac:spMk id="7" creationId="{799BA71D-8D6B-2F47-8CCE-99F12AB12ACD}"/>
          </ac:spMkLst>
        </pc:spChg>
        <pc:spChg chg="mod">
          <ac:chgData name="Wencai Zhang" userId="4a86a1d0-2108-4707-8228-1110f3c1be85" providerId="ADAL" clId="{5D13D192-A431-0440-A34B-CA198DD15CA1}" dt="2022-05-16T00:06:43.328" v="1980" actId="6559"/>
          <ac:spMkLst>
            <pc:docMk/>
            <pc:sldMk cId="3756175224" sldId="284"/>
            <ac:spMk id="16" creationId="{03A6ADD2-67A5-154A-AACF-42CB11D378BB}"/>
          </ac:spMkLst>
        </pc:spChg>
        <pc:spChg chg="mod">
          <ac:chgData name="Wencai Zhang" userId="4a86a1d0-2108-4707-8228-1110f3c1be85" providerId="ADAL" clId="{5D13D192-A431-0440-A34B-CA198DD15CA1}" dt="2022-05-16T00:01:20.344" v="1973" actId="947"/>
          <ac:spMkLst>
            <pc:docMk/>
            <pc:sldMk cId="3756175224" sldId="284"/>
            <ac:spMk id="17" creationId="{14893B54-54C3-3940-84C8-6A9E90F309F1}"/>
          </ac:spMkLst>
        </pc:spChg>
        <pc:spChg chg="mod">
          <ac:chgData name="Wencai Zhang" userId="4a86a1d0-2108-4707-8228-1110f3c1be85" providerId="ADAL" clId="{5D13D192-A431-0440-A34B-CA198DD15CA1}" dt="2022-05-16T00:09:31.114" v="1993" actId="947"/>
          <ac:spMkLst>
            <pc:docMk/>
            <pc:sldMk cId="3756175224" sldId="284"/>
            <ac:spMk id="22" creationId="{C251204B-5D72-474F-86EF-09A696BEFB75}"/>
          </ac:spMkLst>
        </pc:spChg>
        <pc:spChg chg="mod">
          <ac:chgData name="Wencai Zhang" userId="4a86a1d0-2108-4707-8228-1110f3c1be85" providerId="ADAL" clId="{5D13D192-A431-0440-A34B-CA198DD15CA1}" dt="2022-05-16T00:06:09.977" v="1978" actId="6559"/>
          <ac:spMkLst>
            <pc:docMk/>
            <pc:sldMk cId="3756175224" sldId="284"/>
            <ac:spMk id="25" creationId="{B92B14F2-E13B-BF40-B4C7-80144DBA03B5}"/>
          </ac:spMkLst>
        </pc:spChg>
        <pc:spChg chg="mod">
          <ac:chgData name="Wencai Zhang" userId="4a86a1d0-2108-4707-8228-1110f3c1be85" providerId="ADAL" clId="{5D13D192-A431-0440-A34B-CA198DD15CA1}" dt="2022-05-24T12:47:51.965" v="2076" actId="20577"/>
          <ac:spMkLst>
            <pc:docMk/>
            <pc:sldMk cId="3756175224" sldId="284"/>
            <ac:spMk id="31" creationId="{7F3D7F35-06B9-4943-84B9-6DF15AE47D97}"/>
          </ac:spMkLst>
        </pc:spChg>
        <pc:spChg chg="mod">
          <ac:chgData name="Wencai Zhang" userId="4a86a1d0-2108-4707-8228-1110f3c1be85" providerId="ADAL" clId="{5D13D192-A431-0440-A34B-CA198DD15CA1}" dt="2022-05-24T12:48:00.707" v="2078" actId="113"/>
          <ac:spMkLst>
            <pc:docMk/>
            <pc:sldMk cId="3756175224" sldId="284"/>
            <ac:spMk id="35" creationId="{B533D00D-0568-104C-A03C-30A15EA72F6E}"/>
          </ac:spMkLst>
        </pc:spChg>
        <pc:spChg chg="add mod">
          <ac:chgData name="Wencai Zhang" userId="4a86a1d0-2108-4707-8228-1110f3c1be85" providerId="ADAL" clId="{5D13D192-A431-0440-A34B-CA198DD15CA1}" dt="2022-05-15T23:56:35.941" v="1966"/>
          <ac:spMkLst>
            <pc:docMk/>
            <pc:sldMk cId="3756175224" sldId="284"/>
            <ac:spMk id="45" creationId="{E6458144-0FA7-0F7B-EFF6-1134687516B6}"/>
          </ac:spMkLst>
        </pc:spChg>
        <pc:grpChg chg="mod">
          <ac:chgData name="Wencai Zhang" userId="4a86a1d0-2108-4707-8228-1110f3c1be85" providerId="ADAL" clId="{5D13D192-A431-0440-A34B-CA198DD15CA1}" dt="2022-04-30T09:13:20.875" v="1026" actId="1035"/>
          <ac:grpSpMkLst>
            <pc:docMk/>
            <pc:sldMk cId="3756175224" sldId="284"/>
            <ac:grpSpMk id="34" creationId="{4C2A78FB-6C8A-C941-A132-B65C2914441B}"/>
          </ac:grpSpMkLst>
        </pc:grpChg>
        <pc:grpChg chg="add del mod">
          <ac:chgData name="Wencai Zhang" userId="4a86a1d0-2108-4707-8228-1110f3c1be85" providerId="ADAL" clId="{5D13D192-A431-0440-A34B-CA198DD15CA1}" dt="2022-05-16T00:10:56.987" v="1997" actId="1076"/>
          <ac:grpSpMkLst>
            <pc:docMk/>
            <pc:sldMk cId="3756175224" sldId="284"/>
            <ac:grpSpMk id="36" creationId="{285AC0BC-FF77-6872-942F-B0185A00644F}"/>
          </ac:grpSpMkLst>
        </pc:grpChg>
        <pc:cxnChg chg="mod">
          <ac:chgData name="Wencai Zhang" userId="4a86a1d0-2108-4707-8228-1110f3c1be85" providerId="ADAL" clId="{5D13D192-A431-0440-A34B-CA198DD15CA1}" dt="2022-05-15T23:54:27.073" v="1961"/>
          <ac:cxnSpMkLst>
            <pc:docMk/>
            <pc:sldMk cId="3756175224" sldId="284"/>
            <ac:cxnSpMk id="37" creationId="{175BAEB3-C380-8718-B416-539406735D44}"/>
          </ac:cxnSpMkLst>
        </pc:cxnChg>
        <pc:cxnChg chg="mod">
          <ac:chgData name="Wencai Zhang" userId="4a86a1d0-2108-4707-8228-1110f3c1be85" providerId="ADAL" clId="{5D13D192-A431-0440-A34B-CA198DD15CA1}" dt="2022-05-15T23:54:27.073" v="1961"/>
          <ac:cxnSpMkLst>
            <pc:docMk/>
            <pc:sldMk cId="3756175224" sldId="284"/>
            <ac:cxnSpMk id="38" creationId="{A4180627-0D3B-5A7F-D3F8-B16C1DF15285}"/>
          </ac:cxnSpMkLst>
        </pc:cxnChg>
        <pc:cxnChg chg="mod">
          <ac:chgData name="Wencai Zhang" userId="4a86a1d0-2108-4707-8228-1110f3c1be85" providerId="ADAL" clId="{5D13D192-A431-0440-A34B-CA198DD15CA1}" dt="2022-05-15T23:54:27.073" v="1961"/>
          <ac:cxnSpMkLst>
            <pc:docMk/>
            <pc:sldMk cId="3756175224" sldId="284"/>
            <ac:cxnSpMk id="39" creationId="{64FD257C-F5A3-22B8-082B-6A43BF4555D8}"/>
          </ac:cxnSpMkLst>
        </pc:cxnChg>
        <pc:cxnChg chg="mod">
          <ac:chgData name="Wencai Zhang" userId="4a86a1d0-2108-4707-8228-1110f3c1be85" providerId="ADAL" clId="{5D13D192-A431-0440-A34B-CA198DD15CA1}" dt="2022-05-15T23:54:27.073" v="1961"/>
          <ac:cxnSpMkLst>
            <pc:docMk/>
            <pc:sldMk cId="3756175224" sldId="284"/>
            <ac:cxnSpMk id="40" creationId="{863ED12F-B6C2-CF44-CA7E-D4FE108CB803}"/>
          </ac:cxnSpMkLst>
        </pc:cxnChg>
        <pc:cxnChg chg="mod">
          <ac:chgData name="Wencai Zhang" userId="4a86a1d0-2108-4707-8228-1110f3c1be85" providerId="ADAL" clId="{5D13D192-A431-0440-A34B-CA198DD15CA1}" dt="2022-05-15T23:54:27.073" v="1961"/>
          <ac:cxnSpMkLst>
            <pc:docMk/>
            <pc:sldMk cId="3756175224" sldId="284"/>
            <ac:cxnSpMk id="41" creationId="{5A3905E3-0FF1-6788-8669-5E479228A8F5}"/>
          </ac:cxnSpMkLst>
        </pc:cxnChg>
        <pc:cxnChg chg="mod">
          <ac:chgData name="Wencai Zhang" userId="4a86a1d0-2108-4707-8228-1110f3c1be85" providerId="ADAL" clId="{5D13D192-A431-0440-A34B-CA198DD15CA1}" dt="2022-05-15T23:54:27.073" v="1961"/>
          <ac:cxnSpMkLst>
            <pc:docMk/>
            <pc:sldMk cId="3756175224" sldId="284"/>
            <ac:cxnSpMk id="42" creationId="{E55500E2-50F5-B169-B2A7-9F1F4502979C}"/>
          </ac:cxnSpMkLst>
        </pc:cxnChg>
        <pc:cxnChg chg="mod">
          <ac:chgData name="Wencai Zhang" userId="4a86a1d0-2108-4707-8228-1110f3c1be85" providerId="ADAL" clId="{5D13D192-A431-0440-A34B-CA198DD15CA1}" dt="2022-05-15T23:54:27.073" v="1961"/>
          <ac:cxnSpMkLst>
            <pc:docMk/>
            <pc:sldMk cId="3756175224" sldId="284"/>
            <ac:cxnSpMk id="43" creationId="{3544F241-CEDE-9CA3-F608-69B812B34D12}"/>
          </ac:cxnSpMkLst>
        </pc:cxnChg>
        <pc:cxnChg chg="mod">
          <ac:chgData name="Wencai Zhang" userId="4a86a1d0-2108-4707-8228-1110f3c1be85" providerId="ADAL" clId="{5D13D192-A431-0440-A34B-CA198DD15CA1}" dt="2022-05-15T23:54:27.073" v="1961"/>
          <ac:cxnSpMkLst>
            <pc:docMk/>
            <pc:sldMk cId="3756175224" sldId="284"/>
            <ac:cxnSpMk id="44" creationId="{710DB877-E421-EE98-9AE9-3C1131121ADC}"/>
          </ac:cxnSpMkLst>
        </pc:cxnChg>
      </pc:sldChg>
      <pc:sldChg chg="delSp modSp mod">
        <pc:chgData name="Wencai Zhang" userId="4a86a1d0-2108-4707-8228-1110f3c1be85" providerId="ADAL" clId="{5D13D192-A431-0440-A34B-CA198DD15CA1}" dt="2022-05-24T12:49:23.652" v="2089" actId="1076"/>
        <pc:sldMkLst>
          <pc:docMk/>
          <pc:sldMk cId="3813348304" sldId="285"/>
        </pc:sldMkLst>
        <pc:spChg chg="mod">
          <ac:chgData name="Wencai Zhang" userId="4a86a1d0-2108-4707-8228-1110f3c1be85" providerId="ADAL" clId="{5D13D192-A431-0440-A34B-CA198DD15CA1}" dt="2022-05-24T12:48:56.600" v="2087" actId="1076"/>
          <ac:spMkLst>
            <pc:docMk/>
            <pc:sldMk cId="3813348304" sldId="285"/>
            <ac:spMk id="5" creationId="{3DDAAADC-4070-A747-8C1A-EEAE7CFF713C}"/>
          </ac:spMkLst>
        </pc:spChg>
        <pc:spChg chg="del">
          <ac:chgData name="Wencai Zhang" userId="4a86a1d0-2108-4707-8228-1110f3c1be85" providerId="ADAL" clId="{5D13D192-A431-0440-A34B-CA198DD15CA1}" dt="2022-04-30T01:06:28.043" v="893" actId="478"/>
          <ac:spMkLst>
            <pc:docMk/>
            <pc:sldMk cId="3813348304" sldId="285"/>
            <ac:spMk id="6" creationId="{1C695B3C-3E32-3F49-9033-3C5810C8B422}"/>
          </ac:spMkLst>
        </pc:spChg>
        <pc:spChg chg="mod">
          <ac:chgData name="Wencai Zhang" userId="4a86a1d0-2108-4707-8228-1110f3c1be85" providerId="ADAL" clId="{5D13D192-A431-0440-A34B-CA198DD15CA1}" dt="2022-04-30T01:06:17.596" v="891" actId="1076"/>
          <ac:spMkLst>
            <pc:docMk/>
            <pc:sldMk cId="3813348304" sldId="285"/>
            <ac:spMk id="9" creationId="{60CBE95C-044B-F148-A4DC-2843A1E3E272}"/>
          </ac:spMkLst>
        </pc:spChg>
        <pc:spChg chg="mod">
          <ac:chgData name="Wencai Zhang" userId="4a86a1d0-2108-4707-8228-1110f3c1be85" providerId="ADAL" clId="{5D13D192-A431-0440-A34B-CA198DD15CA1}" dt="2022-05-24T12:49:23.652" v="2089" actId="1076"/>
          <ac:spMkLst>
            <pc:docMk/>
            <pc:sldMk cId="3813348304" sldId="285"/>
            <ac:spMk id="10" creationId="{8BDD8655-50B0-6B4A-9822-B72CC7B84BD0}"/>
          </ac:spMkLst>
        </pc:spChg>
        <pc:picChg chg="mod">
          <ac:chgData name="Wencai Zhang" userId="4a86a1d0-2108-4707-8228-1110f3c1be85" providerId="ADAL" clId="{5D13D192-A431-0440-A34B-CA198DD15CA1}" dt="2022-04-30T01:06:17.596" v="891" actId="1076"/>
          <ac:picMkLst>
            <pc:docMk/>
            <pc:sldMk cId="3813348304" sldId="285"/>
            <ac:picMk id="8" creationId="{5F2F550F-763A-3C43-BF25-4B903D048A45}"/>
          </ac:picMkLst>
        </pc:picChg>
      </pc:sldChg>
      <pc:sldChg chg="addSp delSp modSp mod">
        <pc:chgData name="Wencai Zhang" userId="4a86a1d0-2108-4707-8228-1110f3c1be85" providerId="ADAL" clId="{5D13D192-A431-0440-A34B-CA198DD15CA1}" dt="2022-05-24T12:50:24.917" v="2098" actId="1076"/>
        <pc:sldMkLst>
          <pc:docMk/>
          <pc:sldMk cId="3541618713" sldId="666"/>
        </pc:sldMkLst>
        <pc:spChg chg="mod">
          <ac:chgData name="Wencai Zhang" userId="4a86a1d0-2108-4707-8228-1110f3c1be85" providerId="ADAL" clId="{5D13D192-A431-0440-A34B-CA198DD15CA1}" dt="2022-05-24T12:50:24.917" v="2098" actId="1076"/>
          <ac:spMkLst>
            <pc:docMk/>
            <pc:sldMk cId="3541618713" sldId="666"/>
            <ac:spMk id="2" creationId="{9C268384-A989-0C40-9716-C30417941384}"/>
          </ac:spMkLst>
        </pc:spChg>
        <pc:spChg chg="add mod">
          <ac:chgData name="Wencai Zhang" userId="4a86a1d0-2108-4707-8228-1110f3c1be85" providerId="ADAL" clId="{5D13D192-A431-0440-A34B-CA198DD15CA1}" dt="2022-05-01T23:59:32.473" v="1366" actId="1076"/>
          <ac:spMkLst>
            <pc:docMk/>
            <pc:sldMk cId="3541618713" sldId="666"/>
            <ac:spMk id="10" creationId="{764FC35E-E199-8E40-AD2F-6B50B5821997}"/>
          </ac:spMkLst>
        </pc:spChg>
        <pc:spChg chg="mod">
          <ac:chgData name="Wencai Zhang" userId="4a86a1d0-2108-4707-8228-1110f3c1be85" providerId="ADAL" clId="{5D13D192-A431-0440-A34B-CA198DD15CA1}" dt="2022-05-02T00:02:50.777" v="1532" actId="1038"/>
          <ac:spMkLst>
            <pc:docMk/>
            <pc:sldMk cId="3541618713" sldId="666"/>
            <ac:spMk id="20" creationId="{C165489E-2F32-ED48-8FCC-427E5C3E6028}"/>
          </ac:spMkLst>
        </pc:spChg>
        <pc:spChg chg="mod">
          <ac:chgData name="Wencai Zhang" userId="4a86a1d0-2108-4707-8228-1110f3c1be85" providerId="ADAL" clId="{5D13D192-A431-0440-A34B-CA198DD15CA1}" dt="2022-05-02T00:02:50.777" v="1532" actId="1038"/>
          <ac:spMkLst>
            <pc:docMk/>
            <pc:sldMk cId="3541618713" sldId="666"/>
            <ac:spMk id="21" creationId="{C89AF50C-CA3A-354A-9151-611E16E85C2A}"/>
          </ac:spMkLst>
        </pc:spChg>
        <pc:spChg chg="mod">
          <ac:chgData name="Wencai Zhang" userId="4a86a1d0-2108-4707-8228-1110f3c1be85" providerId="ADAL" clId="{5D13D192-A431-0440-A34B-CA198DD15CA1}" dt="2022-05-24T12:50:18.084" v="2097" actId="113"/>
          <ac:spMkLst>
            <pc:docMk/>
            <pc:sldMk cId="3541618713" sldId="666"/>
            <ac:spMk id="22" creationId="{ECE1F930-CF1A-EA40-A16A-F288F7FE60E6}"/>
          </ac:spMkLst>
        </pc:spChg>
        <pc:spChg chg="mod">
          <ac:chgData name="Wencai Zhang" userId="4a86a1d0-2108-4707-8228-1110f3c1be85" providerId="ADAL" clId="{5D13D192-A431-0440-A34B-CA198DD15CA1}" dt="2022-05-02T00:00:01.120" v="1375" actId="1076"/>
          <ac:spMkLst>
            <pc:docMk/>
            <pc:sldMk cId="3541618713" sldId="666"/>
            <ac:spMk id="82" creationId="{D9A20610-2CD0-B640-984E-313F07A102C1}"/>
          </ac:spMkLst>
        </pc:spChg>
        <pc:spChg chg="mod">
          <ac:chgData name="Wencai Zhang" userId="4a86a1d0-2108-4707-8228-1110f3c1be85" providerId="ADAL" clId="{5D13D192-A431-0440-A34B-CA198DD15CA1}" dt="2022-05-02T00:00:01.120" v="1375" actId="1076"/>
          <ac:spMkLst>
            <pc:docMk/>
            <pc:sldMk cId="3541618713" sldId="666"/>
            <ac:spMk id="83" creationId="{BF60F3B4-E808-034F-B708-F3917C9F301B}"/>
          </ac:spMkLst>
        </pc:spChg>
        <pc:spChg chg="mod">
          <ac:chgData name="Wencai Zhang" userId="4a86a1d0-2108-4707-8228-1110f3c1be85" providerId="ADAL" clId="{5D13D192-A431-0440-A34B-CA198DD15CA1}" dt="2022-04-30T00:52:20.190" v="422" actId="164"/>
          <ac:spMkLst>
            <pc:docMk/>
            <pc:sldMk cId="3541618713" sldId="666"/>
            <ac:spMk id="100" creationId="{D4CE4864-7668-F04F-A007-80B0C5DBF0F2}"/>
          </ac:spMkLst>
        </pc:spChg>
        <pc:spChg chg="mod">
          <ac:chgData name="Wencai Zhang" userId="4a86a1d0-2108-4707-8228-1110f3c1be85" providerId="ADAL" clId="{5D13D192-A431-0440-A34B-CA198DD15CA1}" dt="2022-04-30T00:52:20.190" v="422" actId="164"/>
          <ac:spMkLst>
            <pc:docMk/>
            <pc:sldMk cId="3541618713" sldId="666"/>
            <ac:spMk id="102" creationId="{B6E40456-C95D-4547-A7E3-D618DE8B22A3}"/>
          </ac:spMkLst>
        </pc:spChg>
        <pc:spChg chg="mod">
          <ac:chgData name="Wencai Zhang" userId="4a86a1d0-2108-4707-8228-1110f3c1be85" providerId="ADAL" clId="{5D13D192-A431-0440-A34B-CA198DD15CA1}" dt="2022-05-02T00:02:50.777" v="1532" actId="1038"/>
          <ac:spMkLst>
            <pc:docMk/>
            <pc:sldMk cId="3541618713" sldId="666"/>
            <ac:spMk id="106" creationId="{A94F31BB-3C2E-3C4D-AC10-EE80FE91348B}"/>
          </ac:spMkLst>
        </pc:spChg>
        <pc:spChg chg="mod">
          <ac:chgData name="Wencai Zhang" userId="4a86a1d0-2108-4707-8228-1110f3c1be85" providerId="ADAL" clId="{5D13D192-A431-0440-A34B-CA198DD15CA1}" dt="2022-04-30T00:52:20.190" v="422" actId="164"/>
          <ac:spMkLst>
            <pc:docMk/>
            <pc:sldMk cId="3541618713" sldId="666"/>
            <ac:spMk id="107" creationId="{189A6441-C87F-5B46-85EA-34FA36AF763B}"/>
          </ac:spMkLst>
        </pc:spChg>
        <pc:spChg chg="mod">
          <ac:chgData name="Wencai Zhang" userId="4a86a1d0-2108-4707-8228-1110f3c1be85" providerId="ADAL" clId="{5D13D192-A431-0440-A34B-CA198DD15CA1}" dt="2022-04-30T00:39:40.589" v="32"/>
          <ac:spMkLst>
            <pc:docMk/>
            <pc:sldMk cId="3541618713" sldId="666"/>
            <ac:spMk id="146" creationId="{BD8E6B27-6C58-2049-8CA2-5B08EC6486A3}"/>
          </ac:spMkLst>
        </pc:spChg>
        <pc:spChg chg="mod">
          <ac:chgData name="Wencai Zhang" userId="4a86a1d0-2108-4707-8228-1110f3c1be85" providerId="ADAL" clId="{5D13D192-A431-0440-A34B-CA198DD15CA1}" dt="2022-04-30T00:39:40.589" v="32"/>
          <ac:spMkLst>
            <pc:docMk/>
            <pc:sldMk cId="3541618713" sldId="666"/>
            <ac:spMk id="147" creationId="{1E83784B-8362-6545-A9C2-46791AD346E0}"/>
          </ac:spMkLst>
        </pc:spChg>
        <pc:spChg chg="mod">
          <ac:chgData name="Wencai Zhang" userId="4a86a1d0-2108-4707-8228-1110f3c1be85" providerId="ADAL" clId="{5D13D192-A431-0440-A34B-CA198DD15CA1}" dt="2022-04-30T00:39:40.589" v="32"/>
          <ac:spMkLst>
            <pc:docMk/>
            <pc:sldMk cId="3541618713" sldId="666"/>
            <ac:spMk id="148" creationId="{30904CC7-5C25-7C45-A50F-073B6F4C7D95}"/>
          </ac:spMkLst>
        </pc:spChg>
        <pc:spChg chg="mod">
          <ac:chgData name="Wencai Zhang" userId="4a86a1d0-2108-4707-8228-1110f3c1be85" providerId="ADAL" clId="{5D13D192-A431-0440-A34B-CA198DD15CA1}" dt="2022-04-30T00:39:40.589" v="32"/>
          <ac:spMkLst>
            <pc:docMk/>
            <pc:sldMk cId="3541618713" sldId="666"/>
            <ac:spMk id="150" creationId="{0BE29D01-2BC3-0543-81FC-517F7E539C66}"/>
          </ac:spMkLst>
        </pc:spChg>
        <pc:spChg chg="mod">
          <ac:chgData name="Wencai Zhang" userId="4a86a1d0-2108-4707-8228-1110f3c1be85" providerId="ADAL" clId="{5D13D192-A431-0440-A34B-CA198DD15CA1}" dt="2022-04-30T00:39:40.589" v="32"/>
          <ac:spMkLst>
            <pc:docMk/>
            <pc:sldMk cId="3541618713" sldId="666"/>
            <ac:spMk id="151" creationId="{8D5EB31C-E4B5-4E4B-929F-C94D89524F3D}"/>
          </ac:spMkLst>
        </pc:spChg>
        <pc:spChg chg="mod">
          <ac:chgData name="Wencai Zhang" userId="4a86a1d0-2108-4707-8228-1110f3c1be85" providerId="ADAL" clId="{5D13D192-A431-0440-A34B-CA198DD15CA1}" dt="2022-04-30T00:39:40.589" v="32"/>
          <ac:spMkLst>
            <pc:docMk/>
            <pc:sldMk cId="3541618713" sldId="666"/>
            <ac:spMk id="152" creationId="{19B5AC5F-E4A4-B74A-9D83-C71CBBC914C6}"/>
          </ac:spMkLst>
        </pc:spChg>
        <pc:spChg chg="mod">
          <ac:chgData name="Wencai Zhang" userId="4a86a1d0-2108-4707-8228-1110f3c1be85" providerId="ADAL" clId="{5D13D192-A431-0440-A34B-CA198DD15CA1}" dt="2022-04-30T00:39:40.589" v="32"/>
          <ac:spMkLst>
            <pc:docMk/>
            <pc:sldMk cId="3541618713" sldId="666"/>
            <ac:spMk id="153" creationId="{31DA7DA0-7F3B-7F48-840D-2D00D230978A}"/>
          </ac:spMkLst>
        </pc:spChg>
        <pc:spChg chg="add mod">
          <ac:chgData name="Wencai Zhang" userId="4a86a1d0-2108-4707-8228-1110f3c1be85" providerId="ADAL" clId="{5D13D192-A431-0440-A34B-CA198DD15CA1}" dt="2022-05-02T00:02:50.777" v="1532" actId="1038"/>
          <ac:spMkLst>
            <pc:docMk/>
            <pc:sldMk cId="3541618713" sldId="666"/>
            <ac:spMk id="156" creationId="{7021BEBC-86A0-A944-8123-AF0E26DA465B}"/>
          </ac:spMkLst>
        </pc:spChg>
        <pc:spChg chg="mod">
          <ac:chgData name="Wencai Zhang" userId="4a86a1d0-2108-4707-8228-1110f3c1be85" providerId="ADAL" clId="{5D13D192-A431-0440-A34B-CA198DD15CA1}" dt="2022-04-30T00:47:27.638" v="44"/>
          <ac:spMkLst>
            <pc:docMk/>
            <pc:sldMk cId="3541618713" sldId="666"/>
            <ac:spMk id="158" creationId="{BFDAFBAA-DCA2-4B49-9E07-B154A8B3C6CF}"/>
          </ac:spMkLst>
        </pc:spChg>
        <pc:spChg chg="mod">
          <ac:chgData name="Wencai Zhang" userId="4a86a1d0-2108-4707-8228-1110f3c1be85" providerId="ADAL" clId="{5D13D192-A431-0440-A34B-CA198DD15CA1}" dt="2022-04-30T01:00:40.875" v="807" actId="1036"/>
          <ac:spMkLst>
            <pc:docMk/>
            <pc:sldMk cId="3541618713" sldId="666"/>
            <ac:spMk id="159" creationId="{C72B4B3E-1AA7-4C46-9E99-14EC69B3216A}"/>
          </ac:spMkLst>
        </pc:spChg>
        <pc:spChg chg="mod">
          <ac:chgData name="Wencai Zhang" userId="4a86a1d0-2108-4707-8228-1110f3c1be85" providerId="ADAL" clId="{5D13D192-A431-0440-A34B-CA198DD15CA1}" dt="2022-04-30T00:47:27.638" v="44"/>
          <ac:spMkLst>
            <pc:docMk/>
            <pc:sldMk cId="3541618713" sldId="666"/>
            <ac:spMk id="160" creationId="{7328677E-19C4-E547-8A8B-8DC9E7D90708}"/>
          </ac:spMkLst>
        </pc:spChg>
        <pc:spChg chg="mod">
          <ac:chgData name="Wencai Zhang" userId="4a86a1d0-2108-4707-8228-1110f3c1be85" providerId="ADAL" clId="{5D13D192-A431-0440-A34B-CA198DD15CA1}" dt="2022-04-30T00:47:27.638" v="44"/>
          <ac:spMkLst>
            <pc:docMk/>
            <pc:sldMk cId="3541618713" sldId="666"/>
            <ac:spMk id="161" creationId="{D0DFDFF3-96E2-C64F-AFC6-19336638387B}"/>
          </ac:spMkLst>
        </pc:spChg>
        <pc:spChg chg="add mod">
          <ac:chgData name="Wencai Zhang" userId="4a86a1d0-2108-4707-8228-1110f3c1be85" providerId="ADAL" clId="{5D13D192-A431-0440-A34B-CA198DD15CA1}" dt="2022-05-01T23:59:49.088" v="1374" actId="1037"/>
          <ac:spMkLst>
            <pc:docMk/>
            <pc:sldMk cId="3541618713" sldId="666"/>
            <ac:spMk id="162" creationId="{57C97C19-A020-D546-8AC7-BFA81726CFAC}"/>
          </ac:spMkLst>
        </pc:spChg>
        <pc:spChg chg="del mod topLvl">
          <ac:chgData name="Wencai Zhang" userId="4a86a1d0-2108-4707-8228-1110f3c1be85" providerId="ADAL" clId="{5D13D192-A431-0440-A34B-CA198DD15CA1}" dt="2022-04-30T00:49:58.517" v="353" actId="478"/>
          <ac:spMkLst>
            <pc:docMk/>
            <pc:sldMk cId="3541618713" sldId="666"/>
            <ac:spMk id="163" creationId="{36CCDCB2-09D4-DB4D-8F7E-E42C8683F914}"/>
          </ac:spMkLst>
        </pc:spChg>
        <pc:spChg chg="mod">
          <ac:chgData name="Wencai Zhang" userId="4a86a1d0-2108-4707-8228-1110f3c1be85" providerId="ADAL" clId="{5D13D192-A431-0440-A34B-CA198DD15CA1}" dt="2022-04-30T00:50:24.067" v="394" actId="14100"/>
          <ac:spMkLst>
            <pc:docMk/>
            <pc:sldMk cId="3541618713" sldId="666"/>
            <ac:spMk id="165" creationId="{A6F24B1C-1A9E-7E4E-8E5C-F04E8CD75F90}"/>
          </ac:spMkLst>
        </pc:spChg>
        <pc:spChg chg="mod">
          <ac:chgData name="Wencai Zhang" userId="4a86a1d0-2108-4707-8228-1110f3c1be85" providerId="ADAL" clId="{5D13D192-A431-0440-A34B-CA198DD15CA1}" dt="2022-04-30T00:50:24.067" v="394" actId="14100"/>
          <ac:spMkLst>
            <pc:docMk/>
            <pc:sldMk cId="3541618713" sldId="666"/>
            <ac:spMk id="166" creationId="{88749DB7-47DA-0142-AF15-66EAF099D779}"/>
          </ac:spMkLst>
        </pc:spChg>
        <pc:spChg chg="mod">
          <ac:chgData name="Wencai Zhang" userId="4a86a1d0-2108-4707-8228-1110f3c1be85" providerId="ADAL" clId="{5D13D192-A431-0440-A34B-CA198DD15CA1}" dt="2022-04-30T00:50:24.067" v="394" actId="14100"/>
          <ac:spMkLst>
            <pc:docMk/>
            <pc:sldMk cId="3541618713" sldId="666"/>
            <ac:spMk id="167" creationId="{64E53190-6161-6D4A-990E-F4EE4A5D447C}"/>
          </ac:spMkLst>
        </pc:spChg>
        <pc:spChg chg="mod">
          <ac:chgData name="Wencai Zhang" userId="4a86a1d0-2108-4707-8228-1110f3c1be85" providerId="ADAL" clId="{5D13D192-A431-0440-A34B-CA198DD15CA1}" dt="2022-04-30T00:47:27.638" v="44"/>
          <ac:spMkLst>
            <pc:docMk/>
            <pc:sldMk cId="3541618713" sldId="666"/>
            <ac:spMk id="168" creationId="{CF253157-EF5C-E94C-8B1A-D5F5953CBA21}"/>
          </ac:spMkLst>
        </pc:spChg>
        <pc:spChg chg="del mod topLvl">
          <ac:chgData name="Wencai Zhang" userId="4a86a1d0-2108-4707-8228-1110f3c1be85" providerId="ADAL" clId="{5D13D192-A431-0440-A34B-CA198DD15CA1}" dt="2022-04-30T00:50:39.407" v="397" actId="478"/>
          <ac:spMkLst>
            <pc:docMk/>
            <pc:sldMk cId="3541618713" sldId="666"/>
            <ac:spMk id="170" creationId="{6DE88D85-0165-8249-8F49-F1B6952F9209}"/>
          </ac:spMkLst>
        </pc:spChg>
        <pc:spChg chg="mod">
          <ac:chgData name="Wencai Zhang" userId="4a86a1d0-2108-4707-8228-1110f3c1be85" providerId="ADAL" clId="{5D13D192-A431-0440-A34B-CA198DD15CA1}" dt="2022-04-30T00:50:35.785" v="396" actId="14100"/>
          <ac:spMkLst>
            <pc:docMk/>
            <pc:sldMk cId="3541618713" sldId="666"/>
            <ac:spMk id="172" creationId="{2E9CCD4A-70A7-E04D-88FA-76A7B3F8E6BC}"/>
          </ac:spMkLst>
        </pc:spChg>
        <pc:spChg chg="mod">
          <ac:chgData name="Wencai Zhang" userId="4a86a1d0-2108-4707-8228-1110f3c1be85" providerId="ADAL" clId="{5D13D192-A431-0440-A34B-CA198DD15CA1}" dt="2022-04-30T00:59:44.783" v="783" actId="1037"/>
          <ac:spMkLst>
            <pc:docMk/>
            <pc:sldMk cId="3541618713" sldId="666"/>
            <ac:spMk id="173" creationId="{6AB9A2E5-490A-134D-B90C-5F7811E6F886}"/>
          </ac:spMkLst>
        </pc:spChg>
        <pc:spChg chg="mod">
          <ac:chgData name="Wencai Zhang" userId="4a86a1d0-2108-4707-8228-1110f3c1be85" providerId="ADAL" clId="{5D13D192-A431-0440-A34B-CA198DD15CA1}" dt="2022-04-30T00:50:35.785" v="396" actId="14100"/>
          <ac:spMkLst>
            <pc:docMk/>
            <pc:sldMk cId="3541618713" sldId="666"/>
            <ac:spMk id="174" creationId="{45FF5396-3EF3-B54C-B356-91D1C14B1127}"/>
          </ac:spMkLst>
        </pc:spChg>
        <pc:spChg chg="mod">
          <ac:chgData name="Wencai Zhang" userId="4a86a1d0-2108-4707-8228-1110f3c1be85" providerId="ADAL" clId="{5D13D192-A431-0440-A34B-CA198DD15CA1}" dt="2022-04-30T00:47:27.638" v="44"/>
          <ac:spMkLst>
            <pc:docMk/>
            <pc:sldMk cId="3541618713" sldId="666"/>
            <ac:spMk id="175" creationId="{AA502880-F7A4-D041-8224-AF54C6DE7C5D}"/>
          </ac:spMkLst>
        </pc:spChg>
        <pc:spChg chg="add mod">
          <ac:chgData name="Wencai Zhang" userId="4a86a1d0-2108-4707-8228-1110f3c1be85" providerId="ADAL" clId="{5D13D192-A431-0440-A34B-CA198DD15CA1}" dt="2022-05-01T23:59:49.088" v="1374" actId="1037"/>
          <ac:spMkLst>
            <pc:docMk/>
            <pc:sldMk cId="3541618713" sldId="666"/>
            <ac:spMk id="176" creationId="{404D4F78-C706-194F-BCA2-B8C1CCE6DE5F}"/>
          </ac:spMkLst>
        </pc:spChg>
        <pc:spChg chg="del mod topLvl">
          <ac:chgData name="Wencai Zhang" userId="4a86a1d0-2108-4707-8228-1110f3c1be85" providerId="ADAL" clId="{5D13D192-A431-0440-A34B-CA198DD15CA1}" dt="2022-04-30T00:50:59.981" v="400" actId="478"/>
          <ac:spMkLst>
            <pc:docMk/>
            <pc:sldMk cId="3541618713" sldId="666"/>
            <ac:spMk id="177" creationId="{9FC548C2-48E6-944D-9D40-0E13B1F33F5A}"/>
          </ac:spMkLst>
        </pc:spChg>
        <pc:spChg chg="mod">
          <ac:chgData name="Wencai Zhang" userId="4a86a1d0-2108-4707-8228-1110f3c1be85" providerId="ADAL" clId="{5D13D192-A431-0440-A34B-CA198DD15CA1}" dt="2022-04-30T00:50:56.295" v="399" actId="14100"/>
          <ac:spMkLst>
            <pc:docMk/>
            <pc:sldMk cId="3541618713" sldId="666"/>
            <ac:spMk id="179" creationId="{A63819AE-B9E8-344E-BB7A-A92691CB92F6}"/>
          </ac:spMkLst>
        </pc:spChg>
        <pc:spChg chg="mod">
          <ac:chgData name="Wencai Zhang" userId="4a86a1d0-2108-4707-8228-1110f3c1be85" providerId="ADAL" clId="{5D13D192-A431-0440-A34B-CA198DD15CA1}" dt="2022-04-30T00:50:56.295" v="399" actId="14100"/>
          <ac:spMkLst>
            <pc:docMk/>
            <pc:sldMk cId="3541618713" sldId="666"/>
            <ac:spMk id="180" creationId="{22133E61-D20D-BA45-BC7B-9542F65DC58D}"/>
          </ac:spMkLst>
        </pc:spChg>
        <pc:spChg chg="mod">
          <ac:chgData name="Wencai Zhang" userId="4a86a1d0-2108-4707-8228-1110f3c1be85" providerId="ADAL" clId="{5D13D192-A431-0440-A34B-CA198DD15CA1}" dt="2022-04-30T00:50:56.295" v="399" actId="14100"/>
          <ac:spMkLst>
            <pc:docMk/>
            <pc:sldMk cId="3541618713" sldId="666"/>
            <ac:spMk id="181" creationId="{5A6A5E75-804B-3E4A-9A9E-071F0564D929}"/>
          </ac:spMkLst>
        </pc:spChg>
        <pc:spChg chg="mod">
          <ac:chgData name="Wencai Zhang" userId="4a86a1d0-2108-4707-8228-1110f3c1be85" providerId="ADAL" clId="{5D13D192-A431-0440-A34B-CA198DD15CA1}" dt="2022-04-30T00:47:27.638" v="44"/>
          <ac:spMkLst>
            <pc:docMk/>
            <pc:sldMk cId="3541618713" sldId="666"/>
            <ac:spMk id="182" creationId="{234AECA3-0406-5B47-914F-F069A65EE354}"/>
          </ac:spMkLst>
        </pc:spChg>
        <pc:spChg chg="mod">
          <ac:chgData name="Wencai Zhang" userId="4a86a1d0-2108-4707-8228-1110f3c1be85" providerId="ADAL" clId="{5D13D192-A431-0440-A34B-CA198DD15CA1}" dt="2022-04-30T00:52:22.239" v="423"/>
          <ac:spMkLst>
            <pc:docMk/>
            <pc:sldMk cId="3541618713" sldId="666"/>
            <ac:spMk id="184" creationId="{43D5FBA1-7D7E-9E43-9C71-01AC16947A8C}"/>
          </ac:spMkLst>
        </pc:spChg>
        <pc:spChg chg="mod">
          <ac:chgData name="Wencai Zhang" userId="4a86a1d0-2108-4707-8228-1110f3c1be85" providerId="ADAL" clId="{5D13D192-A431-0440-A34B-CA198DD15CA1}" dt="2022-04-30T00:52:22.239" v="423"/>
          <ac:spMkLst>
            <pc:docMk/>
            <pc:sldMk cId="3541618713" sldId="666"/>
            <ac:spMk id="185" creationId="{C3D873B6-153A-A540-8450-61F5F646D5E0}"/>
          </ac:spMkLst>
        </pc:spChg>
        <pc:spChg chg="mod">
          <ac:chgData name="Wencai Zhang" userId="4a86a1d0-2108-4707-8228-1110f3c1be85" providerId="ADAL" clId="{5D13D192-A431-0440-A34B-CA198DD15CA1}" dt="2022-04-30T00:52:22.239" v="423"/>
          <ac:spMkLst>
            <pc:docMk/>
            <pc:sldMk cId="3541618713" sldId="666"/>
            <ac:spMk id="186" creationId="{27678710-917A-FC4F-AEA8-ACC1EAEE6848}"/>
          </ac:spMkLst>
        </pc:spChg>
        <pc:spChg chg="add mod">
          <ac:chgData name="Wencai Zhang" userId="4a86a1d0-2108-4707-8228-1110f3c1be85" providerId="ADAL" clId="{5D13D192-A431-0440-A34B-CA198DD15CA1}" dt="2022-05-02T00:02:50.777" v="1532" actId="1038"/>
          <ac:spMkLst>
            <pc:docMk/>
            <pc:sldMk cId="3541618713" sldId="666"/>
            <ac:spMk id="187" creationId="{7733DC22-374A-DF47-A3C5-FF0185F47001}"/>
          </ac:spMkLst>
        </pc:spChg>
        <pc:spChg chg="mod">
          <ac:chgData name="Wencai Zhang" userId="4a86a1d0-2108-4707-8228-1110f3c1be85" providerId="ADAL" clId="{5D13D192-A431-0440-A34B-CA198DD15CA1}" dt="2022-05-01T23:59:01.310" v="1305"/>
          <ac:spMkLst>
            <pc:docMk/>
            <pc:sldMk cId="3541618713" sldId="666"/>
            <ac:spMk id="191" creationId="{20A42C1D-3994-1B44-BE6D-2EAC4574F09A}"/>
          </ac:spMkLst>
        </pc:spChg>
        <pc:spChg chg="mod">
          <ac:chgData name="Wencai Zhang" userId="4a86a1d0-2108-4707-8228-1110f3c1be85" providerId="ADAL" clId="{5D13D192-A431-0440-A34B-CA198DD15CA1}" dt="2022-05-01T23:59:01.310" v="1305"/>
          <ac:spMkLst>
            <pc:docMk/>
            <pc:sldMk cId="3541618713" sldId="666"/>
            <ac:spMk id="192" creationId="{E4925BB5-A957-7F4B-B154-FF846635FA37}"/>
          </ac:spMkLst>
        </pc:spChg>
        <pc:spChg chg="mod">
          <ac:chgData name="Wencai Zhang" userId="4a86a1d0-2108-4707-8228-1110f3c1be85" providerId="ADAL" clId="{5D13D192-A431-0440-A34B-CA198DD15CA1}" dt="2022-05-01T23:59:01.310" v="1305"/>
          <ac:spMkLst>
            <pc:docMk/>
            <pc:sldMk cId="3541618713" sldId="666"/>
            <ac:spMk id="193" creationId="{D877E70B-E80F-EA41-9410-B83DA7DD81BA}"/>
          </ac:spMkLst>
        </pc:spChg>
        <pc:spChg chg="mod">
          <ac:chgData name="Wencai Zhang" userId="4a86a1d0-2108-4707-8228-1110f3c1be85" providerId="ADAL" clId="{5D13D192-A431-0440-A34B-CA198DD15CA1}" dt="2022-05-01T23:59:01.310" v="1305"/>
          <ac:spMkLst>
            <pc:docMk/>
            <pc:sldMk cId="3541618713" sldId="666"/>
            <ac:spMk id="195" creationId="{F5FC6ACD-D234-E74D-AEAB-DEF3A909169D}"/>
          </ac:spMkLst>
        </pc:spChg>
        <pc:spChg chg="mod">
          <ac:chgData name="Wencai Zhang" userId="4a86a1d0-2108-4707-8228-1110f3c1be85" providerId="ADAL" clId="{5D13D192-A431-0440-A34B-CA198DD15CA1}" dt="2022-05-01T23:59:01.310" v="1305"/>
          <ac:spMkLst>
            <pc:docMk/>
            <pc:sldMk cId="3541618713" sldId="666"/>
            <ac:spMk id="196" creationId="{0CEFE3BC-ECE8-F645-A57E-78000D48DEB2}"/>
          </ac:spMkLst>
        </pc:spChg>
        <pc:spChg chg="mod">
          <ac:chgData name="Wencai Zhang" userId="4a86a1d0-2108-4707-8228-1110f3c1be85" providerId="ADAL" clId="{5D13D192-A431-0440-A34B-CA198DD15CA1}" dt="2022-05-01T23:59:01.310" v="1305"/>
          <ac:spMkLst>
            <pc:docMk/>
            <pc:sldMk cId="3541618713" sldId="666"/>
            <ac:spMk id="197" creationId="{AABF9FE9-07FA-3249-B1BD-14A5AE970AC8}"/>
          </ac:spMkLst>
        </pc:spChg>
        <pc:spChg chg="mod">
          <ac:chgData name="Wencai Zhang" userId="4a86a1d0-2108-4707-8228-1110f3c1be85" providerId="ADAL" clId="{5D13D192-A431-0440-A34B-CA198DD15CA1}" dt="2022-05-01T23:59:01.310" v="1305"/>
          <ac:spMkLst>
            <pc:docMk/>
            <pc:sldMk cId="3541618713" sldId="666"/>
            <ac:spMk id="198" creationId="{463C1C14-44D1-0742-920E-5C2D75D047A1}"/>
          </ac:spMkLst>
        </pc:spChg>
        <pc:spChg chg="mod">
          <ac:chgData name="Wencai Zhang" userId="4a86a1d0-2108-4707-8228-1110f3c1be85" providerId="ADAL" clId="{5D13D192-A431-0440-A34B-CA198DD15CA1}" dt="2022-05-01T23:59:01.310" v="1305"/>
          <ac:spMkLst>
            <pc:docMk/>
            <pc:sldMk cId="3541618713" sldId="666"/>
            <ac:spMk id="200" creationId="{C6742D58-B91F-E148-A227-4CAF7E204011}"/>
          </ac:spMkLst>
        </pc:spChg>
        <pc:spChg chg="mod">
          <ac:chgData name="Wencai Zhang" userId="4a86a1d0-2108-4707-8228-1110f3c1be85" providerId="ADAL" clId="{5D13D192-A431-0440-A34B-CA198DD15CA1}" dt="2022-05-01T23:59:01.310" v="1305"/>
          <ac:spMkLst>
            <pc:docMk/>
            <pc:sldMk cId="3541618713" sldId="666"/>
            <ac:spMk id="202" creationId="{CBCDC98A-1722-A740-A1BF-F9C2651D3F7C}"/>
          </ac:spMkLst>
        </pc:spChg>
        <pc:spChg chg="mod">
          <ac:chgData name="Wencai Zhang" userId="4a86a1d0-2108-4707-8228-1110f3c1be85" providerId="ADAL" clId="{5D13D192-A431-0440-A34B-CA198DD15CA1}" dt="2022-05-01T23:59:01.310" v="1305"/>
          <ac:spMkLst>
            <pc:docMk/>
            <pc:sldMk cId="3541618713" sldId="666"/>
            <ac:spMk id="203" creationId="{B9122239-0B15-BD43-A625-6DDC08C321A3}"/>
          </ac:spMkLst>
        </pc:spChg>
        <pc:spChg chg="mod">
          <ac:chgData name="Wencai Zhang" userId="4a86a1d0-2108-4707-8228-1110f3c1be85" providerId="ADAL" clId="{5D13D192-A431-0440-A34B-CA198DD15CA1}" dt="2022-05-01T23:59:01.310" v="1305"/>
          <ac:spMkLst>
            <pc:docMk/>
            <pc:sldMk cId="3541618713" sldId="666"/>
            <ac:spMk id="204" creationId="{A1446D6F-8CE2-9549-B906-D847BB6C3AB3}"/>
          </ac:spMkLst>
        </pc:spChg>
        <pc:spChg chg="mod">
          <ac:chgData name="Wencai Zhang" userId="4a86a1d0-2108-4707-8228-1110f3c1be85" providerId="ADAL" clId="{5D13D192-A431-0440-A34B-CA198DD15CA1}" dt="2022-05-01T23:59:01.310" v="1305"/>
          <ac:spMkLst>
            <pc:docMk/>
            <pc:sldMk cId="3541618713" sldId="666"/>
            <ac:spMk id="205" creationId="{9D30DBF4-385A-FD42-A340-EC51D3ED626B}"/>
          </ac:spMkLst>
        </pc:spChg>
        <pc:spChg chg="mod">
          <ac:chgData name="Wencai Zhang" userId="4a86a1d0-2108-4707-8228-1110f3c1be85" providerId="ADAL" clId="{5D13D192-A431-0440-A34B-CA198DD15CA1}" dt="2022-05-01T23:59:01.310" v="1305"/>
          <ac:spMkLst>
            <pc:docMk/>
            <pc:sldMk cId="3541618713" sldId="666"/>
            <ac:spMk id="207" creationId="{D347D8D1-A8E8-4F44-8C01-69BE314ACF5C}"/>
          </ac:spMkLst>
        </pc:spChg>
        <pc:spChg chg="mod">
          <ac:chgData name="Wencai Zhang" userId="4a86a1d0-2108-4707-8228-1110f3c1be85" providerId="ADAL" clId="{5D13D192-A431-0440-A34B-CA198DD15CA1}" dt="2022-05-01T23:59:01.310" v="1305"/>
          <ac:spMkLst>
            <pc:docMk/>
            <pc:sldMk cId="3541618713" sldId="666"/>
            <ac:spMk id="209" creationId="{F9FF26EE-4DEA-1842-B373-6AD47F198ED0}"/>
          </ac:spMkLst>
        </pc:spChg>
        <pc:spChg chg="mod">
          <ac:chgData name="Wencai Zhang" userId="4a86a1d0-2108-4707-8228-1110f3c1be85" providerId="ADAL" clId="{5D13D192-A431-0440-A34B-CA198DD15CA1}" dt="2022-05-01T23:59:01.310" v="1305"/>
          <ac:spMkLst>
            <pc:docMk/>
            <pc:sldMk cId="3541618713" sldId="666"/>
            <ac:spMk id="210" creationId="{975C5811-4B2D-C445-B17E-02BBC58BC02B}"/>
          </ac:spMkLst>
        </pc:spChg>
        <pc:spChg chg="mod">
          <ac:chgData name="Wencai Zhang" userId="4a86a1d0-2108-4707-8228-1110f3c1be85" providerId="ADAL" clId="{5D13D192-A431-0440-A34B-CA198DD15CA1}" dt="2022-05-01T23:59:01.310" v="1305"/>
          <ac:spMkLst>
            <pc:docMk/>
            <pc:sldMk cId="3541618713" sldId="666"/>
            <ac:spMk id="211" creationId="{DC005D3E-89AD-4841-BC98-CA5B549D75A6}"/>
          </ac:spMkLst>
        </pc:spChg>
        <pc:spChg chg="mod">
          <ac:chgData name="Wencai Zhang" userId="4a86a1d0-2108-4707-8228-1110f3c1be85" providerId="ADAL" clId="{5D13D192-A431-0440-A34B-CA198DD15CA1}" dt="2022-05-01T23:59:01.310" v="1305"/>
          <ac:spMkLst>
            <pc:docMk/>
            <pc:sldMk cId="3541618713" sldId="666"/>
            <ac:spMk id="212" creationId="{93456EB9-6974-FE41-BEBE-EF2CECF82994}"/>
          </ac:spMkLst>
        </pc:spChg>
        <pc:spChg chg="mod">
          <ac:chgData name="Wencai Zhang" userId="4a86a1d0-2108-4707-8228-1110f3c1be85" providerId="ADAL" clId="{5D13D192-A431-0440-A34B-CA198DD15CA1}" dt="2022-05-01T23:59:01.310" v="1305"/>
          <ac:spMkLst>
            <pc:docMk/>
            <pc:sldMk cId="3541618713" sldId="666"/>
            <ac:spMk id="214" creationId="{89379C53-B1B3-4F49-B2E1-83CE4F0B62A1}"/>
          </ac:spMkLst>
        </pc:spChg>
        <pc:spChg chg="mod">
          <ac:chgData name="Wencai Zhang" userId="4a86a1d0-2108-4707-8228-1110f3c1be85" providerId="ADAL" clId="{5D13D192-A431-0440-A34B-CA198DD15CA1}" dt="2022-05-01T23:59:01.310" v="1305"/>
          <ac:spMkLst>
            <pc:docMk/>
            <pc:sldMk cId="3541618713" sldId="666"/>
            <ac:spMk id="216" creationId="{BA4C2DB1-E275-0B42-925B-BF25A35AF477}"/>
          </ac:spMkLst>
        </pc:spChg>
        <pc:spChg chg="mod">
          <ac:chgData name="Wencai Zhang" userId="4a86a1d0-2108-4707-8228-1110f3c1be85" providerId="ADAL" clId="{5D13D192-A431-0440-A34B-CA198DD15CA1}" dt="2022-05-01T23:59:01.310" v="1305"/>
          <ac:spMkLst>
            <pc:docMk/>
            <pc:sldMk cId="3541618713" sldId="666"/>
            <ac:spMk id="217" creationId="{3323D5C9-AABB-C746-A38D-875398977DDA}"/>
          </ac:spMkLst>
        </pc:spChg>
        <pc:spChg chg="mod">
          <ac:chgData name="Wencai Zhang" userId="4a86a1d0-2108-4707-8228-1110f3c1be85" providerId="ADAL" clId="{5D13D192-A431-0440-A34B-CA198DD15CA1}" dt="2022-05-01T23:59:01.310" v="1305"/>
          <ac:spMkLst>
            <pc:docMk/>
            <pc:sldMk cId="3541618713" sldId="666"/>
            <ac:spMk id="218" creationId="{3B2AEA9D-8B50-894B-8E61-EFCBC838FBB9}"/>
          </ac:spMkLst>
        </pc:spChg>
        <pc:spChg chg="mod">
          <ac:chgData name="Wencai Zhang" userId="4a86a1d0-2108-4707-8228-1110f3c1be85" providerId="ADAL" clId="{5D13D192-A431-0440-A34B-CA198DD15CA1}" dt="2022-05-01T23:59:01.310" v="1305"/>
          <ac:spMkLst>
            <pc:docMk/>
            <pc:sldMk cId="3541618713" sldId="666"/>
            <ac:spMk id="219" creationId="{E3F33244-0707-B749-90A0-D914548C4584}"/>
          </ac:spMkLst>
        </pc:spChg>
        <pc:spChg chg="add mod">
          <ac:chgData name="Wencai Zhang" userId="4a86a1d0-2108-4707-8228-1110f3c1be85" providerId="ADAL" clId="{5D13D192-A431-0440-A34B-CA198DD15CA1}" dt="2022-05-02T00:00:23.620" v="1379" actId="1076"/>
          <ac:spMkLst>
            <pc:docMk/>
            <pc:sldMk cId="3541618713" sldId="666"/>
            <ac:spMk id="224" creationId="{C3207D5B-27A1-7843-8A6F-B764CDB01140}"/>
          </ac:spMkLst>
        </pc:spChg>
        <pc:spChg chg="add mod">
          <ac:chgData name="Wencai Zhang" userId="4a86a1d0-2108-4707-8228-1110f3c1be85" providerId="ADAL" clId="{5D13D192-A431-0440-A34B-CA198DD15CA1}" dt="2022-05-02T00:00:23.620" v="1379" actId="1076"/>
          <ac:spMkLst>
            <pc:docMk/>
            <pc:sldMk cId="3541618713" sldId="666"/>
            <ac:spMk id="232" creationId="{6C77EEB5-3073-A846-B3DA-7C840601B1D3}"/>
          </ac:spMkLst>
        </pc:spChg>
        <pc:spChg chg="mod">
          <ac:chgData name="Wencai Zhang" userId="4a86a1d0-2108-4707-8228-1110f3c1be85" providerId="ADAL" clId="{5D13D192-A431-0440-A34B-CA198DD15CA1}" dt="2022-05-02T00:00:20.320" v="1378"/>
          <ac:spMkLst>
            <pc:docMk/>
            <pc:sldMk cId="3541618713" sldId="666"/>
            <ac:spMk id="234" creationId="{9413CA60-249B-B346-AAE5-64D4B58E44CE}"/>
          </ac:spMkLst>
        </pc:spChg>
        <pc:spChg chg="mod">
          <ac:chgData name="Wencai Zhang" userId="4a86a1d0-2108-4707-8228-1110f3c1be85" providerId="ADAL" clId="{5D13D192-A431-0440-A34B-CA198DD15CA1}" dt="2022-05-02T00:00:20.320" v="1378"/>
          <ac:spMkLst>
            <pc:docMk/>
            <pc:sldMk cId="3541618713" sldId="666"/>
            <ac:spMk id="235" creationId="{9CD7E394-66F2-DF47-B45C-19634E27AEB2}"/>
          </ac:spMkLst>
        </pc:spChg>
        <pc:spChg chg="mod">
          <ac:chgData name="Wencai Zhang" userId="4a86a1d0-2108-4707-8228-1110f3c1be85" providerId="ADAL" clId="{5D13D192-A431-0440-A34B-CA198DD15CA1}" dt="2022-05-02T00:00:20.320" v="1378"/>
          <ac:spMkLst>
            <pc:docMk/>
            <pc:sldMk cId="3541618713" sldId="666"/>
            <ac:spMk id="236" creationId="{A73BBEE3-7639-544A-ADD9-6BACA4F21D4D}"/>
          </ac:spMkLst>
        </pc:spChg>
        <pc:spChg chg="mod">
          <ac:chgData name="Wencai Zhang" userId="4a86a1d0-2108-4707-8228-1110f3c1be85" providerId="ADAL" clId="{5D13D192-A431-0440-A34B-CA198DD15CA1}" dt="2022-05-02T00:00:20.320" v="1378"/>
          <ac:spMkLst>
            <pc:docMk/>
            <pc:sldMk cId="3541618713" sldId="666"/>
            <ac:spMk id="237" creationId="{E24FA925-3AD4-FC40-8AE2-246BACB21DB8}"/>
          </ac:spMkLst>
        </pc:spChg>
        <pc:spChg chg="mod">
          <ac:chgData name="Wencai Zhang" userId="4a86a1d0-2108-4707-8228-1110f3c1be85" providerId="ADAL" clId="{5D13D192-A431-0440-A34B-CA198DD15CA1}" dt="2022-05-02T00:00:20.320" v="1378"/>
          <ac:spMkLst>
            <pc:docMk/>
            <pc:sldMk cId="3541618713" sldId="666"/>
            <ac:spMk id="239" creationId="{F79EE0A1-A550-714E-9430-B0F397DF10E9}"/>
          </ac:spMkLst>
        </pc:spChg>
        <pc:spChg chg="mod">
          <ac:chgData name="Wencai Zhang" userId="4a86a1d0-2108-4707-8228-1110f3c1be85" providerId="ADAL" clId="{5D13D192-A431-0440-A34B-CA198DD15CA1}" dt="2022-05-02T00:00:20.320" v="1378"/>
          <ac:spMkLst>
            <pc:docMk/>
            <pc:sldMk cId="3541618713" sldId="666"/>
            <ac:spMk id="240" creationId="{AA83883F-7830-E540-BFD1-7DF4E528CF96}"/>
          </ac:spMkLst>
        </pc:spChg>
        <pc:spChg chg="mod">
          <ac:chgData name="Wencai Zhang" userId="4a86a1d0-2108-4707-8228-1110f3c1be85" providerId="ADAL" clId="{5D13D192-A431-0440-A34B-CA198DD15CA1}" dt="2022-05-02T00:00:20.320" v="1378"/>
          <ac:spMkLst>
            <pc:docMk/>
            <pc:sldMk cId="3541618713" sldId="666"/>
            <ac:spMk id="241" creationId="{2ABF772D-AD4D-8049-AA4F-029DDEDDF94A}"/>
          </ac:spMkLst>
        </pc:spChg>
        <pc:spChg chg="mod">
          <ac:chgData name="Wencai Zhang" userId="4a86a1d0-2108-4707-8228-1110f3c1be85" providerId="ADAL" clId="{5D13D192-A431-0440-A34B-CA198DD15CA1}" dt="2022-05-02T00:00:20.320" v="1378"/>
          <ac:spMkLst>
            <pc:docMk/>
            <pc:sldMk cId="3541618713" sldId="666"/>
            <ac:spMk id="242" creationId="{4AA4B047-37A5-5746-B6EC-994917B9E367}"/>
          </ac:spMkLst>
        </pc:spChg>
        <pc:spChg chg="mod">
          <ac:chgData name="Wencai Zhang" userId="4a86a1d0-2108-4707-8228-1110f3c1be85" providerId="ADAL" clId="{5D13D192-A431-0440-A34B-CA198DD15CA1}" dt="2022-05-02T00:00:20.320" v="1378"/>
          <ac:spMkLst>
            <pc:docMk/>
            <pc:sldMk cId="3541618713" sldId="666"/>
            <ac:spMk id="244" creationId="{3ECF7A18-FE95-0F45-908F-2A6CCFA4906C}"/>
          </ac:spMkLst>
        </pc:spChg>
        <pc:spChg chg="mod">
          <ac:chgData name="Wencai Zhang" userId="4a86a1d0-2108-4707-8228-1110f3c1be85" providerId="ADAL" clId="{5D13D192-A431-0440-A34B-CA198DD15CA1}" dt="2022-05-02T00:00:20.320" v="1378"/>
          <ac:spMkLst>
            <pc:docMk/>
            <pc:sldMk cId="3541618713" sldId="666"/>
            <ac:spMk id="245" creationId="{CFC01F71-528C-6F45-B1DA-4ACA9A40C60F}"/>
          </ac:spMkLst>
        </pc:spChg>
        <pc:spChg chg="mod">
          <ac:chgData name="Wencai Zhang" userId="4a86a1d0-2108-4707-8228-1110f3c1be85" providerId="ADAL" clId="{5D13D192-A431-0440-A34B-CA198DD15CA1}" dt="2022-05-02T00:00:20.320" v="1378"/>
          <ac:spMkLst>
            <pc:docMk/>
            <pc:sldMk cId="3541618713" sldId="666"/>
            <ac:spMk id="246" creationId="{0540471C-A23E-9F45-B2EB-7B9FC11DEFC2}"/>
          </ac:spMkLst>
        </pc:spChg>
        <pc:spChg chg="mod">
          <ac:chgData name="Wencai Zhang" userId="4a86a1d0-2108-4707-8228-1110f3c1be85" providerId="ADAL" clId="{5D13D192-A431-0440-A34B-CA198DD15CA1}" dt="2022-05-02T00:00:20.320" v="1378"/>
          <ac:spMkLst>
            <pc:docMk/>
            <pc:sldMk cId="3541618713" sldId="666"/>
            <ac:spMk id="247" creationId="{42DAEAF1-FF32-3B4A-989D-E9EC443B27C6}"/>
          </ac:spMkLst>
        </pc:spChg>
        <pc:spChg chg="mod">
          <ac:chgData name="Wencai Zhang" userId="4a86a1d0-2108-4707-8228-1110f3c1be85" providerId="ADAL" clId="{5D13D192-A431-0440-A34B-CA198DD15CA1}" dt="2022-05-02T00:00:20.320" v="1378"/>
          <ac:spMkLst>
            <pc:docMk/>
            <pc:sldMk cId="3541618713" sldId="666"/>
            <ac:spMk id="249" creationId="{53C3B540-FF71-764A-BA44-6CA0CDAFB47A}"/>
          </ac:spMkLst>
        </pc:spChg>
        <pc:spChg chg="mod">
          <ac:chgData name="Wencai Zhang" userId="4a86a1d0-2108-4707-8228-1110f3c1be85" providerId="ADAL" clId="{5D13D192-A431-0440-A34B-CA198DD15CA1}" dt="2022-05-02T00:00:20.320" v="1378"/>
          <ac:spMkLst>
            <pc:docMk/>
            <pc:sldMk cId="3541618713" sldId="666"/>
            <ac:spMk id="250" creationId="{A3E15802-DA87-1542-924B-C814F4EF209E}"/>
          </ac:spMkLst>
        </pc:spChg>
        <pc:spChg chg="mod">
          <ac:chgData name="Wencai Zhang" userId="4a86a1d0-2108-4707-8228-1110f3c1be85" providerId="ADAL" clId="{5D13D192-A431-0440-A34B-CA198DD15CA1}" dt="2022-05-02T00:00:20.320" v="1378"/>
          <ac:spMkLst>
            <pc:docMk/>
            <pc:sldMk cId="3541618713" sldId="666"/>
            <ac:spMk id="251" creationId="{421AFF84-A429-FB43-BDB2-9C256DA1EB26}"/>
          </ac:spMkLst>
        </pc:spChg>
        <pc:spChg chg="mod">
          <ac:chgData name="Wencai Zhang" userId="4a86a1d0-2108-4707-8228-1110f3c1be85" providerId="ADAL" clId="{5D13D192-A431-0440-A34B-CA198DD15CA1}" dt="2022-05-02T00:00:20.320" v="1378"/>
          <ac:spMkLst>
            <pc:docMk/>
            <pc:sldMk cId="3541618713" sldId="666"/>
            <ac:spMk id="252" creationId="{8F28A21B-DB30-4B4F-B6C4-8284AAAFC73F}"/>
          </ac:spMkLst>
        </pc:spChg>
        <pc:spChg chg="mod">
          <ac:chgData name="Wencai Zhang" userId="4a86a1d0-2108-4707-8228-1110f3c1be85" providerId="ADAL" clId="{5D13D192-A431-0440-A34B-CA198DD15CA1}" dt="2022-05-02T00:00:20.320" v="1378"/>
          <ac:spMkLst>
            <pc:docMk/>
            <pc:sldMk cId="3541618713" sldId="666"/>
            <ac:spMk id="254" creationId="{4B20D2A6-B6E5-5440-A532-D7AED94DA89A}"/>
          </ac:spMkLst>
        </pc:spChg>
        <pc:spChg chg="mod">
          <ac:chgData name="Wencai Zhang" userId="4a86a1d0-2108-4707-8228-1110f3c1be85" providerId="ADAL" clId="{5D13D192-A431-0440-A34B-CA198DD15CA1}" dt="2022-05-02T00:00:20.320" v="1378"/>
          <ac:spMkLst>
            <pc:docMk/>
            <pc:sldMk cId="3541618713" sldId="666"/>
            <ac:spMk id="255" creationId="{FD697A85-B7B0-7C4E-81A6-6DD81DC08E63}"/>
          </ac:spMkLst>
        </pc:spChg>
        <pc:spChg chg="mod">
          <ac:chgData name="Wencai Zhang" userId="4a86a1d0-2108-4707-8228-1110f3c1be85" providerId="ADAL" clId="{5D13D192-A431-0440-A34B-CA198DD15CA1}" dt="2022-05-02T00:00:20.320" v="1378"/>
          <ac:spMkLst>
            <pc:docMk/>
            <pc:sldMk cId="3541618713" sldId="666"/>
            <ac:spMk id="256" creationId="{504E7697-940A-5947-9AEC-DC255033C3DD}"/>
          </ac:spMkLst>
        </pc:spChg>
        <pc:spChg chg="add mod">
          <ac:chgData name="Wencai Zhang" userId="4a86a1d0-2108-4707-8228-1110f3c1be85" providerId="ADAL" clId="{5D13D192-A431-0440-A34B-CA198DD15CA1}" dt="2022-05-02T00:00:23.620" v="1379" actId="1076"/>
          <ac:spMkLst>
            <pc:docMk/>
            <pc:sldMk cId="3541618713" sldId="666"/>
            <ac:spMk id="257" creationId="{9A0A5181-7D45-3B4D-BED9-25025121045B}"/>
          </ac:spMkLst>
        </pc:spChg>
        <pc:grpChg chg="mod">
          <ac:chgData name="Wencai Zhang" userId="4a86a1d0-2108-4707-8228-1110f3c1be85" providerId="ADAL" clId="{5D13D192-A431-0440-A34B-CA198DD15CA1}" dt="2022-05-01T23:58:53.032" v="1304" actId="1037"/>
          <ac:grpSpMkLst>
            <pc:docMk/>
            <pc:sldMk cId="3541618713" sldId="666"/>
            <ac:grpSpMk id="4" creationId="{0EA780D2-78DF-F34F-B455-4E3FFA348744}"/>
          </ac:grpSpMkLst>
        </pc:grpChg>
        <pc:grpChg chg="mod">
          <ac:chgData name="Wencai Zhang" userId="4a86a1d0-2108-4707-8228-1110f3c1be85" providerId="ADAL" clId="{5D13D192-A431-0440-A34B-CA198DD15CA1}" dt="2022-05-01T23:58:53.032" v="1304" actId="1037"/>
          <ac:grpSpMkLst>
            <pc:docMk/>
            <pc:sldMk cId="3541618713" sldId="666"/>
            <ac:grpSpMk id="6" creationId="{6A66C6AC-B9FF-3443-92D8-BC83C143C0EF}"/>
          </ac:grpSpMkLst>
        </pc:grpChg>
        <pc:grpChg chg="del">
          <ac:chgData name="Wencai Zhang" userId="4a86a1d0-2108-4707-8228-1110f3c1be85" providerId="ADAL" clId="{5D13D192-A431-0440-A34B-CA198DD15CA1}" dt="2022-04-30T00:53:46.048" v="572" actId="478"/>
          <ac:grpSpMkLst>
            <pc:docMk/>
            <pc:sldMk cId="3541618713" sldId="666"/>
            <ac:grpSpMk id="10" creationId="{DD5E4817-C56F-754D-B508-3BF2BF6E57E4}"/>
          </ac:grpSpMkLst>
        </pc:grpChg>
        <pc:grpChg chg="mod">
          <ac:chgData name="Wencai Zhang" userId="4a86a1d0-2108-4707-8228-1110f3c1be85" providerId="ADAL" clId="{5D13D192-A431-0440-A34B-CA198DD15CA1}" dt="2022-05-02T00:02:50.777" v="1532" actId="1038"/>
          <ac:grpSpMkLst>
            <pc:docMk/>
            <pc:sldMk cId="3541618713" sldId="666"/>
            <ac:grpSpMk id="14" creationId="{8FC06CE0-B335-9049-A6E0-2A1C8011AFA2}"/>
          </ac:grpSpMkLst>
        </pc:grpChg>
        <pc:grpChg chg="add mod">
          <ac:chgData name="Wencai Zhang" userId="4a86a1d0-2108-4707-8228-1110f3c1be85" providerId="ADAL" clId="{5D13D192-A431-0440-A34B-CA198DD15CA1}" dt="2022-05-02T00:02:50.777" v="1532" actId="1038"/>
          <ac:grpSpMkLst>
            <pc:docMk/>
            <pc:sldMk cId="3541618713" sldId="666"/>
            <ac:grpSpMk id="17" creationId="{4B8440A3-CBED-3145-A781-5A4E1AEE9171}"/>
          </ac:grpSpMkLst>
        </pc:grpChg>
        <pc:grpChg chg="del">
          <ac:chgData name="Wencai Zhang" userId="4a86a1d0-2108-4707-8228-1110f3c1be85" providerId="ADAL" clId="{5D13D192-A431-0440-A34B-CA198DD15CA1}" dt="2022-04-30T00:53:49.255" v="573" actId="478"/>
          <ac:grpSpMkLst>
            <pc:docMk/>
            <pc:sldMk cId="3541618713" sldId="666"/>
            <ac:grpSpMk id="85" creationId="{766244D7-B5C9-4E49-8E0D-6BA0B2FE3508}"/>
          </ac:grpSpMkLst>
        </pc:grpChg>
        <pc:grpChg chg="mod">
          <ac:chgData name="Wencai Zhang" userId="4a86a1d0-2108-4707-8228-1110f3c1be85" providerId="ADAL" clId="{5D13D192-A431-0440-A34B-CA198DD15CA1}" dt="2022-05-02T00:02:50.777" v="1532" actId="1038"/>
          <ac:grpSpMkLst>
            <pc:docMk/>
            <pc:sldMk cId="3541618713" sldId="666"/>
            <ac:grpSpMk id="108" creationId="{2161D8CF-F0C8-BF46-B831-F162939FA3D5}"/>
          </ac:grpSpMkLst>
        </pc:grpChg>
        <pc:grpChg chg="add mod">
          <ac:chgData name="Wencai Zhang" userId="4a86a1d0-2108-4707-8228-1110f3c1be85" providerId="ADAL" clId="{5D13D192-A431-0440-A34B-CA198DD15CA1}" dt="2022-05-02T00:00:01.120" v="1375" actId="1076"/>
          <ac:grpSpMkLst>
            <pc:docMk/>
            <pc:sldMk cId="3541618713" sldId="666"/>
            <ac:grpSpMk id="122" creationId="{4A553EEC-C997-2046-8B8B-EEC8B90C77D8}"/>
          </ac:grpSpMkLst>
        </pc:grpChg>
        <pc:grpChg chg="mod">
          <ac:chgData name="Wencai Zhang" userId="4a86a1d0-2108-4707-8228-1110f3c1be85" providerId="ADAL" clId="{5D13D192-A431-0440-A34B-CA198DD15CA1}" dt="2022-05-02T00:02:50.777" v="1532" actId="1038"/>
          <ac:grpSpMkLst>
            <pc:docMk/>
            <pc:sldMk cId="3541618713" sldId="666"/>
            <ac:grpSpMk id="124" creationId="{74691FC7-87C8-754B-AFEE-05EC81E72D56}"/>
          </ac:grpSpMkLst>
        </pc:grpChg>
        <pc:grpChg chg="del mod">
          <ac:chgData name="Wencai Zhang" userId="4a86a1d0-2108-4707-8228-1110f3c1be85" providerId="ADAL" clId="{5D13D192-A431-0440-A34B-CA198DD15CA1}" dt="2022-05-02T00:02:13.970" v="1447" actId="478"/>
          <ac:grpSpMkLst>
            <pc:docMk/>
            <pc:sldMk cId="3541618713" sldId="666"/>
            <ac:grpSpMk id="134" creationId="{DC1CD75F-F5F8-A347-A187-B47E38C2B0E9}"/>
          </ac:grpSpMkLst>
        </pc:grpChg>
        <pc:grpChg chg="add mod">
          <ac:chgData name="Wencai Zhang" userId="4a86a1d0-2108-4707-8228-1110f3c1be85" providerId="ADAL" clId="{5D13D192-A431-0440-A34B-CA198DD15CA1}" dt="2022-05-02T00:02:50.777" v="1532" actId="1038"/>
          <ac:grpSpMkLst>
            <pc:docMk/>
            <pc:sldMk cId="3541618713" sldId="666"/>
            <ac:grpSpMk id="157" creationId="{C1D98A06-ADFC-E343-8DB2-324F3A6DB172}"/>
          </ac:grpSpMkLst>
        </pc:grpChg>
        <pc:grpChg chg="add del mod">
          <ac:chgData name="Wencai Zhang" userId="4a86a1d0-2108-4707-8228-1110f3c1be85" providerId="ADAL" clId="{5D13D192-A431-0440-A34B-CA198DD15CA1}" dt="2022-04-30T00:49:58.517" v="353" actId="478"/>
          <ac:grpSpMkLst>
            <pc:docMk/>
            <pc:sldMk cId="3541618713" sldId="666"/>
            <ac:grpSpMk id="162" creationId="{0ED9F746-173A-0244-8F4E-0C4C921B19A3}"/>
          </ac:grpSpMkLst>
        </pc:grpChg>
        <pc:grpChg chg="mod topLvl">
          <ac:chgData name="Wencai Zhang" userId="4a86a1d0-2108-4707-8228-1110f3c1be85" providerId="ADAL" clId="{5D13D192-A431-0440-A34B-CA198DD15CA1}" dt="2022-05-02T00:02:50.777" v="1532" actId="1038"/>
          <ac:grpSpMkLst>
            <pc:docMk/>
            <pc:sldMk cId="3541618713" sldId="666"/>
            <ac:grpSpMk id="164" creationId="{06002F43-6414-644A-9857-A76570F6CFF9}"/>
          </ac:grpSpMkLst>
        </pc:grpChg>
        <pc:grpChg chg="add del mod">
          <ac:chgData name="Wencai Zhang" userId="4a86a1d0-2108-4707-8228-1110f3c1be85" providerId="ADAL" clId="{5D13D192-A431-0440-A34B-CA198DD15CA1}" dt="2022-04-30T00:50:39.407" v="397" actId="478"/>
          <ac:grpSpMkLst>
            <pc:docMk/>
            <pc:sldMk cId="3541618713" sldId="666"/>
            <ac:grpSpMk id="169" creationId="{69EBA417-011D-7F42-90BF-6D13A8755DF5}"/>
          </ac:grpSpMkLst>
        </pc:grpChg>
        <pc:grpChg chg="mod topLvl">
          <ac:chgData name="Wencai Zhang" userId="4a86a1d0-2108-4707-8228-1110f3c1be85" providerId="ADAL" clId="{5D13D192-A431-0440-A34B-CA198DD15CA1}" dt="2022-05-02T00:02:50.777" v="1532" actId="1038"/>
          <ac:grpSpMkLst>
            <pc:docMk/>
            <pc:sldMk cId="3541618713" sldId="666"/>
            <ac:grpSpMk id="171" creationId="{2F96E9B5-70C9-1B4A-8427-5A1115ECFF03}"/>
          </ac:grpSpMkLst>
        </pc:grpChg>
        <pc:grpChg chg="add del mod">
          <ac:chgData name="Wencai Zhang" userId="4a86a1d0-2108-4707-8228-1110f3c1be85" providerId="ADAL" clId="{5D13D192-A431-0440-A34B-CA198DD15CA1}" dt="2022-04-30T00:50:59.981" v="400" actId="478"/>
          <ac:grpSpMkLst>
            <pc:docMk/>
            <pc:sldMk cId="3541618713" sldId="666"/>
            <ac:grpSpMk id="176" creationId="{5304F403-F75C-A340-BB19-E09123303F59}"/>
          </ac:grpSpMkLst>
        </pc:grpChg>
        <pc:grpChg chg="add mod">
          <ac:chgData name="Wencai Zhang" userId="4a86a1d0-2108-4707-8228-1110f3c1be85" providerId="ADAL" clId="{5D13D192-A431-0440-A34B-CA198DD15CA1}" dt="2022-05-01T23:59:49.088" v="1374" actId="1037"/>
          <ac:grpSpMkLst>
            <pc:docMk/>
            <pc:sldMk cId="3541618713" sldId="666"/>
            <ac:grpSpMk id="177" creationId="{D1851ED6-0EF7-C647-8FE6-A17EC4DF1B4D}"/>
          </ac:grpSpMkLst>
        </pc:grpChg>
        <pc:grpChg chg="del mod topLvl">
          <ac:chgData name="Wencai Zhang" userId="4a86a1d0-2108-4707-8228-1110f3c1be85" providerId="ADAL" clId="{5D13D192-A431-0440-A34B-CA198DD15CA1}" dt="2022-05-02T00:00:35.858" v="1381" actId="478"/>
          <ac:grpSpMkLst>
            <pc:docMk/>
            <pc:sldMk cId="3541618713" sldId="666"/>
            <ac:grpSpMk id="178" creationId="{D96402C6-B284-0C42-9C01-3FF76AA1471F}"/>
          </ac:grpSpMkLst>
        </pc:grpChg>
        <pc:grpChg chg="add mod">
          <ac:chgData name="Wencai Zhang" userId="4a86a1d0-2108-4707-8228-1110f3c1be85" providerId="ADAL" clId="{5D13D192-A431-0440-A34B-CA198DD15CA1}" dt="2022-05-02T00:02:50.777" v="1532" actId="1038"/>
          <ac:grpSpMkLst>
            <pc:docMk/>
            <pc:sldMk cId="3541618713" sldId="666"/>
            <ac:grpSpMk id="183" creationId="{5265DA9D-7659-234D-8FDC-015F41F2BB8A}"/>
          </ac:grpSpMkLst>
        </pc:grpChg>
        <pc:grpChg chg="add mod">
          <ac:chgData name="Wencai Zhang" userId="4a86a1d0-2108-4707-8228-1110f3c1be85" providerId="ADAL" clId="{5D13D192-A431-0440-A34B-CA198DD15CA1}" dt="2022-05-01T23:59:49.088" v="1374" actId="1037"/>
          <ac:grpSpMkLst>
            <pc:docMk/>
            <pc:sldMk cId="3541618713" sldId="666"/>
            <ac:grpSpMk id="194" creationId="{3E012EAE-46E4-0D45-8ACB-BE594F2C998F}"/>
          </ac:grpSpMkLst>
        </pc:grpChg>
        <pc:grpChg chg="add mod">
          <ac:chgData name="Wencai Zhang" userId="4a86a1d0-2108-4707-8228-1110f3c1be85" providerId="ADAL" clId="{5D13D192-A431-0440-A34B-CA198DD15CA1}" dt="2022-05-01T23:59:49.088" v="1374" actId="1037"/>
          <ac:grpSpMkLst>
            <pc:docMk/>
            <pc:sldMk cId="3541618713" sldId="666"/>
            <ac:grpSpMk id="199" creationId="{52D4694C-B1A8-B34E-964E-7F0915CE6DAF}"/>
          </ac:grpSpMkLst>
        </pc:grpChg>
        <pc:grpChg chg="mod">
          <ac:chgData name="Wencai Zhang" userId="4a86a1d0-2108-4707-8228-1110f3c1be85" providerId="ADAL" clId="{5D13D192-A431-0440-A34B-CA198DD15CA1}" dt="2022-05-01T23:59:01.310" v="1305"/>
          <ac:grpSpMkLst>
            <pc:docMk/>
            <pc:sldMk cId="3541618713" sldId="666"/>
            <ac:grpSpMk id="201" creationId="{546F136C-1BB3-2D4E-95D0-450099747383}"/>
          </ac:grpSpMkLst>
        </pc:grpChg>
        <pc:grpChg chg="add mod">
          <ac:chgData name="Wencai Zhang" userId="4a86a1d0-2108-4707-8228-1110f3c1be85" providerId="ADAL" clId="{5D13D192-A431-0440-A34B-CA198DD15CA1}" dt="2022-05-01T23:59:49.088" v="1374" actId="1037"/>
          <ac:grpSpMkLst>
            <pc:docMk/>
            <pc:sldMk cId="3541618713" sldId="666"/>
            <ac:grpSpMk id="206" creationId="{6BF5002B-316E-0F46-843D-2F9F2EE49337}"/>
          </ac:grpSpMkLst>
        </pc:grpChg>
        <pc:grpChg chg="mod">
          <ac:chgData name="Wencai Zhang" userId="4a86a1d0-2108-4707-8228-1110f3c1be85" providerId="ADAL" clId="{5D13D192-A431-0440-A34B-CA198DD15CA1}" dt="2022-05-01T23:59:01.310" v="1305"/>
          <ac:grpSpMkLst>
            <pc:docMk/>
            <pc:sldMk cId="3541618713" sldId="666"/>
            <ac:grpSpMk id="208" creationId="{9160C591-9C8A-E04F-8937-65BA2ABCD9FD}"/>
          </ac:grpSpMkLst>
        </pc:grpChg>
        <pc:grpChg chg="add mod">
          <ac:chgData name="Wencai Zhang" userId="4a86a1d0-2108-4707-8228-1110f3c1be85" providerId="ADAL" clId="{5D13D192-A431-0440-A34B-CA198DD15CA1}" dt="2022-05-01T23:59:49.088" v="1374" actId="1037"/>
          <ac:grpSpMkLst>
            <pc:docMk/>
            <pc:sldMk cId="3541618713" sldId="666"/>
            <ac:grpSpMk id="213" creationId="{49B15EE0-C296-0F4C-A8D4-238BA70DF348}"/>
          </ac:grpSpMkLst>
        </pc:grpChg>
        <pc:grpChg chg="mod">
          <ac:chgData name="Wencai Zhang" userId="4a86a1d0-2108-4707-8228-1110f3c1be85" providerId="ADAL" clId="{5D13D192-A431-0440-A34B-CA198DD15CA1}" dt="2022-05-01T23:59:01.310" v="1305"/>
          <ac:grpSpMkLst>
            <pc:docMk/>
            <pc:sldMk cId="3541618713" sldId="666"/>
            <ac:grpSpMk id="215" creationId="{1BCD3E0E-2C27-3044-BE55-A70DF32F0CAC}"/>
          </ac:grpSpMkLst>
        </pc:grpChg>
        <pc:grpChg chg="add mod">
          <ac:chgData name="Wencai Zhang" userId="4a86a1d0-2108-4707-8228-1110f3c1be85" providerId="ADAL" clId="{5D13D192-A431-0440-A34B-CA198DD15CA1}" dt="2022-05-02T00:00:23.620" v="1379" actId="1076"/>
          <ac:grpSpMkLst>
            <pc:docMk/>
            <pc:sldMk cId="3541618713" sldId="666"/>
            <ac:grpSpMk id="233" creationId="{FB86B9BD-9686-6943-9879-6919F7DCB8D8}"/>
          </ac:grpSpMkLst>
        </pc:grpChg>
        <pc:grpChg chg="add mod">
          <ac:chgData name="Wencai Zhang" userId="4a86a1d0-2108-4707-8228-1110f3c1be85" providerId="ADAL" clId="{5D13D192-A431-0440-A34B-CA198DD15CA1}" dt="2022-05-02T00:00:23.620" v="1379" actId="1076"/>
          <ac:grpSpMkLst>
            <pc:docMk/>
            <pc:sldMk cId="3541618713" sldId="666"/>
            <ac:grpSpMk id="238" creationId="{8129F932-D4B3-9C4A-A8B4-E1473CA879C3}"/>
          </ac:grpSpMkLst>
        </pc:grpChg>
        <pc:grpChg chg="add mod">
          <ac:chgData name="Wencai Zhang" userId="4a86a1d0-2108-4707-8228-1110f3c1be85" providerId="ADAL" clId="{5D13D192-A431-0440-A34B-CA198DD15CA1}" dt="2022-05-02T00:00:23.620" v="1379" actId="1076"/>
          <ac:grpSpMkLst>
            <pc:docMk/>
            <pc:sldMk cId="3541618713" sldId="666"/>
            <ac:grpSpMk id="243" creationId="{D6E23419-29C0-E74B-8CE7-4F388663BD4E}"/>
          </ac:grpSpMkLst>
        </pc:grpChg>
        <pc:grpChg chg="add mod">
          <ac:chgData name="Wencai Zhang" userId="4a86a1d0-2108-4707-8228-1110f3c1be85" providerId="ADAL" clId="{5D13D192-A431-0440-A34B-CA198DD15CA1}" dt="2022-05-02T00:00:23.620" v="1379" actId="1076"/>
          <ac:grpSpMkLst>
            <pc:docMk/>
            <pc:sldMk cId="3541618713" sldId="666"/>
            <ac:grpSpMk id="248" creationId="{A48A6746-BFB7-2D4E-AB14-589331CE5A30}"/>
          </ac:grpSpMkLst>
        </pc:grpChg>
        <pc:grpChg chg="add mod">
          <ac:chgData name="Wencai Zhang" userId="4a86a1d0-2108-4707-8228-1110f3c1be85" providerId="ADAL" clId="{5D13D192-A431-0440-A34B-CA198DD15CA1}" dt="2022-05-02T00:00:23.620" v="1379" actId="1076"/>
          <ac:grpSpMkLst>
            <pc:docMk/>
            <pc:sldMk cId="3541618713" sldId="666"/>
            <ac:grpSpMk id="253" creationId="{6F6EF5B0-0E45-2D4F-8B90-FF517F4C2BE9}"/>
          </ac:grpSpMkLst>
        </pc:grpChg>
        <pc:picChg chg="mod">
          <ac:chgData name="Wencai Zhang" userId="4a86a1d0-2108-4707-8228-1110f3c1be85" providerId="ADAL" clId="{5D13D192-A431-0440-A34B-CA198DD15CA1}" dt="2022-05-02T00:00:17.720" v="1377" actId="1076"/>
          <ac:picMkLst>
            <pc:docMk/>
            <pc:sldMk cId="3541618713" sldId="666"/>
            <ac:picMk id="9" creationId="{1726E957-8321-CB4D-80DB-2F8948BAEBB9}"/>
          </ac:picMkLst>
        </pc:picChg>
        <pc:picChg chg="mod">
          <ac:chgData name="Wencai Zhang" userId="4a86a1d0-2108-4707-8228-1110f3c1be85" providerId="ADAL" clId="{5D13D192-A431-0440-A34B-CA198DD15CA1}" dt="2022-05-02T00:00:17.720" v="1377" actId="1076"/>
          <ac:picMkLst>
            <pc:docMk/>
            <pc:sldMk cId="3541618713" sldId="666"/>
            <ac:picMk id="16" creationId="{611C47D4-C579-D04A-BDC3-09F33DE2A9A3}"/>
          </ac:picMkLst>
        </pc:picChg>
        <pc:picChg chg="mod">
          <ac:chgData name="Wencai Zhang" userId="4a86a1d0-2108-4707-8228-1110f3c1be85" providerId="ADAL" clId="{5D13D192-A431-0440-A34B-CA198DD15CA1}" dt="2022-04-30T01:02:11.539" v="880" actId="1038"/>
          <ac:picMkLst>
            <pc:docMk/>
            <pc:sldMk cId="3541618713" sldId="666"/>
            <ac:picMk id="18" creationId="{9AE8DF4A-82C7-CB4B-BD9C-13B402B96180}"/>
          </ac:picMkLst>
        </pc:picChg>
        <pc:picChg chg="mod">
          <ac:chgData name="Wencai Zhang" userId="4a86a1d0-2108-4707-8228-1110f3c1be85" providerId="ADAL" clId="{5D13D192-A431-0440-A34B-CA198DD15CA1}" dt="2022-04-30T01:02:11.539" v="880" actId="1038"/>
          <ac:picMkLst>
            <pc:docMk/>
            <pc:sldMk cId="3541618713" sldId="666"/>
            <ac:picMk id="23" creationId="{35A6ABF1-51A9-C94F-9B2C-207F8A463865}"/>
          </ac:picMkLst>
        </pc:picChg>
        <pc:picChg chg="mod modCrop">
          <ac:chgData name="Wencai Zhang" userId="4a86a1d0-2108-4707-8228-1110f3c1be85" providerId="ADAL" clId="{5D13D192-A431-0440-A34B-CA198DD15CA1}" dt="2022-05-02T00:02:50.777" v="1532" actId="1038"/>
          <ac:picMkLst>
            <pc:docMk/>
            <pc:sldMk cId="3541618713" sldId="666"/>
            <ac:picMk id="93" creationId="{224624CA-5B12-8F43-A11E-3756334F7D22}"/>
          </ac:picMkLst>
        </pc:picChg>
        <pc:picChg chg="mod modCrop">
          <ac:chgData name="Wencai Zhang" userId="4a86a1d0-2108-4707-8228-1110f3c1be85" providerId="ADAL" clId="{5D13D192-A431-0440-A34B-CA198DD15CA1}" dt="2022-05-02T00:02:50.777" v="1532" actId="1038"/>
          <ac:picMkLst>
            <pc:docMk/>
            <pc:sldMk cId="3541618713" sldId="666"/>
            <ac:picMk id="94" creationId="{97FA3EE4-0D2E-CF46-8279-346A61519E43}"/>
          </ac:picMkLst>
        </pc:picChg>
        <pc:picChg chg="mod modCrop">
          <ac:chgData name="Wencai Zhang" userId="4a86a1d0-2108-4707-8228-1110f3c1be85" providerId="ADAL" clId="{5D13D192-A431-0440-A34B-CA198DD15CA1}" dt="2022-05-02T00:02:50.777" v="1532" actId="1038"/>
          <ac:picMkLst>
            <pc:docMk/>
            <pc:sldMk cId="3541618713" sldId="666"/>
            <ac:picMk id="95" creationId="{2EBE4A23-7F14-1E40-A397-5C7958B4AE2D}"/>
          </ac:picMkLst>
        </pc:picChg>
        <pc:picChg chg="mod">
          <ac:chgData name="Wencai Zhang" userId="4a86a1d0-2108-4707-8228-1110f3c1be85" providerId="ADAL" clId="{5D13D192-A431-0440-A34B-CA198DD15CA1}" dt="2022-04-30T00:39:40.589" v="32"/>
          <ac:picMkLst>
            <pc:docMk/>
            <pc:sldMk cId="3541618713" sldId="666"/>
            <ac:picMk id="123" creationId="{1FDD0412-9C04-EE44-90AC-9F6E669B41C0}"/>
          </ac:picMkLst>
        </pc:picChg>
        <pc:picChg chg="mod modCrop">
          <ac:chgData name="Wencai Zhang" userId="4a86a1d0-2108-4707-8228-1110f3c1be85" providerId="ADAL" clId="{5D13D192-A431-0440-A34B-CA198DD15CA1}" dt="2022-05-02T00:02:50.777" v="1532" actId="1038"/>
          <ac:picMkLst>
            <pc:docMk/>
            <pc:sldMk cId="3541618713" sldId="666"/>
            <ac:picMk id="142" creationId="{23B4D11B-E5E2-3E41-B836-99B310EC35C5}"/>
          </ac:picMkLst>
        </pc:picChg>
        <pc:picChg chg="mod modCrop">
          <ac:chgData name="Wencai Zhang" userId="4a86a1d0-2108-4707-8228-1110f3c1be85" providerId="ADAL" clId="{5D13D192-A431-0440-A34B-CA198DD15CA1}" dt="2022-05-02T00:02:50.777" v="1532" actId="1038"/>
          <ac:picMkLst>
            <pc:docMk/>
            <pc:sldMk cId="3541618713" sldId="666"/>
            <ac:picMk id="143" creationId="{70B7AD56-1A40-0D44-BBAA-1E8E839AC2D3}"/>
          </ac:picMkLst>
        </pc:picChg>
        <pc:picChg chg="mod modCrop">
          <ac:chgData name="Wencai Zhang" userId="4a86a1d0-2108-4707-8228-1110f3c1be85" providerId="ADAL" clId="{5D13D192-A431-0440-A34B-CA198DD15CA1}" dt="2022-05-02T00:02:50.777" v="1532" actId="1038"/>
          <ac:picMkLst>
            <pc:docMk/>
            <pc:sldMk cId="3541618713" sldId="666"/>
            <ac:picMk id="144" creationId="{75EE320D-7DD2-C745-ADE8-5FE4E458278F}"/>
          </ac:picMkLst>
        </pc:picChg>
        <pc:picChg chg="mod">
          <ac:chgData name="Wencai Zhang" userId="4a86a1d0-2108-4707-8228-1110f3c1be85" providerId="ADAL" clId="{5D13D192-A431-0440-A34B-CA198DD15CA1}" dt="2022-04-30T00:39:40.589" v="32"/>
          <ac:picMkLst>
            <pc:docMk/>
            <pc:sldMk cId="3541618713" sldId="666"/>
            <ac:picMk id="145" creationId="{D6D3A886-0ED2-7948-B618-10675242C3B8}"/>
          </ac:picMkLst>
        </pc:picChg>
        <pc:picChg chg="mod">
          <ac:chgData name="Wencai Zhang" userId="4a86a1d0-2108-4707-8228-1110f3c1be85" providerId="ADAL" clId="{5D13D192-A431-0440-A34B-CA198DD15CA1}" dt="2022-04-30T00:39:40.589" v="32"/>
          <ac:picMkLst>
            <pc:docMk/>
            <pc:sldMk cId="3541618713" sldId="666"/>
            <ac:picMk id="149" creationId="{897A1781-A8D8-0A47-A3C3-5C05F169D1DD}"/>
          </ac:picMkLst>
        </pc:picChg>
        <pc:picChg chg="add del mod modCrop">
          <ac:chgData name="Wencai Zhang" userId="4a86a1d0-2108-4707-8228-1110f3c1be85" providerId="ADAL" clId="{5D13D192-A431-0440-A34B-CA198DD15CA1}" dt="2022-05-02T00:00:31.421" v="1380" actId="478"/>
          <ac:picMkLst>
            <pc:docMk/>
            <pc:sldMk cId="3541618713" sldId="666"/>
            <ac:picMk id="154" creationId="{A31617F5-775F-8444-9E98-EEB03228D296}"/>
          </ac:picMkLst>
        </pc:picChg>
        <pc:picChg chg="add del mod modCrop">
          <ac:chgData name="Wencai Zhang" userId="4a86a1d0-2108-4707-8228-1110f3c1be85" providerId="ADAL" clId="{5D13D192-A431-0440-A34B-CA198DD15CA1}" dt="2022-05-02T00:00:31.421" v="1380" actId="478"/>
          <ac:picMkLst>
            <pc:docMk/>
            <pc:sldMk cId="3541618713" sldId="666"/>
            <ac:picMk id="155" creationId="{8E86A90D-0AA1-E24E-8A4A-6C1724325896}"/>
          </ac:picMkLst>
        </pc:picChg>
        <pc:picChg chg="add mod">
          <ac:chgData name="Wencai Zhang" userId="4a86a1d0-2108-4707-8228-1110f3c1be85" providerId="ADAL" clId="{5D13D192-A431-0440-A34B-CA198DD15CA1}" dt="2022-05-01T23:59:49.088" v="1374" actId="1037"/>
          <ac:picMkLst>
            <pc:docMk/>
            <pc:sldMk cId="3541618713" sldId="666"/>
            <ac:picMk id="163" creationId="{CF9877FE-ADC0-C94E-8422-07F2C13298CD}"/>
          </ac:picMkLst>
        </pc:picChg>
        <pc:picChg chg="add mod">
          <ac:chgData name="Wencai Zhang" userId="4a86a1d0-2108-4707-8228-1110f3c1be85" providerId="ADAL" clId="{5D13D192-A431-0440-A34B-CA198DD15CA1}" dt="2022-05-01T23:59:49.088" v="1374" actId="1037"/>
          <ac:picMkLst>
            <pc:docMk/>
            <pc:sldMk cId="3541618713" sldId="666"/>
            <ac:picMk id="169" creationId="{58A52B1C-E496-4E49-A4F9-651BD26FF5AB}"/>
          </ac:picMkLst>
        </pc:picChg>
        <pc:picChg chg="add mod">
          <ac:chgData name="Wencai Zhang" userId="4a86a1d0-2108-4707-8228-1110f3c1be85" providerId="ADAL" clId="{5D13D192-A431-0440-A34B-CA198DD15CA1}" dt="2022-05-01T23:59:49.088" v="1374" actId="1037"/>
          <ac:picMkLst>
            <pc:docMk/>
            <pc:sldMk cId="3541618713" sldId="666"/>
            <ac:picMk id="170" creationId="{1E5919F0-8334-F14A-9AE0-DB778DFD2D64}"/>
          </ac:picMkLst>
        </pc:picChg>
        <pc:picChg chg="add mod">
          <ac:chgData name="Wencai Zhang" userId="4a86a1d0-2108-4707-8228-1110f3c1be85" providerId="ADAL" clId="{5D13D192-A431-0440-A34B-CA198DD15CA1}" dt="2022-05-01T23:59:49.088" v="1374" actId="1037"/>
          <ac:picMkLst>
            <pc:docMk/>
            <pc:sldMk cId="3541618713" sldId="666"/>
            <ac:picMk id="220" creationId="{97B90C4B-3F10-2644-AEAE-61D80E6EC636}"/>
          </ac:picMkLst>
        </pc:picChg>
        <pc:picChg chg="add mod">
          <ac:chgData name="Wencai Zhang" userId="4a86a1d0-2108-4707-8228-1110f3c1be85" providerId="ADAL" clId="{5D13D192-A431-0440-A34B-CA198DD15CA1}" dt="2022-05-01T23:59:49.088" v="1374" actId="1037"/>
          <ac:picMkLst>
            <pc:docMk/>
            <pc:sldMk cId="3541618713" sldId="666"/>
            <ac:picMk id="221" creationId="{E3F3A5C9-E2C2-BF42-B524-5B714C0ECBAE}"/>
          </ac:picMkLst>
        </pc:picChg>
        <pc:picChg chg="add mod">
          <ac:chgData name="Wencai Zhang" userId="4a86a1d0-2108-4707-8228-1110f3c1be85" providerId="ADAL" clId="{5D13D192-A431-0440-A34B-CA198DD15CA1}" dt="2022-05-02T00:00:23.620" v="1379" actId="1076"/>
          <ac:picMkLst>
            <pc:docMk/>
            <pc:sldMk cId="3541618713" sldId="666"/>
            <ac:picMk id="225" creationId="{2CD42E40-65E4-5249-8C42-8931B441A6E4}"/>
          </ac:picMkLst>
        </pc:picChg>
        <pc:picChg chg="add mod">
          <ac:chgData name="Wencai Zhang" userId="4a86a1d0-2108-4707-8228-1110f3c1be85" providerId="ADAL" clId="{5D13D192-A431-0440-A34B-CA198DD15CA1}" dt="2022-05-02T00:00:23.620" v="1379" actId="1076"/>
          <ac:picMkLst>
            <pc:docMk/>
            <pc:sldMk cId="3541618713" sldId="666"/>
            <ac:picMk id="226" creationId="{6A04A849-B9EE-9246-98BC-77B5F9910933}"/>
          </ac:picMkLst>
        </pc:picChg>
        <pc:picChg chg="add mod">
          <ac:chgData name="Wencai Zhang" userId="4a86a1d0-2108-4707-8228-1110f3c1be85" providerId="ADAL" clId="{5D13D192-A431-0440-A34B-CA198DD15CA1}" dt="2022-05-02T00:00:23.620" v="1379" actId="1076"/>
          <ac:picMkLst>
            <pc:docMk/>
            <pc:sldMk cId="3541618713" sldId="666"/>
            <ac:picMk id="227" creationId="{A130B70F-340F-C64B-8BAC-3F241ECCD891}"/>
          </ac:picMkLst>
        </pc:picChg>
        <pc:picChg chg="add mod">
          <ac:chgData name="Wencai Zhang" userId="4a86a1d0-2108-4707-8228-1110f3c1be85" providerId="ADAL" clId="{5D13D192-A431-0440-A34B-CA198DD15CA1}" dt="2022-05-02T00:00:23.620" v="1379" actId="1076"/>
          <ac:picMkLst>
            <pc:docMk/>
            <pc:sldMk cId="3541618713" sldId="666"/>
            <ac:picMk id="228" creationId="{5A213F1E-F9B9-2C4F-AB37-BA0BE0D22ADA}"/>
          </ac:picMkLst>
        </pc:picChg>
        <pc:picChg chg="add mod">
          <ac:chgData name="Wencai Zhang" userId="4a86a1d0-2108-4707-8228-1110f3c1be85" providerId="ADAL" clId="{5D13D192-A431-0440-A34B-CA198DD15CA1}" dt="2022-05-02T00:00:23.620" v="1379" actId="1076"/>
          <ac:picMkLst>
            <pc:docMk/>
            <pc:sldMk cId="3541618713" sldId="666"/>
            <ac:picMk id="229" creationId="{2F4483FE-7258-B44C-8776-19AC58C147F3}"/>
          </ac:picMkLst>
        </pc:picChg>
        <pc:picChg chg="add mod">
          <ac:chgData name="Wencai Zhang" userId="4a86a1d0-2108-4707-8228-1110f3c1be85" providerId="ADAL" clId="{5D13D192-A431-0440-A34B-CA198DD15CA1}" dt="2022-05-02T00:00:23.620" v="1379" actId="1076"/>
          <ac:picMkLst>
            <pc:docMk/>
            <pc:sldMk cId="3541618713" sldId="666"/>
            <ac:picMk id="230" creationId="{FAE16E2D-0666-7745-888D-22835EDD3A37}"/>
          </ac:picMkLst>
        </pc:picChg>
        <pc:picChg chg="add mod">
          <ac:chgData name="Wencai Zhang" userId="4a86a1d0-2108-4707-8228-1110f3c1be85" providerId="ADAL" clId="{5D13D192-A431-0440-A34B-CA198DD15CA1}" dt="2022-05-02T00:00:23.620" v="1379" actId="1076"/>
          <ac:picMkLst>
            <pc:docMk/>
            <pc:sldMk cId="3541618713" sldId="666"/>
            <ac:picMk id="231" creationId="{64750205-7734-774C-9D95-61F4AF54207D}"/>
          </ac:picMkLst>
        </pc:picChg>
        <pc:cxnChg chg="add del mod">
          <ac:chgData name="Wencai Zhang" userId="4a86a1d0-2108-4707-8228-1110f3c1be85" providerId="ADAL" clId="{5D13D192-A431-0440-A34B-CA198DD15CA1}" dt="2022-05-02T00:00:55.439" v="1420" actId="478"/>
          <ac:cxnSpMkLst>
            <pc:docMk/>
            <pc:sldMk cId="3541618713" sldId="666"/>
            <ac:cxnSpMk id="24" creationId="{432EDA4C-AF4A-654A-8136-B7AAEFB79031}"/>
          </ac:cxnSpMkLst>
        </pc:cxnChg>
        <pc:cxnChg chg="add">
          <ac:chgData name="Wencai Zhang" userId="4a86a1d0-2108-4707-8228-1110f3c1be85" providerId="ADAL" clId="{5D13D192-A431-0440-A34B-CA198DD15CA1}" dt="2022-05-02T00:03:15.038" v="1533" actId="11529"/>
          <ac:cxnSpMkLst>
            <pc:docMk/>
            <pc:sldMk cId="3541618713" sldId="666"/>
            <ac:cxnSpMk id="38" creationId="{85BEC5E9-6483-6249-A3BD-939443D3D6DF}"/>
          </ac:cxnSpMkLst>
        </pc:cxnChg>
        <pc:cxnChg chg="add mod">
          <ac:chgData name="Wencai Zhang" userId="4a86a1d0-2108-4707-8228-1110f3c1be85" providerId="ADAL" clId="{5D13D192-A431-0440-A34B-CA198DD15CA1}" dt="2022-05-02T00:02:50.777" v="1532" actId="1038"/>
          <ac:cxnSpMkLst>
            <pc:docMk/>
            <pc:sldMk cId="3541618713" sldId="666"/>
            <ac:cxnSpMk id="188" creationId="{77D04D79-B689-D54E-8D1C-6E67FD68915C}"/>
          </ac:cxnSpMkLst>
        </pc:cxnChg>
        <pc:cxnChg chg="add del mod">
          <ac:chgData name="Wencai Zhang" userId="4a86a1d0-2108-4707-8228-1110f3c1be85" providerId="ADAL" clId="{5D13D192-A431-0440-A34B-CA198DD15CA1}" dt="2022-05-02T00:02:05.639" v="1446" actId="478"/>
          <ac:cxnSpMkLst>
            <pc:docMk/>
            <pc:sldMk cId="3541618713" sldId="666"/>
            <ac:cxnSpMk id="189" creationId="{2FB2DC6F-9FAD-F548-8C72-636830508060}"/>
          </ac:cxnSpMkLst>
        </pc:cxnChg>
        <pc:cxnChg chg="add mod">
          <ac:chgData name="Wencai Zhang" userId="4a86a1d0-2108-4707-8228-1110f3c1be85" providerId="ADAL" clId="{5D13D192-A431-0440-A34B-CA198DD15CA1}" dt="2022-05-02T00:02:50.777" v="1532" actId="1038"/>
          <ac:cxnSpMkLst>
            <pc:docMk/>
            <pc:sldMk cId="3541618713" sldId="666"/>
            <ac:cxnSpMk id="190" creationId="{C6124C7C-6FBD-2749-9A9C-56CEBFD5B596}"/>
          </ac:cxnSpMkLst>
        </pc:cxnChg>
        <pc:cxnChg chg="add mod">
          <ac:chgData name="Wencai Zhang" userId="4a86a1d0-2108-4707-8228-1110f3c1be85" providerId="ADAL" clId="{5D13D192-A431-0440-A34B-CA198DD15CA1}" dt="2022-05-01T23:59:49.088" v="1374" actId="1037"/>
          <ac:cxnSpMkLst>
            <pc:docMk/>
            <pc:sldMk cId="3541618713" sldId="666"/>
            <ac:cxnSpMk id="222" creationId="{926C437B-8960-C046-8933-FBB896CE9992}"/>
          </ac:cxnSpMkLst>
        </pc:cxnChg>
        <pc:cxnChg chg="add mod">
          <ac:chgData name="Wencai Zhang" userId="4a86a1d0-2108-4707-8228-1110f3c1be85" providerId="ADAL" clId="{5D13D192-A431-0440-A34B-CA198DD15CA1}" dt="2022-05-01T23:59:49.088" v="1374" actId="1037"/>
          <ac:cxnSpMkLst>
            <pc:docMk/>
            <pc:sldMk cId="3541618713" sldId="666"/>
            <ac:cxnSpMk id="223" creationId="{A736B73C-695F-CF4B-8099-EAEA2CC1DD38}"/>
          </ac:cxnSpMkLst>
        </pc:cxnChg>
        <pc:cxnChg chg="add mod">
          <ac:chgData name="Wencai Zhang" userId="4a86a1d0-2108-4707-8228-1110f3c1be85" providerId="ADAL" clId="{5D13D192-A431-0440-A34B-CA198DD15CA1}" dt="2022-05-02T00:00:23.620" v="1379" actId="1076"/>
          <ac:cxnSpMkLst>
            <pc:docMk/>
            <pc:sldMk cId="3541618713" sldId="666"/>
            <ac:cxnSpMk id="258" creationId="{8F229508-4E2A-2047-B2B4-4D472F1FE298}"/>
          </ac:cxnSpMkLst>
        </pc:cxnChg>
        <pc:cxnChg chg="add mod">
          <ac:chgData name="Wencai Zhang" userId="4a86a1d0-2108-4707-8228-1110f3c1be85" providerId="ADAL" clId="{5D13D192-A431-0440-A34B-CA198DD15CA1}" dt="2022-05-02T00:00:23.620" v="1379" actId="1076"/>
          <ac:cxnSpMkLst>
            <pc:docMk/>
            <pc:sldMk cId="3541618713" sldId="666"/>
            <ac:cxnSpMk id="259" creationId="{BA9E0C58-962A-6942-B7AA-46BA682E503F}"/>
          </ac:cxnSpMkLst>
        </pc:cxnChg>
        <pc:cxnChg chg="add mod">
          <ac:chgData name="Wencai Zhang" userId="4a86a1d0-2108-4707-8228-1110f3c1be85" providerId="ADAL" clId="{5D13D192-A431-0440-A34B-CA198DD15CA1}" dt="2022-05-02T00:03:24.375" v="1537" actId="1076"/>
          <ac:cxnSpMkLst>
            <pc:docMk/>
            <pc:sldMk cId="3541618713" sldId="666"/>
            <ac:cxnSpMk id="260" creationId="{59B9FF1B-CA78-5A40-8DFE-6C686DA86935}"/>
          </ac:cxnSpMkLst>
        </pc:cxnChg>
        <pc:cxnChg chg="add mod">
          <ac:chgData name="Wencai Zhang" userId="4a86a1d0-2108-4707-8228-1110f3c1be85" providerId="ADAL" clId="{5D13D192-A431-0440-A34B-CA198DD15CA1}" dt="2022-05-02T00:03:21.797" v="1536" actId="1076"/>
          <ac:cxnSpMkLst>
            <pc:docMk/>
            <pc:sldMk cId="3541618713" sldId="666"/>
            <ac:cxnSpMk id="261" creationId="{44D255A7-5F7E-A145-82FE-F0283B7F63CB}"/>
          </ac:cxnSpMkLst>
        </pc:cxnChg>
      </pc:sldChg>
      <pc:sldChg chg="modSp mod">
        <pc:chgData name="Wencai Zhang" userId="4a86a1d0-2108-4707-8228-1110f3c1be85" providerId="ADAL" clId="{5D13D192-A431-0440-A34B-CA198DD15CA1}" dt="2022-05-24T12:48:44.383" v="2086" actId="113"/>
        <pc:sldMkLst>
          <pc:docMk/>
          <pc:sldMk cId="328925770" sldId="668"/>
        </pc:sldMkLst>
        <pc:spChg chg="mod">
          <ac:chgData name="Wencai Zhang" userId="4a86a1d0-2108-4707-8228-1110f3c1be85" providerId="ADAL" clId="{5D13D192-A431-0440-A34B-CA198DD15CA1}" dt="2022-05-24T12:48:44.383" v="2086" actId="113"/>
          <ac:spMkLst>
            <pc:docMk/>
            <pc:sldMk cId="328925770" sldId="668"/>
            <ac:spMk id="2" creationId="{67924208-D2B4-B24D-8A38-44DCDBFAF8C8}"/>
          </ac:spMkLst>
        </pc:spChg>
        <pc:spChg chg="mod">
          <ac:chgData name="Wencai Zhang" userId="4a86a1d0-2108-4707-8228-1110f3c1be85" providerId="ADAL" clId="{5D13D192-A431-0440-A34B-CA198DD15CA1}" dt="2022-05-24T12:48:41.863" v="2085" actId="1076"/>
          <ac:spMkLst>
            <pc:docMk/>
            <pc:sldMk cId="328925770" sldId="668"/>
            <ac:spMk id="20" creationId="{C6CB0638-1ED0-824B-9AB5-180EBE5C00EF}"/>
          </ac:spMkLst>
        </pc:spChg>
      </pc:sldChg>
      <pc:sldChg chg="delSp add del mod">
        <pc:chgData name="Wencai Zhang" userId="4a86a1d0-2108-4707-8228-1110f3c1be85" providerId="ADAL" clId="{5D13D192-A431-0440-A34B-CA198DD15CA1}" dt="2022-05-16T00:28:33.533" v="2064" actId="2696"/>
        <pc:sldMkLst>
          <pc:docMk/>
          <pc:sldMk cId="29491834" sldId="669"/>
        </pc:sldMkLst>
        <pc:grpChg chg="del">
          <ac:chgData name="Wencai Zhang" userId="4a86a1d0-2108-4707-8228-1110f3c1be85" providerId="ADAL" clId="{5D13D192-A431-0440-A34B-CA198DD15CA1}" dt="2022-05-16T00:13:51.179" v="1999" actId="478"/>
          <ac:grpSpMkLst>
            <pc:docMk/>
            <pc:sldMk cId="29491834" sldId="669"/>
            <ac:grpSpMk id="42" creationId="{FA6C4DC2-9D72-8E09-7C51-C2A06A092364}"/>
          </ac:grpSpMkLst>
        </pc:grpChg>
      </pc:sldChg>
      <pc:sldChg chg="delSp add del mod">
        <pc:chgData name="Wencai Zhang" userId="4a86a1d0-2108-4707-8228-1110f3c1be85" providerId="ADAL" clId="{5D13D192-A431-0440-A34B-CA198DD15CA1}" dt="2022-05-16T00:10:26.520" v="1994" actId="2696"/>
        <pc:sldMkLst>
          <pc:docMk/>
          <pc:sldMk cId="2475794415" sldId="669"/>
        </pc:sldMkLst>
        <pc:grpChg chg="del">
          <ac:chgData name="Wencai Zhang" userId="4a86a1d0-2108-4707-8228-1110f3c1be85" providerId="ADAL" clId="{5D13D192-A431-0440-A34B-CA198DD15CA1}" dt="2022-05-15T23:54:45.926" v="1964" actId="478"/>
          <ac:grpSpMkLst>
            <pc:docMk/>
            <pc:sldMk cId="2475794415" sldId="669"/>
            <ac:grpSpMk id="36" creationId="{285AC0BC-FF77-6872-942F-B0185A00644F}"/>
          </ac:grpSpMkLst>
        </pc:grpChg>
      </pc:sldChg>
      <pc:sldChg chg="add del">
        <pc:chgData name="Wencai Zhang" userId="4a86a1d0-2108-4707-8228-1110f3c1be85" providerId="ADAL" clId="{5D13D192-A431-0440-A34B-CA198DD15CA1}" dt="2022-05-15T23:53:26.323" v="1960" actId="2696"/>
        <pc:sldMkLst>
          <pc:docMk/>
          <pc:sldMk cId="3195065247" sldId="669"/>
        </pc:sldMkLst>
      </pc:sldChg>
    </pc:docChg>
  </pc:docChgLst>
  <pc:docChgLst>
    <pc:chgData name="Wencai Zhang" userId="4a86a1d0-2108-4707-8228-1110f3c1be85" providerId="ADAL" clId="{4F30B913-801A-9F4E-A0FB-25BE0507F327}"/>
    <pc:docChg chg="undo custSel addSld delSld">
      <pc:chgData name="Wencai Zhang" userId="4a86a1d0-2108-4707-8228-1110f3c1be85" providerId="ADAL" clId="{4F30B913-801A-9F4E-A0FB-25BE0507F327}" dt="2022-06-23T12:09:06.516" v="3" actId="2696"/>
      <pc:docMkLst>
        <pc:docMk/>
      </pc:docMkLst>
      <pc:sldChg chg="del">
        <pc:chgData name="Wencai Zhang" userId="4a86a1d0-2108-4707-8228-1110f3c1be85" providerId="ADAL" clId="{4F30B913-801A-9F4E-A0FB-25BE0507F327}" dt="2022-06-23T12:09:00.264" v="2" actId="2696"/>
        <pc:sldMkLst>
          <pc:docMk/>
          <pc:sldMk cId="3759201367" sldId="279"/>
        </pc:sldMkLst>
      </pc:sldChg>
      <pc:sldChg chg="add del">
        <pc:chgData name="Wencai Zhang" userId="4a86a1d0-2108-4707-8228-1110f3c1be85" providerId="ADAL" clId="{4F30B913-801A-9F4E-A0FB-25BE0507F327}" dt="2022-06-23T12:08:57.536" v="1" actId="2696"/>
        <pc:sldMkLst>
          <pc:docMk/>
          <pc:sldMk cId="2061921346" sldId="281"/>
        </pc:sldMkLst>
      </pc:sldChg>
      <pc:sldChg chg="add del">
        <pc:chgData name="Wencai Zhang" userId="4a86a1d0-2108-4707-8228-1110f3c1be85" providerId="ADAL" clId="{4F30B913-801A-9F4E-A0FB-25BE0507F327}" dt="2022-06-23T12:09:06.516" v="3" actId="2696"/>
        <pc:sldMkLst>
          <pc:docMk/>
          <pc:sldMk cId="495234596" sldId="282"/>
        </pc:sldMkLst>
      </pc:sldChg>
      <pc:sldChg chg="add del">
        <pc:chgData name="Wencai Zhang" userId="4a86a1d0-2108-4707-8228-1110f3c1be85" providerId="ADAL" clId="{4F30B913-801A-9F4E-A0FB-25BE0507F327}" dt="2022-06-23T12:08:57.536" v="1" actId="2696"/>
        <pc:sldMkLst>
          <pc:docMk/>
          <pc:sldMk cId="2930520000" sldId="283"/>
        </pc:sldMkLst>
      </pc:sldChg>
      <pc:sldChg chg="add del">
        <pc:chgData name="Wencai Zhang" userId="4a86a1d0-2108-4707-8228-1110f3c1be85" providerId="ADAL" clId="{4F30B913-801A-9F4E-A0FB-25BE0507F327}" dt="2022-06-23T12:08:57.536" v="1" actId="2696"/>
        <pc:sldMkLst>
          <pc:docMk/>
          <pc:sldMk cId="3756175224" sldId="284"/>
        </pc:sldMkLst>
      </pc:sldChg>
      <pc:sldChg chg="add del">
        <pc:chgData name="Wencai Zhang" userId="4a86a1d0-2108-4707-8228-1110f3c1be85" providerId="ADAL" clId="{4F30B913-801A-9F4E-A0FB-25BE0507F327}" dt="2022-06-23T12:09:06.516" v="3" actId="2696"/>
        <pc:sldMkLst>
          <pc:docMk/>
          <pc:sldMk cId="3813348304" sldId="285"/>
        </pc:sldMkLst>
      </pc:sldChg>
      <pc:sldChg chg="add del">
        <pc:chgData name="Wencai Zhang" userId="4a86a1d0-2108-4707-8228-1110f3c1be85" providerId="ADAL" clId="{4F30B913-801A-9F4E-A0FB-25BE0507F327}" dt="2022-06-23T12:09:06.516" v="3" actId="2696"/>
        <pc:sldMkLst>
          <pc:docMk/>
          <pc:sldMk cId="3541618713" sldId="666"/>
        </pc:sldMkLst>
      </pc:sldChg>
      <pc:sldChg chg="add del">
        <pc:chgData name="Wencai Zhang" userId="4a86a1d0-2108-4707-8228-1110f3c1be85" providerId="ADAL" clId="{4F30B913-801A-9F4E-A0FB-25BE0507F327}" dt="2022-06-23T12:08:57.536" v="1" actId="2696"/>
        <pc:sldMkLst>
          <pc:docMk/>
          <pc:sldMk cId="328925770" sldId="668"/>
        </pc:sldMkLst>
      </pc:sldChg>
    </pc:docChg>
  </pc:docChgLst>
  <pc:docChgLst>
    <pc:chgData name="Wencai Zhang" userId="4a86a1d0-2108-4707-8228-1110f3c1be85" providerId="ADAL" clId="{A813DD5E-EF6A-D74E-9200-EB703B190439}"/>
    <pc:docChg chg="custSel addSld delSld modSld">
      <pc:chgData name="Wencai Zhang" userId="4a86a1d0-2108-4707-8228-1110f3c1be85" providerId="ADAL" clId="{A813DD5E-EF6A-D74E-9200-EB703B190439}" dt="2020-12-27T16:35:33.626" v="545" actId="478"/>
      <pc:docMkLst>
        <pc:docMk/>
      </pc:docMkLst>
      <pc:sldChg chg="del">
        <pc:chgData name="Wencai Zhang" userId="4a86a1d0-2108-4707-8228-1110f3c1be85" providerId="ADAL" clId="{A813DD5E-EF6A-D74E-9200-EB703B190439}" dt="2020-12-23T02:04:18.731" v="346" actId="2696"/>
        <pc:sldMkLst>
          <pc:docMk/>
          <pc:sldMk cId="34500481" sldId="262"/>
        </pc:sldMkLst>
      </pc:sldChg>
      <pc:sldChg chg="del">
        <pc:chgData name="Wencai Zhang" userId="4a86a1d0-2108-4707-8228-1110f3c1be85" providerId="ADAL" clId="{A813DD5E-EF6A-D74E-9200-EB703B190439}" dt="2020-12-23T02:04:22.242" v="348" actId="2696"/>
        <pc:sldMkLst>
          <pc:docMk/>
          <pc:sldMk cId="1118328605" sldId="263"/>
        </pc:sldMkLst>
      </pc:sldChg>
      <pc:sldChg chg="del">
        <pc:chgData name="Wencai Zhang" userId="4a86a1d0-2108-4707-8228-1110f3c1be85" providerId="ADAL" clId="{A813DD5E-EF6A-D74E-9200-EB703B190439}" dt="2020-12-23T02:04:02.334" v="344" actId="2696"/>
        <pc:sldMkLst>
          <pc:docMk/>
          <pc:sldMk cId="1209886007" sldId="267"/>
        </pc:sldMkLst>
      </pc:sldChg>
      <pc:sldChg chg="del">
        <pc:chgData name="Wencai Zhang" userId="4a86a1d0-2108-4707-8228-1110f3c1be85" providerId="ADAL" clId="{A813DD5E-EF6A-D74E-9200-EB703B190439}" dt="2020-12-23T01:58:34.423" v="343" actId="2696"/>
        <pc:sldMkLst>
          <pc:docMk/>
          <pc:sldMk cId="1094955203" sldId="268"/>
        </pc:sldMkLst>
      </pc:sldChg>
      <pc:sldChg chg="del">
        <pc:chgData name="Wencai Zhang" userId="4a86a1d0-2108-4707-8228-1110f3c1be85" providerId="ADAL" clId="{A813DD5E-EF6A-D74E-9200-EB703B190439}" dt="2020-12-23T01:58:32.428" v="342" actId="2696"/>
        <pc:sldMkLst>
          <pc:docMk/>
          <pc:sldMk cId="213598964" sldId="269"/>
        </pc:sldMkLst>
      </pc:sldChg>
      <pc:sldChg chg="add del">
        <pc:chgData name="Wencai Zhang" userId="4a86a1d0-2108-4707-8228-1110f3c1be85" providerId="ADAL" clId="{A813DD5E-EF6A-D74E-9200-EB703B190439}" dt="2020-12-23T02:04:08.862" v="345" actId="2696"/>
        <pc:sldMkLst>
          <pc:docMk/>
          <pc:sldMk cId="4076714075" sldId="270"/>
        </pc:sldMkLst>
      </pc:sldChg>
      <pc:sldChg chg="addSp delSp modSp add mod">
        <pc:chgData name="Wencai Zhang" userId="4a86a1d0-2108-4707-8228-1110f3c1be85" providerId="ADAL" clId="{A813DD5E-EF6A-D74E-9200-EB703B190439}" dt="2020-12-24T00:37:39.856" v="387" actId="478"/>
        <pc:sldMkLst>
          <pc:docMk/>
          <pc:sldMk cId="2562103204" sldId="271"/>
        </pc:sldMkLst>
        <pc:spChg chg="del mod">
          <ac:chgData name="Wencai Zhang" userId="4a86a1d0-2108-4707-8228-1110f3c1be85" providerId="ADAL" clId="{A813DD5E-EF6A-D74E-9200-EB703B190439}" dt="2020-12-22T00:29:35.797" v="15" actId="478"/>
          <ac:spMkLst>
            <pc:docMk/>
            <pc:sldMk cId="2562103204" sldId="271"/>
            <ac:spMk id="2" creationId="{362B0428-7154-4C24-8283-8438539A6857}"/>
          </ac:spMkLst>
        </pc:spChg>
        <pc:spChg chg="mod">
          <ac:chgData name="Wencai Zhang" userId="4a86a1d0-2108-4707-8228-1110f3c1be85" providerId="ADAL" clId="{A813DD5E-EF6A-D74E-9200-EB703B190439}" dt="2020-12-23T01:05:22.629" v="93" actId="1076"/>
          <ac:spMkLst>
            <pc:docMk/>
            <pc:sldMk cId="2562103204" sldId="271"/>
            <ac:spMk id="7" creationId="{6C6543DB-A79E-4B7B-9E18-CB9461DC5821}"/>
          </ac:spMkLst>
        </pc:spChg>
        <pc:spChg chg="mod">
          <ac:chgData name="Wencai Zhang" userId="4a86a1d0-2108-4707-8228-1110f3c1be85" providerId="ADAL" clId="{A813DD5E-EF6A-D74E-9200-EB703B190439}" dt="2020-12-23T01:05:22.629" v="93" actId="1076"/>
          <ac:spMkLst>
            <pc:docMk/>
            <pc:sldMk cId="2562103204" sldId="271"/>
            <ac:spMk id="8" creationId="{9C856B6A-98E6-4841-BB8B-4B20BF289E70}"/>
          </ac:spMkLst>
        </pc:spChg>
        <pc:spChg chg="mod">
          <ac:chgData name="Wencai Zhang" userId="4a86a1d0-2108-4707-8228-1110f3c1be85" providerId="ADAL" clId="{A813DD5E-EF6A-D74E-9200-EB703B190439}" dt="2020-12-23T01:05:22.629" v="93" actId="1076"/>
          <ac:spMkLst>
            <pc:docMk/>
            <pc:sldMk cId="2562103204" sldId="271"/>
            <ac:spMk id="9" creationId="{EB467658-39E7-4F94-ADB5-86A859F1912B}"/>
          </ac:spMkLst>
        </pc:spChg>
        <pc:spChg chg="add del mod">
          <ac:chgData name="Wencai Zhang" userId="4a86a1d0-2108-4707-8228-1110f3c1be85" providerId="ADAL" clId="{A813DD5E-EF6A-D74E-9200-EB703B190439}" dt="2020-12-24T00:37:35.637" v="386" actId="478"/>
          <ac:spMkLst>
            <pc:docMk/>
            <pc:sldMk cId="2562103204" sldId="271"/>
            <ac:spMk id="19" creationId="{BF109CE8-51B4-2340-9893-6E159E7209E6}"/>
          </ac:spMkLst>
        </pc:spChg>
        <pc:spChg chg="add del mod">
          <ac:chgData name="Wencai Zhang" userId="4a86a1d0-2108-4707-8228-1110f3c1be85" providerId="ADAL" clId="{A813DD5E-EF6A-D74E-9200-EB703B190439}" dt="2020-12-24T00:37:35.637" v="386" actId="478"/>
          <ac:spMkLst>
            <pc:docMk/>
            <pc:sldMk cId="2562103204" sldId="271"/>
            <ac:spMk id="20" creationId="{DFE49A88-69F1-9D47-93FE-33B0E5A39FAE}"/>
          </ac:spMkLst>
        </pc:spChg>
        <pc:spChg chg="add del mod">
          <ac:chgData name="Wencai Zhang" userId="4a86a1d0-2108-4707-8228-1110f3c1be85" providerId="ADAL" clId="{A813DD5E-EF6A-D74E-9200-EB703B190439}" dt="2020-12-24T00:37:35.637" v="386" actId="478"/>
          <ac:spMkLst>
            <pc:docMk/>
            <pc:sldMk cId="2562103204" sldId="271"/>
            <ac:spMk id="21" creationId="{A05E77F0-8650-1248-AD3B-4EF641AAFE85}"/>
          </ac:spMkLst>
        </pc:spChg>
        <pc:spChg chg="add del mod">
          <ac:chgData name="Wencai Zhang" userId="4a86a1d0-2108-4707-8228-1110f3c1be85" providerId="ADAL" clId="{A813DD5E-EF6A-D74E-9200-EB703B190439}" dt="2020-12-24T00:37:35.637" v="386" actId="478"/>
          <ac:spMkLst>
            <pc:docMk/>
            <pc:sldMk cId="2562103204" sldId="271"/>
            <ac:spMk id="22" creationId="{32ED7292-6136-5B4A-A103-6958E7397478}"/>
          </ac:spMkLst>
        </pc:spChg>
        <pc:spChg chg="add mod">
          <ac:chgData name="Wencai Zhang" userId="4a86a1d0-2108-4707-8228-1110f3c1be85" providerId="ADAL" clId="{A813DD5E-EF6A-D74E-9200-EB703B190439}" dt="2020-12-23T17:22:39.065" v="381" actId="1076"/>
          <ac:spMkLst>
            <pc:docMk/>
            <pc:sldMk cId="2562103204" sldId="271"/>
            <ac:spMk id="23" creationId="{3C921590-F4B9-E949-BA0F-2DCE38D2F7DB}"/>
          </ac:spMkLst>
        </pc:spChg>
        <pc:spChg chg="add mod">
          <ac:chgData name="Wencai Zhang" userId="4a86a1d0-2108-4707-8228-1110f3c1be85" providerId="ADAL" clId="{A813DD5E-EF6A-D74E-9200-EB703B190439}" dt="2020-12-22T00:34:45.384" v="66" actId="20577"/>
          <ac:spMkLst>
            <pc:docMk/>
            <pc:sldMk cId="2562103204" sldId="271"/>
            <ac:spMk id="45" creationId="{B882A580-67E1-F440-B291-900E8489FA77}"/>
          </ac:spMkLst>
        </pc:spChg>
        <pc:spChg chg="add mod">
          <ac:chgData name="Wencai Zhang" userId="4a86a1d0-2108-4707-8228-1110f3c1be85" providerId="ADAL" clId="{A813DD5E-EF6A-D74E-9200-EB703B190439}" dt="2020-12-23T00:47:53.751" v="91" actId="1076"/>
          <ac:spMkLst>
            <pc:docMk/>
            <pc:sldMk cId="2562103204" sldId="271"/>
            <ac:spMk id="46" creationId="{D5B3E6F0-E1FF-2446-8547-64F1CD6C30C0}"/>
          </ac:spMkLst>
        </pc:spChg>
        <pc:spChg chg="add del mod">
          <ac:chgData name="Wencai Zhang" userId="4a86a1d0-2108-4707-8228-1110f3c1be85" providerId="ADAL" clId="{A813DD5E-EF6A-D74E-9200-EB703B190439}" dt="2020-12-24T00:37:35.637" v="386" actId="478"/>
          <ac:spMkLst>
            <pc:docMk/>
            <pc:sldMk cId="2562103204" sldId="271"/>
            <ac:spMk id="47" creationId="{EADFE855-BA49-2B49-8DF4-99272D47E072}"/>
          </ac:spMkLst>
        </pc:spChg>
        <pc:spChg chg="add del mod">
          <ac:chgData name="Wencai Zhang" userId="4a86a1d0-2108-4707-8228-1110f3c1be85" providerId="ADAL" clId="{A813DD5E-EF6A-D74E-9200-EB703B190439}" dt="2020-12-24T00:37:35.637" v="386" actId="478"/>
          <ac:spMkLst>
            <pc:docMk/>
            <pc:sldMk cId="2562103204" sldId="271"/>
            <ac:spMk id="48" creationId="{DC95A885-217F-2F45-A5DC-0AE0043B0BF3}"/>
          </ac:spMkLst>
        </pc:spChg>
        <pc:spChg chg="add del mod">
          <ac:chgData name="Wencai Zhang" userId="4a86a1d0-2108-4707-8228-1110f3c1be85" providerId="ADAL" clId="{A813DD5E-EF6A-D74E-9200-EB703B190439}" dt="2020-12-24T00:37:35.637" v="386" actId="478"/>
          <ac:spMkLst>
            <pc:docMk/>
            <pc:sldMk cId="2562103204" sldId="271"/>
            <ac:spMk id="49" creationId="{B0DCFCD0-0085-0149-8BBD-8E4E4374108C}"/>
          </ac:spMkLst>
        </pc:spChg>
        <pc:spChg chg="add del mod">
          <ac:chgData name="Wencai Zhang" userId="4a86a1d0-2108-4707-8228-1110f3c1be85" providerId="ADAL" clId="{A813DD5E-EF6A-D74E-9200-EB703B190439}" dt="2020-12-24T00:37:39.856" v="387" actId="478"/>
          <ac:spMkLst>
            <pc:docMk/>
            <pc:sldMk cId="2562103204" sldId="271"/>
            <ac:spMk id="50" creationId="{7F76F87D-80B1-3A45-9C44-41CBA0B58E4A}"/>
          </ac:spMkLst>
        </pc:spChg>
        <pc:spChg chg="add del mod">
          <ac:chgData name="Wencai Zhang" userId="4a86a1d0-2108-4707-8228-1110f3c1be85" providerId="ADAL" clId="{A813DD5E-EF6A-D74E-9200-EB703B190439}" dt="2020-12-24T00:37:39.856" v="387" actId="478"/>
          <ac:spMkLst>
            <pc:docMk/>
            <pc:sldMk cId="2562103204" sldId="271"/>
            <ac:spMk id="51" creationId="{53F781C3-5349-D94E-B45F-874779A78BD2}"/>
          </ac:spMkLst>
        </pc:spChg>
        <pc:grpChg chg="del mod">
          <ac:chgData name="Wencai Zhang" userId="4a86a1d0-2108-4707-8228-1110f3c1be85" providerId="ADAL" clId="{A813DD5E-EF6A-D74E-9200-EB703B190439}" dt="2020-12-24T00:35:34.992" v="382" actId="478"/>
          <ac:grpSpMkLst>
            <pc:docMk/>
            <pc:sldMk cId="2562103204" sldId="271"/>
            <ac:grpSpMk id="6" creationId="{5BBCE63B-3F6E-4628-9D2A-69AE69EAC276}"/>
          </ac:grpSpMkLst>
        </pc:grpChg>
        <pc:grpChg chg="del">
          <ac:chgData name="Wencai Zhang" userId="4a86a1d0-2108-4707-8228-1110f3c1be85" providerId="ADAL" clId="{A813DD5E-EF6A-D74E-9200-EB703B190439}" dt="2020-12-22T00:35:07.467" v="67" actId="478"/>
          <ac:grpSpMkLst>
            <pc:docMk/>
            <pc:sldMk cId="2562103204" sldId="271"/>
            <ac:grpSpMk id="12" creationId="{15B01F17-AC59-4BA2-BA55-EFB794259900}"/>
          </ac:grpSpMkLst>
        </pc:grpChg>
        <pc:grpChg chg="del">
          <ac:chgData name="Wencai Zhang" userId="4a86a1d0-2108-4707-8228-1110f3c1be85" providerId="ADAL" clId="{A813DD5E-EF6A-D74E-9200-EB703B190439}" dt="2020-12-23T01:22:02.483" v="146" actId="21"/>
          <ac:grpSpMkLst>
            <pc:docMk/>
            <pc:sldMk cId="2562103204" sldId="271"/>
            <ac:grpSpMk id="26" creationId="{0803CBC6-41A5-4C74-9AF1-5A04B8163ADE}"/>
          </ac:grpSpMkLst>
        </pc:grpChg>
        <pc:graphicFrameChg chg="del">
          <ac:chgData name="Wencai Zhang" userId="4a86a1d0-2108-4707-8228-1110f3c1be85" providerId="ADAL" clId="{A813DD5E-EF6A-D74E-9200-EB703B190439}" dt="2020-12-22T00:35:27.547" v="68" actId="478"/>
          <ac:graphicFrameMkLst>
            <pc:docMk/>
            <pc:sldMk cId="2562103204" sldId="271"/>
            <ac:graphicFrameMk id="3" creationId="{7067052F-377D-4FB1-BCD6-25BD2CA7B2C7}"/>
          </ac:graphicFrameMkLst>
        </pc:graphicFrameChg>
        <pc:graphicFrameChg chg="mod">
          <ac:chgData name="Wencai Zhang" userId="4a86a1d0-2108-4707-8228-1110f3c1be85" providerId="ADAL" clId="{A813DD5E-EF6A-D74E-9200-EB703B190439}" dt="2020-12-22T00:35:51.560" v="71" actId="1076"/>
          <ac:graphicFrameMkLst>
            <pc:docMk/>
            <pc:sldMk cId="2562103204" sldId="271"/>
            <ac:graphicFrameMk id="4" creationId="{FECBB647-E687-4186-8B52-0CB0DB06E286}"/>
          </ac:graphicFrameMkLst>
        </pc:graphicFrameChg>
        <pc:graphicFrameChg chg="del mod">
          <ac:chgData name="Wencai Zhang" userId="4a86a1d0-2108-4707-8228-1110f3c1be85" providerId="ADAL" clId="{A813DD5E-EF6A-D74E-9200-EB703B190439}" dt="2020-12-24T00:35:34.992" v="382" actId="478"/>
          <ac:graphicFrameMkLst>
            <pc:docMk/>
            <pc:sldMk cId="2562103204" sldId="271"/>
            <ac:graphicFrameMk id="5" creationId="{91492FF7-4DC1-45F4-90C6-3ADE091545C6}"/>
          </ac:graphicFrameMkLst>
        </pc:graphicFrameChg>
        <pc:graphicFrameChg chg="del mod">
          <ac:chgData name="Wencai Zhang" userId="4a86a1d0-2108-4707-8228-1110f3c1be85" providerId="ADAL" clId="{A813DD5E-EF6A-D74E-9200-EB703B190439}" dt="2020-12-23T01:05:07.951" v="92" actId="478"/>
          <ac:graphicFrameMkLst>
            <pc:docMk/>
            <pc:sldMk cId="2562103204" sldId="271"/>
            <ac:graphicFrameMk id="11" creationId="{4223F8AD-F09F-4E23-A8D6-4C72B161D781}"/>
          </ac:graphicFrameMkLst>
        </pc:graphicFrameChg>
        <pc:graphicFrameChg chg="del">
          <ac:chgData name="Wencai Zhang" userId="4a86a1d0-2108-4707-8228-1110f3c1be85" providerId="ADAL" clId="{A813DD5E-EF6A-D74E-9200-EB703B190439}" dt="2020-12-23T01:22:02.483" v="146" actId="21"/>
          <ac:graphicFrameMkLst>
            <pc:docMk/>
            <pc:sldMk cId="2562103204" sldId="271"/>
            <ac:graphicFrameMk id="25" creationId="{0A1AA60E-C860-4D12-A783-21D62CADDDEF}"/>
          </ac:graphicFrameMkLst>
        </pc:graphicFrameChg>
        <pc:graphicFrameChg chg="del mod">
          <ac:chgData name="Wencai Zhang" userId="4a86a1d0-2108-4707-8228-1110f3c1be85" providerId="ADAL" clId="{A813DD5E-EF6A-D74E-9200-EB703B190439}" dt="2020-12-24T00:37:35.637" v="386" actId="478"/>
          <ac:graphicFrameMkLst>
            <pc:docMk/>
            <pc:sldMk cId="2562103204" sldId="271"/>
            <ac:graphicFrameMk id="42" creationId="{E211DBCD-FED6-4E5D-B97E-D7F88C009DB2}"/>
          </ac:graphicFrameMkLst>
        </pc:graphicFrameChg>
        <pc:graphicFrameChg chg="del mod">
          <ac:chgData name="Wencai Zhang" userId="4a86a1d0-2108-4707-8228-1110f3c1be85" providerId="ADAL" clId="{A813DD5E-EF6A-D74E-9200-EB703B190439}" dt="2020-12-24T00:37:35.637" v="386" actId="478"/>
          <ac:graphicFrameMkLst>
            <pc:docMk/>
            <pc:sldMk cId="2562103204" sldId="271"/>
            <ac:graphicFrameMk id="43" creationId="{1838E2F6-5E19-4642-8B66-F4D69CBC9E05}"/>
          </ac:graphicFrameMkLst>
        </pc:graphicFrameChg>
        <pc:graphicFrameChg chg="del mod">
          <ac:chgData name="Wencai Zhang" userId="4a86a1d0-2108-4707-8228-1110f3c1be85" providerId="ADAL" clId="{A813DD5E-EF6A-D74E-9200-EB703B190439}" dt="2020-12-24T00:37:35.637" v="386" actId="478"/>
          <ac:graphicFrameMkLst>
            <pc:docMk/>
            <pc:sldMk cId="2562103204" sldId="271"/>
            <ac:graphicFrameMk id="44" creationId="{17020119-D512-4B25-8B64-9EEEEAB525FC}"/>
          </ac:graphicFrameMkLst>
        </pc:graphicFrameChg>
        <pc:picChg chg="del mod">
          <ac:chgData name="Wencai Zhang" userId="4a86a1d0-2108-4707-8228-1110f3c1be85" providerId="ADAL" clId="{A813DD5E-EF6A-D74E-9200-EB703B190439}" dt="2020-12-24T00:37:35.637" v="386" actId="478"/>
          <ac:picMkLst>
            <pc:docMk/>
            <pc:sldMk cId="2562103204" sldId="271"/>
            <ac:picMk id="10" creationId="{14E0937F-7FB1-4809-92BE-B016C2A7A156}"/>
          </ac:picMkLst>
        </pc:picChg>
      </pc:sldChg>
      <pc:sldChg chg="addSp delSp modSp add mod">
        <pc:chgData name="Wencai Zhang" userId="4a86a1d0-2108-4707-8228-1110f3c1be85" providerId="ADAL" clId="{A813DD5E-EF6A-D74E-9200-EB703B190439}" dt="2020-12-23T17:21:37.982" v="371" actId="1076"/>
        <pc:sldMkLst>
          <pc:docMk/>
          <pc:sldMk cId="555486090" sldId="272"/>
        </pc:sldMkLst>
        <pc:spChg chg="add mod">
          <ac:chgData name="Wencai Zhang" userId="4a86a1d0-2108-4707-8228-1110f3c1be85" providerId="ADAL" clId="{A813DD5E-EF6A-D74E-9200-EB703B190439}" dt="2020-12-23T01:25:46.834" v="314" actId="1076"/>
          <ac:spMkLst>
            <pc:docMk/>
            <pc:sldMk cId="555486090" sldId="272"/>
            <ac:spMk id="2" creationId="{62A0247D-6003-704B-9909-D67560E97746}"/>
          </ac:spMkLst>
        </pc:spChg>
        <pc:spChg chg="add mod">
          <ac:chgData name="Wencai Zhang" userId="4a86a1d0-2108-4707-8228-1110f3c1be85" providerId="ADAL" clId="{A813DD5E-EF6A-D74E-9200-EB703B190439}" dt="2020-12-23T17:19:53.763" v="365" actId="207"/>
          <ac:spMkLst>
            <pc:docMk/>
            <pc:sldMk cId="555486090" sldId="272"/>
            <ac:spMk id="4" creationId="{1515AAF5-B1D8-AF4D-9FD6-B3084B37A167}"/>
          </ac:spMkLst>
        </pc:spChg>
        <pc:spChg chg="mod">
          <ac:chgData name="Wencai Zhang" userId="4a86a1d0-2108-4707-8228-1110f3c1be85" providerId="ADAL" clId="{A813DD5E-EF6A-D74E-9200-EB703B190439}" dt="2020-12-23T01:25:46.834" v="314" actId="1076"/>
          <ac:spMkLst>
            <pc:docMk/>
            <pc:sldMk cId="555486090" sldId="272"/>
            <ac:spMk id="7" creationId="{6C6543DB-A79E-4B7B-9E18-CB9461DC5821}"/>
          </ac:spMkLst>
        </pc:spChg>
        <pc:spChg chg="mod">
          <ac:chgData name="Wencai Zhang" userId="4a86a1d0-2108-4707-8228-1110f3c1be85" providerId="ADAL" clId="{A813DD5E-EF6A-D74E-9200-EB703B190439}" dt="2020-12-23T01:25:46.834" v="314" actId="1076"/>
          <ac:spMkLst>
            <pc:docMk/>
            <pc:sldMk cId="555486090" sldId="272"/>
            <ac:spMk id="8" creationId="{9C856B6A-98E6-4841-BB8B-4B20BF289E70}"/>
          </ac:spMkLst>
        </pc:spChg>
        <pc:spChg chg="mod">
          <ac:chgData name="Wencai Zhang" userId="4a86a1d0-2108-4707-8228-1110f3c1be85" providerId="ADAL" clId="{A813DD5E-EF6A-D74E-9200-EB703B190439}" dt="2020-12-23T01:25:46.834" v="314" actId="1076"/>
          <ac:spMkLst>
            <pc:docMk/>
            <pc:sldMk cId="555486090" sldId="272"/>
            <ac:spMk id="9" creationId="{EB467658-39E7-4F94-ADB5-86A859F1912B}"/>
          </ac:spMkLst>
        </pc:spChg>
        <pc:spChg chg="mod">
          <ac:chgData name="Wencai Zhang" userId="4a86a1d0-2108-4707-8228-1110f3c1be85" providerId="ADAL" clId="{A813DD5E-EF6A-D74E-9200-EB703B190439}" dt="2020-12-23T01:25:46.834" v="314" actId="1076"/>
          <ac:spMkLst>
            <pc:docMk/>
            <pc:sldMk cId="555486090" sldId="272"/>
            <ac:spMk id="14" creationId="{F2CF0DDF-2105-41B2-A771-E6152B5E7EAC}"/>
          </ac:spMkLst>
        </pc:spChg>
        <pc:spChg chg="mod">
          <ac:chgData name="Wencai Zhang" userId="4a86a1d0-2108-4707-8228-1110f3c1be85" providerId="ADAL" clId="{A813DD5E-EF6A-D74E-9200-EB703B190439}" dt="2020-12-23T01:25:46.834" v="314" actId="1076"/>
          <ac:spMkLst>
            <pc:docMk/>
            <pc:sldMk cId="555486090" sldId="272"/>
            <ac:spMk id="15" creationId="{FA8A4BA1-E8A5-4368-8B8E-D6B9C65F24D5}"/>
          </ac:spMkLst>
        </pc:spChg>
        <pc:spChg chg="mod">
          <ac:chgData name="Wencai Zhang" userId="4a86a1d0-2108-4707-8228-1110f3c1be85" providerId="ADAL" clId="{A813DD5E-EF6A-D74E-9200-EB703B190439}" dt="2020-12-23T01:25:46.834" v="314" actId="1076"/>
          <ac:spMkLst>
            <pc:docMk/>
            <pc:sldMk cId="555486090" sldId="272"/>
            <ac:spMk id="17" creationId="{AA556D15-7026-4ACB-8A16-89B31966DE69}"/>
          </ac:spMkLst>
        </pc:spChg>
        <pc:spChg chg="mod">
          <ac:chgData name="Wencai Zhang" userId="4a86a1d0-2108-4707-8228-1110f3c1be85" providerId="ADAL" clId="{A813DD5E-EF6A-D74E-9200-EB703B190439}" dt="2020-12-23T01:49:05.089" v="336" actId="20577"/>
          <ac:spMkLst>
            <pc:docMk/>
            <pc:sldMk cId="555486090" sldId="272"/>
            <ac:spMk id="35" creationId="{3CD46702-79E1-4022-BE80-E030647E61EA}"/>
          </ac:spMkLst>
        </pc:spChg>
        <pc:spChg chg="del mod">
          <ac:chgData name="Wencai Zhang" userId="4a86a1d0-2108-4707-8228-1110f3c1be85" providerId="ADAL" clId="{A813DD5E-EF6A-D74E-9200-EB703B190439}" dt="2020-12-23T01:54:44.646" v="340" actId="478"/>
          <ac:spMkLst>
            <pc:docMk/>
            <pc:sldMk cId="555486090" sldId="272"/>
            <ac:spMk id="36" creationId="{CA53CCF7-CE6D-4D97-9453-E04CD06BDF51}"/>
          </ac:spMkLst>
        </pc:spChg>
        <pc:spChg chg="mod">
          <ac:chgData name="Wencai Zhang" userId="4a86a1d0-2108-4707-8228-1110f3c1be85" providerId="ADAL" clId="{A813DD5E-EF6A-D74E-9200-EB703B190439}" dt="2020-12-23T01:44:30.765" v="321" actId="1076"/>
          <ac:spMkLst>
            <pc:docMk/>
            <pc:sldMk cId="555486090" sldId="272"/>
            <ac:spMk id="37" creationId="{183B7CA4-46A0-4371-AEFB-BCF6539CB67B}"/>
          </ac:spMkLst>
        </pc:spChg>
        <pc:spChg chg="mod">
          <ac:chgData name="Wencai Zhang" userId="4a86a1d0-2108-4707-8228-1110f3c1be85" providerId="ADAL" clId="{A813DD5E-EF6A-D74E-9200-EB703B190439}" dt="2020-12-23T01:44:30.765" v="321" actId="1076"/>
          <ac:spMkLst>
            <pc:docMk/>
            <pc:sldMk cId="555486090" sldId="272"/>
            <ac:spMk id="39" creationId="{2FF524B7-0E31-48D2-9DE4-DBF18908290E}"/>
          </ac:spMkLst>
        </pc:spChg>
        <pc:spChg chg="mod">
          <ac:chgData name="Wencai Zhang" userId="4a86a1d0-2108-4707-8228-1110f3c1be85" providerId="ADAL" clId="{A813DD5E-EF6A-D74E-9200-EB703B190439}" dt="2020-12-23T01:44:30.765" v="321" actId="1076"/>
          <ac:spMkLst>
            <pc:docMk/>
            <pc:sldMk cId="555486090" sldId="272"/>
            <ac:spMk id="41" creationId="{99FDF159-51A5-4577-A7B2-699B6A37C5A0}"/>
          </ac:spMkLst>
        </pc:spChg>
        <pc:spChg chg="add mod">
          <ac:chgData name="Wencai Zhang" userId="4a86a1d0-2108-4707-8228-1110f3c1be85" providerId="ADAL" clId="{A813DD5E-EF6A-D74E-9200-EB703B190439}" dt="2020-12-23T17:20:02.847" v="367" actId="1076"/>
          <ac:spMkLst>
            <pc:docMk/>
            <pc:sldMk cId="555486090" sldId="272"/>
            <ac:spMk id="42" creationId="{89EDAEB4-CA84-D441-9589-6D12D20313AD}"/>
          </ac:spMkLst>
        </pc:spChg>
        <pc:spChg chg="add mod">
          <ac:chgData name="Wencai Zhang" userId="4a86a1d0-2108-4707-8228-1110f3c1be85" providerId="ADAL" clId="{A813DD5E-EF6A-D74E-9200-EB703B190439}" dt="2020-12-23T17:21:34.470" v="369" actId="1076"/>
          <ac:spMkLst>
            <pc:docMk/>
            <pc:sldMk cId="555486090" sldId="272"/>
            <ac:spMk id="43" creationId="{37CFE433-1F3F-2F4B-90BE-2C0A049BAF5D}"/>
          </ac:spMkLst>
        </pc:spChg>
        <pc:spChg chg="add mod">
          <ac:chgData name="Wencai Zhang" userId="4a86a1d0-2108-4707-8228-1110f3c1be85" providerId="ADAL" clId="{A813DD5E-EF6A-D74E-9200-EB703B190439}" dt="2020-12-23T17:21:37.982" v="371" actId="1076"/>
          <ac:spMkLst>
            <pc:docMk/>
            <pc:sldMk cId="555486090" sldId="272"/>
            <ac:spMk id="44" creationId="{6B65C643-D0FC-764C-BE41-6D5DB9FE3C3C}"/>
          </ac:spMkLst>
        </pc:spChg>
        <pc:spChg chg="add mod">
          <ac:chgData name="Wencai Zhang" userId="4a86a1d0-2108-4707-8228-1110f3c1be85" providerId="ADAL" clId="{A813DD5E-EF6A-D74E-9200-EB703B190439}" dt="2020-12-23T01:25:46.834" v="314" actId="1076"/>
          <ac:spMkLst>
            <pc:docMk/>
            <pc:sldMk cId="555486090" sldId="272"/>
            <ac:spMk id="45" creationId="{B2AA6943-EB8B-EE4C-9137-93FF3149EADA}"/>
          </ac:spMkLst>
        </pc:spChg>
        <pc:spChg chg="add mod">
          <ac:chgData name="Wencai Zhang" userId="4a86a1d0-2108-4707-8228-1110f3c1be85" providerId="ADAL" clId="{A813DD5E-EF6A-D74E-9200-EB703B190439}" dt="2020-12-23T01:25:46.834" v="314" actId="1076"/>
          <ac:spMkLst>
            <pc:docMk/>
            <pc:sldMk cId="555486090" sldId="272"/>
            <ac:spMk id="46" creationId="{AE153BE9-E801-9F46-B19E-88780C594949}"/>
          </ac:spMkLst>
        </pc:spChg>
        <pc:spChg chg="add del mod">
          <ac:chgData name="Wencai Zhang" userId="4a86a1d0-2108-4707-8228-1110f3c1be85" providerId="ADAL" clId="{A813DD5E-EF6A-D74E-9200-EB703B190439}" dt="2020-12-23T00:47:15.853" v="83"/>
          <ac:spMkLst>
            <pc:docMk/>
            <pc:sldMk cId="555486090" sldId="272"/>
            <ac:spMk id="47" creationId="{5F1E6A7B-785F-E24A-AA73-405BFBDE77AD}"/>
          </ac:spMkLst>
        </pc:spChg>
        <pc:spChg chg="add del mod">
          <ac:chgData name="Wencai Zhang" userId="4a86a1d0-2108-4707-8228-1110f3c1be85" providerId="ADAL" clId="{A813DD5E-EF6A-D74E-9200-EB703B190439}" dt="2020-12-23T00:47:14.201" v="81"/>
          <ac:spMkLst>
            <pc:docMk/>
            <pc:sldMk cId="555486090" sldId="272"/>
            <ac:spMk id="48" creationId="{E51DA2D6-9A1B-1D44-919A-CC7375F7F2C7}"/>
          </ac:spMkLst>
        </pc:spChg>
        <pc:spChg chg="add del mod">
          <ac:chgData name="Wencai Zhang" userId="4a86a1d0-2108-4707-8228-1110f3c1be85" providerId="ADAL" clId="{A813DD5E-EF6A-D74E-9200-EB703B190439}" dt="2020-12-23T00:47:27.419" v="87"/>
          <ac:spMkLst>
            <pc:docMk/>
            <pc:sldMk cId="555486090" sldId="272"/>
            <ac:spMk id="49" creationId="{3B71D9A2-6A86-3A4F-9D3A-9764B8BA5442}"/>
          </ac:spMkLst>
        </pc:spChg>
        <pc:spChg chg="add del mod">
          <ac:chgData name="Wencai Zhang" userId="4a86a1d0-2108-4707-8228-1110f3c1be85" providerId="ADAL" clId="{A813DD5E-EF6A-D74E-9200-EB703B190439}" dt="2020-12-23T00:47:29.102" v="89"/>
          <ac:spMkLst>
            <pc:docMk/>
            <pc:sldMk cId="555486090" sldId="272"/>
            <ac:spMk id="50" creationId="{93CD84BF-DE59-9441-A3E7-3FD2A42DC4EC}"/>
          </ac:spMkLst>
        </pc:spChg>
        <pc:spChg chg="add mod">
          <ac:chgData name="Wencai Zhang" userId="4a86a1d0-2108-4707-8228-1110f3c1be85" providerId="ADAL" clId="{A813DD5E-EF6A-D74E-9200-EB703B190439}" dt="2020-12-23T01:25:50.534" v="316" actId="20577"/>
          <ac:spMkLst>
            <pc:docMk/>
            <pc:sldMk cId="555486090" sldId="272"/>
            <ac:spMk id="51" creationId="{E37AD563-CB3E-E24F-B69A-5D3C8532C49B}"/>
          </ac:spMkLst>
        </pc:spChg>
        <pc:spChg chg="add mod">
          <ac:chgData name="Wencai Zhang" userId="4a86a1d0-2108-4707-8228-1110f3c1be85" providerId="ADAL" clId="{A813DD5E-EF6A-D74E-9200-EB703B190439}" dt="2020-12-23T01:25:53.221" v="318" actId="20577"/>
          <ac:spMkLst>
            <pc:docMk/>
            <pc:sldMk cId="555486090" sldId="272"/>
            <ac:spMk id="52" creationId="{2551E2E5-9EEC-084B-B42A-894A2E03799D}"/>
          </ac:spMkLst>
        </pc:spChg>
        <pc:spChg chg="add mod">
          <ac:chgData name="Wencai Zhang" userId="4a86a1d0-2108-4707-8228-1110f3c1be85" providerId="ADAL" clId="{A813DD5E-EF6A-D74E-9200-EB703B190439}" dt="2020-12-23T01:45:59.188" v="325" actId="20577"/>
          <ac:spMkLst>
            <pc:docMk/>
            <pc:sldMk cId="555486090" sldId="272"/>
            <ac:spMk id="53" creationId="{D6BBD254-7480-734E-B168-8777EB93D3F8}"/>
          </ac:spMkLst>
        </pc:spChg>
        <pc:grpChg chg="mod">
          <ac:chgData name="Wencai Zhang" userId="4a86a1d0-2108-4707-8228-1110f3c1be85" providerId="ADAL" clId="{A813DD5E-EF6A-D74E-9200-EB703B190439}" dt="2020-12-23T01:25:46.834" v="314" actId="1076"/>
          <ac:grpSpMkLst>
            <pc:docMk/>
            <pc:sldMk cId="555486090" sldId="272"/>
            <ac:grpSpMk id="6" creationId="{5BBCE63B-3F6E-4628-9D2A-69AE69EAC276}"/>
          </ac:grpSpMkLst>
        </pc:grpChg>
        <pc:grpChg chg="mod">
          <ac:chgData name="Wencai Zhang" userId="4a86a1d0-2108-4707-8228-1110f3c1be85" providerId="ADAL" clId="{A813DD5E-EF6A-D74E-9200-EB703B190439}" dt="2020-12-23T01:25:46.834" v="314" actId="1076"/>
          <ac:grpSpMkLst>
            <pc:docMk/>
            <pc:sldMk cId="555486090" sldId="272"/>
            <ac:grpSpMk id="12" creationId="{15B01F17-AC59-4BA2-BA55-EFB794259900}"/>
          </ac:grpSpMkLst>
        </pc:grpChg>
        <pc:grpChg chg="mod">
          <ac:chgData name="Wencai Zhang" userId="4a86a1d0-2108-4707-8228-1110f3c1be85" providerId="ADAL" clId="{A813DD5E-EF6A-D74E-9200-EB703B190439}" dt="2020-12-23T01:25:46.834" v="314" actId="1076"/>
          <ac:grpSpMkLst>
            <pc:docMk/>
            <pc:sldMk cId="555486090" sldId="272"/>
            <ac:grpSpMk id="13" creationId="{A8ADF8AD-4936-453B-8E63-1FAC7F47221D}"/>
          </ac:grpSpMkLst>
        </pc:grpChg>
        <pc:grpChg chg="mod">
          <ac:chgData name="Wencai Zhang" userId="4a86a1d0-2108-4707-8228-1110f3c1be85" providerId="ADAL" clId="{A813DD5E-EF6A-D74E-9200-EB703B190439}" dt="2020-12-23T01:25:46.834" v="314" actId="1076"/>
          <ac:grpSpMkLst>
            <pc:docMk/>
            <pc:sldMk cId="555486090" sldId="272"/>
            <ac:grpSpMk id="16" creationId="{E75124E7-0FAF-4238-B9D2-FC3DF7199FBF}"/>
          </ac:grpSpMkLst>
        </pc:grpChg>
        <pc:grpChg chg="mod">
          <ac:chgData name="Wencai Zhang" userId="4a86a1d0-2108-4707-8228-1110f3c1be85" providerId="ADAL" clId="{A813DD5E-EF6A-D74E-9200-EB703B190439}" dt="2020-12-23T01:44:30.765" v="321" actId="1076"/>
          <ac:grpSpMkLst>
            <pc:docMk/>
            <pc:sldMk cId="555486090" sldId="272"/>
            <ac:grpSpMk id="26" creationId="{0803CBC6-41A5-4C74-9AF1-5A04B8163ADE}"/>
          </ac:grpSpMkLst>
        </pc:grpChg>
        <pc:grpChg chg="mod">
          <ac:chgData name="Wencai Zhang" userId="4a86a1d0-2108-4707-8228-1110f3c1be85" providerId="ADAL" clId="{A813DD5E-EF6A-D74E-9200-EB703B190439}" dt="2020-12-23T01:44:30.765" v="321" actId="1076"/>
          <ac:grpSpMkLst>
            <pc:docMk/>
            <pc:sldMk cId="555486090" sldId="272"/>
            <ac:grpSpMk id="27" creationId="{0E11CCF2-473B-47E6-964D-9AF6ECCFE9C7}"/>
          </ac:grpSpMkLst>
        </pc:grpChg>
        <pc:grpChg chg="mod">
          <ac:chgData name="Wencai Zhang" userId="4a86a1d0-2108-4707-8228-1110f3c1be85" providerId="ADAL" clId="{A813DD5E-EF6A-D74E-9200-EB703B190439}" dt="2020-12-23T01:44:30.765" v="321" actId="1076"/>
          <ac:grpSpMkLst>
            <pc:docMk/>
            <pc:sldMk cId="555486090" sldId="272"/>
            <ac:grpSpMk id="29" creationId="{B2C79571-2AF8-4871-848C-7ECD4EC123C4}"/>
          </ac:grpSpMkLst>
        </pc:grpChg>
        <pc:grpChg chg="mod">
          <ac:chgData name="Wencai Zhang" userId="4a86a1d0-2108-4707-8228-1110f3c1be85" providerId="ADAL" clId="{A813DD5E-EF6A-D74E-9200-EB703B190439}" dt="2020-12-23T01:44:30.765" v="321" actId="1076"/>
          <ac:grpSpMkLst>
            <pc:docMk/>
            <pc:sldMk cId="555486090" sldId="272"/>
            <ac:grpSpMk id="30" creationId="{9A089C50-AA9D-42E7-ADA1-E34FED23432B}"/>
          </ac:grpSpMkLst>
        </pc:grpChg>
        <pc:graphicFrameChg chg="mod">
          <ac:chgData name="Wencai Zhang" userId="4a86a1d0-2108-4707-8228-1110f3c1be85" providerId="ADAL" clId="{A813DD5E-EF6A-D74E-9200-EB703B190439}" dt="2020-12-23T01:25:46.834" v="314" actId="1076"/>
          <ac:graphicFrameMkLst>
            <pc:docMk/>
            <pc:sldMk cId="555486090" sldId="272"/>
            <ac:graphicFrameMk id="3" creationId="{7067052F-377D-4FB1-BCD6-25BD2CA7B2C7}"/>
          </ac:graphicFrameMkLst>
        </pc:graphicFrameChg>
        <pc:graphicFrameChg chg="del">
          <ac:chgData name="Wencai Zhang" userId="4a86a1d0-2108-4707-8228-1110f3c1be85" providerId="ADAL" clId="{A813DD5E-EF6A-D74E-9200-EB703B190439}" dt="2020-12-22T00:34:19.783" v="58" actId="478"/>
          <ac:graphicFrameMkLst>
            <pc:docMk/>
            <pc:sldMk cId="555486090" sldId="272"/>
            <ac:graphicFrameMk id="4" creationId="{FECBB647-E687-4186-8B52-0CB0DB06E286}"/>
          </ac:graphicFrameMkLst>
        </pc:graphicFrameChg>
        <pc:graphicFrameChg chg="mod">
          <ac:chgData name="Wencai Zhang" userId="4a86a1d0-2108-4707-8228-1110f3c1be85" providerId="ADAL" clId="{A813DD5E-EF6A-D74E-9200-EB703B190439}" dt="2020-12-23T01:25:46.834" v="314" actId="1076"/>
          <ac:graphicFrameMkLst>
            <pc:docMk/>
            <pc:sldMk cId="555486090" sldId="272"/>
            <ac:graphicFrameMk id="5" creationId="{91492FF7-4DC1-45F4-90C6-3ADE091545C6}"/>
          </ac:graphicFrameMkLst>
        </pc:graphicFrameChg>
        <pc:graphicFrameChg chg="del">
          <ac:chgData name="Wencai Zhang" userId="4a86a1d0-2108-4707-8228-1110f3c1be85" providerId="ADAL" clId="{A813DD5E-EF6A-D74E-9200-EB703B190439}" dt="2020-12-22T00:32:40.051" v="45" actId="478"/>
          <ac:graphicFrameMkLst>
            <pc:docMk/>
            <pc:sldMk cId="555486090" sldId="272"/>
            <ac:graphicFrameMk id="11" creationId="{4223F8AD-F09F-4E23-A8D6-4C72B161D781}"/>
          </ac:graphicFrameMkLst>
        </pc:graphicFrameChg>
        <pc:graphicFrameChg chg="mod">
          <ac:chgData name="Wencai Zhang" userId="4a86a1d0-2108-4707-8228-1110f3c1be85" providerId="ADAL" clId="{A813DD5E-EF6A-D74E-9200-EB703B190439}" dt="2020-12-23T01:25:46.834" v="314" actId="1076"/>
          <ac:graphicFrameMkLst>
            <pc:docMk/>
            <pc:sldMk cId="555486090" sldId="272"/>
            <ac:graphicFrameMk id="25" creationId="{0A1AA60E-C860-4D12-A783-21D62CADDDEF}"/>
          </ac:graphicFrameMkLst>
        </pc:graphicFrameChg>
        <pc:graphicFrameChg chg="mod">
          <ac:chgData name="Wencai Zhang" userId="4a86a1d0-2108-4707-8228-1110f3c1be85" providerId="ADAL" clId="{A813DD5E-EF6A-D74E-9200-EB703B190439}" dt="2020-12-23T01:54:10.530" v="337" actId="14100"/>
          <ac:graphicFrameMkLst>
            <pc:docMk/>
            <pc:sldMk cId="555486090" sldId="272"/>
            <ac:graphicFrameMk id="28" creationId="{6DE37873-86DA-4861-99FF-6B2BA260EFC9}"/>
          </ac:graphicFrameMkLst>
        </pc:graphicFrameChg>
        <pc:graphicFrameChg chg="del mod">
          <ac:chgData name="Wencai Zhang" userId="4a86a1d0-2108-4707-8228-1110f3c1be85" providerId="ADAL" clId="{A813DD5E-EF6A-D74E-9200-EB703B190439}" dt="2020-12-23T01:44:19.398" v="319" actId="478"/>
          <ac:graphicFrameMkLst>
            <pc:docMk/>
            <pc:sldMk cId="555486090" sldId="272"/>
            <ac:graphicFrameMk id="42" creationId="{E211DBCD-FED6-4E5D-B97E-D7F88C009DB2}"/>
          </ac:graphicFrameMkLst>
        </pc:graphicFrameChg>
        <pc:graphicFrameChg chg="del mod">
          <ac:chgData name="Wencai Zhang" userId="4a86a1d0-2108-4707-8228-1110f3c1be85" providerId="ADAL" clId="{A813DD5E-EF6A-D74E-9200-EB703B190439}" dt="2020-12-23T01:44:19.398" v="319" actId="478"/>
          <ac:graphicFrameMkLst>
            <pc:docMk/>
            <pc:sldMk cId="555486090" sldId="272"/>
            <ac:graphicFrameMk id="43" creationId="{1838E2F6-5E19-4642-8B66-F4D69CBC9E05}"/>
          </ac:graphicFrameMkLst>
        </pc:graphicFrameChg>
        <pc:graphicFrameChg chg="del mod">
          <ac:chgData name="Wencai Zhang" userId="4a86a1d0-2108-4707-8228-1110f3c1be85" providerId="ADAL" clId="{A813DD5E-EF6A-D74E-9200-EB703B190439}" dt="2020-12-23T01:44:24.694" v="320" actId="478"/>
          <ac:graphicFrameMkLst>
            <pc:docMk/>
            <pc:sldMk cId="555486090" sldId="272"/>
            <ac:graphicFrameMk id="44" creationId="{17020119-D512-4B25-8B64-9EEEEAB525FC}"/>
          </ac:graphicFrameMkLst>
        </pc:graphicFrameChg>
        <pc:picChg chg="del">
          <ac:chgData name="Wencai Zhang" userId="4a86a1d0-2108-4707-8228-1110f3c1be85" providerId="ADAL" clId="{A813DD5E-EF6A-D74E-9200-EB703B190439}" dt="2020-12-22T00:32:04.197" v="43" actId="478"/>
          <ac:picMkLst>
            <pc:docMk/>
            <pc:sldMk cId="555486090" sldId="272"/>
            <ac:picMk id="10" creationId="{14E0937F-7FB1-4809-92BE-B016C2A7A156}"/>
          </ac:picMkLst>
        </pc:picChg>
        <pc:picChg chg="mod">
          <ac:chgData name="Wencai Zhang" userId="4a86a1d0-2108-4707-8228-1110f3c1be85" providerId="ADAL" clId="{A813DD5E-EF6A-D74E-9200-EB703B190439}" dt="2020-12-23T01:25:46.834" v="314" actId="1076"/>
          <ac:picMkLst>
            <pc:docMk/>
            <pc:sldMk cId="555486090" sldId="272"/>
            <ac:picMk id="18" creationId="{8300A042-3D8A-42A6-B11B-15AEA36C834A}"/>
          </ac:picMkLst>
        </pc:picChg>
        <pc:picChg chg="mod">
          <ac:chgData name="Wencai Zhang" userId="4a86a1d0-2108-4707-8228-1110f3c1be85" providerId="ADAL" clId="{A813DD5E-EF6A-D74E-9200-EB703B190439}" dt="2020-12-23T01:25:46.834" v="314" actId="1076"/>
          <ac:picMkLst>
            <pc:docMk/>
            <pc:sldMk cId="555486090" sldId="272"/>
            <ac:picMk id="19" creationId="{647F4939-1A2B-4C56-817A-AEE61453D508}"/>
          </ac:picMkLst>
        </pc:picChg>
        <pc:picChg chg="mod">
          <ac:chgData name="Wencai Zhang" userId="4a86a1d0-2108-4707-8228-1110f3c1be85" providerId="ADAL" clId="{A813DD5E-EF6A-D74E-9200-EB703B190439}" dt="2020-12-23T01:25:46.834" v="314" actId="1076"/>
          <ac:picMkLst>
            <pc:docMk/>
            <pc:sldMk cId="555486090" sldId="272"/>
            <ac:picMk id="20" creationId="{CA72BFF6-85C3-40A8-8A92-5B8818AD2492}"/>
          </ac:picMkLst>
        </pc:picChg>
        <pc:picChg chg="mod">
          <ac:chgData name="Wencai Zhang" userId="4a86a1d0-2108-4707-8228-1110f3c1be85" providerId="ADAL" clId="{A813DD5E-EF6A-D74E-9200-EB703B190439}" dt="2020-12-23T01:25:46.834" v="314" actId="1076"/>
          <ac:picMkLst>
            <pc:docMk/>
            <pc:sldMk cId="555486090" sldId="272"/>
            <ac:picMk id="22" creationId="{F307A6D6-56CA-43C4-9F2D-7E9215D1FC51}"/>
          </ac:picMkLst>
        </pc:picChg>
        <pc:picChg chg="mod">
          <ac:chgData name="Wencai Zhang" userId="4a86a1d0-2108-4707-8228-1110f3c1be85" providerId="ADAL" clId="{A813DD5E-EF6A-D74E-9200-EB703B190439}" dt="2020-12-23T01:25:46.834" v="314" actId="1076"/>
          <ac:picMkLst>
            <pc:docMk/>
            <pc:sldMk cId="555486090" sldId="272"/>
            <ac:picMk id="23" creationId="{6B81F09F-CC72-4483-B955-C131B3DFA02F}"/>
          </ac:picMkLst>
        </pc:picChg>
        <pc:picChg chg="mod">
          <ac:chgData name="Wencai Zhang" userId="4a86a1d0-2108-4707-8228-1110f3c1be85" providerId="ADAL" clId="{A813DD5E-EF6A-D74E-9200-EB703B190439}" dt="2020-12-23T01:25:46.834" v="314" actId="1076"/>
          <ac:picMkLst>
            <pc:docMk/>
            <pc:sldMk cId="555486090" sldId="272"/>
            <ac:picMk id="24" creationId="{04AA4DFD-B189-45F9-8954-5E7D202E2C71}"/>
          </ac:picMkLst>
        </pc:picChg>
        <pc:picChg chg="del mod">
          <ac:chgData name="Wencai Zhang" userId="4a86a1d0-2108-4707-8228-1110f3c1be85" providerId="ADAL" clId="{A813DD5E-EF6A-D74E-9200-EB703B190439}" dt="2020-12-23T01:54:41.392" v="339" actId="478"/>
          <ac:picMkLst>
            <pc:docMk/>
            <pc:sldMk cId="555486090" sldId="272"/>
            <ac:picMk id="31" creationId="{1D68C3EF-88CD-402F-8A60-EC95AD6704D1}"/>
          </ac:picMkLst>
        </pc:picChg>
        <pc:picChg chg="mod">
          <ac:chgData name="Wencai Zhang" userId="4a86a1d0-2108-4707-8228-1110f3c1be85" providerId="ADAL" clId="{A813DD5E-EF6A-D74E-9200-EB703B190439}" dt="2020-12-23T01:44:30.765" v="321" actId="1076"/>
          <ac:picMkLst>
            <pc:docMk/>
            <pc:sldMk cId="555486090" sldId="272"/>
            <ac:picMk id="32" creationId="{55EE5086-2E5A-45D4-9330-4E6307F5124B}"/>
          </ac:picMkLst>
        </pc:picChg>
        <pc:picChg chg="mod">
          <ac:chgData name="Wencai Zhang" userId="4a86a1d0-2108-4707-8228-1110f3c1be85" providerId="ADAL" clId="{A813DD5E-EF6A-D74E-9200-EB703B190439}" dt="2020-12-23T01:44:30.765" v="321" actId="1076"/>
          <ac:picMkLst>
            <pc:docMk/>
            <pc:sldMk cId="555486090" sldId="272"/>
            <ac:picMk id="33" creationId="{ED4F1A12-5D07-4879-9DDA-5F11E0FCD50B}"/>
          </ac:picMkLst>
        </pc:picChg>
        <pc:picChg chg="del mod">
          <ac:chgData name="Wencai Zhang" userId="4a86a1d0-2108-4707-8228-1110f3c1be85" providerId="ADAL" clId="{A813DD5E-EF6A-D74E-9200-EB703B190439}" dt="2020-12-23T01:54:38.775" v="338" actId="478"/>
          <ac:picMkLst>
            <pc:docMk/>
            <pc:sldMk cId="555486090" sldId="272"/>
            <ac:picMk id="34" creationId="{47BFBDA0-361B-4D27-8DF5-55E9A2C9812F}"/>
          </ac:picMkLst>
        </pc:picChg>
        <pc:picChg chg="mod">
          <ac:chgData name="Wencai Zhang" userId="4a86a1d0-2108-4707-8228-1110f3c1be85" providerId="ADAL" clId="{A813DD5E-EF6A-D74E-9200-EB703B190439}" dt="2020-12-23T01:44:30.765" v="321" actId="1076"/>
          <ac:picMkLst>
            <pc:docMk/>
            <pc:sldMk cId="555486090" sldId="272"/>
            <ac:picMk id="38" creationId="{6CB0A001-8D65-4213-8838-FE016B2FF9B8}"/>
          </ac:picMkLst>
        </pc:picChg>
        <pc:picChg chg="mod">
          <ac:chgData name="Wencai Zhang" userId="4a86a1d0-2108-4707-8228-1110f3c1be85" providerId="ADAL" clId="{A813DD5E-EF6A-D74E-9200-EB703B190439}" dt="2020-12-23T01:44:30.765" v="321" actId="1076"/>
          <ac:picMkLst>
            <pc:docMk/>
            <pc:sldMk cId="555486090" sldId="272"/>
            <ac:picMk id="40" creationId="{71E183B4-1D02-4877-A19F-52EDF7D572F3}"/>
          </ac:picMkLst>
        </pc:picChg>
        <pc:cxnChg chg="mod">
          <ac:chgData name="Wencai Zhang" userId="4a86a1d0-2108-4707-8228-1110f3c1be85" providerId="ADAL" clId="{A813DD5E-EF6A-D74E-9200-EB703B190439}" dt="2020-12-23T01:25:46.834" v="314" actId="1076"/>
          <ac:cxnSpMkLst>
            <pc:docMk/>
            <pc:sldMk cId="555486090" sldId="272"/>
            <ac:cxnSpMk id="21" creationId="{5CC220F3-4B33-4BDF-8C34-F82E869578EC}"/>
          </ac:cxnSpMkLst>
        </pc:cxnChg>
      </pc:sldChg>
      <pc:sldChg chg="new del">
        <pc:chgData name="Wencai Zhang" userId="4a86a1d0-2108-4707-8228-1110f3c1be85" providerId="ADAL" clId="{A813DD5E-EF6A-D74E-9200-EB703B190439}" dt="2020-12-23T02:04:20.457" v="347" actId="2696"/>
        <pc:sldMkLst>
          <pc:docMk/>
          <pc:sldMk cId="1217043507" sldId="273"/>
        </pc:sldMkLst>
      </pc:sldChg>
      <pc:sldChg chg="delSp modSp add mod">
        <pc:chgData name="Wencai Zhang" userId="4a86a1d0-2108-4707-8228-1110f3c1be85" providerId="ADAL" clId="{A813DD5E-EF6A-D74E-9200-EB703B190439}" dt="2020-12-27T16:01:48.517" v="544" actId="20577"/>
        <pc:sldMkLst>
          <pc:docMk/>
          <pc:sldMk cId="3603884933" sldId="273"/>
        </pc:sldMkLst>
        <pc:spChg chg="mod">
          <ac:chgData name="Wencai Zhang" userId="4a86a1d0-2108-4707-8228-1110f3c1be85" providerId="ADAL" clId="{A813DD5E-EF6A-D74E-9200-EB703B190439}" dt="2020-12-27T16:01:48.517" v="544" actId="20577"/>
          <ac:spMkLst>
            <pc:docMk/>
            <pc:sldMk cId="3603884933" sldId="273"/>
            <ac:spMk id="19" creationId="{BF109CE8-51B4-2340-9893-6E159E7209E6}"/>
          </ac:spMkLst>
        </pc:spChg>
        <pc:spChg chg="del">
          <ac:chgData name="Wencai Zhang" userId="4a86a1d0-2108-4707-8228-1110f3c1be85" providerId="ADAL" clId="{A813DD5E-EF6A-D74E-9200-EB703B190439}" dt="2020-12-24T00:37:57.195" v="392" actId="478"/>
          <ac:spMkLst>
            <pc:docMk/>
            <pc:sldMk cId="3603884933" sldId="273"/>
            <ac:spMk id="20" creationId="{DFE49A88-69F1-9D47-93FE-33B0E5A39FAE}"/>
          </ac:spMkLst>
        </pc:spChg>
        <pc:spChg chg="del">
          <ac:chgData name="Wencai Zhang" userId="4a86a1d0-2108-4707-8228-1110f3c1be85" providerId="ADAL" clId="{A813DD5E-EF6A-D74E-9200-EB703B190439}" dt="2020-12-24T00:37:57.195" v="392" actId="478"/>
          <ac:spMkLst>
            <pc:docMk/>
            <pc:sldMk cId="3603884933" sldId="273"/>
            <ac:spMk id="21" creationId="{A05E77F0-8650-1248-AD3B-4EF641AAFE85}"/>
          </ac:spMkLst>
        </pc:spChg>
        <pc:spChg chg="del">
          <ac:chgData name="Wencai Zhang" userId="4a86a1d0-2108-4707-8228-1110f3c1be85" providerId="ADAL" clId="{A813DD5E-EF6A-D74E-9200-EB703B190439}" dt="2020-12-24T00:37:57.195" v="392" actId="478"/>
          <ac:spMkLst>
            <pc:docMk/>
            <pc:sldMk cId="3603884933" sldId="273"/>
            <ac:spMk id="22" creationId="{32ED7292-6136-5B4A-A103-6958E7397478}"/>
          </ac:spMkLst>
        </pc:spChg>
        <pc:spChg chg="del">
          <ac:chgData name="Wencai Zhang" userId="4a86a1d0-2108-4707-8228-1110f3c1be85" providerId="ADAL" clId="{A813DD5E-EF6A-D74E-9200-EB703B190439}" dt="2020-12-24T00:37:45.829" v="388" actId="478"/>
          <ac:spMkLst>
            <pc:docMk/>
            <pc:sldMk cId="3603884933" sldId="273"/>
            <ac:spMk id="23" creationId="{3C921590-F4B9-E949-BA0F-2DCE38D2F7DB}"/>
          </ac:spMkLst>
        </pc:spChg>
        <pc:spChg chg="mod">
          <ac:chgData name="Wencai Zhang" userId="4a86a1d0-2108-4707-8228-1110f3c1be85" providerId="ADAL" clId="{A813DD5E-EF6A-D74E-9200-EB703B190439}" dt="2020-12-24T00:37:49.008" v="390" actId="20577"/>
          <ac:spMkLst>
            <pc:docMk/>
            <pc:sldMk cId="3603884933" sldId="273"/>
            <ac:spMk id="45" creationId="{B882A580-67E1-F440-B291-900E8489FA77}"/>
          </ac:spMkLst>
        </pc:spChg>
        <pc:spChg chg="del">
          <ac:chgData name="Wencai Zhang" userId="4a86a1d0-2108-4707-8228-1110f3c1be85" providerId="ADAL" clId="{A813DD5E-EF6A-D74E-9200-EB703B190439}" dt="2020-12-24T00:37:45.829" v="388" actId="478"/>
          <ac:spMkLst>
            <pc:docMk/>
            <pc:sldMk cId="3603884933" sldId="273"/>
            <ac:spMk id="46" creationId="{D5B3E6F0-E1FF-2446-8547-64F1CD6C30C0}"/>
          </ac:spMkLst>
        </pc:spChg>
        <pc:spChg chg="del">
          <ac:chgData name="Wencai Zhang" userId="4a86a1d0-2108-4707-8228-1110f3c1be85" providerId="ADAL" clId="{A813DD5E-EF6A-D74E-9200-EB703B190439}" dt="2020-12-24T00:37:52.044" v="391" actId="478"/>
          <ac:spMkLst>
            <pc:docMk/>
            <pc:sldMk cId="3603884933" sldId="273"/>
            <ac:spMk id="47" creationId="{EADFE855-BA49-2B49-8DF4-99272D47E072}"/>
          </ac:spMkLst>
        </pc:spChg>
        <pc:spChg chg="del">
          <ac:chgData name="Wencai Zhang" userId="4a86a1d0-2108-4707-8228-1110f3c1be85" providerId="ADAL" clId="{A813DD5E-EF6A-D74E-9200-EB703B190439}" dt="2020-12-24T00:37:45.829" v="388" actId="478"/>
          <ac:spMkLst>
            <pc:docMk/>
            <pc:sldMk cId="3603884933" sldId="273"/>
            <ac:spMk id="48" creationId="{DC95A885-217F-2F45-A5DC-0AE0043B0BF3}"/>
          </ac:spMkLst>
        </pc:spChg>
        <pc:spChg chg="del">
          <ac:chgData name="Wencai Zhang" userId="4a86a1d0-2108-4707-8228-1110f3c1be85" providerId="ADAL" clId="{A813DD5E-EF6A-D74E-9200-EB703B190439}" dt="2020-12-24T00:37:57.195" v="392" actId="478"/>
          <ac:spMkLst>
            <pc:docMk/>
            <pc:sldMk cId="3603884933" sldId="273"/>
            <ac:spMk id="49" creationId="{B0DCFCD0-0085-0149-8BBD-8E4E4374108C}"/>
          </ac:spMkLst>
        </pc:spChg>
        <pc:spChg chg="del">
          <ac:chgData name="Wencai Zhang" userId="4a86a1d0-2108-4707-8228-1110f3c1be85" providerId="ADAL" clId="{A813DD5E-EF6A-D74E-9200-EB703B190439}" dt="2020-12-24T00:37:57.195" v="392" actId="478"/>
          <ac:spMkLst>
            <pc:docMk/>
            <pc:sldMk cId="3603884933" sldId="273"/>
            <ac:spMk id="50" creationId="{7F76F87D-80B1-3A45-9C44-41CBA0B58E4A}"/>
          </ac:spMkLst>
        </pc:spChg>
        <pc:spChg chg="del">
          <ac:chgData name="Wencai Zhang" userId="4a86a1d0-2108-4707-8228-1110f3c1be85" providerId="ADAL" clId="{A813DD5E-EF6A-D74E-9200-EB703B190439}" dt="2020-12-24T00:37:57.195" v="392" actId="478"/>
          <ac:spMkLst>
            <pc:docMk/>
            <pc:sldMk cId="3603884933" sldId="273"/>
            <ac:spMk id="51" creationId="{53F781C3-5349-D94E-B45F-874779A78BD2}"/>
          </ac:spMkLst>
        </pc:spChg>
        <pc:graphicFrameChg chg="del">
          <ac:chgData name="Wencai Zhang" userId="4a86a1d0-2108-4707-8228-1110f3c1be85" providerId="ADAL" clId="{A813DD5E-EF6A-D74E-9200-EB703B190439}" dt="2020-12-24T00:37:45.829" v="388" actId="478"/>
          <ac:graphicFrameMkLst>
            <pc:docMk/>
            <pc:sldMk cId="3603884933" sldId="273"/>
            <ac:graphicFrameMk id="4" creationId="{FECBB647-E687-4186-8B52-0CB0DB06E286}"/>
          </ac:graphicFrameMkLst>
        </pc:graphicFrameChg>
        <pc:graphicFrameChg chg="del">
          <ac:chgData name="Wencai Zhang" userId="4a86a1d0-2108-4707-8228-1110f3c1be85" providerId="ADAL" clId="{A813DD5E-EF6A-D74E-9200-EB703B190439}" dt="2020-12-24T00:37:57.195" v="392" actId="478"/>
          <ac:graphicFrameMkLst>
            <pc:docMk/>
            <pc:sldMk cId="3603884933" sldId="273"/>
            <ac:graphicFrameMk id="42" creationId="{E211DBCD-FED6-4E5D-B97E-D7F88C009DB2}"/>
          </ac:graphicFrameMkLst>
        </pc:graphicFrameChg>
        <pc:graphicFrameChg chg="del">
          <ac:chgData name="Wencai Zhang" userId="4a86a1d0-2108-4707-8228-1110f3c1be85" providerId="ADAL" clId="{A813DD5E-EF6A-D74E-9200-EB703B190439}" dt="2020-12-24T00:37:57.195" v="392" actId="478"/>
          <ac:graphicFrameMkLst>
            <pc:docMk/>
            <pc:sldMk cId="3603884933" sldId="273"/>
            <ac:graphicFrameMk id="43" creationId="{1838E2F6-5E19-4642-8B66-F4D69CBC9E05}"/>
          </ac:graphicFrameMkLst>
        </pc:graphicFrameChg>
        <pc:graphicFrameChg chg="del">
          <ac:chgData name="Wencai Zhang" userId="4a86a1d0-2108-4707-8228-1110f3c1be85" providerId="ADAL" clId="{A813DD5E-EF6A-D74E-9200-EB703B190439}" dt="2020-12-24T00:37:57.195" v="392" actId="478"/>
          <ac:graphicFrameMkLst>
            <pc:docMk/>
            <pc:sldMk cId="3603884933" sldId="273"/>
            <ac:graphicFrameMk id="44" creationId="{17020119-D512-4B25-8B64-9EEEEAB525FC}"/>
          </ac:graphicFrameMkLst>
        </pc:graphicFrameChg>
        <pc:picChg chg="mod">
          <ac:chgData name="Wencai Zhang" userId="4a86a1d0-2108-4707-8228-1110f3c1be85" providerId="ADAL" clId="{A813DD5E-EF6A-D74E-9200-EB703B190439}" dt="2020-12-27T15:48:28.193" v="403" actId="1076"/>
          <ac:picMkLst>
            <pc:docMk/>
            <pc:sldMk cId="3603884933" sldId="273"/>
            <ac:picMk id="10" creationId="{14E0937F-7FB1-4809-92BE-B016C2A7A156}"/>
          </ac:picMkLst>
        </pc:picChg>
      </pc:sldChg>
      <pc:sldChg chg="delSp modSp add mod">
        <pc:chgData name="Wencai Zhang" userId="4a86a1d0-2108-4707-8228-1110f3c1be85" providerId="ADAL" clId="{A813DD5E-EF6A-D74E-9200-EB703B190439}" dt="2020-12-27T16:35:33.626" v="545" actId="478"/>
        <pc:sldMkLst>
          <pc:docMk/>
          <pc:sldMk cId="4021043559" sldId="274"/>
        </pc:sldMkLst>
        <pc:spChg chg="mod">
          <ac:chgData name="Wencai Zhang" userId="4a86a1d0-2108-4707-8228-1110f3c1be85" providerId="ADAL" clId="{A813DD5E-EF6A-D74E-9200-EB703B190439}" dt="2020-12-24T00:38:21.339" v="397" actId="1076"/>
          <ac:spMkLst>
            <pc:docMk/>
            <pc:sldMk cId="4021043559" sldId="274"/>
            <ac:spMk id="19" creationId="{BF109CE8-51B4-2340-9893-6E159E7209E6}"/>
          </ac:spMkLst>
        </pc:spChg>
        <pc:spChg chg="del">
          <ac:chgData name="Wencai Zhang" userId="4a86a1d0-2108-4707-8228-1110f3c1be85" providerId="ADAL" clId="{A813DD5E-EF6A-D74E-9200-EB703B190439}" dt="2020-12-24T00:38:55.282" v="402" actId="478"/>
          <ac:spMkLst>
            <pc:docMk/>
            <pc:sldMk cId="4021043559" sldId="274"/>
            <ac:spMk id="20" creationId="{DFE49A88-69F1-9D47-93FE-33B0E5A39FAE}"/>
          </ac:spMkLst>
        </pc:spChg>
        <pc:spChg chg="mod">
          <ac:chgData name="Wencai Zhang" userId="4a86a1d0-2108-4707-8228-1110f3c1be85" providerId="ADAL" clId="{A813DD5E-EF6A-D74E-9200-EB703B190439}" dt="2020-12-24T00:38:52.666" v="401" actId="1076"/>
          <ac:spMkLst>
            <pc:docMk/>
            <pc:sldMk cId="4021043559" sldId="274"/>
            <ac:spMk id="21" creationId="{A05E77F0-8650-1248-AD3B-4EF641AAFE85}"/>
          </ac:spMkLst>
        </pc:spChg>
        <pc:spChg chg="del mod">
          <ac:chgData name="Wencai Zhang" userId="4a86a1d0-2108-4707-8228-1110f3c1be85" providerId="ADAL" clId="{A813DD5E-EF6A-D74E-9200-EB703B190439}" dt="2020-12-27T16:35:33.626" v="545" actId="478"/>
          <ac:spMkLst>
            <pc:docMk/>
            <pc:sldMk cId="4021043559" sldId="274"/>
            <ac:spMk id="22" creationId="{32ED7292-6136-5B4A-A103-6958E7397478}"/>
          </ac:spMkLst>
        </pc:spChg>
        <pc:spChg chg="del">
          <ac:chgData name="Wencai Zhang" userId="4a86a1d0-2108-4707-8228-1110f3c1be85" providerId="ADAL" clId="{A813DD5E-EF6A-D74E-9200-EB703B190439}" dt="2020-12-24T00:38:08.171" v="393" actId="478"/>
          <ac:spMkLst>
            <pc:docMk/>
            <pc:sldMk cId="4021043559" sldId="274"/>
            <ac:spMk id="23" creationId="{3C921590-F4B9-E949-BA0F-2DCE38D2F7DB}"/>
          </ac:spMkLst>
        </pc:spChg>
        <pc:spChg chg="mod">
          <ac:chgData name="Wencai Zhang" userId="4a86a1d0-2108-4707-8228-1110f3c1be85" providerId="ADAL" clId="{A813DD5E-EF6A-D74E-9200-EB703B190439}" dt="2020-12-24T00:38:15.611" v="396" actId="20577"/>
          <ac:spMkLst>
            <pc:docMk/>
            <pc:sldMk cId="4021043559" sldId="274"/>
            <ac:spMk id="45" creationId="{B882A580-67E1-F440-B291-900E8489FA77}"/>
          </ac:spMkLst>
        </pc:spChg>
        <pc:spChg chg="del mod">
          <ac:chgData name="Wencai Zhang" userId="4a86a1d0-2108-4707-8228-1110f3c1be85" providerId="ADAL" clId="{A813DD5E-EF6A-D74E-9200-EB703B190439}" dt="2020-12-27T16:35:33.626" v="545" actId="478"/>
          <ac:spMkLst>
            <pc:docMk/>
            <pc:sldMk cId="4021043559" sldId="274"/>
            <ac:spMk id="48" creationId="{DC95A885-217F-2F45-A5DC-0AE0043B0BF3}"/>
          </ac:spMkLst>
        </pc:spChg>
        <pc:spChg chg="del">
          <ac:chgData name="Wencai Zhang" userId="4a86a1d0-2108-4707-8228-1110f3c1be85" providerId="ADAL" clId="{A813DD5E-EF6A-D74E-9200-EB703B190439}" dt="2020-12-24T00:38:55.282" v="402" actId="478"/>
          <ac:spMkLst>
            <pc:docMk/>
            <pc:sldMk cId="4021043559" sldId="274"/>
            <ac:spMk id="49" creationId="{B0DCFCD0-0085-0149-8BBD-8E4E4374108C}"/>
          </ac:spMkLst>
        </pc:spChg>
        <pc:spChg chg="del">
          <ac:chgData name="Wencai Zhang" userId="4a86a1d0-2108-4707-8228-1110f3c1be85" providerId="ADAL" clId="{A813DD5E-EF6A-D74E-9200-EB703B190439}" dt="2020-12-24T00:38:55.282" v="402" actId="478"/>
          <ac:spMkLst>
            <pc:docMk/>
            <pc:sldMk cId="4021043559" sldId="274"/>
            <ac:spMk id="50" creationId="{7F76F87D-80B1-3A45-9C44-41CBA0B58E4A}"/>
          </ac:spMkLst>
        </pc:spChg>
        <pc:spChg chg="del">
          <ac:chgData name="Wencai Zhang" userId="4a86a1d0-2108-4707-8228-1110f3c1be85" providerId="ADAL" clId="{A813DD5E-EF6A-D74E-9200-EB703B190439}" dt="2020-12-24T00:38:55.282" v="402" actId="478"/>
          <ac:spMkLst>
            <pc:docMk/>
            <pc:sldMk cId="4021043559" sldId="274"/>
            <ac:spMk id="51" creationId="{53F781C3-5349-D94E-B45F-874779A78BD2}"/>
          </ac:spMkLst>
        </pc:spChg>
        <pc:graphicFrameChg chg="del">
          <ac:chgData name="Wencai Zhang" userId="4a86a1d0-2108-4707-8228-1110f3c1be85" providerId="ADAL" clId="{A813DD5E-EF6A-D74E-9200-EB703B190439}" dt="2020-12-24T00:38:08.171" v="393" actId="478"/>
          <ac:graphicFrameMkLst>
            <pc:docMk/>
            <pc:sldMk cId="4021043559" sldId="274"/>
            <ac:graphicFrameMk id="4" creationId="{FECBB647-E687-4186-8B52-0CB0DB06E286}"/>
          </ac:graphicFrameMkLst>
        </pc:graphicFrameChg>
        <pc:graphicFrameChg chg="mod">
          <ac:chgData name="Wencai Zhang" userId="4a86a1d0-2108-4707-8228-1110f3c1be85" providerId="ADAL" clId="{A813DD5E-EF6A-D74E-9200-EB703B190439}" dt="2020-12-24T00:38:12.130" v="394" actId="1076"/>
          <ac:graphicFrameMkLst>
            <pc:docMk/>
            <pc:sldMk cId="4021043559" sldId="274"/>
            <ac:graphicFrameMk id="42" creationId="{E211DBCD-FED6-4E5D-B97E-D7F88C009DB2}"/>
          </ac:graphicFrameMkLst>
        </pc:graphicFrameChg>
        <pc:graphicFrameChg chg="mod">
          <ac:chgData name="Wencai Zhang" userId="4a86a1d0-2108-4707-8228-1110f3c1be85" providerId="ADAL" clId="{A813DD5E-EF6A-D74E-9200-EB703B190439}" dt="2020-12-24T00:38:30.038" v="398" actId="1076"/>
          <ac:graphicFrameMkLst>
            <pc:docMk/>
            <pc:sldMk cId="4021043559" sldId="274"/>
            <ac:graphicFrameMk id="43" creationId="{1838E2F6-5E19-4642-8B66-F4D69CBC9E05}"/>
          </ac:graphicFrameMkLst>
        </pc:graphicFrameChg>
        <pc:graphicFrameChg chg="del mod">
          <ac:chgData name="Wencai Zhang" userId="4a86a1d0-2108-4707-8228-1110f3c1be85" providerId="ADAL" clId="{A813DD5E-EF6A-D74E-9200-EB703B190439}" dt="2020-12-27T16:35:33.626" v="545" actId="478"/>
          <ac:graphicFrameMkLst>
            <pc:docMk/>
            <pc:sldMk cId="4021043559" sldId="274"/>
            <ac:graphicFrameMk id="44" creationId="{17020119-D512-4B25-8B64-9EEEEAB525FC}"/>
          </ac:graphicFrameMkLst>
        </pc:graphicFrameChg>
        <pc:picChg chg="del">
          <ac:chgData name="Wencai Zhang" userId="4a86a1d0-2108-4707-8228-1110f3c1be85" providerId="ADAL" clId="{A813DD5E-EF6A-D74E-9200-EB703B190439}" dt="2020-12-24T00:38:08.171" v="393" actId="478"/>
          <ac:picMkLst>
            <pc:docMk/>
            <pc:sldMk cId="4021043559" sldId="274"/>
            <ac:picMk id="10" creationId="{14E0937F-7FB1-4809-92BE-B016C2A7A156}"/>
          </ac:picMkLst>
        </pc:picChg>
      </pc:sldChg>
    </pc:docChg>
  </pc:docChgLst>
  <pc:docChgLst>
    <pc:chgData name="Wencai Zhang" userId="4a86a1d0-2108-4707-8228-1110f3c1be85" providerId="ADAL" clId="{112F1500-E63F-C344-98C9-79D978A7E0E3}"/>
    <pc:docChg chg="undo custSel addSld modSld sldOrd">
      <pc:chgData name="Wencai Zhang" userId="4a86a1d0-2108-4707-8228-1110f3c1be85" providerId="ADAL" clId="{112F1500-E63F-C344-98C9-79D978A7E0E3}" dt="2021-06-14T17:49:15.571" v="2919" actId="20577"/>
      <pc:docMkLst>
        <pc:docMk/>
      </pc:docMkLst>
      <pc:sldChg chg="addSp delSp modSp mod">
        <pc:chgData name="Wencai Zhang" userId="4a86a1d0-2108-4707-8228-1110f3c1be85" providerId="ADAL" clId="{112F1500-E63F-C344-98C9-79D978A7E0E3}" dt="2021-06-14T17:46:59.893" v="2796" actId="207"/>
        <pc:sldMkLst>
          <pc:docMk/>
          <pc:sldMk cId="555486090" sldId="272"/>
        </pc:sldMkLst>
        <pc:spChg chg="del">
          <ac:chgData name="Wencai Zhang" userId="4a86a1d0-2108-4707-8228-1110f3c1be85" providerId="ADAL" clId="{112F1500-E63F-C344-98C9-79D978A7E0E3}" dt="2021-06-14T15:48:17.059" v="1737" actId="478"/>
          <ac:spMkLst>
            <pc:docMk/>
            <pc:sldMk cId="555486090" sldId="272"/>
            <ac:spMk id="4" creationId="{1515AAF5-B1D8-AF4D-9FD6-B3084B37A167}"/>
          </ac:spMkLst>
        </pc:spChg>
        <pc:spChg chg="del mod">
          <ac:chgData name="Wencai Zhang" userId="4a86a1d0-2108-4707-8228-1110f3c1be85" providerId="ADAL" clId="{112F1500-E63F-C344-98C9-79D978A7E0E3}" dt="2021-06-14T14:57:09.288" v="1712" actId="478"/>
          <ac:spMkLst>
            <pc:docMk/>
            <pc:sldMk cId="555486090" sldId="272"/>
            <ac:spMk id="10" creationId="{62912344-2FB8-3C40-9A45-09AA43D769D8}"/>
          </ac:spMkLst>
        </pc:spChg>
        <pc:spChg chg="mod">
          <ac:chgData name="Wencai Zhang" userId="4a86a1d0-2108-4707-8228-1110f3c1be85" providerId="ADAL" clId="{112F1500-E63F-C344-98C9-79D978A7E0E3}" dt="2021-06-14T15:59:45.585" v="2452" actId="1076"/>
          <ac:spMkLst>
            <pc:docMk/>
            <pc:sldMk cId="555486090" sldId="272"/>
            <ac:spMk id="35" creationId="{3CD46702-79E1-4022-BE80-E030647E61EA}"/>
          </ac:spMkLst>
        </pc:spChg>
        <pc:spChg chg="mod">
          <ac:chgData name="Wencai Zhang" userId="4a86a1d0-2108-4707-8228-1110f3c1be85" providerId="ADAL" clId="{112F1500-E63F-C344-98C9-79D978A7E0E3}" dt="2021-06-14T15:59:45.585" v="2452" actId="1076"/>
          <ac:spMkLst>
            <pc:docMk/>
            <pc:sldMk cId="555486090" sldId="272"/>
            <ac:spMk id="37" creationId="{183B7CA4-46A0-4371-AEFB-BCF6539CB67B}"/>
          </ac:spMkLst>
        </pc:spChg>
        <pc:spChg chg="mod">
          <ac:chgData name="Wencai Zhang" userId="4a86a1d0-2108-4707-8228-1110f3c1be85" providerId="ADAL" clId="{112F1500-E63F-C344-98C9-79D978A7E0E3}" dt="2021-06-14T15:50:28.995" v="1809" actId="1037"/>
          <ac:spMkLst>
            <pc:docMk/>
            <pc:sldMk cId="555486090" sldId="272"/>
            <ac:spMk id="39" creationId="{2FF524B7-0E31-48D2-9DE4-DBF18908290E}"/>
          </ac:spMkLst>
        </pc:spChg>
        <pc:spChg chg="mod">
          <ac:chgData name="Wencai Zhang" userId="4a86a1d0-2108-4707-8228-1110f3c1be85" providerId="ADAL" clId="{112F1500-E63F-C344-98C9-79D978A7E0E3}" dt="2021-06-14T15:50:28.995" v="1809" actId="1037"/>
          <ac:spMkLst>
            <pc:docMk/>
            <pc:sldMk cId="555486090" sldId="272"/>
            <ac:spMk id="41" creationId="{99FDF159-51A5-4577-A7B2-699B6A37C5A0}"/>
          </ac:spMkLst>
        </pc:spChg>
        <pc:spChg chg="del">
          <ac:chgData name="Wencai Zhang" userId="4a86a1d0-2108-4707-8228-1110f3c1be85" providerId="ADAL" clId="{112F1500-E63F-C344-98C9-79D978A7E0E3}" dt="2021-06-14T15:47:32.004" v="1735" actId="478"/>
          <ac:spMkLst>
            <pc:docMk/>
            <pc:sldMk cId="555486090" sldId="272"/>
            <ac:spMk id="42" creationId="{89EDAEB4-CA84-D441-9589-6D12D20313AD}"/>
          </ac:spMkLst>
        </pc:spChg>
        <pc:spChg chg="del">
          <ac:chgData name="Wencai Zhang" userId="4a86a1d0-2108-4707-8228-1110f3c1be85" providerId="ADAL" clId="{112F1500-E63F-C344-98C9-79D978A7E0E3}" dt="2021-06-14T15:47:34.701" v="1736" actId="478"/>
          <ac:spMkLst>
            <pc:docMk/>
            <pc:sldMk cId="555486090" sldId="272"/>
            <ac:spMk id="43" creationId="{37CFE433-1F3F-2F4B-90BE-2C0A049BAF5D}"/>
          </ac:spMkLst>
        </pc:spChg>
        <pc:spChg chg="mod">
          <ac:chgData name="Wencai Zhang" userId="4a86a1d0-2108-4707-8228-1110f3c1be85" providerId="ADAL" clId="{112F1500-E63F-C344-98C9-79D978A7E0E3}" dt="2021-06-12T01:26:03.300" v="33" actId="1038"/>
          <ac:spMkLst>
            <pc:docMk/>
            <pc:sldMk cId="555486090" sldId="272"/>
            <ac:spMk id="46" creationId="{AE153BE9-E801-9F46-B19E-88780C594949}"/>
          </ac:spMkLst>
        </pc:spChg>
        <pc:spChg chg="add mod">
          <ac:chgData name="Wencai Zhang" userId="4a86a1d0-2108-4707-8228-1110f3c1be85" providerId="ADAL" clId="{112F1500-E63F-C344-98C9-79D978A7E0E3}" dt="2021-06-14T15:46:36.245" v="1729" actId="20577"/>
          <ac:spMkLst>
            <pc:docMk/>
            <pc:sldMk cId="555486090" sldId="272"/>
            <ac:spMk id="48" creationId="{829C7543-2313-C64A-A0C2-8EF1CB391436}"/>
          </ac:spMkLst>
        </pc:spChg>
        <pc:spChg chg="add mod">
          <ac:chgData name="Wencai Zhang" userId="4a86a1d0-2108-4707-8228-1110f3c1be85" providerId="ADAL" clId="{112F1500-E63F-C344-98C9-79D978A7E0E3}" dt="2021-06-14T15:48:51.394" v="1768" actId="1037"/>
          <ac:spMkLst>
            <pc:docMk/>
            <pc:sldMk cId="555486090" sldId="272"/>
            <ac:spMk id="49" creationId="{5928BE95-2796-A747-B02A-8B1E6FA4C0E3}"/>
          </ac:spMkLst>
        </pc:spChg>
        <pc:spChg chg="add mod">
          <ac:chgData name="Wencai Zhang" userId="4a86a1d0-2108-4707-8228-1110f3c1be85" providerId="ADAL" clId="{112F1500-E63F-C344-98C9-79D978A7E0E3}" dt="2021-06-14T15:50:49.226" v="1812" actId="20577"/>
          <ac:spMkLst>
            <pc:docMk/>
            <pc:sldMk cId="555486090" sldId="272"/>
            <ac:spMk id="50" creationId="{A80CCE98-BA8F-8B4D-A1EC-D2F6DD9BA398}"/>
          </ac:spMkLst>
        </pc:spChg>
        <pc:spChg chg="del">
          <ac:chgData name="Wencai Zhang" userId="4a86a1d0-2108-4707-8228-1110f3c1be85" providerId="ADAL" clId="{112F1500-E63F-C344-98C9-79D978A7E0E3}" dt="2021-06-14T15:47:07.404" v="1733" actId="478"/>
          <ac:spMkLst>
            <pc:docMk/>
            <pc:sldMk cId="555486090" sldId="272"/>
            <ac:spMk id="52" creationId="{2551E2E5-9EEC-084B-B42A-894A2E03799D}"/>
          </ac:spMkLst>
        </pc:spChg>
        <pc:spChg chg="del">
          <ac:chgData name="Wencai Zhang" userId="4a86a1d0-2108-4707-8228-1110f3c1be85" providerId="ADAL" clId="{112F1500-E63F-C344-98C9-79D978A7E0E3}" dt="2021-06-14T15:49:36.127" v="1779" actId="478"/>
          <ac:spMkLst>
            <pc:docMk/>
            <pc:sldMk cId="555486090" sldId="272"/>
            <ac:spMk id="53" creationId="{D6BBD254-7480-734E-B168-8777EB93D3F8}"/>
          </ac:spMkLst>
        </pc:spChg>
        <pc:spChg chg="add mod">
          <ac:chgData name="Wencai Zhang" userId="4a86a1d0-2108-4707-8228-1110f3c1be85" providerId="ADAL" clId="{112F1500-E63F-C344-98C9-79D978A7E0E3}" dt="2021-06-14T17:42:45.695" v="2479" actId="20577"/>
          <ac:spMkLst>
            <pc:docMk/>
            <pc:sldMk cId="555486090" sldId="272"/>
            <ac:spMk id="56" creationId="{5A58CCDB-73EB-9148-B163-A80A32AA1702}"/>
          </ac:spMkLst>
        </pc:spChg>
        <pc:spChg chg="add mod">
          <ac:chgData name="Wencai Zhang" userId="4a86a1d0-2108-4707-8228-1110f3c1be85" providerId="ADAL" clId="{112F1500-E63F-C344-98C9-79D978A7E0E3}" dt="2021-06-14T17:43:03.351" v="2482" actId="20577"/>
          <ac:spMkLst>
            <pc:docMk/>
            <pc:sldMk cId="555486090" sldId="272"/>
            <ac:spMk id="57" creationId="{301A7A5C-DA57-A44A-8607-E805FB9E6EA0}"/>
          </ac:spMkLst>
        </pc:spChg>
        <pc:grpChg chg="del mod">
          <ac:chgData name="Wencai Zhang" userId="4a86a1d0-2108-4707-8228-1110f3c1be85" providerId="ADAL" clId="{112F1500-E63F-C344-98C9-79D978A7E0E3}" dt="2021-06-14T15:49:14.220" v="1773" actId="165"/>
          <ac:grpSpMkLst>
            <pc:docMk/>
            <pc:sldMk cId="555486090" sldId="272"/>
            <ac:grpSpMk id="26" creationId="{0803CBC6-41A5-4C74-9AF1-5A04B8163ADE}"/>
          </ac:grpSpMkLst>
        </pc:grpChg>
        <pc:grpChg chg="mod topLvl">
          <ac:chgData name="Wencai Zhang" userId="4a86a1d0-2108-4707-8228-1110f3c1be85" providerId="ADAL" clId="{112F1500-E63F-C344-98C9-79D978A7E0E3}" dt="2021-06-14T15:49:44.082" v="1789" actId="1037"/>
          <ac:grpSpMkLst>
            <pc:docMk/>
            <pc:sldMk cId="555486090" sldId="272"/>
            <ac:grpSpMk id="27" creationId="{0E11CCF2-473B-47E6-964D-9AF6ECCFE9C7}"/>
          </ac:grpSpMkLst>
        </pc:grpChg>
        <pc:grpChg chg="mod">
          <ac:chgData name="Wencai Zhang" userId="4a86a1d0-2108-4707-8228-1110f3c1be85" providerId="ADAL" clId="{112F1500-E63F-C344-98C9-79D978A7E0E3}" dt="2021-06-14T15:49:14.220" v="1773" actId="165"/>
          <ac:grpSpMkLst>
            <pc:docMk/>
            <pc:sldMk cId="555486090" sldId="272"/>
            <ac:grpSpMk id="29" creationId="{B2C79571-2AF8-4871-848C-7ECD4EC123C4}"/>
          </ac:grpSpMkLst>
        </pc:grpChg>
        <pc:grpChg chg="mod">
          <ac:chgData name="Wencai Zhang" userId="4a86a1d0-2108-4707-8228-1110f3c1be85" providerId="ADAL" clId="{112F1500-E63F-C344-98C9-79D978A7E0E3}" dt="2021-06-14T15:49:14.220" v="1773" actId="165"/>
          <ac:grpSpMkLst>
            <pc:docMk/>
            <pc:sldMk cId="555486090" sldId="272"/>
            <ac:grpSpMk id="30" creationId="{9A089C50-AA9D-42E7-ADA1-E34FED23432B}"/>
          </ac:grpSpMkLst>
        </pc:grpChg>
        <pc:graphicFrameChg chg="mod">
          <ac:chgData name="Wencai Zhang" userId="4a86a1d0-2108-4707-8228-1110f3c1be85" providerId="ADAL" clId="{112F1500-E63F-C344-98C9-79D978A7E0E3}" dt="2021-06-14T15:59:12.549" v="2451" actId="14100"/>
          <ac:graphicFrameMkLst>
            <pc:docMk/>
            <pc:sldMk cId="555486090" sldId="272"/>
            <ac:graphicFrameMk id="3" creationId="{7067052F-377D-4FB1-BCD6-25BD2CA7B2C7}"/>
          </ac:graphicFrameMkLst>
        </pc:graphicFrameChg>
        <pc:graphicFrameChg chg="mod">
          <ac:chgData name="Wencai Zhang" userId="4a86a1d0-2108-4707-8228-1110f3c1be85" providerId="ADAL" clId="{112F1500-E63F-C344-98C9-79D978A7E0E3}" dt="2021-06-14T17:46:46.121" v="2795" actId="404"/>
          <ac:graphicFrameMkLst>
            <pc:docMk/>
            <pc:sldMk cId="555486090" sldId="272"/>
            <ac:graphicFrameMk id="25" creationId="{0A1AA60E-C860-4D12-A783-21D62CADDDEF}"/>
          </ac:graphicFrameMkLst>
        </pc:graphicFrameChg>
        <pc:graphicFrameChg chg="mod topLvl">
          <ac:chgData name="Wencai Zhang" userId="4a86a1d0-2108-4707-8228-1110f3c1be85" providerId="ADAL" clId="{112F1500-E63F-C344-98C9-79D978A7E0E3}" dt="2021-06-14T15:49:59.275" v="1790" actId="1076"/>
          <ac:graphicFrameMkLst>
            <pc:docMk/>
            <pc:sldMk cId="555486090" sldId="272"/>
            <ac:graphicFrameMk id="28" creationId="{6DE37873-86DA-4861-99FF-6B2BA260EFC9}"/>
          </ac:graphicFrameMkLst>
        </pc:graphicFrameChg>
        <pc:graphicFrameChg chg="add del mod">
          <ac:chgData name="Wencai Zhang" userId="4a86a1d0-2108-4707-8228-1110f3c1be85" providerId="ADAL" clId="{112F1500-E63F-C344-98C9-79D978A7E0E3}" dt="2021-06-14T17:40:37.129" v="2464" actId="1076"/>
          <ac:graphicFrameMkLst>
            <pc:docMk/>
            <pc:sldMk cId="555486090" sldId="272"/>
            <ac:graphicFrameMk id="44" creationId="{CFE24D7E-ED14-4449-B7FA-5A1795C3E7D8}"/>
          </ac:graphicFrameMkLst>
        </pc:graphicFrameChg>
        <pc:graphicFrameChg chg="add mod">
          <ac:chgData name="Wencai Zhang" userId="4a86a1d0-2108-4707-8228-1110f3c1be85" providerId="ADAL" clId="{112F1500-E63F-C344-98C9-79D978A7E0E3}" dt="2021-06-14T15:48:29.579" v="1739" actId="14100"/>
          <ac:graphicFrameMkLst>
            <pc:docMk/>
            <pc:sldMk cId="555486090" sldId="272"/>
            <ac:graphicFrameMk id="47" creationId="{E4D88BE1-3C42-47FA-9727-53A658189E2C}"/>
          </ac:graphicFrameMkLst>
        </pc:graphicFrameChg>
        <pc:graphicFrameChg chg="add mod">
          <ac:chgData name="Wencai Zhang" userId="4a86a1d0-2108-4707-8228-1110f3c1be85" providerId="ADAL" clId="{112F1500-E63F-C344-98C9-79D978A7E0E3}" dt="2021-06-14T17:43:12.086" v="2483" actId="1076"/>
          <ac:graphicFrameMkLst>
            <pc:docMk/>
            <pc:sldMk cId="555486090" sldId="272"/>
            <ac:graphicFrameMk id="54" creationId="{3FCBC587-C540-1D43-99E4-010E512411DF}"/>
          </ac:graphicFrameMkLst>
        </pc:graphicFrameChg>
        <pc:graphicFrameChg chg="add mod">
          <ac:chgData name="Wencai Zhang" userId="4a86a1d0-2108-4707-8228-1110f3c1be85" providerId="ADAL" clId="{112F1500-E63F-C344-98C9-79D978A7E0E3}" dt="2021-06-14T17:46:59.893" v="2796" actId="207"/>
          <ac:graphicFrameMkLst>
            <pc:docMk/>
            <pc:sldMk cId="555486090" sldId="272"/>
            <ac:graphicFrameMk id="55" creationId="{84BF6B52-23DD-EB44-B60A-2222A59D363C}"/>
          </ac:graphicFrameMkLst>
        </pc:graphicFrameChg>
        <pc:picChg chg="mod">
          <ac:chgData name="Wencai Zhang" userId="4a86a1d0-2108-4707-8228-1110f3c1be85" providerId="ADAL" clId="{112F1500-E63F-C344-98C9-79D978A7E0E3}" dt="2021-06-14T15:49:14.220" v="1773" actId="165"/>
          <ac:picMkLst>
            <pc:docMk/>
            <pc:sldMk cId="555486090" sldId="272"/>
            <ac:picMk id="32" creationId="{55EE5086-2E5A-45D4-9330-4E6307F5124B}"/>
          </ac:picMkLst>
        </pc:picChg>
        <pc:picChg chg="mod">
          <ac:chgData name="Wencai Zhang" userId="4a86a1d0-2108-4707-8228-1110f3c1be85" providerId="ADAL" clId="{112F1500-E63F-C344-98C9-79D978A7E0E3}" dt="2021-06-14T15:49:14.220" v="1773" actId="165"/>
          <ac:picMkLst>
            <pc:docMk/>
            <pc:sldMk cId="555486090" sldId="272"/>
            <ac:picMk id="33" creationId="{ED4F1A12-5D07-4879-9DDA-5F11E0FCD50B}"/>
          </ac:picMkLst>
        </pc:picChg>
        <pc:picChg chg="mod">
          <ac:chgData name="Wencai Zhang" userId="4a86a1d0-2108-4707-8228-1110f3c1be85" providerId="ADAL" clId="{112F1500-E63F-C344-98C9-79D978A7E0E3}" dt="2021-06-14T15:49:14.220" v="1773" actId="165"/>
          <ac:picMkLst>
            <pc:docMk/>
            <pc:sldMk cId="555486090" sldId="272"/>
            <ac:picMk id="38" creationId="{6CB0A001-8D65-4213-8838-FE016B2FF9B8}"/>
          </ac:picMkLst>
        </pc:picChg>
        <pc:picChg chg="mod">
          <ac:chgData name="Wencai Zhang" userId="4a86a1d0-2108-4707-8228-1110f3c1be85" providerId="ADAL" clId="{112F1500-E63F-C344-98C9-79D978A7E0E3}" dt="2021-06-14T15:49:14.220" v="1773" actId="165"/>
          <ac:picMkLst>
            <pc:docMk/>
            <pc:sldMk cId="555486090" sldId="272"/>
            <ac:picMk id="40" creationId="{71E183B4-1D02-4877-A19F-52EDF7D572F3}"/>
          </ac:picMkLst>
        </pc:picChg>
      </pc:sldChg>
      <pc:sldChg chg="addSp modSp mod">
        <pc:chgData name="Wencai Zhang" userId="4a86a1d0-2108-4707-8228-1110f3c1be85" providerId="ADAL" clId="{112F1500-E63F-C344-98C9-79D978A7E0E3}" dt="2021-06-13T10:46:12.558" v="482" actId="1076"/>
        <pc:sldMkLst>
          <pc:docMk/>
          <pc:sldMk cId="4220638819" sldId="275"/>
        </pc:sldMkLst>
        <pc:graphicFrameChg chg="add mod">
          <ac:chgData name="Wencai Zhang" userId="4a86a1d0-2108-4707-8228-1110f3c1be85" providerId="ADAL" clId="{112F1500-E63F-C344-98C9-79D978A7E0E3}" dt="2021-06-13T10:46:12.558" v="482" actId="1076"/>
          <ac:graphicFrameMkLst>
            <pc:docMk/>
            <pc:sldMk cId="4220638819" sldId="275"/>
            <ac:graphicFrameMk id="2" creationId="{B64F26AC-D8C5-FD45-AE10-8D5B11D39687}"/>
          </ac:graphicFrameMkLst>
        </pc:graphicFrameChg>
      </pc:sldChg>
      <pc:sldChg chg="addSp delSp modSp mod">
        <pc:chgData name="Wencai Zhang" userId="4a86a1d0-2108-4707-8228-1110f3c1be85" providerId="ADAL" clId="{112F1500-E63F-C344-98C9-79D978A7E0E3}" dt="2021-06-14T15:40:16.928" v="1715" actId="1076"/>
        <pc:sldMkLst>
          <pc:docMk/>
          <pc:sldMk cId="399587783" sldId="276"/>
        </pc:sldMkLst>
        <pc:spChg chg="add mod">
          <ac:chgData name="Wencai Zhang" userId="4a86a1d0-2108-4707-8228-1110f3c1be85" providerId="ADAL" clId="{112F1500-E63F-C344-98C9-79D978A7E0E3}" dt="2021-06-12T01:28:16.022" v="35" actId="1076"/>
          <ac:spMkLst>
            <pc:docMk/>
            <pc:sldMk cId="399587783" sldId="276"/>
            <ac:spMk id="3" creationId="{D5B9DCEA-F986-784C-BCBE-1201D9780C0E}"/>
          </ac:spMkLst>
        </pc:spChg>
        <pc:spChg chg="add mod">
          <ac:chgData name="Wencai Zhang" userId="4a86a1d0-2108-4707-8228-1110f3c1be85" providerId="ADAL" clId="{112F1500-E63F-C344-98C9-79D978A7E0E3}" dt="2021-06-13T10:42:12.698" v="480" actId="404"/>
          <ac:spMkLst>
            <pc:docMk/>
            <pc:sldMk cId="399587783" sldId="276"/>
            <ac:spMk id="10" creationId="{DFF01E0D-9661-D94A-A54C-3DA2C6CE9304}"/>
          </ac:spMkLst>
        </pc:spChg>
        <pc:spChg chg="del">
          <ac:chgData name="Wencai Zhang" userId="4a86a1d0-2108-4707-8228-1110f3c1be85" providerId="ADAL" clId="{112F1500-E63F-C344-98C9-79D978A7E0E3}" dt="2021-06-12T01:28:41.860" v="36" actId="478"/>
          <ac:spMkLst>
            <pc:docMk/>
            <pc:sldMk cId="399587783" sldId="276"/>
            <ac:spMk id="44" creationId="{6B65C643-D0FC-764C-BE41-6D5DB9FE3C3C}"/>
          </ac:spMkLst>
        </pc:spChg>
        <pc:spChg chg="del">
          <ac:chgData name="Wencai Zhang" userId="4a86a1d0-2108-4707-8228-1110f3c1be85" providerId="ADAL" clId="{112F1500-E63F-C344-98C9-79D978A7E0E3}" dt="2021-06-14T15:40:12.896" v="1714" actId="478"/>
          <ac:spMkLst>
            <pc:docMk/>
            <pc:sldMk cId="399587783" sldId="276"/>
            <ac:spMk id="51" creationId="{E37AD563-CB3E-E24F-B69A-5D3C8532C49B}"/>
          </ac:spMkLst>
        </pc:spChg>
        <pc:graphicFrameChg chg="mod">
          <ac:chgData name="Wencai Zhang" userId="4a86a1d0-2108-4707-8228-1110f3c1be85" providerId="ADAL" clId="{112F1500-E63F-C344-98C9-79D978A7E0E3}" dt="2021-06-12T10:44:11.329" v="234" actId="14100"/>
          <ac:graphicFrameMkLst>
            <pc:docMk/>
            <pc:sldMk cId="399587783" sldId="276"/>
            <ac:graphicFrameMk id="5" creationId="{91492FF7-4DC1-45F4-90C6-3ADE091545C6}"/>
          </ac:graphicFrameMkLst>
        </pc:graphicFrameChg>
        <pc:graphicFrameChg chg="add mod">
          <ac:chgData name="Wencai Zhang" userId="4a86a1d0-2108-4707-8228-1110f3c1be85" providerId="ADAL" clId="{112F1500-E63F-C344-98C9-79D978A7E0E3}" dt="2021-06-14T15:40:16.928" v="1715" actId="1076"/>
          <ac:graphicFrameMkLst>
            <pc:docMk/>
            <pc:sldMk cId="399587783" sldId="276"/>
            <ac:graphicFrameMk id="11" creationId="{FB75039B-C464-DC4D-BCA0-578D3061AAAB}"/>
          </ac:graphicFrameMkLst>
        </pc:graphicFrameChg>
        <pc:graphicFrameChg chg="add del mod">
          <ac:chgData name="Wencai Zhang" userId="4a86a1d0-2108-4707-8228-1110f3c1be85" providerId="ADAL" clId="{112F1500-E63F-C344-98C9-79D978A7E0E3}" dt="2021-06-13T21:52:18.042" v="646" actId="478"/>
          <ac:graphicFrameMkLst>
            <pc:docMk/>
            <pc:sldMk cId="399587783" sldId="276"/>
            <ac:graphicFrameMk id="34" creationId="{A0B63AE7-C241-604B-BCCE-AEA4190EB6B2}"/>
          </ac:graphicFrameMkLst>
        </pc:graphicFrameChg>
        <pc:graphicFrameChg chg="add del mod">
          <ac:chgData name="Wencai Zhang" userId="4a86a1d0-2108-4707-8228-1110f3c1be85" providerId="ADAL" clId="{112F1500-E63F-C344-98C9-79D978A7E0E3}" dt="2021-06-13T21:52:16.147" v="645" actId="478"/>
          <ac:graphicFrameMkLst>
            <pc:docMk/>
            <pc:sldMk cId="399587783" sldId="276"/>
            <ac:graphicFrameMk id="36" creationId="{410F9F47-8246-3B4C-82EF-36A1E6BAE934}"/>
          </ac:graphicFrameMkLst>
        </pc:graphicFrameChg>
      </pc:sldChg>
      <pc:sldChg chg="addSp delSp modSp new mod ord">
        <pc:chgData name="Wencai Zhang" userId="4a86a1d0-2108-4707-8228-1110f3c1be85" providerId="ADAL" clId="{112F1500-E63F-C344-98C9-79D978A7E0E3}" dt="2021-06-13T10:38:15.348" v="373" actId="1076"/>
        <pc:sldMkLst>
          <pc:docMk/>
          <pc:sldMk cId="2650755790" sldId="277"/>
        </pc:sldMkLst>
        <pc:spChg chg="del">
          <ac:chgData name="Wencai Zhang" userId="4a86a1d0-2108-4707-8228-1110f3c1be85" providerId="ADAL" clId="{112F1500-E63F-C344-98C9-79D978A7E0E3}" dt="2021-06-12T10:35:00.713" v="38" actId="478"/>
          <ac:spMkLst>
            <pc:docMk/>
            <pc:sldMk cId="2650755790" sldId="277"/>
            <ac:spMk id="2" creationId="{74491342-A4E5-594D-9CA7-0F2255527147}"/>
          </ac:spMkLst>
        </pc:spChg>
        <pc:spChg chg="del">
          <ac:chgData name="Wencai Zhang" userId="4a86a1d0-2108-4707-8228-1110f3c1be85" providerId="ADAL" clId="{112F1500-E63F-C344-98C9-79D978A7E0E3}" dt="2021-06-12T10:35:00.713" v="38" actId="478"/>
          <ac:spMkLst>
            <pc:docMk/>
            <pc:sldMk cId="2650755790" sldId="277"/>
            <ac:spMk id="3" creationId="{6CFD1393-C971-FF4B-A6C3-F3CBC0152087}"/>
          </ac:spMkLst>
        </pc:spChg>
        <pc:spChg chg="add mod">
          <ac:chgData name="Wencai Zhang" userId="4a86a1d0-2108-4707-8228-1110f3c1be85" providerId="ADAL" clId="{112F1500-E63F-C344-98C9-79D978A7E0E3}" dt="2021-06-13T10:37:03.554" v="357" actId="20577"/>
          <ac:spMkLst>
            <pc:docMk/>
            <pc:sldMk cId="2650755790" sldId="277"/>
            <ac:spMk id="4" creationId="{3F93EE33-98E6-3A41-B628-C0D0014E8476}"/>
          </ac:spMkLst>
        </pc:spChg>
        <pc:spChg chg="add mod">
          <ac:chgData name="Wencai Zhang" userId="4a86a1d0-2108-4707-8228-1110f3c1be85" providerId="ADAL" clId="{112F1500-E63F-C344-98C9-79D978A7E0E3}" dt="2021-06-13T10:37:15.638" v="359" actId="1076"/>
          <ac:spMkLst>
            <pc:docMk/>
            <pc:sldMk cId="2650755790" sldId="277"/>
            <ac:spMk id="5" creationId="{BB2CA66C-E740-1441-928C-D9964DC8499C}"/>
          </ac:spMkLst>
        </pc:spChg>
        <pc:graphicFrameChg chg="add mod">
          <ac:chgData name="Wencai Zhang" userId="4a86a1d0-2108-4707-8228-1110f3c1be85" providerId="ADAL" clId="{112F1500-E63F-C344-98C9-79D978A7E0E3}" dt="2021-06-13T10:37:24.427" v="361" actId="1076"/>
          <ac:graphicFrameMkLst>
            <pc:docMk/>
            <pc:sldMk cId="2650755790" sldId="277"/>
            <ac:graphicFrameMk id="6" creationId="{66CD7BB6-CDE1-9447-BECE-C681B2FA2E90}"/>
          </ac:graphicFrameMkLst>
        </pc:graphicFrameChg>
        <pc:graphicFrameChg chg="add mod">
          <ac:chgData name="Wencai Zhang" userId="4a86a1d0-2108-4707-8228-1110f3c1be85" providerId="ADAL" clId="{112F1500-E63F-C344-98C9-79D978A7E0E3}" dt="2021-06-13T10:38:15.348" v="373" actId="1076"/>
          <ac:graphicFrameMkLst>
            <pc:docMk/>
            <pc:sldMk cId="2650755790" sldId="277"/>
            <ac:graphicFrameMk id="7" creationId="{C6071921-8BB5-C343-B396-FB0E39F887EA}"/>
          </ac:graphicFrameMkLst>
        </pc:graphicFrameChg>
      </pc:sldChg>
      <pc:sldChg chg="addSp modSp add mod ord">
        <pc:chgData name="Wencai Zhang" userId="4a86a1d0-2108-4707-8228-1110f3c1be85" providerId="ADAL" clId="{112F1500-E63F-C344-98C9-79D978A7E0E3}" dt="2021-06-14T17:49:15.571" v="2919" actId="20577"/>
        <pc:sldMkLst>
          <pc:docMk/>
          <pc:sldMk cId="2842178971" sldId="278"/>
        </pc:sldMkLst>
        <pc:spChg chg="add mod">
          <ac:chgData name="Wencai Zhang" userId="4a86a1d0-2108-4707-8228-1110f3c1be85" providerId="ADAL" clId="{112F1500-E63F-C344-98C9-79D978A7E0E3}" dt="2021-06-14T17:49:15.571" v="2919" actId="20577"/>
          <ac:spMkLst>
            <pc:docMk/>
            <pc:sldMk cId="2842178971" sldId="278"/>
            <ac:spMk id="2" creationId="{265ED06E-F70D-AB4A-9F48-1698B31C51D7}"/>
          </ac:spMkLst>
        </pc:spChg>
      </pc:sldChg>
      <pc:sldChg chg="addSp delSp modSp add mod">
        <pc:chgData name="Wencai Zhang" userId="4a86a1d0-2108-4707-8228-1110f3c1be85" providerId="ADAL" clId="{112F1500-E63F-C344-98C9-79D978A7E0E3}" dt="2021-06-14T10:26:14.889" v="895"/>
        <pc:sldMkLst>
          <pc:docMk/>
          <pc:sldMk cId="3759201367" sldId="279"/>
        </pc:sldMkLst>
        <pc:spChg chg="mod">
          <ac:chgData name="Wencai Zhang" userId="4a86a1d0-2108-4707-8228-1110f3c1be85" providerId="ADAL" clId="{112F1500-E63F-C344-98C9-79D978A7E0E3}" dt="2021-06-13T21:10:33.129" v="612" actId="1037"/>
          <ac:spMkLst>
            <pc:docMk/>
            <pc:sldMk cId="3759201367" sldId="279"/>
            <ac:spMk id="2" creationId="{62A0247D-6003-704B-9909-D67560E97746}"/>
          </ac:spMkLst>
        </pc:spChg>
        <pc:spChg chg="del">
          <ac:chgData name="Wencai Zhang" userId="4a86a1d0-2108-4707-8228-1110f3c1be85" providerId="ADAL" clId="{112F1500-E63F-C344-98C9-79D978A7E0E3}" dt="2021-06-13T21:09:01.858" v="518" actId="478"/>
          <ac:spMkLst>
            <pc:docMk/>
            <pc:sldMk cId="3759201367" sldId="279"/>
            <ac:spMk id="3" creationId="{D5B9DCEA-F986-784C-BCBE-1201D9780C0E}"/>
          </ac:spMkLst>
        </pc:spChg>
        <pc:spChg chg="del">
          <ac:chgData name="Wencai Zhang" userId="4a86a1d0-2108-4707-8228-1110f3c1be85" providerId="ADAL" clId="{112F1500-E63F-C344-98C9-79D978A7E0E3}" dt="2021-06-13T21:09:24.358" v="542" actId="478"/>
          <ac:spMkLst>
            <pc:docMk/>
            <pc:sldMk cId="3759201367" sldId="279"/>
            <ac:spMk id="4" creationId="{1515AAF5-B1D8-AF4D-9FD6-B3084B37A167}"/>
          </ac:spMkLst>
        </pc:spChg>
        <pc:spChg chg="del">
          <ac:chgData name="Wencai Zhang" userId="4a86a1d0-2108-4707-8228-1110f3c1be85" providerId="ADAL" clId="{112F1500-E63F-C344-98C9-79D978A7E0E3}" dt="2021-06-13T21:09:27.076" v="543" actId="478"/>
          <ac:spMkLst>
            <pc:docMk/>
            <pc:sldMk cId="3759201367" sldId="279"/>
            <ac:spMk id="10" creationId="{DFF01E0D-9661-D94A-A54C-3DA2C6CE9304}"/>
          </ac:spMkLst>
        </pc:spChg>
        <pc:spChg chg="add del mod">
          <ac:chgData name="Wencai Zhang" userId="4a86a1d0-2108-4707-8228-1110f3c1be85" providerId="ADAL" clId="{112F1500-E63F-C344-98C9-79D978A7E0E3}" dt="2021-06-14T01:29:31.716" v="678" actId="478"/>
          <ac:spMkLst>
            <pc:docMk/>
            <pc:sldMk cId="3759201367" sldId="279"/>
            <ac:spMk id="12" creationId="{5D38D212-CF39-6F45-AE38-39C9FF93F04B}"/>
          </ac:spMkLst>
        </pc:spChg>
        <pc:spChg chg="del mod">
          <ac:chgData name="Wencai Zhang" userId="4a86a1d0-2108-4707-8228-1110f3c1be85" providerId="ADAL" clId="{112F1500-E63F-C344-98C9-79D978A7E0E3}" dt="2021-06-13T21:10:48.977" v="622" actId="478"/>
          <ac:spMkLst>
            <pc:docMk/>
            <pc:sldMk cId="3759201367" sldId="279"/>
            <ac:spMk id="42" creationId="{89EDAEB4-CA84-D441-9589-6D12D20313AD}"/>
          </ac:spMkLst>
        </pc:spChg>
        <pc:spChg chg="add del mod">
          <ac:chgData name="Wencai Zhang" userId="4a86a1d0-2108-4707-8228-1110f3c1be85" providerId="ADAL" clId="{112F1500-E63F-C344-98C9-79D978A7E0E3}" dt="2021-06-14T01:29:34.420" v="679" actId="478"/>
          <ac:spMkLst>
            <pc:docMk/>
            <pc:sldMk cId="3759201367" sldId="279"/>
            <ac:spMk id="44" creationId="{18D3FA0D-44E1-FF4A-848A-EFD8F183DFEA}"/>
          </ac:spMkLst>
        </pc:spChg>
        <pc:spChg chg="mod">
          <ac:chgData name="Wencai Zhang" userId="4a86a1d0-2108-4707-8228-1110f3c1be85" providerId="ADAL" clId="{112F1500-E63F-C344-98C9-79D978A7E0E3}" dt="2021-06-14T10:23:47.969" v="825" actId="1076"/>
          <ac:spMkLst>
            <pc:docMk/>
            <pc:sldMk cId="3759201367" sldId="279"/>
            <ac:spMk id="45" creationId="{B2AA6943-EB8B-EE4C-9137-93FF3149EADA}"/>
          </ac:spMkLst>
        </pc:spChg>
        <pc:spChg chg="mod">
          <ac:chgData name="Wencai Zhang" userId="4a86a1d0-2108-4707-8228-1110f3c1be85" providerId="ADAL" clId="{112F1500-E63F-C344-98C9-79D978A7E0E3}" dt="2021-06-14T10:24:23.682" v="854" actId="1036"/>
          <ac:spMkLst>
            <pc:docMk/>
            <pc:sldMk cId="3759201367" sldId="279"/>
            <ac:spMk id="46" creationId="{AE153BE9-E801-9F46-B19E-88780C594949}"/>
          </ac:spMkLst>
        </pc:spChg>
        <pc:spChg chg="del mod">
          <ac:chgData name="Wencai Zhang" userId="4a86a1d0-2108-4707-8228-1110f3c1be85" providerId="ADAL" clId="{112F1500-E63F-C344-98C9-79D978A7E0E3}" dt="2021-06-14T10:23:55.243" v="827" actId="478"/>
          <ac:spMkLst>
            <pc:docMk/>
            <pc:sldMk cId="3759201367" sldId="279"/>
            <ac:spMk id="51" creationId="{E37AD563-CB3E-E24F-B69A-5D3C8532C49B}"/>
          </ac:spMkLst>
        </pc:spChg>
        <pc:spChg chg="del">
          <ac:chgData name="Wencai Zhang" userId="4a86a1d0-2108-4707-8228-1110f3c1be85" providerId="ADAL" clId="{112F1500-E63F-C344-98C9-79D978A7E0E3}" dt="2021-06-13T21:08:57.738" v="517" actId="478"/>
          <ac:spMkLst>
            <pc:docMk/>
            <pc:sldMk cId="3759201367" sldId="279"/>
            <ac:spMk id="52" creationId="{2551E2E5-9EEC-084B-B42A-894A2E03799D}"/>
          </ac:spMkLst>
        </pc:spChg>
        <pc:spChg chg="del">
          <ac:chgData name="Wencai Zhang" userId="4a86a1d0-2108-4707-8228-1110f3c1be85" providerId="ADAL" clId="{112F1500-E63F-C344-98C9-79D978A7E0E3}" dt="2021-06-13T21:08:57.738" v="517" actId="478"/>
          <ac:spMkLst>
            <pc:docMk/>
            <pc:sldMk cId="3759201367" sldId="279"/>
            <ac:spMk id="53" creationId="{D6BBD254-7480-734E-B168-8777EB93D3F8}"/>
          </ac:spMkLst>
        </pc:spChg>
        <pc:grpChg chg="mod">
          <ac:chgData name="Wencai Zhang" userId="4a86a1d0-2108-4707-8228-1110f3c1be85" providerId="ADAL" clId="{112F1500-E63F-C344-98C9-79D978A7E0E3}" dt="2021-06-13T21:10:33.129" v="612" actId="1037"/>
          <ac:grpSpMkLst>
            <pc:docMk/>
            <pc:sldMk cId="3759201367" sldId="279"/>
            <ac:grpSpMk id="6" creationId="{5BBCE63B-3F6E-4628-9D2A-69AE69EAC276}"/>
          </ac:grpSpMkLst>
        </pc:grpChg>
        <pc:grpChg chg="del">
          <ac:chgData name="Wencai Zhang" userId="4a86a1d0-2108-4707-8228-1110f3c1be85" providerId="ADAL" clId="{112F1500-E63F-C344-98C9-79D978A7E0E3}" dt="2021-06-13T21:08:57.738" v="517" actId="478"/>
          <ac:grpSpMkLst>
            <pc:docMk/>
            <pc:sldMk cId="3759201367" sldId="279"/>
            <ac:grpSpMk id="26" creationId="{0803CBC6-41A5-4C74-9AF1-5A04B8163ADE}"/>
          </ac:grpSpMkLst>
        </pc:grpChg>
        <pc:graphicFrameChg chg="mod">
          <ac:chgData name="Wencai Zhang" userId="4a86a1d0-2108-4707-8228-1110f3c1be85" providerId="ADAL" clId="{112F1500-E63F-C344-98C9-79D978A7E0E3}" dt="2021-06-14T09:47:59.957" v="683" actId="1076"/>
          <ac:graphicFrameMkLst>
            <pc:docMk/>
            <pc:sldMk cId="3759201367" sldId="279"/>
            <ac:graphicFrameMk id="5" creationId="{91492FF7-4DC1-45F4-90C6-3ADE091545C6}"/>
          </ac:graphicFrameMkLst>
        </pc:graphicFrameChg>
        <pc:graphicFrameChg chg="del">
          <ac:chgData name="Wencai Zhang" userId="4a86a1d0-2108-4707-8228-1110f3c1be85" providerId="ADAL" clId="{112F1500-E63F-C344-98C9-79D978A7E0E3}" dt="2021-06-13T21:08:57.738" v="517" actId="478"/>
          <ac:graphicFrameMkLst>
            <pc:docMk/>
            <pc:sldMk cId="3759201367" sldId="279"/>
            <ac:graphicFrameMk id="25" creationId="{0A1AA60E-C860-4D12-A783-21D62CADDDEF}"/>
          </ac:graphicFrameMkLst>
        </pc:graphicFrameChg>
        <pc:graphicFrameChg chg="del mod">
          <ac:chgData name="Wencai Zhang" userId="4a86a1d0-2108-4707-8228-1110f3c1be85" providerId="ADAL" clId="{112F1500-E63F-C344-98C9-79D978A7E0E3}" dt="2021-06-14T10:14:46.682" v="754" actId="478"/>
          <ac:graphicFrameMkLst>
            <pc:docMk/>
            <pc:sldMk cId="3759201367" sldId="279"/>
            <ac:graphicFrameMk id="34" creationId="{A0B63AE7-C241-604B-BCCE-AEA4190EB6B2}"/>
          </ac:graphicFrameMkLst>
        </pc:graphicFrameChg>
        <pc:graphicFrameChg chg="del mod">
          <ac:chgData name="Wencai Zhang" userId="4a86a1d0-2108-4707-8228-1110f3c1be85" providerId="ADAL" clId="{112F1500-E63F-C344-98C9-79D978A7E0E3}" dt="2021-06-14T10:14:46.682" v="754" actId="478"/>
          <ac:graphicFrameMkLst>
            <pc:docMk/>
            <pc:sldMk cId="3759201367" sldId="279"/>
            <ac:graphicFrameMk id="36" creationId="{410F9F47-8246-3B4C-82EF-36A1E6BAE934}"/>
          </ac:graphicFrameMkLst>
        </pc:graphicFrameChg>
        <pc:graphicFrameChg chg="add del mod">
          <ac:chgData name="Wencai Zhang" userId="4a86a1d0-2108-4707-8228-1110f3c1be85" providerId="ADAL" clId="{112F1500-E63F-C344-98C9-79D978A7E0E3}" dt="2021-06-14T01:23:40.872" v="651" actId="478"/>
          <ac:graphicFrameMkLst>
            <pc:docMk/>
            <pc:sldMk cId="3759201367" sldId="279"/>
            <ac:graphicFrameMk id="43" creationId="{236658BF-CCD0-7949-833E-71623CD9A966}"/>
          </ac:graphicFrameMkLst>
        </pc:graphicFrameChg>
        <pc:graphicFrameChg chg="add mod">
          <ac:chgData name="Wencai Zhang" userId="4a86a1d0-2108-4707-8228-1110f3c1be85" providerId="ADAL" clId="{112F1500-E63F-C344-98C9-79D978A7E0E3}" dt="2021-06-14T10:22:10.522" v="762"/>
          <ac:graphicFrameMkLst>
            <pc:docMk/>
            <pc:sldMk cId="3759201367" sldId="279"/>
            <ac:graphicFrameMk id="47" creationId="{BE817E82-9322-C548-8D94-6D1675BC3DF9}"/>
          </ac:graphicFrameMkLst>
        </pc:graphicFrameChg>
        <pc:graphicFrameChg chg="add mod">
          <ac:chgData name="Wencai Zhang" userId="4a86a1d0-2108-4707-8228-1110f3c1be85" providerId="ADAL" clId="{112F1500-E63F-C344-98C9-79D978A7E0E3}" dt="2021-06-14T10:26:14.889" v="895"/>
          <ac:graphicFrameMkLst>
            <pc:docMk/>
            <pc:sldMk cId="3759201367" sldId="279"/>
            <ac:graphicFrameMk id="48" creationId="{B735A301-EB4D-A841-8B30-B2AF2E6D9ABC}"/>
          </ac:graphicFrameMkLst>
        </pc:graphicFrameChg>
        <pc:picChg chg="add del mod">
          <ac:chgData name="Wencai Zhang" userId="4a86a1d0-2108-4707-8228-1110f3c1be85" providerId="ADAL" clId="{112F1500-E63F-C344-98C9-79D978A7E0E3}" dt="2021-06-14T01:29:28.957" v="677" actId="478"/>
          <ac:picMkLst>
            <pc:docMk/>
            <pc:sldMk cId="3759201367" sldId="279"/>
            <ac:picMk id="11" creationId="{C3B6D0D8-0EEA-2A4C-85E3-1AF6E17F481E}"/>
          </ac:picMkLst>
        </pc:picChg>
        <pc:picChg chg="add mod">
          <ac:chgData name="Wencai Zhang" userId="4a86a1d0-2108-4707-8228-1110f3c1be85" providerId="ADAL" clId="{112F1500-E63F-C344-98C9-79D978A7E0E3}" dt="2021-06-14T10:24:17.390" v="829" actId="1076"/>
          <ac:picMkLst>
            <pc:docMk/>
            <pc:sldMk cId="3759201367" sldId="279"/>
            <ac:picMk id="13" creationId="{23370E1D-80EC-D347-B1F7-2DF6B0EDFA48}"/>
          </ac:picMkLst>
        </pc:picChg>
        <pc:picChg chg="add del mod">
          <ac:chgData name="Wencai Zhang" userId="4a86a1d0-2108-4707-8228-1110f3c1be85" providerId="ADAL" clId="{112F1500-E63F-C344-98C9-79D978A7E0E3}" dt="2021-06-14T10:14:43.607" v="753" actId="478"/>
          <ac:picMkLst>
            <pc:docMk/>
            <pc:sldMk cId="3759201367" sldId="279"/>
            <ac:picMk id="14" creationId="{317D2C68-E6F2-6F46-A357-09A833236BC8}"/>
          </ac:picMkLst>
        </pc:picChg>
        <pc:picChg chg="add del mod">
          <ac:chgData name="Wencai Zhang" userId="4a86a1d0-2108-4707-8228-1110f3c1be85" providerId="ADAL" clId="{112F1500-E63F-C344-98C9-79D978A7E0E3}" dt="2021-06-14T10:22:07.298" v="760" actId="478"/>
          <ac:picMkLst>
            <pc:docMk/>
            <pc:sldMk cId="3759201367" sldId="279"/>
            <ac:picMk id="15" creationId="{72C87D08-0FF5-3748-97F0-15742D1E36F2}"/>
          </ac:picMkLst>
        </pc:picChg>
        <pc:picChg chg="add mod">
          <ac:chgData name="Wencai Zhang" userId="4a86a1d0-2108-4707-8228-1110f3c1be85" providerId="ADAL" clId="{112F1500-E63F-C344-98C9-79D978A7E0E3}" dt="2021-06-14T10:25:36.370" v="893" actId="14100"/>
          <ac:picMkLst>
            <pc:docMk/>
            <pc:sldMk cId="3759201367" sldId="279"/>
            <ac:picMk id="16" creationId="{055A586B-2AE6-784A-A11C-07886E0DC81A}"/>
          </ac:picMkLst>
        </pc:picChg>
        <pc:picChg chg="add mod">
          <ac:chgData name="Wencai Zhang" userId="4a86a1d0-2108-4707-8228-1110f3c1be85" providerId="ADAL" clId="{112F1500-E63F-C344-98C9-79D978A7E0E3}" dt="2021-06-14T10:25:36.370" v="893" actId="14100"/>
          <ac:picMkLst>
            <pc:docMk/>
            <pc:sldMk cId="3759201367" sldId="279"/>
            <ac:picMk id="17" creationId="{5D3B74DC-3E20-1D46-8E5B-367DF83508FD}"/>
          </ac:picMkLst>
        </pc:picChg>
      </pc:sldChg>
      <pc:sldChg chg="modSp add mod">
        <pc:chgData name="Wencai Zhang" userId="4a86a1d0-2108-4707-8228-1110f3c1be85" providerId="ADAL" clId="{112F1500-E63F-C344-98C9-79D978A7E0E3}" dt="2021-06-14T14:20:39.235" v="1273" actId="13926"/>
        <pc:sldMkLst>
          <pc:docMk/>
          <pc:sldMk cId="2833226476" sldId="280"/>
        </pc:sldMkLst>
        <pc:spChg chg="mod">
          <ac:chgData name="Wencai Zhang" userId="4a86a1d0-2108-4707-8228-1110f3c1be85" providerId="ADAL" clId="{112F1500-E63F-C344-98C9-79D978A7E0E3}" dt="2021-06-14T14:20:39.235" v="1273" actId="13926"/>
          <ac:spMkLst>
            <pc:docMk/>
            <pc:sldMk cId="2833226476" sldId="280"/>
            <ac:spMk id="4" creationId="{3F93EE33-98E6-3A41-B628-C0D0014E8476}"/>
          </ac:spMkLst>
        </pc:spChg>
        <pc:spChg chg="mod">
          <ac:chgData name="Wencai Zhang" userId="4a86a1d0-2108-4707-8228-1110f3c1be85" providerId="ADAL" clId="{112F1500-E63F-C344-98C9-79D978A7E0E3}" dt="2021-06-14T10:45:43.079" v="1224" actId="1076"/>
          <ac:spMkLst>
            <pc:docMk/>
            <pc:sldMk cId="2833226476" sldId="280"/>
            <ac:spMk id="5" creationId="{BB2CA66C-E740-1441-928C-D9964DC8499C}"/>
          </ac:spMkLst>
        </pc:spChg>
        <pc:graphicFrameChg chg="mod">
          <ac:chgData name="Wencai Zhang" userId="4a86a1d0-2108-4707-8228-1110f3c1be85" providerId="ADAL" clId="{112F1500-E63F-C344-98C9-79D978A7E0E3}" dt="2021-06-14T10:45:37.860" v="1223" actId="1076"/>
          <ac:graphicFrameMkLst>
            <pc:docMk/>
            <pc:sldMk cId="2833226476" sldId="280"/>
            <ac:graphicFrameMk id="6" creationId="{66CD7BB6-CDE1-9447-BECE-C681B2FA2E90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72B1E0C-5533-3B4C-96E7-B2A064C4ECAC}" type="datetimeFigureOut">
              <a:rPr lang="en-US" smtClean="0"/>
              <a:t>6/23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D0EA0A-6814-514A-BE49-C1EF962D1F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300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39132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75187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49689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37948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39711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25564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66859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30383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87820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61156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70546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B352EF-A4B0-B640-874E-B7ED9C64AEA6}" type="datetimeFigureOut">
              <a:rPr lang="en-US" smtClean="0"/>
              <a:t>6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0C1A51-70A5-6941-B11B-50A16B3741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6110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12" Type="http://schemas.microsoft.com/office/2007/relationships/hdphoto" Target="../media/hdphoto5.wdp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1" Type="http://schemas.openxmlformats.org/officeDocument/2006/relationships/image" Target="../media/image6.png"/><Relationship Id="rId5" Type="http://schemas.openxmlformats.org/officeDocument/2006/relationships/image" Target="../media/image3.png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24D37FD-B82F-244B-9B7C-E21C817CCD6A}"/>
              </a:ext>
            </a:extLst>
          </p:cNvPr>
          <p:cNvSpPr txBox="1"/>
          <p:nvPr/>
        </p:nvSpPr>
        <p:spPr>
          <a:xfrm flipH="1">
            <a:off x="4653927" y="5244072"/>
            <a:ext cx="10134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NA⟵DNA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AF39F428-A678-4A45-93FC-ECC6CA219AF5}"/>
              </a:ext>
            </a:extLst>
          </p:cNvPr>
          <p:cNvSpPr/>
          <p:nvPr/>
        </p:nvSpPr>
        <p:spPr>
          <a:xfrm>
            <a:off x="1505875" y="886290"/>
            <a:ext cx="3704540" cy="10156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 u         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sz="1200" dirty="0" err="1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r>
              <a:rPr lang="en-US" sz="12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     a          a          a</a:t>
            </a:r>
            <a:r>
              <a: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  a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’   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gucgg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en-US" sz="1200" dirty="0" err="1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gcuuauc</a:t>
            </a:r>
            <a:r>
              <a:rPr lang="en-US" sz="12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200" dirty="0" err="1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cug</a:t>
            </a:r>
            <a:r>
              <a:rPr lang="en-US" sz="12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200" dirty="0" err="1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guug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sz="1200" spc="50" dirty="0" err="1">
                <a:latin typeface="Arial" panose="020B0604020202020204" pitchFamily="34" charset="0"/>
                <a:cs typeface="Arial" panose="020B0604020202020204" pitchFamily="34" charset="0"/>
              </a:rPr>
              <a:t>cugu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g  a </a:t>
            </a:r>
          </a:p>
          <a:p>
            <a:r>
              <a:rPr lang="en-US" sz="1200" spc="300" dirty="0">
                <a:latin typeface="Arial" panose="020B0604020202020204" pitchFamily="34" charset="0"/>
                <a:cs typeface="Arial" panose="020B0604020202020204" pitchFamily="34" charset="0"/>
              </a:rPr>
              <a:t>    |||||  </a:t>
            </a:r>
            <a:r>
              <a:rPr lang="en-US" sz="1200" spc="360" dirty="0">
                <a:latin typeface="Arial" panose="020B0604020202020204" pitchFamily="34" charset="0"/>
                <a:cs typeface="Arial" panose="020B0604020202020204" pitchFamily="34" charset="0"/>
              </a:rPr>
              <a:t>||||||||</a:t>
            </a:r>
            <a:r>
              <a:rPr lang="en-US" sz="1200" spc="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spc="320" dirty="0">
                <a:latin typeface="Arial" panose="020B0604020202020204" pitchFamily="34" charset="0"/>
                <a:cs typeface="Arial" panose="020B0604020202020204" pitchFamily="34" charset="0"/>
              </a:rPr>
              <a:t>|||||</a:t>
            </a:r>
            <a:r>
              <a:rPr lang="en-US" sz="1200" spc="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spc="340" dirty="0">
                <a:latin typeface="Arial" panose="020B0604020202020204" pitchFamily="34" charset="0"/>
                <a:cs typeface="Arial" panose="020B0604020202020204" pitchFamily="34" charset="0"/>
              </a:rPr>
              <a:t>|||||</a:t>
            </a:r>
            <a:r>
              <a:rPr lang="en-US" sz="1200" spc="3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200" spc="350" dirty="0">
                <a:latin typeface="Arial" panose="020B0604020202020204" pitchFamily="34" charset="0"/>
                <a:cs typeface="Arial" panose="020B0604020202020204" pitchFamily="34" charset="0"/>
              </a:rPr>
              <a:t>|||</a:t>
            </a:r>
            <a:r>
              <a:rPr lang="en-US" sz="1200" spc="300" dirty="0">
                <a:latin typeface="Arial" panose="020B0604020202020204" pitchFamily="34" charset="0"/>
                <a:cs typeface="Arial" panose="020B0604020202020204" pitchFamily="34" charset="0"/>
              </a:rPr>
              <a:t>| |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’   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agu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en-US" sz="1200" dirty="0" err="1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cggguag</a:t>
            </a:r>
            <a:r>
              <a:rPr lang="en-US" sz="12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200" dirty="0" err="1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gac</a:t>
            </a:r>
            <a:r>
              <a:rPr lang="en-US" sz="12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200" dirty="0" err="1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aa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ggu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c  c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a           </a:t>
            </a:r>
            <a:r>
              <a:rPr lang="en-US" sz="12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g               -          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       -          -  u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8544362-E367-4C4E-A7F7-030AE51C3C55}"/>
              </a:ext>
            </a:extLst>
          </p:cNvPr>
          <p:cNvSpPr txBox="1"/>
          <p:nvPr/>
        </p:nvSpPr>
        <p:spPr>
          <a:xfrm>
            <a:off x="2553935" y="546860"/>
            <a:ext cx="17860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u="sng" dirty="0">
                <a:latin typeface="Arial" panose="020B0604020202020204" pitchFamily="34" charset="0"/>
                <a:cs typeface="Arial" panose="020B0604020202020204" pitchFamily="34" charset="0"/>
              </a:rPr>
              <a:t>hsa-miR-21 pre-miR-21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2D87C540-6C98-8944-ADCD-9E7EE911A211}"/>
              </a:ext>
            </a:extLst>
          </p:cNvPr>
          <p:cNvSpPr/>
          <p:nvPr/>
        </p:nvSpPr>
        <p:spPr>
          <a:xfrm rot="16200000">
            <a:off x="2062814" y="3386036"/>
            <a:ext cx="2459328" cy="10156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     </a:t>
            </a:r>
            <a:r>
              <a:rPr lang="en-US" sz="12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               a          a          a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’        </a:t>
            </a:r>
            <a:r>
              <a:rPr lang="en-US" sz="1200" dirty="0" err="1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gcuuauc</a:t>
            </a:r>
            <a:r>
              <a:rPr lang="en-US" sz="12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200" dirty="0" err="1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cug</a:t>
            </a:r>
            <a:r>
              <a:rPr lang="en-US" sz="12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200" dirty="0" err="1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guug</a:t>
            </a:r>
            <a:endParaRPr lang="en-US" sz="1200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spc="310" dirty="0"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  <a:r>
              <a:rPr lang="en-US" sz="1200" spc="330" dirty="0">
                <a:latin typeface="Arial" panose="020B0604020202020204" pitchFamily="34" charset="0"/>
                <a:cs typeface="Arial" panose="020B0604020202020204" pitchFamily="34" charset="0"/>
              </a:rPr>
              <a:t>|||||||| ||||| |||||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’        </a:t>
            </a:r>
            <a:r>
              <a:rPr lang="en-US" sz="1200" spc="20" dirty="0" err="1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cggguag</a:t>
            </a:r>
            <a:r>
              <a:rPr lang="en-US" sz="1200" spc="2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spc="20" dirty="0" err="1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gac</a:t>
            </a:r>
            <a:r>
              <a:rPr lang="en-US" sz="1200" spc="2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200" spc="20" dirty="0" err="1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aac</a:t>
            </a:r>
            <a:r>
              <a:rPr lang="en-US" sz="1200" spc="2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   </a:t>
            </a:r>
            <a:r>
              <a:rPr lang="en-US" sz="1200" dirty="0" err="1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g</a:t>
            </a:r>
            <a:r>
              <a:rPr lang="en-US" sz="12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     -           c         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029990C-85AF-2147-A476-733A63D9A31A}"/>
              </a:ext>
            </a:extLst>
          </p:cNvPr>
          <p:cNvSpPr txBox="1"/>
          <p:nvPr/>
        </p:nvSpPr>
        <p:spPr>
          <a:xfrm>
            <a:off x="2741962" y="2280590"/>
            <a:ext cx="1200970" cy="4616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iR-21-5p:3p 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uplex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C732350-498E-3D4A-944D-D00BD90F72DA}"/>
              </a:ext>
            </a:extLst>
          </p:cNvPr>
          <p:cNvSpPr txBox="1"/>
          <p:nvPr/>
        </p:nvSpPr>
        <p:spPr>
          <a:xfrm>
            <a:off x="2746808" y="1891369"/>
            <a:ext cx="6254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ICER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258738F4-CE87-844B-80E0-81D7E5D4E9EF}"/>
              </a:ext>
            </a:extLst>
          </p:cNvPr>
          <p:cNvCxnSpPr>
            <a:cxnSpLocks/>
          </p:cNvCxnSpPr>
          <p:nvPr/>
        </p:nvCxnSpPr>
        <p:spPr>
          <a:xfrm rot="10800000" flipV="1">
            <a:off x="3334260" y="1853915"/>
            <a:ext cx="0" cy="36576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CD400E5E-D023-5A44-9C8D-9B326987F385}"/>
              </a:ext>
            </a:extLst>
          </p:cNvPr>
          <p:cNvSpPr txBox="1"/>
          <p:nvPr/>
        </p:nvSpPr>
        <p:spPr>
          <a:xfrm>
            <a:off x="3673833" y="3552060"/>
            <a:ext cx="6110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Unwind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551A3CCA-DB79-1F4A-8493-460CA8910744}"/>
              </a:ext>
            </a:extLst>
          </p:cNvPr>
          <p:cNvCxnSpPr>
            <a:cxnSpLocks/>
          </p:cNvCxnSpPr>
          <p:nvPr/>
        </p:nvCxnSpPr>
        <p:spPr>
          <a:xfrm rot="16200000">
            <a:off x="3998812" y="3351010"/>
            <a:ext cx="0" cy="457200"/>
          </a:xfrm>
          <a:prstGeom prst="straightConnector1">
            <a:avLst/>
          </a:prstGeom>
          <a:ln>
            <a:solidFill>
              <a:srgbClr val="00B0F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Rectangle 13">
            <a:extLst>
              <a:ext uri="{FF2B5EF4-FFF2-40B4-BE49-F238E27FC236}">
                <a16:creationId xmlns:a16="http://schemas.microsoft.com/office/drawing/2014/main" id="{66C163A3-4B0C-B943-9E35-18288CBA2E5B}"/>
              </a:ext>
            </a:extLst>
          </p:cNvPr>
          <p:cNvSpPr/>
          <p:nvPr/>
        </p:nvSpPr>
        <p:spPr>
          <a:xfrm rot="16200000" flipH="1" flipV="1">
            <a:off x="2987618" y="3624376"/>
            <a:ext cx="2926080" cy="461665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6 - </a:t>
            </a:r>
            <a:r>
              <a:rPr lang="en-US" sz="12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  c    a  cag     </a:t>
            </a:r>
            <a:r>
              <a:rPr lang="en-US" sz="1200" spc="-20" dirty="0" err="1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ug</a:t>
            </a:r>
            <a:r>
              <a:rPr lang="en-US" sz="12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ug</a:t>
            </a:r>
            <a:r>
              <a: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 66   3’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  c  a  - -  c      -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u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  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gg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u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79F0A85D-8E83-3547-BC53-8BB087B3ACE7}"/>
              </a:ext>
            </a:extLst>
          </p:cNvPr>
          <p:cNvSpPr/>
          <p:nvPr/>
        </p:nvSpPr>
        <p:spPr>
          <a:xfrm rot="5400000" flipH="1">
            <a:off x="129915" y="3466051"/>
            <a:ext cx="2560320" cy="276999"/>
          </a:xfrm>
          <a:prstGeom prst="rect">
            <a:avLst/>
          </a:prstGeom>
          <a:noFill/>
          <a:ln>
            <a:noFill/>
          </a:ln>
        </p:spPr>
        <p:txBody>
          <a:bodyPr>
            <a:spAutoFit/>
          </a:bodyPr>
          <a:lstStyle/>
          <a:p>
            <a:r>
              <a:rPr lang="en-US" sz="1200" spc="80" dirty="0">
                <a:latin typeface="Arial" panose="020B0604020202020204" pitchFamily="34" charset="0"/>
                <a:cs typeface="Arial" panose="020B0604020202020204" pitchFamily="34" charset="0"/>
              </a:rPr>
              <a:t>       </a:t>
            </a:r>
            <a:r>
              <a:rPr lang="en-US" sz="1200" spc="8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5’ </a:t>
            </a:r>
            <a:r>
              <a:rPr lang="en-US" sz="1200" spc="80" dirty="0" err="1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caacatcagtctgataagcta</a:t>
            </a:r>
            <a:endParaRPr lang="en-US" sz="1200" spc="80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C403BB40-8BC6-CF49-A3BB-DAEC3345D7FA}"/>
              </a:ext>
            </a:extLst>
          </p:cNvPr>
          <p:cNvSpPr/>
          <p:nvPr/>
        </p:nvSpPr>
        <p:spPr>
          <a:xfrm rot="5400000" flipH="1">
            <a:off x="881958" y="3519996"/>
            <a:ext cx="234318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spc="60" dirty="0"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</a:p>
          <a:p>
            <a:r>
              <a:rPr lang="en-US" sz="1200" spc="60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en-US" sz="1200" spc="300" dirty="0">
                <a:latin typeface="Arial" panose="020B0604020202020204" pitchFamily="34" charset="0"/>
                <a:cs typeface="Arial" panose="020B0604020202020204" pitchFamily="34" charset="0"/>
              </a:rPr>
              <a:t>|||</a:t>
            </a:r>
            <a:r>
              <a:rPr lang="en-US" sz="1200" spc="440" dirty="0">
                <a:latin typeface="Arial" panose="020B0604020202020204" pitchFamily="34" charset="0"/>
                <a:cs typeface="Arial" panose="020B0604020202020204" pitchFamily="34" charset="0"/>
              </a:rPr>
              <a:t>|</a:t>
            </a:r>
            <a:r>
              <a:rPr lang="en-US" sz="1200" spc="330" dirty="0">
                <a:latin typeface="Arial" panose="020B0604020202020204" pitchFamily="34" charset="0"/>
                <a:cs typeface="Arial" panose="020B0604020202020204" pitchFamily="34" charset="0"/>
              </a:rPr>
              <a:t>||||||||||||||||||</a:t>
            </a:r>
          </a:p>
          <a:p>
            <a:r>
              <a:rPr lang="en-US" sz="1200" spc="60" dirty="0">
                <a:latin typeface="Arial" panose="020B0604020202020204" pitchFamily="34" charset="0"/>
                <a:cs typeface="Arial" panose="020B0604020202020204" pitchFamily="34" charset="0"/>
              </a:rPr>
              <a:t>5’ </a:t>
            </a:r>
            <a:r>
              <a:rPr lang="en-US" sz="1200" spc="60" dirty="0" err="1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r>
              <a:rPr lang="en-US" sz="1200" spc="-10" dirty="0" err="1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acaucagucugauaagcua</a:t>
            </a:r>
            <a:r>
              <a:rPr lang="en-US" sz="1200" spc="-10" dirty="0">
                <a:solidFill>
                  <a:srgbClr val="C00000"/>
                </a:solidFill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200" spc="-10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0F7AE23-AD41-384B-A913-D043051A7E7D}"/>
              </a:ext>
            </a:extLst>
          </p:cNvPr>
          <p:cNvSpPr txBox="1"/>
          <p:nvPr/>
        </p:nvSpPr>
        <p:spPr>
          <a:xfrm>
            <a:off x="2331620" y="3548392"/>
            <a:ext cx="6110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Unwind</a:t>
            </a:r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44431CC5-B24D-DD43-A06B-132FECB5C457}"/>
              </a:ext>
            </a:extLst>
          </p:cNvPr>
          <p:cNvCxnSpPr>
            <a:cxnSpLocks/>
          </p:cNvCxnSpPr>
          <p:nvPr/>
        </p:nvCxnSpPr>
        <p:spPr>
          <a:xfrm rot="5400000" flipH="1">
            <a:off x="2616818" y="3347342"/>
            <a:ext cx="0" cy="457200"/>
          </a:xfrm>
          <a:prstGeom prst="straightConnector1">
            <a:avLst/>
          </a:prstGeom>
          <a:ln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E4EC7EC8-0B71-3849-A5F4-D5835D07F86D}"/>
              </a:ext>
            </a:extLst>
          </p:cNvPr>
          <p:cNvSpPr txBox="1"/>
          <p:nvPr/>
        </p:nvSpPr>
        <p:spPr>
          <a:xfrm>
            <a:off x="1135790" y="5244073"/>
            <a:ext cx="10134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NA⟶RNA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2FAF02D3-E7CF-7C4E-AE19-426909884E31}"/>
              </a:ext>
            </a:extLst>
          </p:cNvPr>
          <p:cNvSpPr/>
          <p:nvPr/>
        </p:nvSpPr>
        <p:spPr>
          <a:xfrm rot="16200000">
            <a:off x="4119645" y="3860934"/>
            <a:ext cx="2560320" cy="276999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200" spc="80" dirty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5’ </a:t>
            </a:r>
            <a:r>
              <a:rPr lang="en-US" sz="1200" spc="80" dirty="0" err="1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caacatcagtctgataagcta</a:t>
            </a:r>
            <a:endParaRPr lang="en-US" sz="1200" spc="80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0F904C23-6C9E-4244-8CEE-9015521B7052}"/>
              </a:ext>
            </a:extLst>
          </p:cNvPr>
          <p:cNvSpPr/>
          <p:nvPr/>
        </p:nvSpPr>
        <p:spPr>
          <a:xfrm rot="16200000">
            <a:off x="3579911" y="3269571"/>
            <a:ext cx="2343187" cy="830997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r>
              <a:rPr lang="en-US" sz="1200" spc="6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sz="1200" spc="60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</a:p>
          <a:p>
            <a:r>
              <a:rPr lang="en-US" sz="1200" spc="60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en-US" sz="1200" spc="300" dirty="0">
                <a:latin typeface="Arial" panose="020B0604020202020204" pitchFamily="34" charset="0"/>
                <a:cs typeface="Arial" panose="020B0604020202020204" pitchFamily="34" charset="0"/>
              </a:rPr>
              <a:t>||   </a:t>
            </a:r>
            <a:r>
              <a:rPr lang="en-US" sz="1200" spc="360" dirty="0">
                <a:latin typeface="Arial" panose="020B0604020202020204" pitchFamily="34" charset="0"/>
                <a:cs typeface="Arial" panose="020B0604020202020204" pitchFamily="34" charset="0"/>
              </a:rPr>
              <a:t>|||</a:t>
            </a:r>
            <a:r>
              <a:rPr lang="en-US" sz="1200" spc="330" dirty="0">
                <a:latin typeface="Arial" panose="020B0604020202020204" pitchFamily="34" charset="0"/>
                <a:cs typeface="Arial" panose="020B0604020202020204" pitchFamily="34" charset="0"/>
              </a:rPr>
              <a:t>|</a:t>
            </a:r>
            <a:r>
              <a:rPr lang="en-US" sz="1200" spc="300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sz="1200" spc="340" dirty="0">
                <a:latin typeface="Arial" panose="020B0604020202020204" pitchFamily="34" charset="0"/>
                <a:cs typeface="Arial" panose="020B0604020202020204" pitchFamily="34" charset="0"/>
              </a:rPr>
              <a:t>||| </a:t>
            </a:r>
            <a:r>
              <a:rPr lang="en-US" sz="1200" spc="320" dirty="0">
                <a:latin typeface="Arial" panose="020B0604020202020204" pitchFamily="34" charset="0"/>
                <a:cs typeface="Arial" panose="020B0604020202020204" pitchFamily="34" charset="0"/>
              </a:rPr>
              <a:t>|  | |</a:t>
            </a:r>
          </a:p>
          <a:p>
            <a:r>
              <a:rPr lang="en-US" sz="1200" spc="60" dirty="0">
                <a:latin typeface="Arial" panose="020B0604020202020204" pitchFamily="34" charset="0"/>
                <a:cs typeface="Arial" panose="020B0604020202020204" pitchFamily="34" charset="0"/>
              </a:rPr>
              <a:t>5’ </a:t>
            </a:r>
            <a:r>
              <a:rPr lang="en-US" sz="1200" spc="-1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      </a:t>
            </a:r>
            <a:r>
              <a:rPr lang="en-US" sz="1200" spc="40" dirty="0" err="1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uc</a:t>
            </a:r>
            <a:r>
              <a:rPr lang="en-US" sz="1200" spc="-1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</a:t>
            </a:r>
            <a:r>
              <a:rPr lang="en-US" sz="1200" spc="70" dirty="0" err="1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g</a:t>
            </a:r>
            <a:r>
              <a:rPr lang="en-US" sz="1200" spc="-1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u    g  u</a:t>
            </a:r>
          </a:p>
          <a:p>
            <a:r>
              <a:rPr lang="en-US" sz="1200" spc="-1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u   a - -       </a:t>
            </a:r>
            <a:r>
              <a:rPr lang="en-US" sz="1200" spc="-10" dirty="0" err="1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gu</a:t>
            </a:r>
            <a:r>
              <a:rPr lang="en-US" sz="1200" spc="-10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a  aa  c  a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E8A3E89-780F-DE43-94D5-228C1F89DBC5}"/>
              </a:ext>
            </a:extLst>
          </p:cNvPr>
          <p:cNvSpPr txBox="1"/>
          <p:nvPr/>
        </p:nvSpPr>
        <p:spPr>
          <a:xfrm>
            <a:off x="1822405" y="1978472"/>
            <a:ext cx="89960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-21-5p</a:t>
            </a:r>
          </a:p>
          <a:p>
            <a:pPr algn="ctr"/>
            <a:r>
              <a:rPr lang="en-US" sz="1200" u="sng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22-nt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D156526-8BD0-E947-9E49-69DA17E8F015}"/>
              </a:ext>
            </a:extLst>
          </p:cNvPr>
          <p:cNvSpPr txBox="1"/>
          <p:nvPr/>
        </p:nvSpPr>
        <p:spPr>
          <a:xfrm>
            <a:off x="3944434" y="1986812"/>
            <a:ext cx="89960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-21-3p</a:t>
            </a:r>
          </a:p>
          <a:p>
            <a:pPr algn="ctr"/>
            <a:r>
              <a:rPr lang="en-US" sz="1200" u="sng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21-nt)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543F5E0E-E137-8446-9C3A-056AF9CB57D0}"/>
              </a:ext>
            </a:extLst>
          </p:cNvPr>
          <p:cNvSpPr/>
          <p:nvPr/>
        </p:nvSpPr>
        <p:spPr>
          <a:xfrm rot="16200000" flipH="1">
            <a:off x="806042" y="3674640"/>
            <a:ext cx="279012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’  8 -</a:t>
            </a:r>
            <a:r>
              <a:rPr lang="en-US" sz="1200" spc="-10" dirty="0" err="1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agcuuaucagacugauguug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 29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6CA175CA-787A-6747-ABDE-C150D4B207F0}"/>
              </a:ext>
            </a:extLst>
          </p:cNvPr>
          <p:cNvSpPr/>
          <p:nvPr/>
        </p:nvSpPr>
        <p:spPr>
          <a:xfrm>
            <a:off x="1637291" y="2459904"/>
            <a:ext cx="731520" cy="2743200"/>
          </a:xfrm>
          <a:prstGeom prst="rect">
            <a:avLst/>
          </a:prstGeom>
          <a:noFill/>
          <a:ln>
            <a:solidFill>
              <a:srgbClr val="00B05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DB089539-C70F-014A-A770-BE7FB6A49579}"/>
              </a:ext>
            </a:extLst>
          </p:cNvPr>
          <p:cNvSpPr/>
          <p:nvPr/>
        </p:nvSpPr>
        <p:spPr>
          <a:xfrm>
            <a:off x="4240928" y="2459904"/>
            <a:ext cx="917090" cy="2743200"/>
          </a:xfrm>
          <a:prstGeom prst="rect">
            <a:avLst/>
          </a:prstGeom>
          <a:noFill/>
          <a:ln>
            <a:solidFill>
              <a:srgbClr val="00B0F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U-Turn Arrow 26">
            <a:extLst>
              <a:ext uri="{FF2B5EF4-FFF2-40B4-BE49-F238E27FC236}">
                <a16:creationId xmlns:a16="http://schemas.microsoft.com/office/drawing/2014/main" id="{8497600A-7AF0-F443-A5AA-ECED2C713EE6}"/>
              </a:ext>
            </a:extLst>
          </p:cNvPr>
          <p:cNvSpPr/>
          <p:nvPr/>
        </p:nvSpPr>
        <p:spPr>
          <a:xfrm flipV="1">
            <a:off x="1395197" y="4951245"/>
            <a:ext cx="483910" cy="152781"/>
          </a:xfrm>
          <a:prstGeom prst="uturn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28" name="U-Turn Arrow 27">
            <a:extLst>
              <a:ext uri="{FF2B5EF4-FFF2-40B4-BE49-F238E27FC236}">
                <a16:creationId xmlns:a16="http://schemas.microsoft.com/office/drawing/2014/main" id="{238F39F9-8419-7843-927A-563426EF3AD1}"/>
              </a:ext>
            </a:extLst>
          </p:cNvPr>
          <p:cNvSpPr/>
          <p:nvPr/>
        </p:nvSpPr>
        <p:spPr>
          <a:xfrm flipH="1" flipV="1">
            <a:off x="4918097" y="4953493"/>
            <a:ext cx="483910" cy="152781"/>
          </a:xfrm>
          <a:prstGeom prst="uturn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FA65C62-1519-8441-A07C-377FBAE60173}"/>
              </a:ext>
            </a:extLst>
          </p:cNvPr>
          <p:cNvSpPr txBox="1"/>
          <p:nvPr/>
        </p:nvSpPr>
        <p:spPr>
          <a:xfrm rot="5400000">
            <a:off x="-66716" y="3690327"/>
            <a:ext cx="24341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u="sng" dirty="0" err="1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enti</a:t>
            </a:r>
            <a:r>
              <a:rPr lang="en-US" sz="1200" u="sng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iRa-Off-miR-21-5p (22-nt)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359977FD-2673-6F41-81CE-3CA2D7E8124E}"/>
              </a:ext>
            </a:extLst>
          </p:cNvPr>
          <p:cNvSpPr txBox="1"/>
          <p:nvPr/>
        </p:nvSpPr>
        <p:spPr>
          <a:xfrm rot="5400000" flipH="1" flipV="1">
            <a:off x="4438228" y="3668991"/>
            <a:ext cx="24341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u="sng" dirty="0" err="1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enti</a:t>
            </a:r>
            <a:r>
              <a:rPr lang="en-US" sz="1200" u="sng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iRa-Off-miR-21-5p (22-nt)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F7465C9C-78DF-3542-8882-81639FF3A4F4}"/>
              </a:ext>
            </a:extLst>
          </p:cNvPr>
          <p:cNvSpPr txBox="1"/>
          <p:nvPr/>
        </p:nvSpPr>
        <p:spPr>
          <a:xfrm>
            <a:off x="4272274" y="53505"/>
            <a:ext cx="189346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A</a:t>
            </a:r>
          </a:p>
        </p:txBody>
      </p:sp>
    </p:spTree>
    <p:extLst>
      <p:ext uri="{BB962C8B-B14F-4D97-AF65-F5344CB8AC3E}">
        <p14:creationId xmlns:p14="http://schemas.microsoft.com/office/powerpoint/2010/main" val="20619213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" name="Group 33">
            <a:extLst>
              <a:ext uri="{FF2B5EF4-FFF2-40B4-BE49-F238E27FC236}">
                <a16:creationId xmlns:a16="http://schemas.microsoft.com/office/drawing/2014/main" id="{4C2A78FB-6C8A-C941-A132-B65C2914441B}"/>
              </a:ext>
            </a:extLst>
          </p:cNvPr>
          <p:cNvGrpSpPr/>
          <p:nvPr/>
        </p:nvGrpSpPr>
        <p:grpSpPr>
          <a:xfrm>
            <a:off x="1145688" y="470762"/>
            <a:ext cx="4800231" cy="4974212"/>
            <a:chOff x="1145688" y="1011536"/>
            <a:chExt cx="4800231" cy="4974212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130F355E-250F-424C-915E-3FA5BFFA484A}"/>
                </a:ext>
              </a:extLst>
            </p:cNvPr>
            <p:cNvGrpSpPr/>
            <p:nvPr/>
          </p:nvGrpSpPr>
          <p:grpSpPr>
            <a:xfrm>
              <a:off x="1281403" y="1011536"/>
              <a:ext cx="4534299" cy="4974212"/>
              <a:chOff x="6826795" y="878800"/>
              <a:chExt cx="4534299" cy="4974212"/>
            </a:xfrm>
          </p:grpSpPr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11536CAB-5571-784D-87B0-03B841A1659F}"/>
                  </a:ext>
                </a:extLst>
              </p:cNvPr>
              <p:cNvSpPr txBox="1"/>
              <p:nvPr/>
            </p:nvSpPr>
            <p:spPr>
              <a:xfrm flipH="1">
                <a:off x="10347675" y="5576012"/>
                <a:ext cx="101341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RNA⟵DNA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11A0F91C-0883-DE42-BEAB-7C0AECDFC0A8}"/>
                  </a:ext>
                </a:extLst>
              </p:cNvPr>
              <p:cNvSpPr txBox="1"/>
              <p:nvPr/>
            </p:nvSpPr>
            <p:spPr>
              <a:xfrm>
                <a:off x="8126607" y="878800"/>
                <a:ext cx="17860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hsa-miR-21 pre-miR-21</a:t>
                </a:r>
              </a:p>
            </p:txBody>
          </p:sp>
          <p:sp>
            <p:nvSpPr>
              <p:cNvPr id="9" name="Rectangle 8">
                <a:extLst>
                  <a:ext uri="{FF2B5EF4-FFF2-40B4-BE49-F238E27FC236}">
                    <a16:creationId xmlns:a16="http://schemas.microsoft.com/office/drawing/2014/main" id="{AF621718-DF92-3141-90B8-3EA0F499410B}"/>
                  </a:ext>
                </a:extLst>
              </p:cNvPr>
              <p:cNvSpPr/>
              <p:nvPr/>
            </p:nvSpPr>
            <p:spPr>
              <a:xfrm rot="16200000">
                <a:off x="7754358" y="3717976"/>
                <a:ext cx="2459328" cy="1015663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 </a:t>
                </a:r>
                <a:r>
                  <a:rPr lang="en-US" sz="1200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               a          a          a</a:t>
                </a:r>
              </a:p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5’        </a:t>
                </a:r>
                <a:r>
                  <a:rPr lang="en-US" sz="1200" dirty="0" err="1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gcuuauc</a:t>
                </a:r>
                <a:r>
                  <a:rPr lang="en-US" sz="1200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  <a:r>
                  <a:rPr lang="en-US" sz="1200" dirty="0" err="1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acug</a:t>
                </a:r>
                <a:r>
                  <a:rPr lang="en-US" sz="1200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  <a:r>
                  <a:rPr lang="en-US" sz="1200" dirty="0" err="1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guug</a:t>
                </a:r>
                <a:endParaRPr lang="en-US" sz="12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1200" spc="31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</a:t>
                </a:r>
                <a:r>
                  <a:rPr lang="en-US" sz="1200" spc="330" dirty="0">
                    <a:latin typeface="Arial" panose="020B0604020202020204" pitchFamily="34" charset="0"/>
                    <a:cs typeface="Arial" panose="020B0604020202020204" pitchFamily="34" charset="0"/>
                  </a:rPr>
                  <a:t>|||||||| ||||| |||||</a:t>
                </a:r>
              </a:p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3’        </a:t>
                </a:r>
                <a:r>
                  <a:rPr lang="en-US" sz="1200" spc="20" dirty="0" err="1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cggguag</a:t>
                </a:r>
                <a:r>
                  <a:rPr lang="en-US" sz="1200" spc="20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200" spc="20" dirty="0" err="1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ugac</a:t>
                </a:r>
                <a:r>
                  <a:rPr lang="en-US" sz="1200" spc="20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  <a:r>
                  <a:rPr lang="en-US" sz="1200" spc="20" dirty="0" err="1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caac</a:t>
                </a:r>
                <a:r>
                  <a:rPr lang="en-US" sz="1200" spc="20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</a:p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</a:t>
                </a:r>
                <a:r>
                  <a:rPr lang="en-US" sz="1200" dirty="0" err="1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g</a:t>
                </a:r>
                <a:r>
                  <a:rPr lang="en-US" sz="1200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            -           c          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D1A0E655-0FB1-FC41-8648-508ACA1193B7}"/>
                  </a:ext>
                </a:extLst>
              </p:cNvPr>
              <p:cNvSpPr txBox="1"/>
              <p:nvPr/>
            </p:nvSpPr>
            <p:spPr>
              <a:xfrm>
                <a:off x="8433506" y="2612530"/>
                <a:ext cx="1200970" cy="461665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1-5p:3p </a:t>
                </a:r>
              </a:p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uplex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C4B68C6C-7A7C-8246-B263-52DC39EFF84D}"/>
                  </a:ext>
                </a:extLst>
              </p:cNvPr>
              <p:cNvSpPr txBox="1"/>
              <p:nvPr/>
            </p:nvSpPr>
            <p:spPr>
              <a:xfrm>
                <a:off x="8438352" y="2223309"/>
                <a:ext cx="62549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DICER</a:t>
                </a:r>
              </a:p>
            </p:txBody>
          </p:sp>
          <p:cxnSp>
            <p:nvCxnSpPr>
              <p:cNvPr id="12" name="Straight Arrow Connector 11">
                <a:extLst>
                  <a:ext uri="{FF2B5EF4-FFF2-40B4-BE49-F238E27FC236}">
                    <a16:creationId xmlns:a16="http://schemas.microsoft.com/office/drawing/2014/main" id="{EF263A42-90E0-4A4E-94DB-C7CD716C0924}"/>
                  </a:ext>
                </a:extLst>
              </p:cNvPr>
              <p:cNvCxnSpPr>
                <a:cxnSpLocks/>
              </p:cNvCxnSpPr>
              <p:nvPr/>
            </p:nvCxnSpPr>
            <p:spPr>
              <a:xfrm rot="10800000" flipV="1">
                <a:off x="9025804" y="2185855"/>
                <a:ext cx="0" cy="36576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6F8934B5-E8A8-8B47-B0DE-45EAD067E329}"/>
                  </a:ext>
                </a:extLst>
              </p:cNvPr>
              <p:cNvSpPr txBox="1"/>
              <p:nvPr/>
            </p:nvSpPr>
            <p:spPr>
              <a:xfrm>
                <a:off x="9365377" y="3884000"/>
                <a:ext cx="61106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Unwind</a:t>
                </a:r>
              </a:p>
            </p:txBody>
          </p:sp>
          <p:cxnSp>
            <p:nvCxnSpPr>
              <p:cNvPr id="14" name="Straight Arrow Connector 13">
                <a:extLst>
                  <a:ext uri="{FF2B5EF4-FFF2-40B4-BE49-F238E27FC236}">
                    <a16:creationId xmlns:a16="http://schemas.microsoft.com/office/drawing/2014/main" id="{B884D221-B79D-6C4A-A9B5-388D6ACD1842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>
                <a:off x="9690356" y="3682950"/>
                <a:ext cx="0" cy="457200"/>
              </a:xfrm>
              <a:prstGeom prst="straightConnector1">
                <a:avLst/>
              </a:prstGeom>
              <a:ln>
                <a:solidFill>
                  <a:srgbClr val="00B0F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" name="Rectangle 14">
                <a:extLst>
                  <a:ext uri="{FF2B5EF4-FFF2-40B4-BE49-F238E27FC236}">
                    <a16:creationId xmlns:a16="http://schemas.microsoft.com/office/drawing/2014/main" id="{C60F2C10-10F0-A840-9A79-4583E30D6853}"/>
                  </a:ext>
                </a:extLst>
              </p:cNvPr>
              <p:cNvSpPr/>
              <p:nvPr/>
            </p:nvSpPr>
            <p:spPr>
              <a:xfrm rot="16200000" flipH="1" flipV="1">
                <a:off x="8679162" y="3956316"/>
                <a:ext cx="2926080" cy="461665"/>
              </a:xfrm>
              <a:prstGeom prst="rect">
                <a:avLst/>
              </a:prstGeom>
            </p:spPr>
            <p:txBody>
              <a:bodyPr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46 - </a:t>
                </a:r>
                <a:r>
                  <a:rPr lang="en-US" sz="1200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  c    a  cag      </a:t>
                </a:r>
                <a:r>
                  <a:rPr lang="en-US" sz="1200" spc="-20" dirty="0" err="1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aug</a:t>
                </a:r>
                <a:r>
                  <a:rPr lang="en-US" sz="1200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  </a:t>
                </a:r>
                <a:r>
                  <a:rPr lang="en-US" sz="1200" dirty="0" err="1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g</a:t>
                </a:r>
                <a:r>
                  <a:rPr lang="en-US" sz="12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 66   3’</a:t>
                </a:r>
              </a:p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c  a  - -  c      - </a:t>
                </a:r>
                <a:r>
                  <a:rPr lang="en-US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c</a:t>
                </a: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</a:t>
                </a:r>
                <a:r>
                  <a:rPr lang="en-US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gc</a:t>
                </a: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u</a:t>
                </a:r>
              </a:p>
            </p:txBody>
          </p:sp>
          <p:sp>
            <p:nvSpPr>
              <p:cNvPr id="16" name="Rectangle 15">
                <a:extLst>
                  <a:ext uri="{FF2B5EF4-FFF2-40B4-BE49-F238E27FC236}">
                    <a16:creationId xmlns:a16="http://schemas.microsoft.com/office/drawing/2014/main" id="{03A6ADD2-67A5-154A-AACF-42CB11D378BB}"/>
                  </a:ext>
                </a:extLst>
              </p:cNvPr>
              <p:cNvSpPr/>
              <p:nvPr/>
            </p:nvSpPr>
            <p:spPr>
              <a:xfrm rot="5400000" flipH="1">
                <a:off x="5821459" y="3797991"/>
                <a:ext cx="2560320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>
                <a:spAutoFit/>
              </a:bodyPr>
              <a:lstStyle/>
              <a:p>
                <a:r>
                  <a:rPr lang="en-US" sz="1200" spc="8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</a:t>
                </a:r>
                <a:r>
                  <a:rPr lang="en-US" sz="1200" spc="80" dirty="0">
                    <a:solidFill>
                      <a:schemeClr val="bg1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’ </a:t>
                </a:r>
                <a:r>
                  <a:rPr lang="en-US" sz="1200" spc="80" dirty="0" err="1">
                    <a:solidFill>
                      <a:srgbClr val="7030A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aacatcagtctgataagct</a:t>
                </a:r>
                <a:endParaRPr lang="en-US" sz="1200" spc="80" dirty="0">
                  <a:solidFill>
                    <a:srgbClr val="7030A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Rectangle 16">
                <a:extLst>
                  <a:ext uri="{FF2B5EF4-FFF2-40B4-BE49-F238E27FC236}">
                    <a16:creationId xmlns:a16="http://schemas.microsoft.com/office/drawing/2014/main" id="{14893B54-54C3-3940-84C8-6A9E90F309F1}"/>
                  </a:ext>
                </a:extLst>
              </p:cNvPr>
              <p:cNvSpPr/>
              <p:nvPr/>
            </p:nvSpPr>
            <p:spPr>
              <a:xfrm rot="5400000" flipH="1">
                <a:off x="6573502" y="3899642"/>
                <a:ext cx="2343187" cy="64633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200" spc="6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</a:t>
                </a:r>
              </a:p>
              <a:p>
                <a:r>
                  <a:rPr lang="en-US" sz="1200" spc="60" dirty="0">
                    <a:latin typeface="Arial" panose="020B0604020202020204" pitchFamily="34" charset="0"/>
                    <a:cs typeface="Arial" panose="020B0604020202020204" pitchFamily="34" charset="0"/>
                  </a:rPr>
                  <a:t>    </a:t>
                </a:r>
                <a:r>
                  <a:rPr lang="en-US" sz="1200" spc="330" dirty="0">
                    <a:latin typeface="Arial" panose="020B0604020202020204" pitchFamily="34" charset="0"/>
                    <a:cs typeface="Arial" panose="020B0604020202020204" pitchFamily="34" charset="0"/>
                  </a:rPr>
                  <a:t>||||||||||||||||||||</a:t>
                </a:r>
              </a:p>
              <a:p>
                <a:r>
                  <a:rPr lang="en-US" sz="1200" spc="60" dirty="0">
                    <a:latin typeface="Arial" panose="020B0604020202020204" pitchFamily="34" charset="0"/>
                    <a:cs typeface="Arial" panose="020B0604020202020204" pitchFamily="34" charset="0"/>
                  </a:rPr>
                  <a:t>5’ </a:t>
                </a:r>
                <a:r>
                  <a:rPr lang="en-US" sz="1200" dirty="0" err="1">
                    <a:solidFill>
                      <a:srgbClr val="7030A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aacaucagucugauaagcu</a:t>
                </a:r>
                <a:endParaRPr lang="en-US" sz="1200" dirty="0">
                  <a:solidFill>
                    <a:srgbClr val="7030A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126E137B-8F1A-2B4E-ADC2-453E766B5A95}"/>
                  </a:ext>
                </a:extLst>
              </p:cNvPr>
              <p:cNvSpPr txBox="1"/>
              <p:nvPr/>
            </p:nvSpPr>
            <p:spPr>
              <a:xfrm>
                <a:off x="8023164" y="3880332"/>
                <a:ext cx="61106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Unwind</a:t>
                </a:r>
              </a:p>
            </p:txBody>
          </p:sp>
          <p:cxnSp>
            <p:nvCxnSpPr>
              <p:cNvPr id="19" name="Straight Arrow Connector 18">
                <a:extLst>
                  <a:ext uri="{FF2B5EF4-FFF2-40B4-BE49-F238E27FC236}">
                    <a16:creationId xmlns:a16="http://schemas.microsoft.com/office/drawing/2014/main" id="{7D09B15C-369C-9443-ABC3-32C44F6CA1BB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H="1">
                <a:off x="8308362" y="3679282"/>
                <a:ext cx="0" cy="457200"/>
              </a:xfrm>
              <a:prstGeom prst="straightConnector1">
                <a:avLst/>
              </a:prstGeom>
              <a:ln>
                <a:solidFill>
                  <a:srgbClr val="00B05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D3237517-45C7-334A-AFC3-139E4BA69BD3}"/>
                  </a:ext>
                </a:extLst>
              </p:cNvPr>
              <p:cNvSpPr txBox="1"/>
              <p:nvPr/>
            </p:nvSpPr>
            <p:spPr>
              <a:xfrm>
                <a:off x="6826795" y="5576013"/>
                <a:ext cx="101341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DNA⟶RNA</a:t>
                </a:r>
              </a:p>
            </p:txBody>
          </p:sp>
          <p:sp>
            <p:nvSpPr>
              <p:cNvPr id="21" name="Rectangle 20">
                <a:extLst>
                  <a:ext uri="{FF2B5EF4-FFF2-40B4-BE49-F238E27FC236}">
                    <a16:creationId xmlns:a16="http://schemas.microsoft.com/office/drawing/2014/main" id="{B17DD708-2A55-9D4D-97D6-6EC7B0B90CB8}"/>
                  </a:ext>
                </a:extLst>
              </p:cNvPr>
              <p:cNvSpPr/>
              <p:nvPr/>
            </p:nvSpPr>
            <p:spPr>
              <a:xfrm rot="16200000">
                <a:off x="9811189" y="4192874"/>
                <a:ext cx="2560320" cy="276999"/>
              </a:xfrm>
              <a:prstGeom prst="rect">
                <a:avLst/>
              </a:prstGeom>
            </p:spPr>
            <p:txBody>
              <a:bodyPr>
                <a:spAutoFit/>
              </a:bodyPr>
              <a:lstStyle/>
              <a:p>
                <a:r>
                  <a:rPr lang="en-US" sz="1200" spc="80" dirty="0">
                    <a:solidFill>
                      <a:schemeClr val="bg1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    5’ </a:t>
                </a:r>
                <a:r>
                  <a:rPr lang="en-US" sz="1200" spc="80" dirty="0" err="1">
                    <a:solidFill>
                      <a:srgbClr val="7030A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aacatcagtctgataagct</a:t>
                </a:r>
                <a:endParaRPr lang="en-US" sz="1200" spc="80" dirty="0">
                  <a:solidFill>
                    <a:srgbClr val="7030A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Rectangle 21">
                <a:extLst>
                  <a:ext uri="{FF2B5EF4-FFF2-40B4-BE49-F238E27FC236}">
                    <a16:creationId xmlns:a16="http://schemas.microsoft.com/office/drawing/2014/main" id="{C251204B-5D72-474F-86EF-09A696BEFB75}"/>
                  </a:ext>
                </a:extLst>
              </p:cNvPr>
              <p:cNvSpPr/>
              <p:nvPr/>
            </p:nvSpPr>
            <p:spPr>
              <a:xfrm rot="16200000">
                <a:off x="9264367" y="3601511"/>
                <a:ext cx="2343187" cy="83099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/>
              <a:p>
                <a:r>
                  <a:rPr lang="en-US" sz="1200" spc="6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</a:t>
                </a:r>
                <a:r>
                  <a:rPr lang="en-US" sz="1200" spc="60" dirty="0">
                    <a:latin typeface="Arial" panose="020B0604020202020204" pitchFamily="34" charset="0"/>
                    <a:cs typeface="Arial" panose="020B0604020202020204" pitchFamily="34" charset="0"/>
                  </a:rPr>
                  <a:t>   </a:t>
                </a:r>
              </a:p>
              <a:p>
                <a:r>
                  <a:rPr lang="en-US" sz="1200" spc="60" dirty="0">
                    <a:latin typeface="Arial" panose="020B0604020202020204" pitchFamily="34" charset="0"/>
                    <a:cs typeface="Arial" panose="020B0604020202020204" pitchFamily="34" charset="0"/>
                  </a:rPr>
                  <a:t>    </a:t>
                </a:r>
                <a:r>
                  <a:rPr lang="en-US" sz="1200" spc="300" dirty="0">
                    <a:latin typeface="Arial" panose="020B0604020202020204" pitchFamily="34" charset="0"/>
                    <a:cs typeface="Arial" panose="020B0604020202020204" pitchFamily="34" charset="0"/>
                  </a:rPr>
                  <a:t>||   ||||   </a:t>
                </a:r>
                <a:r>
                  <a:rPr lang="en-US" sz="1200" spc="330" dirty="0">
                    <a:latin typeface="Arial" panose="020B0604020202020204" pitchFamily="34" charset="0"/>
                    <a:cs typeface="Arial" panose="020B0604020202020204" pitchFamily="34" charset="0"/>
                  </a:rPr>
                  <a:t>||| |</a:t>
                </a:r>
                <a:r>
                  <a:rPr lang="en-US" sz="1200" spc="380" dirty="0">
                    <a:latin typeface="Arial" panose="020B0604020202020204" pitchFamily="34" charset="0"/>
                    <a:cs typeface="Arial" panose="020B0604020202020204" pitchFamily="34" charset="0"/>
                  </a:rPr>
                  <a:t>  | |</a:t>
                </a:r>
              </a:p>
              <a:p>
                <a:r>
                  <a:rPr lang="en-US" sz="1200" spc="60" dirty="0">
                    <a:latin typeface="Arial" panose="020B0604020202020204" pitchFamily="34" charset="0"/>
                    <a:cs typeface="Arial" panose="020B0604020202020204" pitchFamily="34" charset="0"/>
                  </a:rPr>
                  <a:t>5’ </a:t>
                </a:r>
                <a:r>
                  <a:rPr lang="en-US" sz="1200" spc="-10" dirty="0">
                    <a:solidFill>
                      <a:srgbClr val="7030A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a      </a:t>
                </a:r>
                <a:r>
                  <a:rPr lang="en-US" sz="1200" spc="-10" dirty="0" err="1">
                    <a:solidFill>
                      <a:srgbClr val="7030A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auc</a:t>
                </a:r>
                <a:r>
                  <a:rPr lang="en-US" sz="1200" spc="-10" dirty="0">
                    <a:solidFill>
                      <a:srgbClr val="7030A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   </a:t>
                </a:r>
                <a:r>
                  <a:rPr lang="en-US" sz="1200" spc="-10" dirty="0" err="1">
                    <a:solidFill>
                      <a:srgbClr val="7030A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ug</a:t>
                </a:r>
                <a:r>
                  <a:rPr lang="en-US" sz="1200" spc="-10" dirty="0">
                    <a:solidFill>
                      <a:srgbClr val="7030A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u    </a:t>
                </a:r>
                <a:r>
                  <a:rPr lang="en-US" sz="1200" spc="40" dirty="0">
                    <a:solidFill>
                      <a:srgbClr val="7030A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  u</a:t>
                </a:r>
              </a:p>
              <a:p>
                <a:r>
                  <a:rPr lang="en-US" sz="1200" spc="-1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</a:t>
                </a:r>
                <a:r>
                  <a:rPr lang="en-US" sz="1200" spc="-10" dirty="0">
                    <a:solidFill>
                      <a:srgbClr val="7030A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 - -       </a:t>
                </a:r>
                <a:r>
                  <a:rPr lang="en-US" sz="1200" spc="-10" dirty="0" err="1">
                    <a:solidFill>
                      <a:srgbClr val="7030A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gu</a:t>
                </a:r>
                <a:r>
                  <a:rPr lang="en-US" sz="1200" spc="-10" dirty="0">
                    <a:solidFill>
                      <a:srgbClr val="7030A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  a  aa  c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5A684A73-5221-7B42-AE5D-57020A75084E}"/>
                  </a:ext>
                </a:extLst>
              </p:cNvPr>
              <p:cNvSpPr txBox="1"/>
              <p:nvPr/>
            </p:nvSpPr>
            <p:spPr>
              <a:xfrm>
                <a:off x="7513949" y="2310412"/>
                <a:ext cx="899605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iR-21-5p</a:t>
                </a:r>
              </a:p>
              <a:p>
                <a:pPr algn="ctr"/>
                <a:r>
                  <a:rPr lang="en-US" sz="1200" u="sng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22-nt)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F0A4BDA3-E840-9C4C-8AED-A0106BE735EE}"/>
                  </a:ext>
                </a:extLst>
              </p:cNvPr>
              <p:cNvSpPr txBox="1"/>
              <p:nvPr/>
            </p:nvSpPr>
            <p:spPr>
              <a:xfrm>
                <a:off x="9635978" y="2318752"/>
                <a:ext cx="899605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iR-21-3p</a:t>
                </a:r>
              </a:p>
              <a:p>
                <a:pPr algn="ctr"/>
                <a:r>
                  <a:rPr lang="en-US" sz="1200" u="sng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21-nt)</a:t>
                </a:r>
              </a:p>
            </p:txBody>
          </p:sp>
          <p:sp>
            <p:nvSpPr>
              <p:cNvPr id="25" name="Rectangle 24">
                <a:extLst>
                  <a:ext uri="{FF2B5EF4-FFF2-40B4-BE49-F238E27FC236}">
                    <a16:creationId xmlns:a16="http://schemas.microsoft.com/office/drawing/2014/main" id="{B92B14F2-E13B-BF40-B4C7-80144DBA03B5}"/>
                  </a:ext>
                </a:extLst>
              </p:cNvPr>
              <p:cNvSpPr/>
              <p:nvPr/>
            </p:nvSpPr>
            <p:spPr>
              <a:xfrm rot="16200000" flipH="1">
                <a:off x="6497586" y="4006580"/>
                <a:ext cx="2790125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5’   8 -</a:t>
                </a:r>
                <a:r>
                  <a:rPr lang="en-US" sz="1200" spc="-2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</a:t>
                </a:r>
                <a:r>
                  <a:rPr lang="en-US" sz="1200" spc="-20" dirty="0" err="1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gcuuaucag</a:t>
                </a:r>
                <a:r>
                  <a:rPr lang="en-US" sz="1200" dirty="0" err="1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cugauguug</a:t>
                </a:r>
                <a:r>
                  <a:rPr lang="en-US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 29</a:t>
                </a:r>
              </a:p>
            </p:txBody>
          </p:sp>
          <p:sp>
            <p:nvSpPr>
              <p:cNvPr id="26" name="Rectangle 25">
                <a:extLst>
                  <a:ext uri="{FF2B5EF4-FFF2-40B4-BE49-F238E27FC236}">
                    <a16:creationId xmlns:a16="http://schemas.microsoft.com/office/drawing/2014/main" id="{26D5A68F-0376-E74F-91CA-3001DB9BD906}"/>
                  </a:ext>
                </a:extLst>
              </p:cNvPr>
              <p:cNvSpPr/>
              <p:nvPr/>
            </p:nvSpPr>
            <p:spPr>
              <a:xfrm>
                <a:off x="7328835" y="2791844"/>
                <a:ext cx="731520" cy="2743200"/>
              </a:xfrm>
              <a:prstGeom prst="rect">
                <a:avLst/>
              </a:prstGeom>
              <a:noFill/>
              <a:ln>
                <a:solidFill>
                  <a:srgbClr val="00B05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7" name="Rectangle 26">
                <a:extLst>
                  <a:ext uri="{FF2B5EF4-FFF2-40B4-BE49-F238E27FC236}">
                    <a16:creationId xmlns:a16="http://schemas.microsoft.com/office/drawing/2014/main" id="{0F7D2794-D47C-4C40-AB1F-9D6F36B7E716}"/>
                  </a:ext>
                </a:extLst>
              </p:cNvPr>
              <p:cNvSpPr/>
              <p:nvPr/>
            </p:nvSpPr>
            <p:spPr>
              <a:xfrm>
                <a:off x="9932472" y="2791844"/>
                <a:ext cx="917090" cy="2743200"/>
              </a:xfrm>
              <a:prstGeom prst="rect">
                <a:avLst/>
              </a:prstGeom>
              <a:noFill/>
              <a:ln>
                <a:solidFill>
                  <a:srgbClr val="00B0F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8" name="U-Turn Arrow 27">
                <a:extLst>
                  <a:ext uri="{FF2B5EF4-FFF2-40B4-BE49-F238E27FC236}">
                    <a16:creationId xmlns:a16="http://schemas.microsoft.com/office/drawing/2014/main" id="{3EA11F2B-8599-6A4C-BC5E-44C1764F70DF}"/>
                  </a:ext>
                </a:extLst>
              </p:cNvPr>
              <p:cNvSpPr/>
              <p:nvPr/>
            </p:nvSpPr>
            <p:spPr>
              <a:xfrm flipV="1">
                <a:off x="7086741" y="5274041"/>
                <a:ext cx="483910" cy="152781"/>
              </a:xfrm>
              <a:prstGeom prst="uturnArrow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29" name="U-Turn Arrow 28">
                <a:extLst>
                  <a:ext uri="{FF2B5EF4-FFF2-40B4-BE49-F238E27FC236}">
                    <a16:creationId xmlns:a16="http://schemas.microsoft.com/office/drawing/2014/main" id="{6C611048-0E50-684E-A5D8-056F3727455F}"/>
                  </a:ext>
                </a:extLst>
              </p:cNvPr>
              <p:cNvSpPr/>
              <p:nvPr/>
            </p:nvSpPr>
            <p:spPr>
              <a:xfrm flipH="1" flipV="1">
                <a:off x="10609641" y="5285433"/>
                <a:ext cx="483910" cy="152781"/>
              </a:xfrm>
              <a:prstGeom prst="uturnArrow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</p:grp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4ACB9AE3-08F3-A342-9AC4-D42E34548A4F}"/>
                </a:ext>
              </a:extLst>
            </p:cNvPr>
            <p:cNvSpPr txBox="1"/>
            <p:nvPr/>
          </p:nvSpPr>
          <p:spPr>
            <a:xfrm rot="5400000">
              <a:off x="266569" y="4053718"/>
              <a:ext cx="20352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u="sng" dirty="0">
                  <a:solidFill>
                    <a:srgbClr val="7030A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NA Anti-miR-21-5p (20-nt)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BE42A142-FD8B-C04E-B932-56ECB8E3A7AC}"/>
                </a:ext>
              </a:extLst>
            </p:cNvPr>
            <p:cNvSpPr txBox="1"/>
            <p:nvPr/>
          </p:nvSpPr>
          <p:spPr>
            <a:xfrm rot="5400000" flipH="1" flipV="1">
              <a:off x="4789801" y="4068958"/>
              <a:ext cx="20352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u="sng" dirty="0">
                  <a:solidFill>
                    <a:srgbClr val="7030A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NA Anti-miR-21-5p (20-nt)</a:t>
              </a:r>
            </a:p>
          </p:txBody>
        </p:sp>
      </p:grpSp>
      <p:sp>
        <p:nvSpPr>
          <p:cNvPr id="35" name="TextBox 34">
            <a:extLst>
              <a:ext uri="{FF2B5EF4-FFF2-40B4-BE49-F238E27FC236}">
                <a16:creationId xmlns:a16="http://schemas.microsoft.com/office/drawing/2014/main" id="{B533D00D-0568-104C-A03C-30A15EA72F6E}"/>
              </a:ext>
            </a:extLst>
          </p:cNvPr>
          <p:cNvSpPr txBox="1"/>
          <p:nvPr/>
        </p:nvSpPr>
        <p:spPr>
          <a:xfrm>
            <a:off x="4429586" y="53505"/>
            <a:ext cx="189346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B</a:t>
            </a: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E6458144-0FA7-0F7B-EFF6-1134687516B6}"/>
              </a:ext>
            </a:extLst>
          </p:cNvPr>
          <p:cNvSpPr/>
          <p:nvPr/>
        </p:nvSpPr>
        <p:spPr>
          <a:xfrm>
            <a:off x="1505875" y="886290"/>
            <a:ext cx="3704540" cy="10156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 u         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sz="1200" dirty="0" err="1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r>
              <a:rPr lang="en-US" sz="12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     a          a          a</a:t>
            </a:r>
            <a:r>
              <a: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  a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’   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gucgg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en-US" sz="1200" dirty="0" err="1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gcuuauc</a:t>
            </a:r>
            <a:r>
              <a:rPr lang="en-US" sz="12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200" dirty="0" err="1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cug</a:t>
            </a:r>
            <a:r>
              <a:rPr lang="en-US" sz="12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200" dirty="0" err="1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guug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sz="1200" spc="50" dirty="0" err="1">
                <a:latin typeface="Arial" panose="020B0604020202020204" pitchFamily="34" charset="0"/>
                <a:cs typeface="Arial" panose="020B0604020202020204" pitchFamily="34" charset="0"/>
              </a:rPr>
              <a:t>cugu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g  a </a:t>
            </a:r>
          </a:p>
          <a:p>
            <a:r>
              <a:rPr lang="en-US" sz="1200" spc="300" dirty="0">
                <a:latin typeface="Arial" panose="020B0604020202020204" pitchFamily="34" charset="0"/>
                <a:cs typeface="Arial" panose="020B0604020202020204" pitchFamily="34" charset="0"/>
              </a:rPr>
              <a:t>    |||||  </a:t>
            </a:r>
            <a:r>
              <a:rPr lang="en-US" sz="1200" spc="360" dirty="0">
                <a:latin typeface="Arial" panose="020B0604020202020204" pitchFamily="34" charset="0"/>
                <a:cs typeface="Arial" panose="020B0604020202020204" pitchFamily="34" charset="0"/>
              </a:rPr>
              <a:t>||||||||</a:t>
            </a:r>
            <a:r>
              <a:rPr lang="en-US" sz="1200" spc="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spc="320" dirty="0">
                <a:latin typeface="Arial" panose="020B0604020202020204" pitchFamily="34" charset="0"/>
                <a:cs typeface="Arial" panose="020B0604020202020204" pitchFamily="34" charset="0"/>
              </a:rPr>
              <a:t>|||||</a:t>
            </a:r>
            <a:r>
              <a:rPr lang="en-US" sz="1200" spc="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spc="340" dirty="0">
                <a:latin typeface="Arial" panose="020B0604020202020204" pitchFamily="34" charset="0"/>
                <a:cs typeface="Arial" panose="020B0604020202020204" pitchFamily="34" charset="0"/>
              </a:rPr>
              <a:t>|||||</a:t>
            </a:r>
            <a:r>
              <a:rPr lang="en-US" sz="1200" spc="3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200" spc="350" dirty="0">
                <a:latin typeface="Arial" panose="020B0604020202020204" pitchFamily="34" charset="0"/>
                <a:cs typeface="Arial" panose="020B0604020202020204" pitchFamily="34" charset="0"/>
              </a:rPr>
              <a:t>|||</a:t>
            </a:r>
            <a:r>
              <a:rPr lang="en-US" sz="1200" spc="300" dirty="0">
                <a:latin typeface="Arial" panose="020B0604020202020204" pitchFamily="34" charset="0"/>
                <a:cs typeface="Arial" panose="020B0604020202020204" pitchFamily="34" charset="0"/>
              </a:rPr>
              <a:t>| |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’   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agu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en-US" sz="1200" dirty="0" err="1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cggguag</a:t>
            </a:r>
            <a:r>
              <a:rPr lang="en-US" sz="12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200" dirty="0" err="1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gac</a:t>
            </a:r>
            <a:r>
              <a:rPr lang="en-US" sz="12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200" dirty="0" err="1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aa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ggu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c  c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a           </a:t>
            </a:r>
            <a:r>
              <a:rPr lang="en-US" sz="12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g               -          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       -          -  u </a:t>
            </a:r>
          </a:p>
        </p:txBody>
      </p:sp>
    </p:spTree>
    <p:extLst>
      <p:ext uri="{BB962C8B-B14F-4D97-AF65-F5344CB8AC3E}">
        <p14:creationId xmlns:p14="http://schemas.microsoft.com/office/powerpoint/2010/main" val="37561752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Rectangle 31">
            <a:extLst>
              <a:ext uri="{FF2B5EF4-FFF2-40B4-BE49-F238E27FC236}">
                <a16:creationId xmlns:a16="http://schemas.microsoft.com/office/drawing/2014/main" id="{9FEE489A-8568-7242-B37C-047D6B68E788}"/>
              </a:ext>
            </a:extLst>
          </p:cNvPr>
          <p:cNvSpPr/>
          <p:nvPr/>
        </p:nvSpPr>
        <p:spPr>
          <a:xfrm>
            <a:off x="-2497391" y="474345"/>
            <a:ext cx="6096000" cy="5909310"/>
          </a:xfrm>
          <a:prstGeom prst="rect">
            <a:avLst/>
          </a:prstGeom>
        </p:spPr>
        <p:txBody>
          <a:bodyPr>
            <a:spAutoFit/>
          </a:bodyPr>
          <a:lstStyle/>
          <a:p>
            <a:br>
              <a:rPr lang="en-US" dirty="0"/>
            </a:br>
            <a:endParaRPr lang="en-US" dirty="0"/>
          </a:p>
          <a:p>
            <a:br>
              <a:rPr lang="en-US" dirty="0"/>
            </a:br>
            <a:endParaRPr lang="en-US" dirty="0"/>
          </a:p>
          <a:p>
            <a:br>
              <a:rPr lang="en-US" dirty="0"/>
            </a:br>
            <a:endParaRPr lang="en-US" dirty="0"/>
          </a:p>
          <a:p>
            <a:br>
              <a:rPr lang="en-US" dirty="0"/>
            </a:br>
            <a:endParaRPr lang="en-US" dirty="0"/>
          </a:p>
          <a:p>
            <a:br>
              <a:rPr lang="en-US" dirty="0"/>
            </a:br>
            <a:endParaRPr lang="en-US" dirty="0"/>
          </a:p>
          <a:p>
            <a:br>
              <a:rPr lang="en-US" dirty="0"/>
            </a:br>
            <a:endParaRPr lang="en-US" dirty="0"/>
          </a:p>
          <a:p>
            <a:br>
              <a:rPr lang="en-US" dirty="0"/>
            </a:br>
            <a:endParaRPr lang="en-US" dirty="0"/>
          </a:p>
          <a:p>
            <a:br>
              <a:rPr lang="en-US" dirty="0"/>
            </a:br>
            <a:endParaRPr lang="en-US" dirty="0"/>
          </a:p>
          <a:p>
            <a:br>
              <a:rPr lang="en-US" dirty="0"/>
            </a:br>
            <a:endParaRPr lang="en-US" dirty="0"/>
          </a:p>
          <a:p>
            <a:br>
              <a:rPr lang="en-US" dirty="0"/>
            </a:br>
            <a:endParaRPr lang="en-US" dirty="0"/>
          </a:p>
          <a:p>
            <a:r>
              <a:rPr lang="en-US" dirty="0"/>
              <a:t> </a:t>
            </a:r>
          </a:p>
        </p:txBody>
      </p:sp>
      <p:grpSp>
        <p:nvGrpSpPr>
          <p:cNvPr id="40" name="Group 39">
            <a:extLst>
              <a:ext uri="{FF2B5EF4-FFF2-40B4-BE49-F238E27FC236}">
                <a16:creationId xmlns:a16="http://schemas.microsoft.com/office/drawing/2014/main" id="{C129A40F-6004-F644-B127-48703E4242A3}"/>
              </a:ext>
            </a:extLst>
          </p:cNvPr>
          <p:cNvGrpSpPr/>
          <p:nvPr/>
        </p:nvGrpSpPr>
        <p:grpSpPr>
          <a:xfrm>
            <a:off x="1003762" y="505174"/>
            <a:ext cx="4727079" cy="4974212"/>
            <a:chOff x="1003762" y="878800"/>
            <a:chExt cx="4727079" cy="4974212"/>
          </a:xfrm>
        </p:grpSpPr>
        <p:grpSp>
          <p:nvGrpSpPr>
            <p:cNvPr id="37" name="Group 36">
              <a:extLst>
                <a:ext uri="{FF2B5EF4-FFF2-40B4-BE49-F238E27FC236}">
                  <a16:creationId xmlns:a16="http://schemas.microsoft.com/office/drawing/2014/main" id="{16C0D967-5B4D-B84D-9F77-12A8ACEF063E}"/>
                </a:ext>
              </a:extLst>
            </p:cNvPr>
            <p:cNvGrpSpPr/>
            <p:nvPr/>
          </p:nvGrpSpPr>
          <p:grpSpPr>
            <a:xfrm>
              <a:off x="1104160" y="878800"/>
              <a:ext cx="4530542" cy="4974212"/>
              <a:chOff x="1104160" y="878800"/>
              <a:chExt cx="4530542" cy="4974212"/>
            </a:xfrm>
          </p:grpSpPr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7FA22F7A-BF82-B242-A1E5-ACF925CE6ACB}"/>
                  </a:ext>
                </a:extLst>
              </p:cNvPr>
              <p:cNvSpPr txBox="1"/>
              <p:nvPr/>
            </p:nvSpPr>
            <p:spPr>
              <a:xfrm flipH="1">
                <a:off x="4621284" y="5576012"/>
                <a:ext cx="101341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RNA⟵DNA</a:t>
                </a:r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A9E58F3E-62D9-4745-96DA-7ED832D07127}"/>
                  </a:ext>
                </a:extLst>
              </p:cNvPr>
              <p:cNvSpPr txBox="1"/>
              <p:nvPr/>
            </p:nvSpPr>
            <p:spPr>
              <a:xfrm>
                <a:off x="2581216" y="878800"/>
                <a:ext cx="178606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u="sng" dirty="0">
                    <a:latin typeface="Arial" panose="020B0604020202020204" pitchFamily="34" charset="0"/>
                    <a:cs typeface="Arial" panose="020B0604020202020204" pitchFamily="34" charset="0"/>
                  </a:rPr>
                  <a:t>hsa-miR-21 pre-miR-21</a:t>
                </a:r>
              </a:p>
            </p:txBody>
          </p:sp>
          <p:sp>
            <p:nvSpPr>
              <p:cNvPr id="7" name="Rectangle 6">
                <a:extLst>
                  <a:ext uri="{FF2B5EF4-FFF2-40B4-BE49-F238E27FC236}">
                    <a16:creationId xmlns:a16="http://schemas.microsoft.com/office/drawing/2014/main" id="{876177F7-E053-B146-8C47-9E851EF4DC5B}"/>
                  </a:ext>
                </a:extLst>
              </p:cNvPr>
              <p:cNvSpPr/>
              <p:nvPr/>
            </p:nvSpPr>
            <p:spPr>
              <a:xfrm rot="16200000">
                <a:off x="2208967" y="3717976"/>
                <a:ext cx="2459328" cy="1015663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 </a:t>
                </a:r>
                <a:r>
                  <a:rPr lang="en-US" sz="1200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               a          a          a</a:t>
                </a:r>
              </a:p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5’        </a:t>
                </a:r>
                <a:r>
                  <a:rPr lang="en-US" sz="1200" dirty="0" err="1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gcuuauc</a:t>
                </a:r>
                <a:r>
                  <a:rPr lang="en-US" sz="1200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  <a:r>
                  <a:rPr lang="en-US" sz="1200" dirty="0" err="1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acug</a:t>
                </a:r>
                <a:r>
                  <a:rPr lang="en-US" sz="1200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  <a:r>
                  <a:rPr lang="en-US" sz="1200" dirty="0" err="1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guug</a:t>
                </a:r>
                <a:endParaRPr lang="en-US" sz="12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1200" spc="31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</a:t>
                </a:r>
                <a:r>
                  <a:rPr lang="en-US" sz="1200" spc="330" dirty="0">
                    <a:latin typeface="Arial" panose="020B0604020202020204" pitchFamily="34" charset="0"/>
                    <a:cs typeface="Arial" panose="020B0604020202020204" pitchFamily="34" charset="0"/>
                  </a:rPr>
                  <a:t>|||||||| ||||| |||||</a:t>
                </a:r>
              </a:p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3’        </a:t>
                </a:r>
                <a:r>
                  <a:rPr lang="en-US" sz="1200" spc="20" dirty="0" err="1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cggguag</a:t>
                </a:r>
                <a:r>
                  <a:rPr lang="en-US" sz="1200" spc="20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200" spc="20" dirty="0" err="1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ugac</a:t>
                </a:r>
                <a:r>
                  <a:rPr lang="en-US" sz="1200" spc="20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  <a:r>
                  <a:rPr lang="en-US" sz="1200" spc="20" dirty="0" err="1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caac</a:t>
                </a:r>
                <a:r>
                  <a:rPr lang="en-US" sz="1200" spc="20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</a:p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</a:t>
                </a:r>
                <a:r>
                  <a:rPr lang="en-US" sz="1200" dirty="0" err="1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g</a:t>
                </a:r>
                <a:r>
                  <a:rPr lang="en-US" sz="1200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            -           c          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C4D83DCD-4BFC-2740-97A5-C74A136989A7}"/>
                  </a:ext>
                </a:extLst>
              </p:cNvPr>
              <p:cNvSpPr txBox="1"/>
              <p:nvPr/>
            </p:nvSpPr>
            <p:spPr>
              <a:xfrm>
                <a:off x="2888115" y="2612530"/>
                <a:ext cx="1200970" cy="461665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iR-21-5p:3p </a:t>
                </a:r>
              </a:p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uplex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7619992E-2952-9540-90E0-3DD4DD482AC5}"/>
                  </a:ext>
                </a:extLst>
              </p:cNvPr>
              <p:cNvSpPr txBox="1"/>
              <p:nvPr/>
            </p:nvSpPr>
            <p:spPr>
              <a:xfrm>
                <a:off x="2892961" y="2223309"/>
                <a:ext cx="62549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DICER</a:t>
                </a:r>
              </a:p>
            </p:txBody>
          </p:sp>
          <p:cxnSp>
            <p:nvCxnSpPr>
              <p:cNvPr id="10" name="Straight Arrow Connector 9">
                <a:extLst>
                  <a:ext uri="{FF2B5EF4-FFF2-40B4-BE49-F238E27FC236}">
                    <a16:creationId xmlns:a16="http://schemas.microsoft.com/office/drawing/2014/main" id="{FB8B3C92-4E64-EF49-9D75-6473F98AAA3F}"/>
                  </a:ext>
                </a:extLst>
              </p:cNvPr>
              <p:cNvCxnSpPr>
                <a:cxnSpLocks/>
              </p:cNvCxnSpPr>
              <p:nvPr/>
            </p:nvCxnSpPr>
            <p:spPr>
              <a:xfrm rot="10800000" flipV="1">
                <a:off x="3480413" y="2185855"/>
                <a:ext cx="0" cy="365760"/>
              </a:xfrm>
              <a:prstGeom prst="straightConnector1">
                <a:avLst/>
              </a:prstGeom>
              <a:ln w="1270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62038B08-3308-364A-9F07-7D9D67E596D5}"/>
                  </a:ext>
                </a:extLst>
              </p:cNvPr>
              <p:cNvSpPr txBox="1"/>
              <p:nvPr/>
            </p:nvSpPr>
            <p:spPr>
              <a:xfrm>
                <a:off x="3819986" y="3884000"/>
                <a:ext cx="61106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Unwind</a:t>
                </a:r>
              </a:p>
            </p:txBody>
          </p:sp>
          <p:cxnSp>
            <p:nvCxnSpPr>
              <p:cNvPr id="12" name="Straight Arrow Connector 11">
                <a:extLst>
                  <a:ext uri="{FF2B5EF4-FFF2-40B4-BE49-F238E27FC236}">
                    <a16:creationId xmlns:a16="http://schemas.microsoft.com/office/drawing/2014/main" id="{85916AE7-92F6-D54E-AFDD-BB71B3B1FFB2}"/>
                  </a:ext>
                </a:extLst>
              </p:cNvPr>
              <p:cNvCxnSpPr>
                <a:cxnSpLocks/>
              </p:cNvCxnSpPr>
              <p:nvPr/>
            </p:nvCxnSpPr>
            <p:spPr>
              <a:xfrm rot="16200000">
                <a:off x="4144965" y="3682950"/>
                <a:ext cx="0" cy="457200"/>
              </a:xfrm>
              <a:prstGeom prst="straightConnector1">
                <a:avLst/>
              </a:prstGeom>
              <a:ln>
                <a:solidFill>
                  <a:srgbClr val="00B0F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" name="Rectangle 12">
                <a:extLst>
                  <a:ext uri="{FF2B5EF4-FFF2-40B4-BE49-F238E27FC236}">
                    <a16:creationId xmlns:a16="http://schemas.microsoft.com/office/drawing/2014/main" id="{790E804D-A1AF-0C4A-A022-B382D984B0C5}"/>
                  </a:ext>
                </a:extLst>
              </p:cNvPr>
              <p:cNvSpPr/>
              <p:nvPr/>
            </p:nvSpPr>
            <p:spPr>
              <a:xfrm rot="16200000" flipH="1" flipV="1">
                <a:off x="3133771" y="4048649"/>
                <a:ext cx="2926080" cy="276999"/>
              </a:xfrm>
              <a:prstGeom prst="rect">
                <a:avLst/>
              </a:prstGeom>
            </p:spPr>
            <p:txBody>
              <a:bodyPr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46 - </a:t>
                </a:r>
                <a:r>
                  <a:rPr lang="en-US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r>
                  <a:rPr lang="en-US" sz="1200" dirty="0" err="1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acaccaguc</a:t>
                </a:r>
                <a:r>
                  <a:rPr lang="en-US" sz="1200" spc="-20" dirty="0" err="1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aug</a:t>
                </a:r>
                <a:r>
                  <a:rPr lang="en-US" sz="1200" dirty="0" err="1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gcu</a:t>
                </a:r>
                <a:r>
                  <a:rPr lang="en-US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u</a:t>
                </a:r>
                <a:r>
                  <a:rPr lang="en-US" sz="12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 66   3’</a:t>
                </a:r>
              </a:p>
            </p:txBody>
          </p:sp>
          <p:sp>
            <p:nvSpPr>
              <p:cNvPr id="14" name="Rectangle 13">
                <a:extLst>
                  <a:ext uri="{FF2B5EF4-FFF2-40B4-BE49-F238E27FC236}">
                    <a16:creationId xmlns:a16="http://schemas.microsoft.com/office/drawing/2014/main" id="{FDC5025F-043B-114B-A3B9-4EA1C905A43E}"/>
                  </a:ext>
                </a:extLst>
              </p:cNvPr>
              <p:cNvSpPr/>
              <p:nvPr/>
            </p:nvSpPr>
            <p:spPr>
              <a:xfrm rot="5400000" flipH="1">
                <a:off x="685552" y="3712810"/>
                <a:ext cx="2651760" cy="83099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200" spc="6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</a:t>
                </a:r>
              </a:p>
              <a:p>
                <a:r>
                  <a:rPr lang="en-US" sz="1200" spc="6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 </a:t>
                </a:r>
                <a:r>
                  <a:rPr lang="en-US" sz="1200" spc="330" dirty="0">
                    <a:latin typeface="Arial" panose="020B0604020202020204" pitchFamily="34" charset="0"/>
                    <a:cs typeface="Arial" panose="020B0604020202020204" pitchFamily="34" charset="0"/>
                  </a:rPr>
                  <a:t>| </a:t>
                </a:r>
                <a:r>
                  <a:rPr lang="en-US" sz="1200" spc="450" dirty="0">
                    <a:latin typeface="Arial" panose="020B0604020202020204" pitchFamily="34" charset="0"/>
                    <a:cs typeface="Arial" panose="020B0604020202020204" pitchFamily="34" charset="0"/>
                  </a:rPr>
                  <a:t>|||</a:t>
                </a:r>
                <a:r>
                  <a:rPr lang="en-US" sz="1200" spc="300" dirty="0">
                    <a:latin typeface="Arial" panose="020B0604020202020204" pitchFamily="34" charset="0"/>
                    <a:cs typeface="Arial" panose="020B0604020202020204" pitchFamily="34" charset="0"/>
                  </a:rPr>
                  <a:t>| | |||  |  | |</a:t>
                </a:r>
              </a:p>
              <a:p>
                <a:r>
                  <a:rPr lang="en-US" sz="1200" spc="100" dirty="0">
                    <a:latin typeface="Arial" panose="020B0604020202020204" pitchFamily="34" charset="0"/>
                    <a:cs typeface="Arial" panose="020B0604020202020204" pitchFamily="34" charset="0"/>
                  </a:rPr>
                  <a:t>5’</a:t>
                </a:r>
                <a:r>
                  <a:rPr lang="en-US" sz="1200" spc="100" dirty="0">
                    <a:solidFill>
                      <a:schemeClr val="bg1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  </a:t>
                </a:r>
                <a:r>
                  <a:rPr lang="en-US" sz="1200" spc="100" dirty="0">
                    <a:solidFill>
                      <a:srgbClr val="FFC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  </a:t>
                </a:r>
                <a:r>
                  <a:rPr lang="en-US" sz="1200" spc="100" dirty="0" err="1">
                    <a:solidFill>
                      <a:srgbClr val="FFC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auc</a:t>
                </a:r>
                <a:r>
                  <a:rPr lang="en-US" sz="1200" spc="100" dirty="0">
                    <a:solidFill>
                      <a:srgbClr val="FFC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g </a:t>
                </a:r>
                <a:r>
                  <a:rPr lang="en-US" sz="1200" spc="100" dirty="0" err="1">
                    <a:solidFill>
                      <a:srgbClr val="FFC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ug</a:t>
                </a:r>
                <a:r>
                  <a:rPr lang="en-US" sz="1200" spc="100" dirty="0">
                    <a:solidFill>
                      <a:srgbClr val="FFC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u   g u</a:t>
                </a:r>
              </a:p>
              <a:p>
                <a:r>
                  <a:rPr lang="en-US" sz="1200" spc="100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 </a:t>
                </a:r>
                <a:r>
                  <a:rPr lang="en-US" sz="1200" spc="100" dirty="0">
                    <a:solidFill>
                      <a:srgbClr val="FFC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g c-       - a     g --  u</a:t>
                </a:r>
                <a:endParaRPr lang="en-US" sz="1200" spc="-10" dirty="0">
                  <a:solidFill>
                    <a:srgbClr val="FFC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A0D5BEF8-7D10-C942-9FFD-110B3DE75A99}"/>
                  </a:ext>
                </a:extLst>
              </p:cNvPr>
              <p:cNvSpPr txBox="1"/>
              <p:nvPr/>
            </p:nvSpPr>
            <p:spPr>
              <a:xfrm>
                <a:off x="2477773" y="3880332"/>
                <a:ext cx="61106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Unwind</a:t>
                </a:r>
              </a:p>
            </p:txBody>
          </p:sp>
          <p:cxnSp>
            <p:nvCxnSpPr>
              <p:cNvPr id="16" name="Straight Arrow Connector 15">
                <a:extLst>
                  <a:ext uri="{FF2B5EF4-FFF2-40B4-BE49-F238E27FC236}">
                    <a16:creationId xmlns:a16="http://schemas.microsoft.com/office/drawing/2014/main" id="{582E73CB-3732-6547-B9BF-BA2BA3341641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H="1">
                <a:off x="2762971" y="3679282"/>
                <a:ext cx="0" cy="457200"/>
              </a:xfrm>
              <a:prstGeom prst="straightConnector1">
                <a:avLst/>
              </a:prstGeom>
              <a:ln>
                <a:solidFill>
                  <a:srgbClr val="00B05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DAC3E29A-61EE-1A40-88B4-FA42264AE875}"/>
                  </a:ext>
                </a:extLst>
              </p:cNvPr>
              <p:cNvSpPr txBox="1"/>
              <p:nvPr/>
            </p:nvSpPr>
            <p:spPr>
              <a:xfrm>
                <a:off x="1104160" y="5576013"/>
                <a:ext cx="101341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DNA⟶RNA</a:t>
                </a:r>
              </a:p>
            </p:txBody>
          </p:sp>
          <p:sp>
            <p:nvSpPr>
              <p:cNvPr id="18" name="Rectangle 17">
                <a:extLst>
                  <a:ext uri="{FF2B5EF4-FFF2-40B4-BE49-F238E27FC236}">
                    <a16:creationId xmlns:a16="http://schemas.microsoft.com/office/drawing/2014/main" id="{BE258A10-5065-074C-8CB5-DF8B319EA916}"/>
                  </a:ext>
                </a:extLst>
              </p:cNvPr>
              <p:cNvSpPr/>
              <p:nvPr/>
            </p:nvSpPr>
            <p:spPr>
              <a:xfrm rot="16200000">
                <a:off x="3558761" y="3661392"/>
                <a:ext cx="2340864" cy="64633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/>
              <a:p>
                <a:r>
                  <a:rPr lang="en-US" sz="1200" spc="6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</a:t>
                </a:r>
                <a:r>
                  <a:rPr lang="en-US" sz="1200" spc="60" dirty="0">
                    <a:latin typeface="Arial" panose="020B0604020202020204" pitchFamily="34" charset="0"/>
                    <a:cs typeface="Arial" panose="020B0604020202020204" pitchFamily="34" charset="0"/>
                  </a:rPr>
                  <a:t>   </a:t>
                </a:r>
              </a:p>
              <a:p>
                <a:r>
                  <a:rPr lang="en-US" sz="1200" spc="6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</a:t>
                </a:r>
                <a:r>
                  <a:rPr lang="en-US" sz="1200" spc="23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200" spc="330" dirty="0">
                    <a:latin typeface="Arial" panose="020B0604020202020204" pitchFamily="34" charset="0"/>
                    <a:cs typeface="Arial" panose="020B0604020202020204" pitchFamily="34" charset="0"/>
                  </a:rPr>
                  <a:t>||||||||||||||||||</a:t>
                </a:r>
              </a:p>
              <a:p>
                <a:r>
                  <a:rPr lang="en-US" sz="1200" spc="70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</a:t>
                </a:r>
                <a:r>
                  <a:rPr lang="en-US" sz="1200" spc="10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5’ </a:t>
                </a:r>
                <a:r>
                  <a:rPr lang="en-US" sz="1200" spc="10" dirty="0">
                    <a:solidFill>
                      <a:srgbClr val="FFC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200" dirty="0" err="1">
                    <a:solidFill>
                      <a:srgbClr val="FFC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gcccaucgacugguguu</a:t>
                </a:r>
                <a:r>
                  <a:rPr lang="en-US" sz="1200" spc="10" dirty="0">
                    <a:solidFill>
                      <a:srgbClr val="FFC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DD67C228-28D8-0E41-9089-3FE58A62FE61}"/>
                  </a:ext>
                </a:extLst>
              </p:cNvPr>
              <p:cNvSpPr txBox="1"/>
              <p:nvPr/>
            </p:nvSpPr>
            <p:spPr>
              <a:xfrm>
                <a:off x="1959741" y="2310412"/>
                <a:ext cx="917239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iR-21-5p</a:t>
                </a:r>
              </a:p>
              <a:p>
                <a:pPr algn="ctr"/>
                <a:r>
                  <a:rPr lang="en-US" sz="1200" u="sng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22-nt)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D332F8E0-A2A7-4440-8BF1-B7BFED9FF4C6}"/>
                  </a:ext>
                </a:extLst>
              </p:cNvPr>
              <p:cNvSpPr txBox="1"/>
              <p:nvPr/>
            </p:nvSpPr>
            <p:spPr>
              <a:xfrm>
                <a:off x="4090587" y="2318752"/>
                <a:ext cx="899605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iR-21-3p</a:t>
                </a:r>
              </a:p>
              <a:p>
                <a:pPr algn="ctr"/>
                <a:r>
                  <a:rPr lang="en-US" sz="1200" u="sng" dirty="0">
                    <a:solidFill>
                      <a:srgbClr val="00B0F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(21-nt)</a:t>
                </a:r>
              </a:p>
            </p:txBody>
          </p:sp>
          <p:sp>
            <p:nvSpPr>
              <p:cNvPr id="21" name="Rectangle 20">
                <a:extLst>
                  <a:ext uri="{FF2B5EF4-FFF2-40B4-BE49-F238E27FC236}">
                    <a16:creationId xmlns:a16="http://schemas.microsoft.com/office/drawing/2014/main" id="{28ECE194-1B00-0144-BF88-FAC9FC03051A}"/>
                  </a:ext>
                </a:extLst>
              </p:cNvPr>
              <p:cNvSpPr/>
              <p:nvPr/>
            </p:nvSpPr>
            <p:spPr>
              <a:xfrm rot="16200000" flipH="1">
                <a:off x="932023" y="3947867"/>
                <a:ext cx="2790125" cy="461665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5’   8 -  </a:t>
                </a:r>
                <a:r>
                  <a:rPr lang="en-US" sz="1200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  c    a   cag  c  </a:t>
                </a:r>
                <a:r>
                  <a:rPr lang="en-US" sz="1200" dirty="0" err="1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aug</a:t>
                </a:r>
                <a:r>
                  <a:rPr lang="en-US" sz="1200" spc="-20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g  </a:t>
                </a: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- 29</a:t>
                </a:r>
              </a:p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   </a:t>
                </a:r>
                <a:r>
                  <a:rPr lang="en-US" sz="1200" spc="-20" dirty="0">
                    <a:latin typeface="Arial" panose="020B0604020202020204" pitchFamily="34" charset="0"/>
                    <a:cs typeface="Arial" panose="020B0604020202020204" pitchFamily="34" charset="0"/>
                  </a:rPr>
                  <a:t>u</a:t>
                </a: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  <a:r>
                  <a:rPr lang="en-US" sz="1200" spc="-20" dirty="0">
                    <a:latin typeface="Arial" panose="020B0604020202020204" pitchFamily="34" charset="0"/>
                    <a:cs typeface="Arial" panose="020B0604020202020204" pitchFamily="34" charset="0"/>
                  </a:rPr>
                  <a:t>g</a:t>
                </a: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200" spc="-2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u</a:t>
                </a:r>
                <a:r>
                  <a:rPr lang="en-US" sz="1200" spc="-2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1200" spc="-20" dirty="0">
                    <a:latin typeface="Arial" panose="020B0604020202020204" pitchFamily="34" charset="0"/>
                    <a:cs typeface="Arial" panose="020B0604020202020204" pitchFamily="34" charset="0"/>
                  </a:rPr>
                  <a:t>u</a:t>
                </a: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</a:t>
                </a:r>
                <a:r>
                  <a:rPr lang="en-US" sz="1200" spc="-2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  <a:r>
                  <a:rPr lang="en-US" sz="1200" spc="-20" dirty="0">
                    <a:latin typeface="Arial" panose="020B0604020202020204" pitchFamily="34" charset="0"/>
                    <a:cs typeface="Arial" panose="020B0604020202020204" pitchFamily="34" charset="0"/>
                  </a:rPr>
                  <a:t>u</a:t>
                </a: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   </a:t>
                </a:r>
                <a:r>
                  <a:rPr lang="en-US" sz="1200" spc="-2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u</a:t>
                </a: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  <a:r>
                  <a:rPr lang="en-US" sz="1200" spc="-2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Rectangle 21">
                <a:extLst>
                  <a:ext uri="{FF2B5EF4-FFF2-40B4-BE49-F238E27FC236}">
                    <a16:creationId xmlns:a16="http://schemas.microsoft.com/office/drawing/2014/main" id="{427AEFE6-1204-4940-ACAF-9E65C348E5C5}"/>
                  </a:ext>
                </a:extLst>
              </p:cNvPr>
              <p:cNvSpPr/>
              <p:nvPr/>
            </p:nvSpPr>
            <p:spPr>
              <a:xfrm>
                <a:off x="1615345" y="2791844"/>
                <a:ext cx="914400" cy="2743200"/>
              </a:xfrm>
              <a:prstGeom prst="rect">
                <a:avLst/>
              </a:prstGeom>
              <a:noFill/>
              <a:ln>
                <a:solidFill>
                  <a:srgbClr val="00B05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3" name="Rectangle 22">
                <a:extLst>
                  <a:ext uri="{FF2B5EF4-FFF2-40B4-BE49-F238E27FC236}">
                    <a16:creationId xmlns:a16="http://schemas.microsoft.com/office/drawing/2014/main" id="{760CB009-9867-9741-86B8-36B8BFC259AE}"/>
                  </a:ext>
                </a:extLst>
              </p:cNvPr>
              <p:cNvSpPr/>
              <p:nvPr/>
            </p:nvSpPr>
            <p:spPr>
              <a:xfrm>
                <a:off x="4387081" y="2791844"/>
                <a:ext cx="731520" cy="2743200"/>
              </a:xfrm>
              <a:prstGeom prst="rect">
                <a:avLst/>
              </a:prstGeom>
              <a:noFill/>
              <a:ln>
                <a:solidFill>
                  <a:srgbClr val="00B0F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" name="U-Turn Arrow 23">
                <a:extLst>
                  <a:ext uri="{FF2B5EF4-FFF2-40B4-BE49-F238E27FC236}">
                    <a16:creationId xmlns:a16="http://schemas.microsoft.com/office/drawing/2014/main" id="{133554A4-89E4-7244-BD20-17AE0FD43D73}"/>
                  </a:ext>
                </a:extLst>
              </p:cNvPr>
              <p:cNvSpPr/>
              <p:nvPr/>
            </p:nvSpPr>
            <p:spPr>
              <a:xfrm flipV="1">
                <a:off x="1373250" y="5274041"/>
                <a:ext cx="483910" cy="152781"/>
              </a:xfrm>
              <a:prstGeom prst="uturnArrow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25" name="U-Turn Arrow 24">
                <a:extLst>
                  <a:ext uri="{FF2B5EF4-FFF2-40B4-BE49-F238E27FC236}">
                    <a16:creationId xmlns:a16="http://schemas.microsoft.com/office/drawing/2014/main" id="{0E6892A3-B925-3E41-94DF-24392C5824F5}"/>
                  </a:ext>
                </a:extLst>
              </p:cNvPr>
              <p:cNvSpPr/>
              <p:nvPr/>
            </p:nvSpPr>
            <p:spPr>
              <a:xfrm flipH="1" flipV="1">
                <a:off x="4855816" y="5285433"/>
                <a:ext cx="483910" cy="152781"/>
              </a:xfrm>
              <a:prstGeom prst="uturnArrow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34" name="Rectangle 33">
                <a:extLst>
                  <a:ext uri="{FF2B5EF4-FFF2-40B4-BE49-F238E27FC236}">
                    <a16:creationId xmlns:a16="http://schemas.microsoft.com/office/drawing/2014/main" id="{2992BCBE-98A1-4548-8C17-D214248FD992}"/>
                  </a:ext>
                </a:extLst>
              </p:cNvPr>
              <p:cNvSpPr/>
              <p:nvPr/>
            </p:nvSpPr>
            <p:spPr>
              <a:xfrm rot="5400000">
                <a:off x="-98662" y="3919845"/>
                <a:ext cx="3017520" cy="276999"/>
              </a:xfrm>
              <a:prstGeom prst="rect">
                <a:avLst/>
              </a:prstGeom>
            </p:spPr>
            <p:txBody>
              <a:bodyPr>
                <a:spAutoFit/>
              </a:bodyPr>
              <a:lstStyle/>
              <a:p>
                <a:r>
                  <a:rPr lang="en-US" sz="1200" spc="180" dirty="0">
                    <a:solidFill>
                      <a:schemeClr val="bg1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    5’ </a:t>
                </a:r>
                <a:r>
                  <a:rPr lang="en-US" sz="1200" spc="180" dirty="0" err="1">
                    <a:solidFill>
                      <a:srgbClr val="FFC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gcccatcgactggtgtt</a:t>
                </a:r>
                <a:endParaRPr lang="en-US" sz="1200" spc="180" dirty="0">
                  <a:solidFill>
                    <a:srgbClr val="FFC000"/>
                  </a:solidFill>
                  <a:highlight>
                    <a:srgbClr val="FFFF00"/>
                  </a:highligh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Rectangle 34">
                <a:extLst>
                  <a:ext uri="{FF2B5EF4-FFF2-40B4-BE49-F238E27FC236}">
                    <a16:creationId xmlns:a16="http://schemas.microsoft.com/office/drawing/2014/main" id="{954A5946-19B8-F043-9D1B-2559659F865A}"/>
                  </a:ext>
                </a:extLst>
              </p:cNvPr>
              <p:cNvSpPr/>
              <p:nvPr/>
            </p:nvSpPr>
            <p:spPr>
              <a:xfrm rot="16200000" flipH="1">
                <a:off x="3810031" y="3730304"/>
                <a:ext cx="3017520" cy="276999"/>
              </a:xfrm>
              <a:prstGeom prst="rect">
                <a:avLst/>
              </a:prstGeom>
            </p:spPr>
            <p:txBody>
              <a:bodyPr>
                <a:spAutoFit/>
              </a:bodyPr>
              <a:lstStyle/>
              <a:p>
                <a:r>
                  <a:rPr lang="en-US" sz="1200" spc="120" dirty="0">
                    <a:solidFill>
                      <a:schemeClr val="bg1">
                        <a:lumMod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      5’ </a:t>
                </a:r>
                <a:r>
                  <a:rPr lang="en-US" sz="1200" spc="120" dirty="0" err="1">
                    <a:solidFill>
                      <a:srgbClr val="FFC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gcccatcgactggtgtt</a:t>
                </a:r>
                <a:endParaRPr lang="en-US" sz="1200" spc="120" dirty="0">
                  <a:solidFill>
                    <a:srgbClr val="FFC000"/>
                  </a:solidFill>
                  <a:highlight>
                    <a:srgbClr val="FFFF00"/>
                  </a:highlight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436F94E7-C0D7-7E45-BB33-669ABD51469F}"/>
                </a:ext>
              </a:extLst>
            </p:cNvPr>
            <p:cNvSpPr txBox="1"/>
            <p:nvPr/>
          </p:nvSpPr>
          <p:spPr>
            <a:xfrm rot="5400000">
              <a:off x="142853" y="3927782"/>
              <a:ext cx="199881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u="sng" dirty="0">
                  <a:solidFill>
                    <a:srgbClr val="FFC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NA Anti-miR-21-3p (18nt)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54E02CFD-3761-8444-89C5-5ED0AD6C5385}"/>
                </a:ext>
              </a:extLst>
            </p:cNvPr>
            <p:cNvSpPr txBox="1"/>
            <p:nvPr/>
          </p:nvSpPr>
          <p:spPr>
            <a:xfrm rot="16200000" flipH="1">
              <a:off x="4592933" y="3879014"/>
              <a:ext cx="199881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u="sng" dirty="0">
                  <a:solidFill>
                    <a:srgbClr val="FFC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NA Anti-miR-21-3p (18nt)</a:t>
              </a:r>
            </a:p>
          </p:txBody>
        </p:sp>
      </p:grpSp>
      <p:sp>
        <p:nvSpPr>
          <p:cNvPr id="41" name="TextBox 40">
            <a:extLst>
              <a:ext uri="{FF2B5EF4-FFF2-40B4-BE49-F238E27FC236}">
                <a16:creationId xmlns:a16="http://schemas.microsoft.com/office/drawing/2014/main" id="{BB3EF1F2-108C-AB4E-ADCA-6E324EEB0D13}"/>
              </a:ext>
            </a:extLst>
          </p:cNvPr>
          <p:cNvSpPr txBox="1"/>
          <p:nvPr/>
        </p:nvSpPr>
        <p:spPr>
          <a:xfrm>
            <a:off x="4213276" y="53505"/>
            <a:ext cx="189346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C</a:t>
            </a: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E26891AD-B512-7B63-ABEA-2E7B3EFAF224}"/>
              </a:ext>
            </a:extLst>
          </p:cNvPr>
          <p:cNvSpPr/>
          <p:nvPr/>
        </p:nvSpPr>
        <p:spPr>
          <a:xfrm>
            <a:off x="1505875" y="886290"/>
            <a:ext cx="3704540" cy="1015663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 u         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sz="1200" dirty="0" err="1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</a:t>
            </a:r>
            <a:r>
              <a:rPr lang="en-US" sz="12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      a          a          a</a:t>
            </a:r>
            <a:r>
              <a:rPr lang="en-US" sz="12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  a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’   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gucgg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en-US" sz="1200" dirty="0" err="1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gcuuauc</a:t>
            </a:r>
            <a:r>
              <a:rPr lang="en-US" sz="12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200" dirty="0" err="1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cug</a:t>
            </a:r>
            <a:r>
              <a:rPr lang="en-US" sz="12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200" dirty="0" err="1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guug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</a:t>
            </a:r>
            <a:r>
              <a:rPr lang="en-US" sz="1200" spc="50" dirty="0" err="1">
                <a:latin typeface="Arial" panose="020B0604020202020204" pitchFamily="34" charset="0"/>
                <a:cs typeface="Arial" panose="020B0604020202020204" pitchFamily="34" charset="0"/>
              </a:rPr>
              <a:t>cugu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g  a </a:t>
            </a:r>
          </a:p>
          <a:p>
            <a:r>
              <a:rPr lang="en-US" sz="1200" spc="300" dirty="0">
                <a:latin typeface="Arial" panose="020B0604020202020204" pitchFamily="34" charset="0"/>
                <a:cs typeface="Arial" panose="020B0604020202020204" pitchFamily="34" charset="0"/>
              </a:rPr>
              <a:t>    |||||  </a:t>
            </a:r>
            <a:r>
              <a:rPr lang="en-US" sz="1200" spc="360" dirty="0">
                <a:latin typeface="Arial" panose="020B0604020202020204" pitchFamily="34" charset="0"/>
                <a:cs typeface="Arial" panose="020B0604020202020204" pitchFamily="34" charset="0"/>
              </a:rPr>
              <a:t>||||||||</a:t>
            </a:r>
            <a:r>
              <a:rPr lang="en-US" sz="1200" spc="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spc="320" dirty="0">
                <a:latin typeface="Arial" panose="020B0604020202020204" pitchFamily="34" charset="0"/>
                <a:cs typeface="Arial" panose="020B0604020202020204" pitchFamily="34" charset="0"/>
              </a:rPr>
              <a:t>|||||</a:t>
            </a:r>
            <a:r>
              <a:rPr lang="en-US" sz="1200" spc="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spc="340" dirty="0">
                <a:latin typeface="Arial" panose="020B0604020202020204" pitchFamily="34" charset="0"/>
                <a:cs typeface="Arial" panose="020B0604020202020204" pitchFamily="34" charset="0"/>
              </a:rPr>
              <a:t>|||||</a:t>
            </a:r>
            <a:r>
              <a:rPr lang="en-US" sz="1200" spc="3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200" spc="350" dirty="0">
                <a:latin typeface="Arial" panose="020B0604020202020204" pitchFamily="34" charset="0"/>
                <a:cs typeface="Arial" panose="020B0604020202020204" pitchFamily="34" charset="0"/>
              </a:rPr>
              <a:t>|||</a:t>
            </a:r>
            <a:r>
              <a:rPr lang="en-US" sz="1200" spc="300" dirty="0">
                <a:latin typeface="Arial" panose="020B0604020202020204" pitchFamily="34" charset="0"/>
                <a:cs typeface="Arial" panose="020B0604020202020204" pitchFamily="34" charset="0"/>
              </a:rPr>
              <a:t>| |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’   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agu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en-US" sz="1200" dirty="0" err="1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cggguag</a:t>
            </a:r>
            <a:r>
              <a:rPr lang="en-US" sz="12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200" dirty="0" err="1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ugac</a:t>
            </a:r>
            <a:r>
              <a:rPr lang="en-US" sz="12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1200" dirty="0" err="1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aa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ggu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c  c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a           </a:t>
            </a:r>
            <a:r>
              <a:rPr lang="en-US" sz="1200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g               -          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          -          -  u </a:t>
            </a:r>
          </a:p>
        </p:txBody>
      </p:sp>
    </p:spTree>
    <p:extLst>
      <p:ext uri="{BB962C8B-B14F-4D97-AF65-F5344CB8AC3E}">
        <p14:creationId xmlns:p14="http://schemas.microsoft.com/office/powerpoint/2010/main" val="29305200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7924208-D2B4-B24D-8A38-44DCDBFAF8C8}"/>
              </a:ext>
            </a:extLst>
          </p:cNvPr>
          <p:cNvSpPr txBox="1"/>
          <p:nvPr/>
        </p:nvSpPr>
        <p:spPr>
          <a:xfrm>
            <a:off x="4026463" y="53505"/>
            <a:ext cx="189346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D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E0C93A0-4CB8-7347-9839-5156E123428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87219" y="1935469"/>
            <a:ext cx="1368883" cy="1280160"/>
          </a:xfrm>
          <a:prstGeom prst="rect">
            <a:avLst/>
          </a:prstGeom>
        </p:spPr>
      </p:pic>
      <p:grpSp>
        <p:nvGrpSpPr>
          <p:cNvPr id="4" name="Group 3">
            <a:extLst>
              <a:ext uri="{FF2B5EF4-FFF2-40B4-BE49-F238E27FC236}">
                <a16:creationId xmlns:a16="http://schemas.microsoft.com/office/drawing/2014/main" id="{C66AF02D-AB56-D24A-AAE9-572EAC944459}"/>
              </a:ext>
            </a:extLst>
          </p:cNvPr>
          <p:cNvGrpSpPr>
            <a:grpSpLocks noChangeAspect="1"/>
          </p:cNvGrpSpPr>
          <p:nvPr/>
        </p:nvGrpSpPr>
        <p:grpSpPr>
          <a:xfrm>
            <a:off x="1078623" y="2014233"/>
            <a:ext cx="1463040" cy="1105202"/>
            <a:chOff x="4088319" y="2767832"/>
            <a:chExt cx="1225296" cy="925607"/>
          </a:xfrm>
        </p:grpSpPr>
        <p:pic>
          <p:nvPicPr>
            <p:cNvPr id="5" name="Picture 4" descr="b d1.5 21i 60nm 10x g.tif">
              <a:extLst>
                <a:ext uri="{FF2B5EF4-FFF2-40B4-BE49-F238E27FC236}">
                  <a16:creationId xmlns:a16="http://schemas.microsoft.com/office/drawing/2014/main" id="{0A93ADEE-05CA-7349-A6E2-836C8556CC3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94047" y="2779039"/>
              <a:ext cx="1219200" cy="914400"/>
            </a:xfrm>
            <a:prstGeom prst="rect">
              <a:avLst/>
            </a:prstGeom>
          </p:spPr>
        </p:pic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9F109406-8393-CF4B-A328-DDA591F1F145}"/>
                </a:ext>
              </a:extLst>
            </p:cNvPr>
            <p:cNvSpPr/>
            <p:nvPr/>
          </p:nvSpPr>
          <p:spPr>
            <a:xfrm>
              <a:off x="4088319" y="2767832"/>
              <a:ext cx="1225296" cy="18466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it-IT" sz="600" dirty="0">
                  <a:solidFill>
                    <a:srgbClr val="FFFF00"/>
                  </a:solidFill>
                  <a:latin typeface="Arial"/>
                  <a:cs typeface="Arial"/>
                </a:rPr>
                <a:t>60 nM</a:t>
              </a:r>
            </a:p>
          </p:txBody>
        </p: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F5F1AD83-C790-5746-B315-A5F7208ADF8A}"/>
              </a:ext>
            </a:extLst>
          </p:cNvPr>
          <p:cNvGrpSpPr>
            <a:grpSpLocks noChangeAspect="1"/>
          </p:cNvGrpSpPr>
          <p:nvPr/>
        </p:nvGrpSpPr>
        <p:grpSpPr>
          <a:xfrm>
            <a:off x="4155387" y="833645"/>
            <a:ext cx="1463040" cy="1105202"/>
            <a:chOff x="2914393" y="2767832"/>
            <a:chExt cx="1225296" cy="925607"/>
          </a:xfrm>
        </p:grpSpPr>
        <p:pic>
          <p:nvPicPr>
            <p:cNvPr id="8" name="Picture 7" descr="b d1.5 21i 30nm 10x g.tif">
              <a:extLst>
                <a:ext uri="{FF2B5EF4-FFF2-40B4-BE49-F238E27FC236}">
                  <a16:creationId xmlns:a16="http://schemas.microsoft.com/office/drawing/2014/main" id="{4DD8D5E8-704A-0941-B5C3-F04C94EDAD4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19867" y="2779039"/>
              <a:ext cx="1219200" cy="914400"/>
            </a:xfrm>
            <a:prstGeom prst="rect">
              <a:avLst/>
            </a:prstGeom>
          </p:spPr>
        </p:pic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FDC09D18-4F3D-8548-B1D9-A46101CB8318}"/>
                </a:ext>
              </a:extLst>
            </p:cNvPr>
            <p:cNvSpPr/>
            <p:nvPr/>
          </p:nvSpPr>
          <p:spPr>
            <a:xfrm>
              <a:off x="2914393" y="2767832"/>
              <a:ext cx="1225296" cy="18466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it-IT" sz="600" dirty="0">
                  <a:solidFill>
                    <a:srgbClr val="FFFF00"/>
                  </a:solidFill>
                  <a:latin typeface="Arial"/>
                  <a:cs typeface="Arial"/>
                </a:rPr>
                <a:t>30 nM</a:t>
              </a:r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1EDFC152-EC5E-F948-A1F8-79C5A64DB038}"/>
              </a:ext>
            </a:extLst>
          </p:cNvPr>
          <p:cNvGrpSpPr>
            <a:grpSpLocks noChangeAspect="1"/>
          </p:cNvGrpSpPr>
          <p:nvPr/>
        </p:nvGrpSpPr>
        <p:grpSpPr>
          <a:xfrm>
            <a:off x="2605261" y="830324"/>
            <a:ext cx="1463040" cy="1094492"/>
            <a:chOff x="1649297" y="2768091"/>
            <a:chExt cx="1234274" cy="923353"/>
          </a:xfrm>
        </p:grpSpPr>
        <p:pic>
          <p:nvPicPr>
            <p:cNvPr id="11" name="Picture 10" descr="b d1.5 21i 10nm 10x g.tif">
              <a:extLst>
                <a:ext uri="{FF2B5EF4-FFF2-40B4-BE49-F238E27FC236}">
                  <a16:creationId xmlns:a16="http://schemas.microsoft.com/office/drawing/2014/main" id="{C2A40678-5C94-5248-8CEF-6B5CA9802A5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55000" contrast="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64371" y="2777044"/>
              <a:ext cx="1219200" cy="914400"/>
            </a:xfrm>
            <a:prstGeom prst="rect">
              <a:avLst/>
            </a:prstGeom>
          </p:spPr>
        </p:pic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FBA3559E-5BCE-2044-9EF3-9FFEFBD16B19}"/>
                </a:ext>
              </a:extLst>
            </p:cNvPr>
            <p:cNvSpPr/>
            <p:nvPr/>
          </p:nvSpPr>
          <p:spPr>
            <a:xfrm>
              <a:off x="1649297" y="2768091"/>
              <a:ext cx="1225296" cy="18466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it-IT" sz="600" dirty="0">
                  <a:solidFill>
                    <a:srgbClr val="FFFF00"/>
                  </a:solidFill>
                  <a:latin typeface="Arial"/>
                  <a:cs typeface="Arial"/>
                </a:rPr>
                <a:t>10 nM</a:t>
              </a:r>
            </a:p>
          </p:txBody>
        </p:sp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41101740-8FC0-5F4E-B44C-B32B0B0B1FFC}"/>
              </a:ext>
            </a:extLst>
          </p:cNvPr>
          <p:cNvGrpSpPr>
            <a:grpSpLocks noChangeAspect="1"/>
          </p:cNvGrpSpPr>
          <p:nvPr/>
        </p:nvGrpSpPr>
        <p:grpSpPr>
          <a:xfrm>
            <a:off x="1078709" y="835162"/>
            <a:ext cx="1463040" cy="1085533"/>
            <a:chOff x="411356" y="2772928"/>
            <a:chExt cx="1237941" cy="918516"/>
          </a:xfrm>
        </p:grpSpPr>
        <p:pic>
          <p:nvPicPr>
            <p:cNvPr id="14" name="Picture 13" descr="b d1.5 21i 3nm 10x g.tif">
              <a:extLst>
                <a:ext uri="{FF2B5EF4-FFF2-40B4-BE49-F238E27FC236}">
                  <a16:creationId xmlns:a16="http://schemas.microsoft.com/office/drawing/2014/main" id="{1CC102B5-EDCA-7D47-AAA6-916AE158053A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1356" y="2777044"/>
              <a:ext cx="1219200" cy="914400"/>
            </a:xfrm>
            <a:prstGeom prst="rect">
              <a:avLst/>
            </a:prstGeom>
          </p:spPr>
        </p:pic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75651787-7E6A-D042-9267-E8EECEA21432}"/>
                </a:ext>
              </a:extLst>
            </p:cNvPr>
            <p:cNvSpPr/>
            <p:nvPr/>
          </p:nvSpPr>
          <p:spPr>
            <a:xfrm>
              <a:off x="430097" y="2772928"/>
              <a:ext cx="1219200" cy="18466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it-IT" sz="600" dirty="0">
                  <a:solidFill>
                    <a:srgbClr val="FFFF00"/>
                  </a:solidFill>
                  <a:latin typeface="Arial"/>
                  <a:cs typeface="Arial"/>
                </a:rPr>
                <a:t>3 nM</a:t>
              </a:r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1C519FD9-7211-914E-A0C4-A8F29F723DD8}"/>
              </a:ext>
            </a:extLst>
          </p:cNvPr>
          <p:cNvGrpSpPr>
            <a:grpSpLocks noChangeAspect="1"/>
          </p:cNvGrpSpPr>
          <p:nvPr/>
        </p:nvGrpSpPr>
        <p:grpSpPr>
          <a:xfrm>
            <a:off x="2613163" y="2003215"/>
            <a:ext cx="1463040" cy="1108741"/>
            <a:chOff x="5313615" y="2762100"/>
            <a:chExt cx="1234695" cy="935694"/>
          </a:xfrm>
        </p:grpSpPr>
        <p:pic>
          <p:nvPicPr>
            <p:cNvPr id="17" name="Picture 16" descr="b d1.5 21i 120nm 10x g.tif">
              <a:extLst>
                <a:ext uri="{FF2B5EF4-FFF2-40B4-BE49-F238E27FC236}">
                  <a16:creationId xmlns:a16="http://schemas.microsoft.com/office/drawing/2014/main" id="{685041F3-5CCA-7E40-9F5C-481DA29EE3E5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76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29110" y="2783394"/>
              <a:ext cx="1219200" cy="914400"/>
            </a:xfrm>
            <a:prstGeom prst="rect">
              <a:avLst/>
            </a:prstGeom>
          </p:spPr>
        </p:pic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EE0FE73E-8F49-EF48-80AD-2210D2926D5E}"/>
                </a:ext>
              </a:extLst>
            </p:cNvPr>
            <p:cNvSpPr/>
            <p:nvPr/>
          </p:nvSpPr>
          <p:spPr>
            <a:xfrm>
              <a:off x="5313615" y="2762100"/>
              <a:ext cx="1225296" cy="18466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it-IT" sz="600" dirty="0">
                  <a:solidFill>
                    <a:srgbClr val="FFFF00"/>
                  </a:solidFill>
                  <a:latin typeface="Arial"/>
                  <a:cs typeface="Arial"/>
                </a:rPr>
                <a:t>120 nM</a:t>
              </a:r>
            </a:p>
          </p:txBody>
        </p:sp>
      </p:grpSp>
      <p:sp>
        <p:nvSpPr>
          <p:cNvPr id="19" name="TextBox 18">
            <a:extLst>
              <a:ext uri="{FF2B5EF4-FFF2-40B4-BE49-F238E27FC236}">
                <a16:creationId xmlns:a16="http://schemas.microsoft.com/office/drawing/2014/main" id="{63159054-BA53-7942-8AE8-26607FF3DBD8}"/>
              </a:ext>
            </a:extLst>
          </p:cNvPr>
          <p:cNvSpPr txBox="1"/>
          <p:nvPr/>
        </p:nvSpPr>
        <p:spPr>
          <a:xfrm>
            <a:off x="2904094" y="596273"/>
            <a:ext cx="97654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LNA anti-miR-21-5p</a:t>
            </a:r>
          </a:p>
        </p:txBody>
      </p:sp>
    </p:spTree>
    <p:extLst>
      <p:ext uri="{BB962C8B-B14F-4D97-AF65-F5344CB8AC3E}">
        <p14:creationId xmlns:p14="http://schemas.microsoft.com/office/powerpoint/2010/main" val="3289257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782</TotalTime>
  <Words>539</Words>
  <Application>Microsoft Macintosh PowerPoint</Application>
  <PresentationFormat>Letter Paper (8.5x11 in)</PresentationFormat>
  <Paragraphs>129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IDMC</dc:creator>
  <cp:lastModifiedBy>Wencai Zhang</cp:lastModifiedBy>
  <cp:revision>210</cp:revision>
  <cp:lastPrinted>2022-05-26T19:52:30Z</cp:lastPrinted>
  <dcterms:created xsi:type="dcterms:W3CDTF">2016-03-04T20:57:06Z</dcterms:created>
  <dcterms:modified xsi:type="dcterms:W3CDTF">2022-06-23T12:09:10Z</dcterms:modified>
</cp:coreProperties>
</file>